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91" r:id="rId2"/>
  </p:sldIdLst>
  <p:sldSz cx="6858000" cy="9906000" type="A4"/>
  <p:notesSz cx="6797675" cy="99250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50" userDrawn="1">
          <p15:clr>
            <a:srgbClr val="A4A3A4"/>
          </p15:clr>
        </p15:guide>
        <p15:guide id="3" pos="1178" userDrawn="1">
          <p15:clr>
            <a:srgbClr val="A4A3A4"/>
          </p15:clr>
        </p15:guide>
        <p15:guide id="5" pos="4221" userDrawn="1">
          <p15:clr>
            <a:srgbClr val="A4A3A4"/>
          </p15:clr>
        </p15:guide>
        <p15:guide id="6" orient="horz" pos="5956" userDrawn="1">
          <p15:clr>
            <a:srgbClr val="A4A3A4"/>
          </p15:clr>
        </p15:guide>
        <p15:guide id="7" pos="164" userDrawn="1">
          <p15:clr>
            <a:srgbClr val="A4A3A4"/>
          </p15:clr>
        </p15:guide>
        <p15:guide id="8" pos="415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6600"/>
    <a:srgbClr val="EECCF9"/>
    <a:srgbClr val="CCF9E8"/>
    <a:srgbClr val="FFFFFF"/>
    <a:srgbClr val="FFE0E0"/>
    <a:srgbClr val="EAE8E9"/>
    <a:srgbClr val="151515"/>
    <a:srgbClr val="FFFF00"/>
    <a:srgbClr val="FFC9C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450" autoAdjust="0"/>
    <p:restoredTop sz="92781" autoAdjust="0"/>
  </p:normalViewPr>
  <p:slideViewPr>
    <p:cSldViewPr snapToGrid="0" showGuides="1">
      <p:cViewPr>
        <p:scale>
          <a:sx n="125" d="100"/>
          <a:sy n="125" d="100"/>
        </p:scale>
        <p:origin x="1314" y="-1626"/>
      </p:cViewPr>
      <p:guideLst>
        <p:guide orient="horz" pos="1850"/>
        <p:guide pos="1178"/>
        <p:guide pos="4221"/>
        <p:guide orient="horz" pos="5956"/>
        <p:guide pos="164"/>
        <p:guide pos="415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680AB3-A715-4D44-B0FF-8262B61BB388}" type="datetimeFigureOut">
              <a:rPr lang="zh-CN" altLang="en-US" smtClean="0"/>
              <a:t>2025/6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2E9BA4-A05B-4E19-9F95-99BFD87B324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  <a:t>2025/6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  <a:t>2025/6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  <a:t>2025/6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  <a:t>2025/6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  <a:t>2025/6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  <a:t>2025/6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  <a:t>2025/6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  <a:t>2025/6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  <a:t>2025/6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  <a:t>2025/6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  <a:t>2025/6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FD0B63-93A9-4F6D-9424-323C1571F097}" type="datetimeFigureOut">
              <a:rPr lang="zh-CN" altLang="en-US" smtClean="0"/>
              <a:t>2025/6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1A8BAC-F9FA-4C12-BF8E-665FF48517D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6" name="图片 135">
            <a:extLst>
              <a:ext uri="{FF2B5EF4-FFF2-40B4-BE49-F238E27FC236}">
                <a16:creationId xmlns:a16="http://schemas.microsoft.com/office/drawing/2014/main" id="{D42B247A-8385-6FA7-2305-AF2D33CE0CD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46" t="43464" r="33115" b="34533"/>
          <a:stretch>
            <a:fillRect/>
          </a:stretch>
        </p:blipFill>
        <p:spPr>
          <a:xfrm>
            <a:off x="358178" y="2923017"/>
            <a:ext cx="2999645" cy="2179632"/>
          </a:xfrm>
          <a:prstGeom prst="rect">
            <a:avLst/>
          </a:prstGeom>
        </p:spPr>
      </p:pic>
      <p:pic>
        <p:nvPicPr>
          <p:cNvPr id="132" name="图片 131">
            <a:extLst>
              <a:ext uri="{FF2B5EF4-FFF2-40B4-BE49-F238E27FC236}">
                <a16:creationId xmlns:a16="http://schemas.microsoft.com/office/drawing/2014/main" id="{E1AA2867-23FC-2C89-4FA5-491AD4C451C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4123" y="5605865"/>
            <a:ext cx="6118860" cy="1165860"/>
          </a:xfrm>
          <a:prstGeom prst="rect">
            <a:avLst/>
          </a:prstGeom>
        </p:spPr>
      </p:pic>
      <p:graphicFrame>
        <p:nvGraphicFramePr>
          <p:cNvPr id="4" name="对象 3"/>
          <p:cNvGraphicFramePr/>
          <p:nvPr/>
        </p:nvGraphicFramePr>
        <p:xfrm>
          <a:off x="3687763" y="3824288"/>
          <a:ext cx="2908300" cy="12398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4" imgW="4450080" imgH="2019300" progId="Prism7.Document">
                  <p:embed/>
                </p:oleObj>
              </mc:Choice>
              <mc:Fallback>
                <p:oleObj name="Prism 7" r:id="rId4" imgW="4450080" imgH="2019300" progId="Prism7.Document">
                  <p:embed/>
                  <p:pic>
                    <p:nvPicPr>
                      <p:cNvPr id="0" name="对象 3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687763" y="3824288"/>
                        <a:ext cx="2908300" cy="12398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7" name="文本框 56"/>
          <p:cNvSpPr txBox="1"/>
          <p:nvPr/>
        </p:nvSpPr>
        <p:spPr>
          <a:xfrm>
            <a:off x="53340" y="253621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0" name="组合 109"/>
          <p:cNvGrpSpPr/>
          <p:nvPr/>
        </p:nvGrpSpPr>
        <p:grpSpPr>
          <a:xfrm>
            <a:off x="3375387" y="2536091"/>
            <a:ext cx="3292113" cy="2606931"/>
            <a:chOff x="513234" y="3695375"/>
            <a:chExt cx="3292113" cy="2606931"/>
          </a:xfrm>
        </p:grpSpPr>
        <p:sp>
          <p:nvSpPr>
            <p:cNvPr id="49" name="文本框 48"/>
            <p:cNvSpPr txBox="1"/>
            <p:nvPr/>
          </p:nvSpPr>
          <p:spPr>
            <a:xfrm>
              <a:off x="2884837" y="4577909"/>
              <a:ext cx="92051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defTabSz="489585">
                <a:defRPr sz="80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700" dirty="0"/>
                <a:t>Sacrificed Kidney and liver</a:t>
              </a:r>
            </a:p>
            <a:p>
              <a:endParaRPr lang="zh-CN" altLang="en-US" sz="700" dirty="0"/>
            </a:p>
          </p:txBody>
        </p:sp>
        <p:cxnSp>
          <p:nvCxnSpPr>
            <p:cNvPr id="87" name="直接连接符 86"/>
            <p:cNvCxnSpPr/>
            <p:nvPr/>
          </p:nvCxnSpPr>
          <p:spPr>
            <a:xfrm>
              <a:off x="1585961" y="4448520"/>
              <a:ext cx="0" cy="845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箭头: 直角上 49"/>
            <p:cNvSpPr/>
            <p:nvPr/>
          </p:nvSpPr>
          <p:spPr>
            <a:xfrm rot="5400000">
              <a:off x="2805237" y="4650784"/>
              <a:ext cx="171209" cy="155849"/>
            </a:xfrm>
            <a:prstGeom prst="bentUpArrow">
              <a:avLst>
                <a:gd name="adj1" fmla="val 31154"/>
                <a:gd name="adj2" fmla="val 46855"/>
                <a:gd name="adj3" fmla="val 50000"/>
              </a:avLst>
            </a:prstGeom>
            <a:solidFill>
              <a:srgbClr val="FFC9C9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 dirty="0">
                <a:solidFill>
                  <a:schemeClr val="tx1"/>
                </a:solidFill>
              </a:endParaRPr>
            </a:p>
          </p:txBody>
        </p:sp>
        <p:cxnSp>
          <p:nvCxnSpPr>
            <p:cNvPr id="88" name="直接连接符 87"/>
            <p:cNvCxnSpPr/>
            <p:nvPr/>
          </p:nvCxnSpPr>
          <p:spPr>
            <a:xfrm>
              <a:off x="1695498" y="4448520"/>
              <a:ext cx="0" cy="845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接连接符 88"/>
            <p:cNvCxnSpPr/>
            <p:nvPr/>
          </p:nvCxnSpPr>
          <p:spPr>
            <a:xfrm>
              <a:off x="1816942" y="4448520"/>
              <a:ext cx="0" cy="845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直接连接符 89"/>
            <p:cNvCxnSpPr/>
            <p:nvPr/>
          </p:nvCxnSpPr>
          <p:spPr>
            <a:xfrm>
              <a:off x="1926480" y="4448520"/>
              <a:ext cx="0" cy="845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5" name="组合 54"/>
            <p:cNvGrpSpPr/>
            <p:nvPr/>
          </p:nvGrpSpPr>
          <p:grpSpPr>
            <a:xfrm>
              <a:off x="513234" y="3981450"/>
              <a:ext cx="2781696" cy="2320856"/>
              <a:chOff x="179360" y="972863"/>
              <a:chExt cx="2732649" cy="2183705"/>
            </a:xfrm>
          </p:grpSpPr>
          <p:grpSp>
            <p:nvGrpSpPr>
              <p:cNvPr id="58" name="组合 57"/>
              <p:cNvGrpSpPr/>
              <p:nvPr/>
            </p:nvGrpSpPr>
            <p:grpSpPr>
              <a:xfrm>
                <a:off x="999542" y="972863"/>
                <a:ext cx="1912467" cy="2183705"/>
                <a:chOff x="633446" y="3264754"/>
                <a:chExt cx="1672173" cy="2264276"/>
              </a:xfrm>
            </p:grpSpPr>
            <p:grpSp>
              <p:nvGrpSpPr>
                <p:cNvPr id="74" name="组合 73"/>
                <p:cNvGrpSpPr/>
                <p:nvPr/>
              </p:nvGrpSpPr>
              <p:grpSpPr>
                <a:xfrm>
                  <a:off x="633446" y="3264754"/>
                  <a:ext cx="1672173" cy="2264276"/>
                  <a:chOff x="4136172" y="2134039"/>
                  <a:chExt cx="1672173" cy="2264276"/>
                </a:xfrm>
              </p:grpSpPr>
              <p:sp>
                <p:nvSpPr>
                  <p:cNvPr id="76" name="文本框 75"/>
                  <p:cNvSpPr txBox="1"/>
                  <p:nvPr/>
                </p:nvSpPr>
                <p:spPr>
                  <a:xfrm>
                    <a:off x="5245303" y="2610087"/>
                    <a:ext cx="563042" cy="19517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defTabSz="489585">
                      <a:defRPr/>
                    </a:pPr>
                    <a:r>
                      <a:rPr lang="en-US" altLang="zh-CN" sz="7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rPr>
                      <a:t>90 (days)</a:t>
                    </a:r>
                  </a:p>
                </p:txBody>
              </p:sp>
              <p:sp>
                <p:nvSpPr>
                  <p:cNvPr id="79" name="左中括号 78"/>
                  <p:cNvSpPr/>
                  <p:nvPr/>
                </p:nvSpPr>
                <p:spPr>
                  <a:xfrm rot="16200000">
                    <a:off x="4755322" y="2274774"/>
                    <a:ext cx="108866" cy="1127567"/>
                  </a:xfrm>
                  <a:prstGeom prst="leftBracket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 defTabSz="489585">
                      <a:defRPr/>
                    </a:pPr>
                    <a:endParaRPr lang="zh-CN" altLang="en-US" sz="70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0" name="矩形 79"/>
                  <p:cNvSpPr/>
                  <p:nvPr/>
                </p:nvSpPr>
                <p:spPr>
                  <a:xfrm>
                    <a:off x="4320143" y="2134039"/>
                    <a:ext cx="1204026" cy="300274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pPr algn="ctr" defTabSz="489585">
                      <a:defRPr/>
                    </a:pPr>
                    <a:r>
                      <a:rPr lang="en-US" altLang="zh-CN" sz="700" dirty="0" err="1"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rPr>
                      <a:t>Huaier</a:t>
                    </a:r>
                    <a:r>
                      <a:rPr lang="en-US" altLang="zh-CN" sz="7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rPr>
                      <a:t> (0, 4.5 g/kg)</a:t>
                    </a:r>
                  </a:p>
                  <a:p>
                    <a:pPr algn="ctr" defTabSz="489585">
                      <a:defRPr/>
                    </a:pPr>
                    <a:r>
                      <a:rPr lang="en-US" altLang="zh-CN" sz="7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rPr>
                      <a:t>Daily </a:t>
                    </a:r>
                    <a:r>
                      <a:rPr lang="en-US" altLang="zh-CN" sz="700" dirty="0" err="1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rPr>
                      <a:t>gavaged</a:t>
                    </a:r>
                    <a:endParaRPr lang="en-US" altLang="zh-CN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1" name="左中括号 80"/>
                  <p:cNvSpPr/>
                  <p:nvPr/>
                </p:nvSpPr>
                <p:spPr>
                  <a:xfrm rot="5400000">
                    <a:off x="4708846" y="2009433"/>
                    <a:ext cx="202662" cy="1126718"/>
                  </a:xfrm>
                  <a:prstGeom prst="leftBracket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 defTabSz="489585">
                      <a:defRPr/>
                    </a:pPr>
                    <a:endParaRPr lang="zh-CN" altLang="en-US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3" name="矩形 82"/>
                  <p:cNvSpPr/>
                  <p:nvPr/>
                </p:nvSpPr>
                <p:spPr>
                  <a:xfrm>
                    <a:off x="4392218" y="2839163"/>
                    <a:ext cx="1131951" cy="195178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pPr algn="ctr">
                      <a:defRPr/>
                    </a:pPr>
                    <a:r>
                      <a:rPr lang="en-US" altLang="zh-CN" sz="700" dirty="0"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rPr>
                      <a:t>Weight analysis</a:t>
                    </a:r>
                    <a:endParaRPr lang="zh-CN" altLang="en-US" sz="700" dirty="0"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2" name="矩形 81"/>
                  <p:cNvSpPr/>
                  <p:nvPr/>
                </p:nvSpPr>
                <p:spPr>
                  <a:xfrm>
                    <a:off x="4136172" y="2549203"/>
                    <a:ext cx="1316450" cy="76852"/>
                  </a:xfrm>
                  <a:prstGeom prst="rect">
                    <a:avLst/>
                  </a:prstGeom>
                  <a:solidFill>
                    <a:schemeClr val="tx1"/>
                  </a:solidFill>
                  <a:ln w="3175"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5" name="矩形 94"/>
                  <p:cNvSpPr/>
                  <p:nvPr/>
                </p:nvSpPr>
                <p:spPr>
                  <a:xfrm>
                    <a:off x="4224706" y="4203137"/>
                    <a:ext cx="1131951" cy="195178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pPr algn="ctr">
                      <a:defRPr/>
                    </a:pPr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ime (days)</a:t>
                    </a:r>
                    <a:endParaRPr lang="zh-CN" altLang="en-US" sz="700" dirty="0"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75" name="文本框 74"/>
                <p:cNvSpPr txBox="1"/>
                <p:nvPr/>
              </p:nvSpPr>
              <p:spPr>
                <a:xfrm>
                  <a:off x="637223" y="3754593"/>
                  <a:ext cx="1529622" cy="19517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defTabSz="489585">
                    <a:defRPr/>
                  </a:pPr>
                  <a:r>
                    <a:rPr lang="en-US" altLang="zh-CN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1  2  3  4  5</a:t>
                  </a:r>
                </a:p>
              </p:txBody>
            </p:sp>
          </p:grpSp>
          <p:grpSp>
            <p:nvGrpSpPr>
              <p:cNvPr id="59" name="组合 58"/>
              <p:cNvGrpSpPr/>
              <p:nvPr/>
            </p:nvGrpSpPr>
            <p:grpSpPr>
              <a:xfrm>
                <a:off x="295173" y="1200223"/>
                <a:ext cx="611000" cy="281240"/>
                <a:chOff x="693845" y="2052603"/>
                <a:chExt cx="894563" cy="388142"/>
              </a:xfrm>
            </p:grpSpPr>
            <p:sp>
              <p:nvSpPr>
                <p:cNvPr id="61" name="任意多边形: 形状 56"/>
                <p:cNvSpPr/>
                <p:nvPr/>
              </p:nvSpPr>
              <p:spPr>
                <a:xfrm>
                  <a:off x="748761" y="2061762"/>
                  <a:ext cx="839647" cy="378983"/>
                </a:xfrm>
                <a:custGeom>
                  <a:avLst/>
                  <a:gdLst>
                    <a:gd name="connsiteX0" fmla="*/ 5841 w 721310"/>
                    <a:gd name="connsiteY0" fmla="*/ 219706 h 302958"/>
                    <a:gd name="connsiteX1" fmla="*/ 51878 w 721310"/>
                    <a:gd name="connsiteY1" fmla="*/ 121281 h 302958"/>
                    <a:gd name="connsiteX2" fmla="*/ 97916 w 721310"/>
                    <a:gd name="connsiteY2" fmla="*/ 75244 h 302958"/>
                    <a:gd name="connsiteX3" fmla="*/ 80453 w 721310"/>
                    <a:gd name="connsiteY3" fmla="*/ 49844 h 302958"/>
                    <a:gd name="connsiteX4" fmla="*/ 102678 w 721310"/>
                    <a:gd name="connsiteY4" fmla="*/ 5394 h 302958"/>
                    <a:gd name="connsiteX5" fmla="*/ 151891 w 721310"/>
                    <a:gd name="connsiteY5" fmla="*/ 10156 h 302958"/>
                    <a:gd name="connsiteX6" fmla="*/ 177291 w 721310"/>
                    <a:gd name="connsiteY6" fmla="*/ 48256 h 302958"/>
                    <a:gd name="connsiteX7" fmla="*/ 174116 w 721310"/>
                    <a:gd name="connsiteY7" fmla="*/ 72069 h 302958"/>
                    <a:gd name="connsiteX8" fmla="*/ 223328 w 721310"/>
                    <a:gd name="connsiteY8" fmla="*/ 21269 h 302958"/>
                    <a:gd name="connsiteX9" fmla="*/ 345566 w 721310"/>
                    <a:gd name="connsiteY9" fmla="*/ 3806 h 302958"/>
                    <a:gd name="connsiteX10" fmla="*/ 524953 w 721310"/>
                    <a:gd name="connsiteY10" fmla="*/ 91119 h 302958"/>
                    <a:gd name="connsiteX11" fmla="*/ 561466 w 721310"/>
                    <a:gd name="connsiteY11" fmla="*/ 151444 h 302958"/>
                    <a:gd name="connsiteX12" fmla="*/ 637666 w 721310"/>
                    <a:gd name="connsiteY12" fmla="*/ 203831 h 302958"/>
                    <a:gd name="connsiteX13" fmla="*/ 682116 w 721310"/>
                    <a:gd name="connsiteY13" fmla="*/ 213356 h 302958"/>
                    <a:gd name="connsiteX14" fmla="*/ 691641 w 721310"/>
                    <a:gd name="connsiteY14" fmla="*/ 140331 h 302958"/>
                    <a:gd name="connsiteX15" fmla="*/ 629728 w 721310"/>
                    <a:gd name="connsiteY15" fmla="*/ 19681 h 302958"/>
                    <a:gd name="connsiteX16" fmla="*/ 718628 w 721310"/>
                    <a:gd name="connsiteY16" fmla="*/ 175256 h 302958"/>
                    <a:gd name="connsiteX17" fmla="*/ 691641 w 721310"/>
                    <a:gd name="connsiteY17" fmla="*/ 233994 h 302958"/>
                    <a:gd name="connsiteX18" fmla="*/ 624966 w 721310"/>
                    <a:gd name="connsiteY18" fmla="*/ 229231 h 302958"/>
                    <a:gd name="connsiteX19" fmla="*/ 556703 w 721310"/>
                    <a:gd name="connsiteY19" fmla="*/ 189544 h 302958"/>
                    <a:gd name="connsiteX20" fmla="*/ 559878 w 721310"/>
                    <a:gd name="connsiteY20" fmla="*/ 197481 h 302958"/>
                    <a:gd name="connsiteX21" fmla="*/ 521778 w 721310"/>
                    <a:gd name="connsiteY21" fmla="*/ 227644 h 302958"/>
                    <a:gd name="connsiteX22" fmla="*/ 426528 w 721310"/>
                    <a:gd name="connsiteY22" fmla="*/ 238756 h 302958"/>
                    <a:gd name="connsiteX23" fmla="*/ 345566 w 721310"/>
                    <a:gd name="connsiteY23" fmla="*/ 291144 h 302958"/>
                    <a:gd name="connsiteX24" fmla="*/ 331278 w 721310"/>
                    <a:gd name="connsiteY24" fmla="*/ 295906 h 302958"/>
                    <a:gd name="connsiteX25" fmla="*/ 375728 w 721310"/>
                    <a:gd name="connsiteY25" fmla="*/ 208594 h 302958"/>
                    <a:gd name="connsiteX26" fmla="*/ 313816 w 721310"/>
                    <a:gd name="connsiteY26" fmla="*/ 230819 h 302958"/>
                    <a:gd name="connsiteX27" fmla="*/ 231266 w 721310"/>
                    <a:gd name="connsiteY27" fmla="*/ 230819 h 302958"/>
                    <a:gd name="connsiteX28" fmla="*/ 153478 w 721310"/>
                    <a:gd name="connsiteY28" fmla="*/ 270506 h 302958"/>
                    <a:gd name="connsiteX29" fmla="*/ 193166 w 721310"/>
                    <a:gd name="connsiteY29" fmla="*/ 213356 h 302958"/>
                    <a:gd name="connsiteX30" fmla="*/ 5841 w 721310"/>
                    <a:gd name="connsiteY30" fmla="*/ 219706 h 302958"/>
                    <a:gd name="connsiteX0-1" fmla="*/ 5347 w 728754"/>
                    <a:gd name="connsiteY0-2" fmla="*/ 241931 h 302958"/>
                    <a:gd name="connsiteX1-3" fmla="*/ 59322 w 728754"/>
                    <a:gd name="connsiteY1-4" fmla="*/ 121281 h 302958"/>
                    <a:gd name="connsiteX2-5" fmla="*/ 105360 w 728754"/>
                    <a:gd name="connsiteY2-6" fmla="*/ 75244 h 302958"/>
                    <a:gd name="connsiteX3-7" fmla="*/ 87897 w 728754"/>
                    <a:gd name="connsiteY3-8" fmla="*/ 49844 h 302958"/>
                    <a:gd name="connsiteX4-9" fmla="*/ 110122 w 728754"/>
                    <a:gd name="connsiteY4-10" fmla="*/ 5394 h 302958"/>
                    <a:gd name="connsiteX5-11" fmla="*/ 159335 w 728754"/>
                    <a:gd name="connsiteY5-12" fmla="*/ 10156 h 302958"/>
                    <a:gd name="connsiteX6-13" fmla="*/ 184735 w 728754"/>
                    <a:gd name="connsiteY6-14" fmla="*/ 48256 h 302958"/>
                    <a:gd name="connsiteX7-15" fmla="*/ 181560 w 728754"/>
                    <a:gd name="connsiteY7-16" fmla="*/ 72069 h 302958"/>
                    <a:gd name="connsiteX8-17" fmla="*/ 230772 w 728754"/>
                    <a:gd name="connsiteY8-18" fmla="*/ 21269 h 302958"/>
                    <a:gd name="connsiteX9-19" fmla="*/ 353010 w 728754"/>
                    <a:gd name="connsiteY9-20" fmla="*/ 3806 h 302958"/>
                    <a:gd name="connsiteX10-21" fmla="*/ 532397 w 728754"/>
                    <a:gd name="connsiteY10-22" fmla="*/ 91119 h 302958"/>
                    <a:gd name="connsiteX11-23" fmla="*/ 568910 w 728754"/>
                    <a:gd name="connsiteY11-24" fmla="*/ 151444 h 302958"/>
                    <a:gd name="connsiteX12-25" fmla="*/ 645110 w 728754"/>
                    <a:gd name="connsiteY12-26" fmla="*/ 203831 h 302958"/>
                    <a:gd name="connsiteX13-27" fmla="*/ 689560 w 728754"/>
                    <a:gd name="connsiteY13-28" fmla="*/ 213356 h 302958"/>
                    <a:gd name="connsiteX14-29" fmla="*/ 699085 w 728754"/>
                    <a:gd name="connsiteY14-30" fmla="*/ 140331 h 302958"/>
                    <a:gd name="connsiteX15-31" fmla="*/ 637172 w 728754"/>
                    <a:gd name="connsiteY15-32" fmla="*/ 19681 h 302958"/>
                    <a:gd name="connsiteX16-33" fmla="*/ 726072 w 728754"/>
                    <a:gd name="connsiteY16-34" fmla="*/ 175256 h 302958"/>
                    <a:gd name="connsiteX17-35" fmla="*/ 699085 w 728754"/>
                    <a:gd name="connsiteY17-36" fmla="*/ 233994 h 302958"/>
                    <a:gd name="connsiteX18-37" fmla="*/ 632410 w 728754"/>
                    <a:gd name="connsiteY18-38" fmla="*/ 229231 h 302958"/>
                    <a:gd name="connsiteX19-39" fmla="*/ 564147 w 728754"/>
                    <a:gd name="connsiteY19-40" fmla="*/ 189544 h 302958"/>
                    <a:gd name="connsiteX20-41" fmla="*/ 567322 w 728754"/>
                    <a:gd name="connsiteY20-42" fmla="*/ 197481 h 302958"/>
                    <a:gd name="connsiteX21-43" fmla="*/ 529222 w 728754"/>
                    <a:gd name="connsiteY21-44" fmla="*/ 227644 h 302958"/>
                    <a:gd name="connsiteX22-45" fmla="*/ 433972 w 728754"/>
                    <a:gd name="connsiteY22-46" fmla="*/ 238756 h 302958"/>
                    <a:gd name="connsiteX23-47" fmla="*/ 353010 w 728754"/>
                    <a:gd name="connsiteY23-48" fmla="*/ 291144 h 302958"/>
                    <a:gd name="connsiteX24-49" fmla="*/ 338722 w 728754"/>
                    <a:gd name="connsiteY24-50" fmla="*/ 295906 h 302958"/>
                    <a:gd name="connsiteX25-51" fmla="*/ 383172 w 728754"/>
                    <a:gd name="connsiteY25-52" fmla="*/ 208594 h 302958"/>
                    <a:gd name="connsiteX26-53" fmla="*/ 321260 w 728754"/>
                    <a:gd name="connsiteY26-54" fmla="*/ 230819 h 302958"/>
                    <a:gd name="connsiteX27-55" fmla="*/ 238710 w 728754"/>
                    <a:gd name="connsiteY27-56" fmla="*/ 230819 h 302958"/>
                    <a:gd name="connsiteX28-57" fmla="*/ 160922 w 728754"/>
                    <a:gd name="connsiteY28-58" fmla="*/ 270506 h 302958"/>
                    <a:gd name="connsiteX29-59" fmla="*/ 200610 w 728754"/>
                    <a:gd name="connsiteY29-60" fmla="*/ 213356 h 302958"/>
                    <a:gd name="connsiteX30-61" fmla="*/ 5347 w 728754"/>
                    <a:gd name="connsiteY30-62" fmla="*/ 241931 h 302958"/>
                    <a:gd name="connsiteX0-63" fmla="*/ 5298 w 728705"/>
                    <a:gd name="connsiteY0-64" fmla="*/ 241931 h 302958"/>
                    <a:gd name="connsiteX1-65" fmla="*/ 59273 w 728705"/>
                    <a:gd name="connsiteY1-66" fmla="*/ 121281 h 302958"/>
                    <a:gd name="connsiteX2-67" fmla="*/ 100549 w 728705"/>
                    <a:gd name="connsiteY2-68" fmla="*/ 76831 h 302958"/>
                    <a:gd name="connsiteX3-69" fmla="*/ 87848 w 728705"/>
                    <a:gd name="connsiteY3-70" fmla="*/ 49844 h 302958"/>
                    <a:gd name="connsiteX4-71" fmla="*/ 110073 w 728705"/>
                    <a:gd name="connsiteY4-72" fmla="*/ 5394 h 302958"/>
                    <a:gd name="connsiteX5-73" fmla="*/ 159286 w 728705"/>
                    <a:gd name="connsiteY5-74" fmla="*/ 10156 h 302958"/>
                    <a:gd name="connsiteX6-75" fmla="*/ 184686 w 728705"/>
                    <a:gd name="connsiteY6-76" fmla="*/ 48256 h 302958"/>
                    <a:gd name="connsiteX7-77" fmla="*/ 181511 w 728705"/>
                    <a:gd name="connsiteY7-78" fmla="*/ 72069 h 302958"/>
                    <a:gd name="connsiteX8-79" fmla="*/ 230723 w 728705"/>
                    <a:gd name="connsiteY8-80" fmla="*/ 21269 h 302958"/>
                    <a:gd name="connsiteX9-81" fmla="*/ 352961 w 728705"/>
                    <a:gd name="connsiteY9-82" fmla="*/ 3806 h 302958"/>
                    <a:gd name="connsiteX10-83" fmla="*/ 532348 w 728705"/>
                    <a:gd name="connsiteY10-84" fmla="*/ 91119 h 302958"/>
                    <a:gd name="connsiteX11-85" fmla="*/ 568861 w 728705"/>
                    <a:gd name="connsiteY11-86" fmla="*/ 151444 h 302958"/>
                    <a:gd name="connsiteX12-87" fmla="*/ 645061 w 728705"/>
                    <a:gd name="connsiteY12-88" fmla="*/ 203831 h 302958"/>
                    <a:gd name="connsiteX13-89" fmla="*/ 689511 w 728705"/>
                    <a:gd name="connsiteY13-90" fmla="*/ 213356 h 302958"/>
                    <a:gd name="connsiteX14-91" fmla="*/ 699036 w 728705"/>
                    <a:gd name="connsiteY14-92" fmla="*/ 140331 h 302958"/>
                    <a:gd name="connsiteX15-93" fmla="*/ 637123 w 728705"/>
                    <a:gd name="connsiteY15-94" fmla="*/ 19681 h 302958"/>
                    <a:gd name="connsiteX16-95" fmla="*/ 726023 w 728705"/>
                    <a:gd name="connsiteY16-96" fmla="*/ 175256 h 302958"/>
                    <a:gd name="connsiteX17-97" fmla="*/ 699036 w 728705"/>
                    <a:gd name="connsiteY17-98" fmla="*/ 233994 h 302958"/>
                    <a:gd name="connsiteX18-99" fmla="*/ 632361 w 728705"/>
                    <a:gd name="connsiteY18-100" fmla="*/ 229231 h 302958"/>
                    <a:gd name="connsiteX19-101" fmla="*/ 564098 w 728705"/>
                    <a:gd name="connsiteY19-102" fmla="*/ 189544 h 302958"/>
                    <a:gd name="connsiteX20-103" fmla="*/ 567273 w 728705"/>
                    <a:gd name="connsiteY20-104" fmla="*/ 197481 h 302958"/>
                    <a:gd name="connsiteX21-105" fmla="*/ 529173 w 728705"/>
                    <a:gd name="connsiteY21-106" fmla="*/ 227644 h 302958"/>
                    <a:gd name="connsiteX22-107" fmla="*/ 433923 w 728705"/>
                    <a:gd name="connsiteY22-108" fmla="*/ 238756 h 302958"/>
                    <a:gd name="connsiteX23-109" fmla="*/ 352961 w 728705"/>
                    <a:gd name="connsiteY23-110" fmla="*/ 291144 h 302958"/>
                    <a:gd name="connsiteX24-111" fmla="*/ 338673 w 728705"/>
                    <a:gd name="connsiteY24-112" fmla="*/ 295906 h 302958"/>
                    <a:gd name="connsiteX25-113" fmla="*/ 383123 w 728705"/>
                    <a:gd name="connsiteY25-114" fmla="*/ 208594 h 302958"/>
                    <a:gd name="connsiteX26-115" fmla="*/ 321211 w 728705"/>
                    <a:gd name="connsiteY26-116" fmla="*/ 230819 h 302958"/>
                    <a:gd name="connsiteX27-117" fmla="*/ 238661 w 728705"/>
                    <a:gd name="connsiteY27-118" fmla="*/ 230819 h 302958"/>
                    <a:gd name="connsiteX28-119" fmla="*/ 160873 w 728705"/>
                    <a:gd name="connsiteY28-120" fmla="*/ 270506 h 302958"/>
                    <a:gd name="connsiteX29-121" fmla="*/ 200561 w 728705"/>
                    <a:gd name="connsiteY29-122" fmla="*/ 213356 h 302958"/>
                    <a:gd name="connsiteX30-123" fmla="*/ 5298 w 728705"/>
                    <a:gd name="connsiteY30-124" fmla="*/ 241931 h 302958"/>
                    <a:gd name="connsiteX0-125" fmla="*/ 5298 w 728705"/>
                    <a:gd name="connsiteY0-126" fmla="*/ 241994 h 303021"/>
                    <a:gd name="connsiteX1-127" fmla="*/ 59273 w 728705"/>
                    <a:gd name="connsiteY1-128" fmla="*/ 121344 h 303021"/>
                    <a:gd name="connsiteX2-129" fmla="*/ 100549 w 728705"/>
                    <a:gd name="connsiteY2-130" fmla="*/ 76894 h 303021"/>
                    <a:gd name="connsiteX3-131" fmla="*/ 87848 w 728705"/>
                    <a:gd name="connsiteY3-132" fmla="*/ 49907 h 303021"/>
                    <a:gd name="connsiteX4-133" fmla="*/ 110073 w 728705"/>
                    <a:gd name="connsiteY4-134" fmla="*/ 5457 h 303021"/>
                    <a:gd name="connsiteX5-135" fmla="*/ 164048 w 728705"/>
                    <a:gd name="connsiteY5-136" fmla="*/ 5456 h 303021"/>
                    <a:gd name="connsiteX6-137" fmla="*/ 184686 w 728705"/>
                    <a:gd name="connsiteY6-138" fmla="*/ 48319 h 303021"/>
                    <a:gd name="connsiteX7-139" fmla="*/ 181511 w 728705"/>
                    <a:gd name="connsiteY7-140" fmla="*/ 72132 h 303021"/>
                    <a:gd name="connsiteX8-141" fmla="*/ 230723 w 728705"/>
                    <a:gd name="connsiteY8-142" fmla="*/ 21332 h 303021"/>
                    <a:gd name="connsiteX9-143" fmla="*/ 352961 w 728705"/>
                    <a:gd name="connsiteY9-144" fmla="*/ 3869 h 303021"/>
                    <a:gd name="connsiteX10-145" fmla="*/ 532348 w 728705"/>
                    <a:gd name="connsiteY10-146" fmla="*/ 91182 h 303021"/>
                    <a:gd name="connsiteX11-147" fmla="*/ 568861 w 728705"/>
                    <a:gd name="connsiteY11-148" fmla="*/ 151507 h 303021"/>
                    <a:gd name="connsiteX12-149" fmla="*/ 645061 w 728705"/>
                    <a:gd name="connsiteY12-150" fmla="*/ 203894 h 303021"/>
                    <a:gd name="connsiteX13-151" fmla="*/ 689511 w 728705"/>
                    <a:gd name="connsiteY13-152" fmla="*/ 213419 h 303021"/>
                    <a:gd name="connsiteX14-153" fmla="*/ 699036 w 728705"/>
                    <a:gd name="connsiteY14-154" fmla="*/ 140394 h 303021"/>
                    <a:gd name="connsiteX15-155" fmla="*/ 637123 w 728705"/>
                    <a:gd name="connsiteY15-156" fmla="*/ 19744 h 303021"/>
                    <a:gd name="connsiteX16-157" fmla="*/ 726023 w 728705"/>
                    <a:gd name="connsiteY16-158" fmla="*/ 175319 h 303021"/>
                    <a:gd name="connsiteX17-159" fmla="*/ 699036 w 728705"/>
                    <a:gd name="connsiteY17-160" fmla="*/ 234057 h 303021"/>
                    <a:gd name="connsiteX18-161" fmla="*/ 632361 w 728705"/>
                    <a:gd name="connsiteY18-162" fmla="*/ 229294 h 303021"/>
                    <a:gd name="connsiteX19-163" fmla="*/ 564098 w 728705"/>
                    <a:gd name="connsiteY19-164" fmla="*/ 189607 h 303021"/>
                    <a:gd name="connsiteX20-165" fmla="*/ 567273 w 728705"/>
                    <a:gd name="connsiteY20-166" fmla="*/ 197544 h 303021"/>
                    <a:gd name="connsiteX21-167" fmla="*/ 529173 w 728705"/>
                    <a:gd name="connsiteY21-168" fmla="*/ 227707 h 303021"/>
                    <a:gd name="connsiteX22-169" fmla="*/ 433923 w 728705"/>
                    <a:gd name="connsiteY22-170" fmla="*/ 238819 h 303021"/>
                    <a:gd name="connsiteX23-171" fmla="*/ 352961 w 728705"/>
                    <a:gd name="connsiteY23-172" fmla="*/ 291207 h 303021"/>
                    <a:gd name="connsiteX24-173" fmla="*/ 338673 w 728705"/>
                    <a:gd name="connsiteY24-174" fmla="*/ 295969 h 303021"/>
                    <a:gd name="connsiteX25-175" fmla="*/ 383123 w 728705"/>
                    <a:gd name="connsiteY25-176" fmla="*/ 208657 h 303021"/>
                    <a:gd name="connsiteX26-177" fmla="*/ 321211 w 728705"/>
                    <a:gd name="connsiteY26-178" fmla="*/ 230882 h 303021"/>
                    <a:gd name="connsiteX27-179" fmla="*/ 238661 w 728705"/>
                    <a:gd name="connsiteY27-180" fmla="*/ 230882 h 303021"/>
                    <a:gd name="connsiteX28-181" fmla="*/ 160873 w 728705"/>
                    <a:gd name="connsiteY28-182" fmla="*/ 270569 h 303021"/>
                    <a:gd name="connsiteX29-183" fmla="*/ 200561 w 728705"/>
                    <a:gd name="connsiteY29-184" fmla="*/ 213419 h 303021"/>
                    <a:gd name="connsiteX30-185" fmla="*/ 5298 w 728705"/>
                    <a:gd name="connsiteY30-186" fmla="*/ 241994 h 303021"/>
                    <a:gd name="connsiteX0-187" fmla="*/ 5298 w 728705"/>
                    <a:gd name="connsiteY0-188" fmla="*/ 241994 h 303021"/>
                    <a:gd name="connsiteX1-189" fmla="*/ 59273 w 728705"/>
                    <a:gd name="connsiteY1-190" fmla="*/ 121344 h 303021"/>
                    <a:gd name="connsiteX2-191" fmla="*/ 100549 w 728705"/>
                    <a:gd name="connsiteY2-192" fmla="*/ 76894 h 303021"/>
                    <a:gd name="connsiteX3-193" fmla="*/ 87848 w 728705"/>
                    <a:gd name="connsiteY3-194" fmla="*/ 49907 h 303021"/>
                    <a:gd name="connsiteX4-195" fmla="*/ 110073 w 728705"/>
                    <a:gd name="connsiteY4-196" fmla="*/ 5457 h 303021"/>
                    <a:gd name="connsiteX5-197" fmla="*/ 164048 w 728705"/>
                    <a:gd name="connsiteY5-198" fmla="*/ 5456 h 303021"/>
                    <a:gd name="connsiteX6-199" fmla="*/ 184686 w 728705"/>
                    <a:gd name="connsiteY6-200" fmla="*/ 48319 h 303021"/>
                    <a:gd name="connsiteX7-201" fmla="*/ 181511 w 728705"/>
                    <a:gd name="connsiteY7-202" fmla="*/ 72132 h 303021"/>
                    <a:gd name="connsiteX8-203" fmla="*/ 230723 w 728705"/>
                    <a:gd name="connsiteY8-204" fmla="*/ 21332 h 303021"/>
                    <a:gd name="connsiteX9-205" fmla="*/ 352961 w 728705"/>
                    <a:gd name="connsiteY9-206" fmla="*/ 3869 h 303021"/>
                    <a:gd name="connsiteX10-207" fmla="*/ 532348 w 728705"/>
                    <a:gd name="connsiteY10-208" fmla="*/ 91182 h 303021"/>
                    <a:gd name="connsiteX11-209" fmla="*/ 568861 w 728705"/>
                    <a:gd name="connsiteY11-210" fmla="*/ 151507 h 303021"/>
                    <a:gd name="connsiteX12-211" fmla="*/ 645061 w 728705"/>
                    <a:gd name="connsiteY12-212" fmla="*/ 203894 h 303021"/>
                    <a:gd name="connsiteX13-213" fmla="*/ 689511 w 728705"/>
                    <a:gd name="connsiteY13-214" fmla="*/ 213419 h 303021"/>
                    <a:gd name="connsiteX14-215" fmla="*/ 699036 w 728705"/>
                    <a:gd name="connsiteY14-216" fmla="*/ 140394 h 303021"/>
                    <a:gd name="connsiteX15-217" fmla="*/ 637123 w 728705"/>
                    <a:gd name="connsiteY15-218" fmla="*/ 19744 h 303021"/>
                    <a:gd name="connsiteX16-219" fmla="*/ 726023 w 728705"/>
                    <a:gd name="connsiteY16-220" fmla="*/ 175319 h 303021"/>
                    <a:gd name="connsiteX17-221" fmla="*/ 699036 w 728705"/>
                    <a:gd name="connsiteY17-222" fmla="*/ 234057 h 303021"/>
                    <a:gd name="connsiteX18-223" fmla="*/ 632361 w 728705"/>
                    <a:gd name="connsiteY18-224" fmla="*/ 229294 h 303021"/>
                    <a:gd name="connsiteX19-225" fmla="*/ 564098 w 728705"/>
                    <a:gd name="connsiteY19-226" fmla="*/ 189607 h 303021"/>
                    <a:gd name="connsiteX20-227" fmla="*/ 567273 w 728705"/>
                    <a:gd name="connsiteY20-228" fmla="*/ 197544 h 303021"/>
                    <a:gd name="connsiteX21-229" fmla="*/ 529173 w 728705"/>
                    <a:gd name="connsiteY21-230" fmla="*/ 227707 h 303021"/>
                    <a:gd name="connsiteX22-231" fmla="*/ 433923 w 728705"/>
                    <a:gd name="connsiteY22-232" fmla="*/ 238819 h 303021"/>
                    <a:gd name="connsiteX23-233" fmla="*/ 352961 w 728705"/>
                    <a:gd name="connsiteY23-234" fmla="*/ 291207 h 303021"/>
                    <a:gd name="connsiteX24-235" fmla="*/ 338673 w 728705"/>
                    <a:gd name="connsiteY24-236" fmla="*/ 295969 h 303021"/>
                    <a:gd name="connsiteX25-237" fmla="*/ 383123 w 728705"/>
                    <a:gd name="connsiteY25-238" fmla="*/ 208657 h 303021"/>
                    <a:gd name="connsiteX26-239" fmla="*/ 321211 w 728705"/>
                    <a:gd name="connsiteY26-240" fmla="*/ 230882 h 303021"/>
                    <a:gd name="connsiteX27-241" fmla="*/ 238661 w 728705"/>
                    <a:gd name="connsiteY27-242" fmla="*/ 230882 h 303021"/>
                    <a:gd name="connsiteX28-243" fmla="*/ 167223 w 728705"/>
                    <a:gd name="connsiteY28-244" fmla="*/ 281681 h 303021"/>
                    <a:gd name="connsiteX29-245" fmla="*/ 200561 w 728705"/>
                    <a:gd name="connsiteY29-246" fmla="*/ 213419 h 303021"/>
                    <a:gd name="connsiteX30-247" fmla="*/ 5298 w 728705"/>
                    <a:gd name="connsiteY30-248" fmla="*/ 241994 h 303021"/>
                    <a:gd name="connsiteX0-249" fmla="*/ 5298 w 728705"/>
                    <a:gd name="connsiteY0-250" fmla="*/ 241994 h 306697"/>
                    <a:gd name="connsiteX1-251" fmla="*/ 59273 w 728705"/>
                    <a:gd name="connsiteY1-252" fmla="*/ 121344 h 306697"/>
                    <a:gd name="connsiteX2-253" fmla="*/ 100549 w 728705"/>
                    <a:gd name="connsiteY2-254" fmla="*/ 76894 h 306697"/>
                    <a:gd name="connsiteX3-255" fmla="*/ 87848 w 728705"/>
                    <a:gd name="connsiteY3-256" fmla="*/ 49907 h 306697"/>
                    <a:gd name="connsiteX4-257" fmla="*/ 110073 w 728705"/>
                    <a:gd name="connsiteY4-258" fmla="*/ 5457 h 306697"/>
                    <a:gd name="connsiteX5-259" fmla="*/ 164048 w 728705"/>
                    <a:gd name="connsiteY5-260" fmla="*/ 5456 h 306697"/>
                    <a:gd name="connsiteX6-261" fmla="*/ 184686 w 728705"/>
                    <a:gd name="connsiteY6-262" fmla="*/ 48319 h 306697"/>
                    <a:gd name="connsiteX7-263" fmla="*/ 181511 w 728705"/>
                    <a:gd name="connsiteY7-264" fmla="*/ 72132 h 306697"/>
                    <a:gd name="connsiteX8-265" fmla="*/ 230723 w 728705"/>
                    <a:gd name="connsiteY8-266" fmla="*/ 21332 h 306697"/>
                    <a:gd name="connsiteX9-267" fmla="*/ 352961 w 728705"/>
                    <a:gd name="connsiteY9-268" fmla="*/ 3869 h 306697"/>
                    <a:gd name="connsiteX10-269" fmla="*/ 532348 w 728705"/>
                    <a:gd name="connsiteY10-270" fmla="*/ 91182 h 306697"/>
                    <a:gd name="connsiteX11-271" fmla="*/ 568861 w 728705"/>
                    <a:gd name="connsiteY11-272" fmla="*/ 151507 h 306697"/>
                    <a:gd name="connsiteX12-273" fmla="*/ 645061 w 728705"/>
                    <a:gd name="connsiteY12-274" fmla="*/ 203894 h 306697"/>
                    <a:gd name="connsiteX13-275" fmla="*/ 689511 w 728705"/>
                    <a:gd name="connsiteY13-276" fmla="*/ 213419 h 306697"/>
                    <a:gd name="connsiteX14-277" fmla="*/ 699036 w 728705"/>
                    <a:gd name="connsiteY14-278" fmla="*/ 140394 h 306697"/>
                    <a:gd name="connsiteX15-279" fmla="*/ 637123 w 728705"/>
                    <a:gd name="connsiteY15-280" fmla="*/ 19744 h 306697"/>
                    <a:gd name="connsiteX16-281" fmla="*/ 726023 w 728705"/>
                    <a:gd name="connsiteY16-282" fmla="*/ 175319 h 306697"/>
                    <a:gd name="connsiteX17-283" fmla="*/ 699036 w 728705"/>
                    <a:gd name="connsiteY17-284" fmla="*/ 234057 h 306697"/>
                    <a:gd name="connsiteX18-285" fmla="*/ 632361 w 728705"/>
                    <a:gd name="connsiteY18-286" fmla="*/ 229294 h 306697"/>
                    <a:gd name="connsiteX19-287" fmla="*/ 564098 w 728705"/>
                    <a:gd name="connsiteY19-288" fmla="*/ 189607 h 306697"/>
                    <a:gd name="connsiteX20-289" fmla="*/ 567273 w 728705"/>
                    <a:gd name="connsiteY20-290" fmla="*/ 197544 h 306697"/>
                    <a:gd name="connsiteX21-291" fmla="*/ 529173 w 728705"/>
                    <a:gd name="connsiteY21-292" fmla="*/ 227707 h 306697"/>
                    <a:gd name="connsiteX22-293" fmla="*/ 433923 w 728705"/>
                    <a:gd name="connsiteY22-294" fmla="*/ 238819 h 306697"/>
                    <a:gd name="connsiteX23-295" fmla="*/ 352961 w 728705"/>
                    <a:gd name="connsiteY23-296" fmla="*/ 291207 h 306697"/>
                    <a:gd name="connsiteX24-297" fmla="*/ 338673 w 728705"/>
                    <a:gd name="connsiteY24-298" fmla="*/ 300731 h 306697"/>
                    <a:gd name="connsiteX25-299" fmla="*/ 383123 w 728705"/>
                    <a:gd name="connsiteY25-300" fmla="*/ 208657 h 306697"/>
                    <a:gd name="connsiteX26-301" fmla="*/ 321211 w 728705"/>
                    <a:gd name="connsiteY26-302" fmla="*/ 230882 h 306697"/>
                    <a:gd name="connsiteX27-303" fmla="*/ 238661 w 728705"/>
                    <a:gd name="connsiteY27-304" fmla="*/ 230882 h 306697"/>
                    <a:gd name="connsiteX28-305" fmla="*/ 167223 w 728705"/>
                    <a:gd name="connsiteY28-306" fmla="*/ 281681 h 306697"/>
                    <a:gd name="connsiteX29-307" fmla="*/ 200561 w 728705"/>
                    <a:gd name="connsiteY29-308" fmla="*/ 213419 h 306697"/>
                    <a:gd name="connsiteX30-309" fmla="*/ 5298 w 728705"/>
                    <a:gd name="connsiteY30-310" fmla="*/ 241994 h 306697"/>
                    <a:gd name="connsiteX0-311" fmla="*/ 5298 w 728705"/>
                    <a:gd name="connsiteY0-312" fmla="*/ 241994 h 306697"/>
                    <a:gd name="connsiteX1-313" fmla="*/ 59273 w 728705"/>
                    <a:gd name="connsiteY1-314" fmla="*/ 121344 h 306697"/>
                    <a:gd name="connsiteX2-315" fmla="*/ 100549 w 728705"/>
                    <a:gd name="connsiteY2-316" fmla="*/ 76894 h 306697"/>
                    <a:gd name="connsiteX3-317" fmla="*/ 87848 w 728705"/>
                    <a:gd name="connsiteY3-318" fmla="*/ 49907 h 306697"/>
                    <a:gd name="connsiteX4-319" fmla="*/ 110073 w 728705"/>
                    <a:gd name="connsiteY4-320" fmla="*/ 5457 h 306697"/>
                    <a:gd name="connsiteX5-321" fmla="*/ 164048 w 728705"/>
                    <a:gd name="connsiteY5-322" fmla="*/ 5456 h 306697"/>
                    <a:gd name="connsiteX6-323" fmla="*/ 184686 w 728705"/>
                    <a:gd name="connsiteY6-324" fmla="*/ 48319 h 306697"/>
                    <a:gd name="connsiteX7-325" fmla="*/ 181511 w 728705"/>
                    <a:gd name="connsiteY7-326" fmla="*/ 72132 h 306697"/>
                    <a:gd name="connsiteX8-327" fmla="*/ 230723 w 728705"/>
                    <a:gd name="connsiteY8-328" fmla="*/ 21332 h 306697"/>
                    <a:gd name="connsiteX9-329" fmla="*/ 352961 w 728705"/>
                    <a:gd name="connsiteY9-330" fmla="*/ 3869 h 306697"/>
                    <a:gd name="connsiteX10-331" fmla="*/ 532348 w 728705"/>
                    <a:gd name="connsiteY10-332" fmla="*/ 91182 h 306697"/>
                    <a:gd name="connsiteX11-333" fmla="*/ 568861 w 728705"/>
                    <a:gd name="connsiteY11-334" fmla="*/ 151507 h 306697"/>
                    <a:gd name="connsiteX12-335" fmla="*/ 645061 w 728705"/>
                    <a:gd name="connsiteY12-336" fmla="*/ 203894 h 306697"/>
                    <a:gd name="connsiteX13-337" fmla="*/ 689511 w 728705"/>
                    <a:gd name="connsiteY13-338" fmla="*/ 213419 h 306697"/>
                    <a:gd name="connsiteX14-339" fmla="*/ 699036 w 728705"/>
                    <a:gd name="connsiteY14-340" fmla="*/ 140394 h 306697"/>
                    <a:gd name="connsiteX15-341" fmla="*/ 637123 w 728705"/>
                    <a:gd name="connsiteY15-342" fmla="*/ 19744 h 306697"/>
                    <a:gd name="connsiteX16-343" fmla="*/ 726023 w 728705"/>
                    <a:gd name="connsiteY16-344" fmla="*/ 175319 h 306697"/>
                    <a:gd name="connsiteX17-345" fmla="*/ 699036 w 728705"/>
                    <a:gd name="connsiteY17-346" fmla="*/ 234057 h 306697"/>
                    <a:gd name="connsiteX18-347" fmla="*/ 632361 w 728705"/>
                    <a:gd name="connsiteY18-348" fmla="*/ 229294 h 306697"/>
                    <a:gd name="connsiteX19-349" fmla="*/ 564098 w 728705"/>
                    <a:gd name="connsiteY19-350" fmla="*/ 189607 h 306697"/>
                    <a:gd name="connsiteX20-351" fmla="*/ 567273 w 728705"/>
                    <a:gd name="connsiteY20-352" fmla="*/ 197544 h 306697"/>
                    <a:gd name="connsiteX21-353" fmla="*/ 514886 w 728705"/>
                    <a:gd name="connsiteY21-354" fmla="*/ 234057 h 306697"/>
                    <a:gd name="connsiteX22-355" fmla="*/ 433923 w 728705"/>
                    <a:gd name="connsiteY22-356" fmla="*/ 238819 h 306697"/>
                    <a:gd name="connsiteX23-357" fmla="*/ 352961 w 728705"/>
                    <a:gd name="connsiteY23-358" fmla="*/ 291207 h 306697"/>
                    <a:gd name="connsiteX24-359" fmla="*/ 338673 w 728705"/>
                    <a:gd name="connsiteY24-360" fmla="*/ 300731 h 306697"/>
                    <a:gd name="connsiteX25-361" fmla="*/ 383123 w 728705"/>
                    <a:gd name="connsiteY25-362" fmla="*/ 208657 h 306697"/>
                    <a:gd name="connsiteX26-363" fmla="*/ 321211 w 728705"/>
                    <a:gd name="connsiteY26-364" fmla="*/ 230882 h 306697"/>
                    <a:gd name="connsiteX27-365" fmla="*/ 238661 w 728705"/>
                    <a:gd name="connsiteY27-366" fmla="*/ 230882 h 306697"/>
                    <a:gd name="connsiteX28-367" fmla="*/ 167223 w 728705"/>
                    <a:gd name="connsiteY28-368" fmla="*/ 281681 h 306697"/>
                    <a:gd name="connsiteX29-369" fmla="*/ 200561 w 728705"/>
                    <a:gd name="connsiteY29-370" fmla="*/ 213419 h 306697"/>
                    <a:gd name="connsiteX30-371" fmla="*/ 5298 w 728705"/>
                    <a:gd name="connsiteY30-372" fmla="*/ 241994 h 306697"/>
                    <a:gd name="connsiteX0-373" fmla="*/ 5298 w 728705"/>
                    <a:gd name="connsiteY0-374" fmla="*/ 241994 h 306697"/>
                    <a:gd name="connsiteX1-375" fmla="*/ 59273 w 728705"/>
                    <a:gd name="connsiteY1-376" fmla="*/ 121344 h 306697"/>
                    <a:gd name="connsiteX2-377" fmla="*/ 100549 w 728705"/>
                    <a:gd name="connsiteY2-378" fmla="*/ 76894 h 306697"/>
                    <a:gd name="connsiteX3-379" fmla="*/ 87848 w 728705"/>
                    <a:gd name="connsiteY3-380" fmla="*/ 49907 h 306697"/>
                    <a:gd name="connsiteX4-381" fmla="*/ 110073 w 728705"/>
                    <a:gd name="connsiteY4-382" fmla="*/ 5457 h 306697"/>
                    <a:gd name="connsiteX5-383" fmla="*/ 164048 w 728705"/>
                    <a:gd name="connsiteY5-384" fmla="*/ 5456 h 306697"/>
                    <a:gd name="connsiteX6-385" fmla="*/ 184686 w 728705"/>
                    <a:gd name="connsiteY6-386" fmla="*/ 48319 h 306697"/>
                    <a:gd name="connsiteX7-387" fmla="*/ 181511 w 728705"/>
                    <a:gd name="connsiteY7-388" fmla="*/ 72132 h 306697"/>
                    <a:gd name="connsiteX8-389" fmla="*/ 230723 w 728705"/>
                    <a:gd name="connsiteY8-390" fmla="*/ 21332 h 306697"/>
                    <a:gd name="connsiteX9-391" fmla="*/ 352961 w 728705"/>
                    <a:gd name="connsiteY9-392" fmla="*/ 3869 h 306697"/>
                    <a:gd name="connsiteX10-393" fmla="*/ 532348 w 728705"/>
                    <a:gd name="connsiteY10-394" fmla="*/ 91182 h 306697"/>
                    <a:gd name="connsiteX11-395" fmla="*/ 575211 w 728705"/>
                    <a:gd name="connsiteY11-396" fmla="*/ 143569 h 306697"/>
                    <a:gd name="connsiteX12-397" fmla="*/ 645061 w 728705"/>
                    <a:gd name="connsiteY12-398" fmla="*/ 203894 h 306697"/>
                    <a:gd name="connsiteX13-399" fmla="*/ 689511 w 728705"/>
                    <a:gd name="connsiteY13-400" fmla="*/ 213419 h 306697"/>
                    <a:gd name="connsiteX14-401" fmla="*/ 699036 w 728705"/>
                    <a:gd name="connsiteY14-402" fmla="*/ 140394 h 306697"/>
                    <a:gd name="connsiteX15-403" fmla="*/ 637123 w 728705"/>
                    <a:gd name="connsiteY15-404" fmla="*/ 19744 h 306697"/>
                    <a:gd name="connsiteX16-405" fmla="*/ 726023 w 728705"/>
                    <a:gd name="connsiteY16-406" fmla="*/ 175319 h 306697"/>
                    <a:gd name="connsiteX17-407" fmla="*/ 699036 w 728705"/>
                    <a:gd name="connsiteY17-408" fmla="*/ 234057 h 306697"/>
                    <a:gd name="connsiteX18-409" fmla="*/ 632361 w 728705"/>
                    <a:gd name="connsiteY18-410" fmla="*/ 229294 h 306697"/>
                    <a:gd name="connsiteX19-411" fmla="*/ 564098 w 728705"/>
                    <a:gd name="connsiteY19-412" fmla="*/ 189607 h 306697"/>
                    <a:gd name="connsiteX20-413" fmla="*/ 567273 w 728705"/>
                    <a:gd name="connsiteY20-414" fmla="*/ 197544 h 306697"/>
                    <a:gd name="connsiteX21-415" fmla="*/ 514886 w 728705"/>
                    <a:gd name="connsiteY21-416" fmla="*/ 234057 h 306697"/>
                    <a:gd name="connsiteX22-417" fmla="*/ 433923 w 728705"/>
                    <a:gd name="connsiteY22-418" fmla="*/ 238819 h 306697"/>
                    <a:gd name="connsiteX23-419" fmla="*/ 352961 w 728705"/>
                    <a:gd name="connsiteY23-420" fmla="*/ 291207 h 306697"/>
                    <a:gd name="connsiteX24-421" fmla="*/ 338673 w 728705"/>
                    <a:gd name="connsiteY24-422" fmla="*/ 300731 h 306697"/>
                    <a:gd name="connsiteX25-423" fmla="*/ 383123 w 728705"/>
                    <a:gd name="connsiteY25-424" fmla="*/ 208657 h 306697"/>
                    <a:gd name="connsiteX26-425" fmla="*/ 321211 w 728705"/>
                    <a:gd name="connsiteY26-426" fmla="*/ 230882 h 306697"/>
                    <a:gd name="connsiteX27-427" fmla="*/ 238661 w 728705"/>
                    <a:gd name="connsiteY27-428" fmla="*/ 230882 h 306697"/>
                    <a:gd name="connsiteX28-429" fmla="*/ 167223 w 728705"/>
                    <a:gd name="connsiteY28-430" fmla="*/ 281681 h 306697"/>
                    <a:gd name="connsiteX29-431" fmla="*/ 200561 w 728705"/>
                    <a:gd name="connsiteY29-432" fmla="*/ 213419 h 306697"/>
                    <a:gd name="connsiteX30-433" fmla="*/ 5298 w 728705"/>
                    <a:gd name="connsiteY30-434" fmla="*/ 241994 h 306697"/>
                    <a:gd name="connsiteX0-435" fmla="*/ 5298 w 728705"/>
                    <a:gd name="connsiteY0-436" fmla="*/ 241994 h 306697"/>
                    <a:gd name="connsiteX1-437" fmla="*/ 59273 w 728705"/>
                    <a:gd name="connsiteY1-438" fmla="*/ 121344 h 306697"/>
                    <a:gd name="connsiteX2-439" fmla="*/ 100549 w 728705"/>
                    <a:gd name="connsiteY2-440" fmla="*/ 76894 h 306697"/>
                    <a:gd name="connsiteX3-441" fmla="*/ 87848 w 728705"/>
                    <a:gd name="connsiteY3-442" fmla="*/ 49907 h 306697"/>
                    <a:gd name="connsiteX4-443" fmla="*/ 110073 w 728705"/>
                    <a:gd name="connsiteY4-444" fmla="*/ 5457 h 306697"/>
                    <a:gd name="connsiteX5-445" fmla="*/ 164048 w 728705"/>
                    <a:gd name="connsiteY5-446" fmla="*/ 5456 h 306697"/>
                    <a:gd name="connsiteX6-447" fmla="*/ 184686 w 728705"/>
                    <a:gd name="connsiteY6-448" fmla="*/ 48319 h 306697"/>
                    <a:gd name="connsiteX7-449" fmla="*/ 181511 w 728705"/>
                    <a:gd name="connsiteY7-450" fmla="*/ 72132 h 306697"/>
                    <a:gd name="connsiteX8-451" fmla="*/ 230723 w 728705"/>
                    <a:gd name="connsiteY8-452" fmla="*/ 21332 h 306697"/>
                    <a:gd name="connsiteX9-453" fmla="*/ 352961 w 728705"/>
                    <a:gd name="connsiteY9-454" fmla="*/ 3869 h 306697"/>
                    <a:gd name="connsiteX10-455" fmla="*/ 532348 w 728705"/>
                    <a:gd name="connsiteY10-456" fmla="*/ 91182 h 306697"/>
                    <a:gd name="connsiteX11-457" fmla="*/ 575211 w 728705"/>
                    <a:gd name="connsiteY11-458" fmla="*/ 143569 h 306697"/>
                    <a:gd name="connsiteX12-459" fmla="*/ 645061 w 728705"/>
                    <a:gd name="connsiteY12-460" fmla="*/ 203894 h 306697"/>
                    <a:gd name="connsiteX13-461" fmla="*/ 689511 w 728705"/>
                    <a:gd name="connsiteY13-462" fmla="*/ 213419 h 306697"/>
                    <a:gd name="connsiteX14-463" fmla="*/ 699036 w 728705"/>
                    <a:gd name="connsiteY14-464" fmla="*/ 140394 h 306697"/>
                    <a:gd name="connsiteX15-465" fmla="*/ 637123 w 728705"/>
                    <a:gd name="connsiteY15-466" fmla="*/ 19744 h 306697"/>
                    <a:gd name="connsiteX16-467" fmla="*/ 726023 w 728705"/>
                    <a:gd name="connsiteY16-468" fmla="*/ 175319 h 306697"/>
                    <a:gd name="connsiteX17-469" fmla="*/ 699036 w 728705"/>
                    <a:gd name="connsiteY17-470" fmla="*/ 234057 h 306697"/>
                    <a:gd name="connsiteX18-471" fmla="*/ 632361 w 728705"/>
                    <a:gd name="connsiteY18-472" fmla="*/ 229294 h 306697"/>
                    <a:gd name="connsiteX19-473" fmla="*/ 564098 w 728705"/>
                    <a:gd name="connsiteY19-474" fmla="*/ 189607 h 306697"/>
                    <a:gd name="connsiteX20-475" fmla="*/ 567273 w 728705"/>
                    <a:gd name="connsiteY20-476" fmla="*/ 197544 h 306697"/>
                    <a:gd name="connsiteX21-477" fmla="*/ 514886 w 728705"/>
                    <a:gd name="connsiteY21-478" fmla="*/ 234057 h 306697"/>
                    <a:gd name="connsiteX22-479" fmla="*/ 433923 w 728705"/>
                    <a:gd name="connsiteY22-480" fmla="*/ 238819 h 306697"/>
                    <a:gd name="connsiteX23-481" fmla="*/ 352961 w 728705"/>
                    <a:gd name="connsiteY23-482" fmla="*/ 291207 h 306697"/>
                    <a:gd name="connsiteX24-483" fmla="*/ 338673 w 728705"/>
                    <a:gd name="connsiteY24-484" fmla="*/ 300731 h 306697"/>
                    <a:gd name="connsiteX25-485" fmla="*/ 383123 w 728705"/>
                    <a:gd name="connsiteY25-486" fmla="*/ 208657 h 306697"/>
                    <a:gd name="connsiteX26-487" fmla="*/ 321211 w 728705"/>
                    <a:gd name="connsiteY26-488" fmla="*/ 230882 h 306697"/>
                    <a:gd name="connsiteX27-489" fmla="*/ 238661 w 728705"/>
                    <a:gd name="connsiteY27-490" fmla="*/ 230882 h 306697"/>
                    <a:gd name="connsiteX28-491" fmla="*/ 167223 w 728705"/>
                    <a:gd name="connsiteY28-492" fmla="*/ 281681 h 306697"/>
                    <a:gd name="connsiteX29-493" fmla="*/ 200561 w 728705"/>
                    <a:gd name="connsiteY29-494" fmla="*/ 213419 h 306697"/>
                    <a:gd name="connsiteX30-495" fmla="*/ 5298 w 728705"/>
                    <a:gd name="connsiteY30-496" fmla="*/ 241994 h 306697"/>
                    <a:gd name="connsiteX0-497" fmla="*/ 5298 w 728705"/>
                    <a:gd name="connsiteY0-498" fmla="*/ 241994 h 306697"/>
                    <a:gd name="connsiteX1-499" fmla="*/ 59273 w 728705"/>
                    <a:gd name="connsiteY1-500" fmla="*/ 121344 h 306697"/>
                    <a:gd name="connsiteX2-501" fmla="*/ 100549 w 728705"/>
                    <a:gd name="connsiteY2-502" fmla="*/ 76894 h 306697"/>
                    <a:gd name="connsiteX3-503" fmla="*/ 87848 w 728705"/>
                    <a:gd name="connsiteY3-504" fmla="*/ 49907 h 306697"/>
                    <a:gd name="connsiteX4-505" fmla="*/ 110073 w 728705"/>
                    <a:gd name="connsiteY4-506" fmla="*/ 5457 h 306697"/>
                    <a:gd name="connsiteX5-507" fmla="*/ 164048 w 728705"/>
                    <a:gd name="connsiteY5-508" fmla="*/ 5456 h 306697"/>
                    <a:gd name="connsiteX6-509" fmla="*/ 184686 w 728705"/>
                    <a:gd name="connsiteY6-510" fmla="*/ 48319 h 306697"/>
                    <a:gd name="connsiteX7-511" fmla="*/ 181511 w 728705"/>
                    <a:gd name="connsiteY7-512" fmla="*/ 72132 h 306697"/>
                    <a:gd name="connsiteX8-513" fmla="*/ 230723 w 728705"/>
                    <a:gd name="connsiteY8-514" fmla="*/ 21332 h 306697"/>
                    <a:gd name="connsiteX9-515" fmla="*/ 352961 w 728705"/>
                    <a:gd name="connsiteY9-516" fmla="*/ 3869 h 306697"/>
                    <a:gd name="connsiteX10-517" fmla="*/ 506948 w 728705"/>
                    <a:gd name="connsiteY10-518" fmla="*/ 64195 h 306697"/>
                    <a:gd name="connsiteX11-519" fmla="*/ 575211 w 728705"/>
                    <a:gd name="connsiteY11-520" fmla="*/ 143569 h 306697"/>
                    <a:gd name="connsiteX12-521" fmla="*/ 645061 w 728705"/>
                    <a:gd name="connsiteY12-522" fmla="*/ 203894 h 306697"/>
                    <a:gd name="connsiteX13-523" fmla="*/ 689511 w 728705"/>
                    <a:gd name="connsiteY13-524" fmla="*/ 213419 h 306697"/>
                    <a:gd name="connsiteX14-525" fmla="*/ 699036 w 728705"/>
                    <a:gd name="connsiteY14-526" fmla="*/ 140394 h 306697"/>
                    <a:gd name="connsiteX15-527" fmla="*/ 637123 w 728705"/>
                    <a:gd name="connsiteY15-528" fmla="*/ 19744 h 306697"/>
                    <a:gd name="connsiteX16-529" fmla="*/ 726023 w 728705"/>
                    <a:gd name="connsiteY16-530" fmla="*/ 175319 h 306697"/>
                    <a:gd name="connsiteX17-531" fmla="*/ 699036 w 728705"/>
                    <a:gd name="connsiteY17-532" fmla="*/ 234057 h 306697"/>
                    <a:gd name="connsiteX18-533" fmla="*/ 632361 w 728705"/>
                    <a:gd name="connsiteY18-534" fmla="*/ 229294 h 306697"/>
                    <a:gd name="connsiteX19-535" fmla="*/ 564098 w 728705"/>
                    <a:gd name="connsiteY19-536" fmla="*/ 189607 h 306697"/>
                    <a:gd name="connsiteX20-537" fmla="*/ 567273 w 728705"/>
                    <a:gd name="connsiteY20-538" fmla="*/ 197544 h 306697"/>
                    <a:gd name="connsiteX21-539" fmla="*/ 514886 w 728705"/>
                    <a:gd name="connsiteY21-540" fmla="*/ 234057 h 306697"/>
                    <a:gd name="connsiteX22-541" fmla="*/ 433923 w 728705"/>
                    <a:gd name="connsiteY22-542" fmla="*/ 238819 h 306697"/>
                    <a:gd name="connsiteX23-543" fmla="*/ 352961 w 728705"/>
                    <a:gd name="connsiteY23-544" fmla="*/ 291207 h 306697"/>
                    <a:gd name="connsiteX24-545" fmla="*/ 338673 w 728705"/>
                    <a:gd name="connsiteY24-546" fmla="*/ 300731 h 306697"/>
                    <a:gd name="connsiteX25-547" fmla="*/ 383123 w 728705"/>
                    <a:gd name="connsiteY25-548" fmla="*/ 208657 h 306697"/>
                    <a:gd name="connsiteX26-549" fmla="*/ 321211 w 728705"/>
                    <a:gd name="connsiteY26-550" fmla="*/ 230882 h 306697"/>
                    <a:gd name="connsiteX27-551" fmla="*/ 238661 w 728705"/>
                    <a:gd name="connsiteY27-552" fmla="*/ 230882 h 306697"/>
                    <a:gd name="connsiteX28-553" fmla="*/ 167223 w 728705"/>
                    <a:gd name="connsiteY28-554" fmla="*/ 281681 h 306697"/>
                    <a:gd name="connsiteX29-555" fmla="*/ 200561 w 728705"/>
                    <a:gd name="connsiteY29-556" fmla="*/ 213419 h 306697"/>
                    <a:gd name="connsiteX30-557" fmla="*/ 5298 w 728705"/>
                    <a:gd name="connsiteY30-558" fmla="*/ 241994 h 306697"/>
                    <a:gd name="connsiteX0-559" fmla="*/ 5298 w 729592"/>
                    <a:gd name="connsiteY0-560" fmla="*/ 247862 h 312565"/>
                    <a:gd name="connsiteX1-561" fmla="*/ 59273 w 729592"/>
                    <a:gd name="connsiteY1-562" fmla="*/ 127212 h 312565"/>
                    <a:gd name="connsiteX2-563" fmla="*/ 100549 w 729592"/>
                    <a:gd name="connsiteY2-564" fmla="*/ 82762 h 312565"/>
                    <a:gd name="connsiteX3-565" fmla="*/ 87848 w 729592"/>
                    <a:gd name="connsiteY3-566" fmla="*/ 55775 h 312565"/>
                    <a:gd name="connsiteX4-567" fmla="*/ 110073 w 729592"/>
                    <a:gd name="connsiteY4-568" fmla="*/ 11325 h 312565"/>
                    <a:gd name="connsiteX5-569" fmla="*/ 164048 w 729592"/>
                    <a:gd name="connsiteY5-570" fmla="*/ 11324 h 312565"/>
                    <a:gd name="connsiteX6-571" fmla="*/ 184686 w 729592"/>
                    <a:gd name="connsiteY6-572" fmla="*/ 54187 h 312565"/>
                    <a:gd name="connsiteX7-573" fmla="*/ 181511 w 729592"/>
                    <a:gd name="connsiteY7-574" fmla="*/ 78000 h 312565"/>
                    <a:gd name="connsiteX8-575" fmla="*/ 230723 w 729592"/>
                    <a:gd name="connsiteY8-576" fmla="*/ 27200 h 312565"/>
                    <a:gd name="connsiteX9-577" fmla="*/ 352961 w 729592"/>
                    <a:gd name="connsiteY9-578" fmla="*/ 9737 h 312565"/>
                    <a:gd name="connsiteX10-579" fmla="*/ 506948 w 729592"/>
                    <a:gd name="connsiteY10-580" fmla="*/ 70063 h 312565"/>
                    <a:gd name="connsiteX11-581" fmla="*/ 575211 w 729592"/>
                    <a:gd name="connsiteY11-582" fmla="*/ 149437 h 312565"/>
                    <a:gd name="connsiteX12-583" fmla="*/ 645061 w 729592"/>
                    <a:gd name="connsiteY12-584" fmla="*/ 209762 h 312565"/>
                    <a:gd name="connsiteX13-585" fmla="*/ 689511 w 729592"/>
                    <a:gd name="connsiteY13-586" fmla="*/ 219287 h 312565"/>
                    <a:gd name="connsiteX14-587" fmla="*/ 699036 w 729592"/>
                    <a:gd name="connsiteY14-588" fmla="*/ 146262 h 312565"/>
                    <a:gd name="connsiteX15-589" fmla="*/ 622836 w 729592"/>
                    <a:gd name="connsiteY15-590" fmla="*/ 212 h 312565"/>
                    <a:gd name="connsiteX16-591" fmla="*/ 726023 w 729592"/>
                    <a:gd name="connsiteY16-592" fmla="*/ 181187 h 312565"/>
                    <a:gd name="connsiteX17-593" fmla="*/ 699036 w 729592"/>
                    <a:gd name="connsiteY17-594" fmla="*/ 239925 h 312565"/>
                    <a:gd name="connsiteX18-595" fmla="*/ 632361 w 729592"/>
                    <a:gd name="connsiteY18-596" fmla="*/ 235162 h 312565"/>
                    <a:gd name="connsiteX19-597" fmla="*/ 564098 w 729592"/>
                    <a:gd name="connsiteY19-598" fmla="*/ 195475 h 312565"/>
                    <a:gd name="connsiteX20-599" fmla="*/ 567273 w 729592"/>
                    <a:gd name="connsiteY20-600" fmla="*/ 203412 h 312565"/>
                    <a:gd name="connsiteX21-601" fmla="*/ 514886 w 729592"/>
                    <a:gd name="connsiteY21-602" fmla="*/ 239925 h 312565"/>
                    <a:gd name="connsiteX22-603" fmla="*/ 433923 w 729592"/>
                    <a:gd name="connsiteY22-604" fmla="*/ 244687 h 312565"/>
                    <a:gd name="connsiteX23-605" fmla="*/ 352961 w 729592"/>
                    <a:gd name="connsiteY23-606" fmla="*/ 297075 h 312565"/>
                    <a:gd name="connsiteX24-607" fmla="*/ 338673 w 729592"/>
                    <a:gd name="connsiteY24-608" fmla="*/ 306599 h 312565"/>
                    <a:gd name="connsiteX25-609" fmla="*/ 383123 w 729592"/>
                    <a:gd name="connsiteY25-610" fmla="*/ 214525 h 312565"/>
                    <a:gd name="connsiteX26-611" fmla="*/ 321211 w 729592"/>
                    <a:gd name="connsiteY26-612" fmla="*/ 236750 h 312565"/>
                    <a:gd name="connsiteX27-613" fmla="*/ 238661 w 729592"/>
                    <a:gd name="connsiteY27-614" fmla="*/ 236750 h 312565"/>
                    <a:gd name="connsiteX28-615" fmla="*/ 167223 w 729592"/>
                    <a:gd name="connsiteY28-616" fmla="*/ 287549 h 312565"/>
                    <a:gd name="connsiteX29-617" fmla="*/ 200561 w 729592"/>
                    <a:gd name="connsiteY29-618" fmla="*/ 219287 h 312565"/>
                    <a:gd name="connsiteX30-619" fmla="*/ 5298 w 729592"/>
                    <a:gd name="connsiteY30-620" fmla="*/ 247862 h 312565"/>
                    <a:gd name="connsiteX0-621" fmla="*/ 5298 w 729592"/>
                    <a:gd name="connsiteY0-622" fmla="*/ 248014 h 312717"/>
                    <a:gd name="connsiteX1-623" fmla="*/ 59273 w 729592"/>
                    <a:gd name="connsiteY1-624" fmla="*/ 127364 h 312717"/>
                    <a:gd name="connsiteX2-625" fmla="*/ 100549 w 729592"/>
                    <a:gd name="connsiteY2-626" fmla="*/ 82914 h 312717"/>
                    <a:gd name="connsiteX3-627" fmla="*/ 87848 w 729592"/>
                    <a:gd name="connsiteY3-628" fmla="*/ 55927 h 312717"/>
                    <a:gd name="connsiteX4-629" fmla="*/ 110073 w 729592"/>
                    <a:gd name="connsiteY4-630" fmla="*/ 11477 h 312717"/>
                    <a:gd name="connsiteX5-631" fmla="*/ 164048 w 729592"/>
                    <a:gd name="connsiteY5-632" fmla="*/ 11476 h 312717"/>
                    <a:gd name="connsiteX6-633" fmla="*/ 184686 w 729592"/>
                    <a:gd name="connsiteY6-634" fmla="*/ 54339 h 312717"/>
                    <a:gd name="connsiteX7-635" fmla="*/ 181511 w 729592"/>
                    <a:gd name="connsiteY7-636" fmla="*/ 78152 h 312717"/>
                    <a:gd name="connsiteX8-637" fmla="*/ 230723 w 729592"/>
                    <a:gd name="connsiteY8-638" fmla="*/ 27352 h 312717"/>
                    <a:gd name="connsiteX9-639" fmla="*/ 352961 w 729592"/>
                    <a:gd name="connsiteY9-640" fmla="*/ 9889 h 312717"/>
                    <a:gd name="connsiteX10-641" fmla="*/ 506948 w 729592"/>
                    <a:gd name="connsiteY10-642" fmla="*/ 70215 h 312717"/>
                    <a:gd name="connsiteX11-643" fmla="*/ 575211 w 729592"/>
                    <a:gd name="connsiteY11-644" fmla="*/ 149589 h 312717"/>
                    <a:gd name="connsiteX12-645" fmla="*/ 645061 w 729592"/>
                    <a:gd name="connsiteY12-646" fmla="*/ 209914 h 312717"/>
                    <a:gd name="connsiteX13-647" fmla="*/ 689511 w 729592"/>
                    <a:gd name="connsiteY13-648" fmla="*/ 219439 h 312717"/>
                    <a:gd name="connsiteX14-649" fmla="*/ 687924 w 729592"/>
                    <a:gd name="connsiteY14-650" fmla="*/ 136889 h 312717"/>
                    <a:gd name="connsiteX15-651" fmla="*/ 622836 w 729592"/>
                    <a:gd name="connsiteY15-652" fmla="*/ 364 h 312717"/>
                    <a:gd name="connsiteX16-653" fmla="*/ 726023 w 729592"/>
                    <a:gd name="connsiteY16-654" fmla="*/ 181339 h 312717"/>
                    <a:gd name="connsiteX17-655" fmla="*/ 699036 w 729592"/>
                    <a:gd name="connsiteY17-656" fmla="*/ 240077 h 312717"/>
                    <a:gd name="connsiteX18-657" fmla="*/ 632361 w 729592"/>
                    <a:gd name="connsiteY18-658" fmla="*/ 235314 h 312717"/>
                    <a:gd name="connsiteX19-659" fmla="*/ 564098 w 729592"/>
                    <a:gd name="connsiteY19-660" fmla="*/ 195627 h 312717"/>
                    <a:gd name="connsiteX20-661" fmla="*/ 567273 w 729592"/>
                    <a:gd name="connsiteY20-662" fmla="*/ 203564 h 312717"/>
                    <a:gd name="connsiteX21-663" fmla="*/ 514886 w 729592"/>
                    <a:gd name="connsiteY21-664" fmla="*/ 240077 h 312717"/>
                    <a:gd name="connsiteX22-665" fmla="*/ 433923 w 729592"/>
                    <a:gd name="connsiteY22-666" fmla="*/ 244839 h 312717"/>
                    <a:gd name="connsiteX23-667" fmla="*/ 352961 w 729592"/>
                    <a:gd name="connsiteY23-668" fmla="*/ 297227 h 312717"/>
                    <a:gd name="connsiteX24-669" fmla="*/ 338673 w 729592"/>
                    <a:gd name="connsiteY24-670" fmla="*/ 306751 h 312717"/>
                    <a:gd name="connsiteX25-671" fmla="*/ 383123 w 729592"/>
                    <a:gd name="connsiteY25-672" fmla="*/ 214677 h 312717"/>
                    <a:gd name="connsiteX26-673" fmla="*/ 321211 w 729592"/>
                    <a:gd name="connsiteY26-674" fmla="*/ 236902 h 312717"/>
                    <a:gd name="connsiteX27-675" fmla="*/ 238661 w 729592"/>
                    <a:gd name="connsiteY27-676" fmla="*/ 236902 h 312717"/>
                    <a:gd name="connsiteX28-677" fmla="*/ 167223 w 729592"/>
                    <a:gd name="connsiteY28-678" fmla="*/ 287701 h 312717"/>
                    <a:gd name="connsiteX29-679" fmla="*/ 200561 w 729592"/>
                    <a:gd name="connsiteY29-680" fmla="*/ 219439 h 312717"/>
                    <a:gd name="connsiteX30-681" fmla="*/ 5298 w 729592"/>
                    <a:gd name="connsiteY30-682" fmla="*/ 248014 h 312717"/>
                    <a:gd name="connsiteX0-683" fmla="*/ 5298 w 732516"/>
                    <a:gd name="connsiteY0-684" fmla="*/ 247945 h 312648"/>
                    <a:gd name="connsiteX1-685" fmla="*/ 59273 w 732516"/>
                    <a:gd name="connsiteY1-686" fmla="*/ 127295 h 312648"/>
                    <a:gd name="connsiteX2-687" fmla="*/ 100549 w 732516"/>
                    <a:gd name="connsiteY2-688" fmla="*/ 82845 h 312648"/>
                    <a:gd name="connsiteX3-689" fmla="*/ 87848 w 732516"/>
                    <a:gd name="connsiteY3-690" fmla="*/ 55858 h 312648"/>
                    <a:gd name="connsiteX4-691" fmla="*/ 110073 w 732516"/>
                    <a:gd name="connsiteY4-692" fmla="*/ 11408 h 312648"/>
                    <a:gd name="connsiteX5-693" fmla="*/ 164048 w 732516"/>
                    <a:gd name="connsiteY5-694" fmla="*/ 11407 h 312648"/>
                    <a:gd name="connsiteX6-695" fmla="*/ 184686 w 732516"/>
                    <a:gd name="connsiteY6-696" fmla="*/ 54270 h 312648"/>
                    <a:gd name="connsiteX7-697" fmla="*/ 181511 w 732516"/>
                    <a:gd name="connsiteY7-698" fmla="*/ 78083 h 312648"/>
                    <a:gd name="connsiteX8-699" fmla="*/ 230723 w 732516"/>
                    <a:gd name="connsiteY8-700" fmla="*/ 27283 h 312648"/>
                    <a:gd name="connsiteX9-701" fmla="*/ 352961 w 732516"/>
                    <a:gd name="connsiteY9-702" fmla="*/ 9820 h 312648"/>
                    <a:gd name="connsiteX10-703" fmla="*/ 506948 w 732516"/>
                    <a:gd name="connsiteY10-704" fmla="*/ 70146 h 312648"/>
                    <a:gd name="connsiteX11-705" fmla="*/ 575211 w 732516"/>
                    <a:gd name="connsiteY11-706" fmla="*/ 149520 h 312648"/>
                    <a:gd name="connsiteX12-707" fmla="*/ 645061 w 732516"/>
                    <a:gd name="connsiteY12-708" fmla="*/ 209845 h 312648"/>
                    <a:gd name="connsiteX13-709" fmla="*/ 689511 w 732516"/>
                    <a:gd name="connsiteY13-710" fmla="*/ 219370 h 312648"/>
                    <a:gd name="connsiteX14-711" fmla="*/ 687924 w 732516"/>
                    <a:gd name="connsiteY14-712" fmla="*/ 136820 h 312648"/>
                    <a:gd name="connsiteX15-713" fmla="*/ 622836 w 732516"/>
                    <a:gd name="connsiteY15-714" fmla="*/ 295 h 312648"/>
                    <a:gd name="connsiteX16-715" fmla="*/ 729198 w 732516"/>
                    <a:gd name="connsiteY16-716" fmla="*/ 176508 h 312648"/>
                    <a:gd name="connsiteX17-717" fmla="*/ 699036 w 732516"/>
                    <a:gd name="connsiteY17-718" fmla="*/ 240008 h 312648"/>
                    <a:gd name="connsiteX18-719" fmla="*/ 632361 w 732516"/>
                    <a:gd name="connsiteY18-720" fmla="*/ 235245 h 312648"/>
                    <a:gd name="connsiteX19-721" fmla="*/ 564098 w 732516"/>
                    <a:gd name="connsiteY19-722" fmla="*/ 195558 h 312648"/>
                    <a:gd name="connsiteX20-723" fmla="*/ 567273 w 732516"/>
                    <a:gd name="connsiteY20-724" fmla="*/ 203495 h 312648"/>
                    <a:gd name="connsiteX21-725" fmla="*/ 514886 w 732516"/>
                    <a:gd name="connsiteY21-726" fmla="*/ 240008 h 312648"/>
                    <a:gd name="connsiteX22-727" fmla="*/ 433923 w 732516"/>
                    <a:gd name="connsiteY22-728" fmla="*/ 244770 h 312648"/>
                    <a:gd name="connsiteX23-729" fmla="*/ 352961 w 732516"/>
                    <a:gd name="connsiteY23-730" fmla="*/ 297158 h 312648"/>
                    <a:gd name="connsiteX24-731" fmla="*/ 338673 w 732516"/>
                    <a:gd name="connsiteY24-732" fmla="*/ 306682 h 312648"/>
                    <a:gd name="connsiteX25-733" fmla="*/ 383123 w 732516"/>
                    <a:gd name="connsiteY25-734" fmla="*/ 214608 h 312648"/>
                    <a:gd name="connsiteX26-735" fmla="*/ 321211 w 732516"/>
                    <a:gd name="connsiteY26-736" fmla="*/ 236833 h 312648"/>
                    <a:gd name="connsiteX27-737" fmla="*/ 238661 w 732516"/>
                    <a:gd name="connsiteY27-738" fmla="*/ 236833 h 312648"/>
                    <a:gd name="connsiteX28-739" fmla="*/ 167223 w 732516"/>
                    <a:gd name="connsiteY28-740" fmla="*/ 287632 h 312648"/>
                    <a:gd name="connsiteX29-741" fmla="*/ 200561 w 732516"/>
                    <a:gd name="connsiteY29-742" fmla="*/ 219370 h 312648"/>
                    <a:gd name="connsiteX30-743" fmla="*/ 5298 w 732516"/>
                    <a:gd name="connsiteY30-744" fmla="*/ 247945 h 312648"/>
                    <a:gd name="connsiteX0-745" fmla="*/ 5298 w 732516"/>
                    <a:gd name="connsiteY0-746" fmla="*/ 247945 h 312648"/>
                    <a:gd name="connsiteX1-747" fmla="*/ 59273 w 732516"/>
                    <a:gd name="connsiteY1-748" fmla="*/ 127295 h 312648"/>
                    <a:gd name="connsiteX2-749" fmla="*/ 100549 w 732516"/>
                    <a:gd name="connsiteY2-750" fmla="*/ 82845 h 312648"/>
                    <a:gd name="connsiteX3-751" fmla="*/ 87848 w 732516"/>
                    <a:gd name="connsiteY3-752" fmla="*/ 55858 h 312648"/>
                    <a:gd name="connsiteX4-753" fmla="*/ 110073 w 732516"/>
                    <a:gd name="connsiteY4-754" fmla="*/ 11408 h 312648"/>
                    <a:gd name="connsiteX5-755" fmla="*/ 164048 w 732516"/>
                    <a:gd name="connsiteY5-756" fmla="*/ 11407 h 312648"/>
                    <a:gd name="connsiteX6-757" fmla="*/ 184686 w 732516"/>
                    <a:gd name="connsiteY6-758" fmla="*/ 54270 h 312648"/>
                    <a:gd name="connsiteX7-759" fmla="*/ 181511 w 732516"/>
                    <a:gd name="connsiteY7-760" fmla="*/ 78083 h 312648"/>
                    <a:gd name="connsiteX8-761" fmla="*/ 230723 w 732516"/>
                    <a:gd name="connsiteY8-762" fmla="*/ 27283 h 312648"/>
                    <a:gd name="connsiteX9-763" fmla="*/ 352961 w 732516"/>
                    <a:gd name="connsiteY9-764" fmla="*/ 9820 h 312648"/>
                    <a:gd name="connsiteX10-765" fmla="*/ 506948 w 732516"/>
                    <a:gd name="connsiteY10-766" fmla="*/ 70146 h 312648"/>
                    <a:gd name="connsiteX11-767" fmla="*/ 575211 w 732516"/>
                    <a:gd name="connsiteY11-768" fmla="*/ 149520 h 312648"/>
                    <a:gd name="connsiteX12-769" fmla="*/ 645061 w 732516"/>
                    <a:gd name="connsiteY12-770" fmla="*/ 209845 h 312648"/>
                    <a:gd name="connsiteX13-771" fmla="*/ 689511 w 732516"/>
                    <a:gd name="connsiteY13-772" fmla="*/ 219370 h 312648"/>
                    <a:gd name="connsiteX14-773" fmla="*/ 687924 w 732516"/>
                    <a:gd name="connsiteY14-774" fmla="*/ 136820 h 312648"/>
                    <a:gd name="connsiteX15-775" fmla="*/ 622836 w 732516"/>
                    <a:gd name="connsiteY15-776" fmla="*/ 295 h 312648"/>
                    <a:gd name="connsiteX16-777" fmla="*/ 729198 w 732516"/>
                    <a:gd name="connsiteY16-778" fmla="*/ 176508 h 312648"/>
                    <a:gd name="connsiteX17-779" fmla="*/ 699036 w 732516"/>
                    <a:gd name="connsiteY17-780" fmla="*/ 243183 h 312648"/>
                    <a:gd name="connsiteX18-781" fmla="*/ 632361 w 732516"/>
                    <a:gd name="connsiteY18-782" fmla="*/ 235245 h 312648"/>
                    <a:gd name="connsiteX19-783" fmla="*/ 564098 w 732516"/>
                    <a:gd name="connsiteY19-784" fmla="*/ 195558 h 312648"/>
                    <a:gd name="connsiteX20-785" fmla="*/ 567273 w 732516"/>
                    <a:gd name="connsiteY20-786" fmla="*/ 203495 h 312648"/>
                    <a:gd name="connsiteX21-787" fmla="*/ 514886 w 732516"/>
                    <a:gd name="connsiteY21-788" fmla="*/ 240008 h 312648"/>
                    <a:gd name="connsiteX22-789" fmla="*/ 433923 w 732516"/>
                    <a:gd name="connsiteY22-790" fmla="*/ 244770 h 312648"/>
                    <a:gd name="connsiteX23-791" fmla="*/ 352961 w 732516"/>
                    <a:gd name="connsiteY23-792" fmla="*/ 297158 h 312648"/>
                    <a:gd name="connsiteX24-793" fmla="*/ 338673 w 732516"/>
                    <a:gd name="connsiteY24-794" fmla="*/ 306682 h 312648"/>
                    <a:gd name="connsiteX25-795" fmla="*/ 383123 w 732516"/>
                    <a:gd name="connsiteY25-796" fmla="*/ 214608 h 312648"/>
                    <a:gd name="connsiteX26-797" fmla="*/ 321211 w 732516"/>
                    <a:gd name="connsiteY26-798" fmla="*/ 236833 h 312648"/>
                    <a:gd name="connsiteX27-799" fmla="*/ 238661 w 732516"/>
                    <a:gd name="connsiteY27-800" fmla="*/ 236833 h 312648"/>
                    <a:gd name="connsiteX28-801" fmla="*/ 167223 w 732516"/>
                    <a:gd name="connsiteY28-802" fmla="*/ 287632 h 312648"/>
                    <a:gd name="connsiteX29-803" fmla="*/ 200561 w 732516"/>
                    <a:gd name="connsiteY29-804" fmla="*/ 219370 h 312648"/>
                    <a:gd name="connsiteX30-805" fmla="*/ 5298 w 732516"/>
                    <a:gd name="connsiteY30-806" fmla="*/ 247945 h 312648"/>
                    <a:gd name="connsiteX0-807" fmla="*/ 5298 w 732411"/>
                    <a:gd name="connsiteY0-808" fmla="*/ 247945 h 312648"/>
                    <a:gd name="connsiteX1-809" fmla="*/ 59273 w 732411"/>
                    <a:gd name="connsiteY1-810" fmla="*/ 127295 h 312648"/>
                    <a:gd name="connsiteX2-811" fmla="*/ 100549 w 732411"/>
                    <a:gd name="connsiteY2-812" fmla="*/ 82845 h 312648"/>
                    <a:gd name="connsiteX3-813" fmla="*/ 87848 w 732411"/>
                    <a:gd name="connsiteY3-814" fmla="*/ 55858 h 312648"/>
                    <a:gd name="connsiteX4-815" fmla="*/ 110073 w 732411"/>
                    <a:gd name="connsiteY4-816" fmla="*/ 11408 h 312648"/>
                    <a:gd name="connsiteX5-817" fmla="*/ 164048 w 732411"/>
                    <a:gd name="connsiteY5-818" fmla="*/ 11407 h 312648"/>
                    <a:gd name="connsiteX6-819" fmla="*/ 184686 w 732411"/>
                    <a:gd name="connsiteY6-820" fmla="*/ 54270 h 312648"/>
                    <a:gd name="connsiteX7-821" fmla="*/ 181511 w 732411"/>
                    <a:gd name="connsiteY7-822" fmla="*/ 78083 h 312648"/>
                    <a:gd name="connsiteX8-823" fmla="*/ 230723 w 732411"/>
                    <a:gd name="connsiteY8-824" fmla="*/ 27283 h 312648"/>
                    <a:gd name="connsiteX9-825" fmla="*/ 352961 w 732411"/>
                    <a:gd name="connsiteY9-826" fmla="*/ 9820 h 312648"/>
                    <a:gd name="connsiteX10-827" fmla="*/ 506948 w 732411"/>
                    <a:gd name="connsiteY10-828" fmla="*/ 70146 h 312648"/>
                    <a:gd name="connsiteX11-829" fmla="*/ 575211 w 732411"/>
                    <a:gd name="connsiteY11-830" fmla="*/ 149520 h 312648"/>
                    <a:gd name="connsiteX12-831" fmla="*/ 645061 w 732411"/>
                    <a:gd name="connsiteY12-832" fmla="*/ 209845 h 312648"/>
                    <a:gd name="connsiteX13-833" fmla="*/ 689511 w 732411"/>
                    <a:gd name="connsiteY13-834" fmla="*/ 219370 h 312648"/>
                    <a:gd name="connsiteX14-835" fmla="*/ 687924 w 732411"/>
                    <a:gd name="connsiteY14-836" fmla="*/ 136820 h 312648"/>
                    <a:gd name="connsiteX15-837" fmla="*/ 622836 w 732411"/>
                    <a:gd name="connsiteY15-838" fmla="*/ 295 h 312648"/>
                    <a:gd name="connsiteX16-839" fmla="*/ 729198 w 732411"/>
                    <a:gd name="connsiteY16-840" fmla="*/ 176508 h 312648"/>
                    <a:gd name="connsiteX17-841" fmla="*/ 699036 w 732411"/>
                    <a:gd name="connsiteY17-842" fmla="*/ 243183 h 312648"/>
                    <a:gd name="connsiteX18-843" fmla="*/ 640299 w 732411"/>
                    <a:gd name="connsiteY18-844" fmla="*/ 240008 h 312648"/>
                    <a:gd name="connsiteX19-845" fmla="*/ 564098 w 732411"/>
                    <a:gd name="connsiteY19-846" fmla="*/ 195558 h 312648"/>
                    <a:gd name="connsiteX20-847" fmla="*/ 567273 w 732411"/>
                    <a:gd name="connsiteY20-848" fmla="*/ 203495 h 312648"/>
                    <a:gd name="connsiteX21-849" fmla="*/ 514886 w 732411"/>
                    <a:gd name="connsiteY21-850" fmla="*/ 240008 h 312648"/>
                    <a:gd name="connsiteX22-851" fmla="*/ 433923 w 732411"/>
                    <a:gd name="connsiteY22-852" fmla="*/ 244770 h 312648"/>
                    <a:gd name="connsiteX23-853" fmla="*/ 352961 w 732411"/>
                    <a:gd name="connsiteY23-854" fmla="*/ 297158 h 312648"/>
                    <a:gd name="connsiteX24-855" fmla="*/ 338673 w 732411"/>
                    <a:gd name="connsiteY24-856" fmla="*/ 306682 h 312648"/>
                    <a:gd name="connsiteX25-857" fmla="*/ 383123 w 732411"/>
                    <a:gd name="connsiteY25-858" fmla="*/ 214608 h 312648"/>
                    <a:gd name="connsiteX26-859" fmla="*/ 321211 w 732411"/>
                    <a:gd name="connsiteY26-860" fmla="*/ 236833 h 312648"/>
                    <a:gd name="connsiteX27-861" fmla="*/ 238661 w 732411"/>
                    <a:gd name="connsiteY27-862" fmla="*/ 236833 h 312648"/>
                    <a:gd name="connsiteX28-863" fmla="*/ 167223 w 732411"/>
                    <a:gd name="connsiteY28-864" fmla="*/ 287632 h 312648"/>
                    <a:gd name="connsiteX29-865" fmla="*/ 200561 w 732411"/>
                    <a:gd name="connsiteY29-866" fmla="*/ 219370 h 312648"/>
                    <a:gd name="connsiteX30-867" fmla="*/ 5298 w 732411"/>
                    <a:gd name="connsiteY30-868" fmla="*/ 247945 h 312648"/>
                    <a:gd name="connsiteX0-869" fmla="*/ 5298 w 732411"/>
                    <a:gd name="connsiteY0-870" fmla="*/ 247945 h 312648"/>
                    <a:gd name="connsiteX1-871" fmla="*/ 59273 w 732411"/>
                    <a:gd name="connsiteY1-872" fmla="*/ 127295 h 312648"/>
                    <a:gd name="connsiteX2-873" fmla="*/ 100549 w 732411"/>
                    <a:gd name="connsiteY2-874" fmla="*/ 82845 h 312648"/>
                    <a:gd name="connsiteX3-875" fmla="*/ 87848 w 732411"/>
                    <a:gd name="connsiteY3-876" fmla="*/ 55858 h 312648"/>
                    <a:gd name="connsiteX4-877" fmla="*/ 110073 w 732411"/>
                    <a:gd name="connsiteY4-878" fmla="*/ 11408 h 312648"/>
                    <a:gd name="connsiteX5-879" fmla="*/ 164048 w 732411"/>
                    <a:gd name="connsiteY5-880" fmla="*/ 11407 h 312648"/>
                    <a:gd name="connsiteX6-881" fmla="*/ 184686 w 732411"/>
                    <a:gd name="connsiteY6-882" fmla="*/ 54270 h 312648"/>
                    <a:gd name="connsiteX7-883" fmla="*/ 181511 w 732411"/>
                    <a:gd name="connsiteY7-884" fmla="*/ 78083 h 312648"/>
                    <a:gd name="connsiteX8-885" fmla="*/ 230723 w 732411"/>
                    <a:gd name="connsiteY8-886" fmla="*/ 27283 h 312648"/>
                    <a:gd name="connsiteX9-887" fmla="*/ 352961 w 732411"/>
                    <a:gd name="connsiteY9-888" fmla="*/ 9820 h 312648"/>
                    <a:gd name="connsiteX10-889" fmla="*/ 506948 w 732411"/>
                    <a:gd name="connsiteY10-890" fmla="*/ 70146 h 312648"/>
                    <a:gd name="connsiteX11-891" fmla="*/ 575211 w 732411"/>
                    <a:gd name="connsiteY11-892" fmla="*/ 149520 h 312648"/>
                    <a:gd name="connsiteX12-893" fmla="*/ 643474 w 732411"/>
                    <a:gd name="connsiteY12-894" fmla="*/ 214607 h 312648"/>
                    <a:gd name="connsiteX13-895" fmla="*/ 689511 w 732411"/>
                    <a:gd name="connsiteY13-896" fmla="*/ 219370 h 312648"/>
                    <a:gd name="connsiteX14-897" fmla="*/ 687924 w 732411"/>
                    <a:gd name="connsiteY14-898" fmla="*/ 136820 h 312648"/>
                    <a:gd name="connsiteX15-899" fmla="*/ 622836 w 732411"/>
                    <a:gd name="connsiteY15-900" fmla="*/ 295 h 312648"/>
                    <a:gd name="connsiteX16-901" fmla="*/ 729198 w 732411"/>
                    <a:gd name="connsiteY16-902" fmla="*/ 176508 h 312648"/>
                    <a:gd name="connsiteX17-903" fmla="*/ 699036 w 732411"/>
                    <a:gd name="connsiteY17-904" fmla="*/ 243183 h 312648"/>
                    <a:gd name="connsiteX18-905" fmla="*/ 640299 w 732411"/>
                    <a:gd name="connsiteY18-906" fmla="*/ 240008 h 312648"/>
                    <a:gd name="connsiteX19-907" fmla="*/ 564098 w 732411"/>
                    <a:gd name="connsiteY19-908" fmla="*/ 195558 h 312648"/>
                    <a:gd name="connsiteX20-909" fmla="*/ 567273 w 732411"/>
                    <a:gd name="connsiteY20-910" fmla="*/ 203495 h 312648"/>
                    <a:gd name="connsiteX21-911" fmla="*/ 514886 w 732411"/>
                    <a:gd name="connsiteY21-912" fmla="*/ 240008 h 312648"/>
                    <a:gd name="connsiteX22-913" fmla="*/ 433923 w 732411"/>
                    <a:gd name="connsiteY22-914" fmla="*/ 244770 h 312648"/>
                    <a:gd name="connsiteX23-915" fmla="*/ 352961 w 732411"/>
                    <a:gd name="connsiteY23-916" fmla="*/ 297158 h 312648"/>
                    <a:gd name="connsiteX24-917" fmla="*/ 338673 w 732411"/>
                    <a:gd name="connsiteY24-918" fmla="*/ 306682 h 312648"/>
                    <a:gd name="connsiteX25-919" fmla="*/ 383123 w 732411"/>
                    <a:gd name="connsiteY25-920" fmla="*/ 214608 h 312648"/>
                    <a:gd name="connsiteX26-921" fmla="*/ 321211 w 732411"/>
                    <a:gd name="connsiteY26-922" fmla="*/ 236833 h 312648"/>
                    <a:gd name="connsiteX27-923" fmla="*/ 238661 w 732411"/>
                    <a:gd name="connsiteY27-924" fmla="*/ 236833 h 312648"/>
                    <a:gd name="connsiteX28-925" fmla="*/ 167223 w 732411"/>
                    <a:gd name="connsiteY28-926" fmla="*/ 287632 h 312648"/>
                    <a:gd name="connsiteX29-927" fmla="*/ 200561 w 732411"/>
                    <a:gd name="connsiteY29-928" fmla="*/ 219370 h 312648"/>
                    <a:gd name="connsiteX30-929" fmla="*/ 5298 w 732411"/>
                    <a:gd name="connsiteY30-930" fmla="*/ 247945 h 312648"/>
                    <a:gd name="connsiteX0-931" fmla="*/ 5298 w 732411"/>
                    <a:gd name="connsiteY0-932" fmla="*/ 247942 h 312645"/>
                    <a:gd name="connsiteX1-933" fmla="*/ 59273 w 732411"/>
                    <a:gd name="connsiteY1-934" fmla="*/ 127292 h 312645"/>
                    <a:gd name="connsiteX2-935" fmla="*/ 100549 w 732411"/>
                    <a:gd name="connsiteY2-936" fmla="*/ 82842 h 312645"/>
                    <a:gd name="connsiteX3-937" fmla="*/ 87848 w 732411"/>
                    <a:gd name="connsiteY3-938" fmla="*/ 55855 h 312645"/>
                    <a:gd name="connsiteX4-939" fmla="*/ 110073 w 732411"/>
                    <a:gd name="connsiteY4-940" fmla="*/ 11405 h 312645"/>
                    <a:gd name="connsiteX5-941" fmla="*/ 164048 w 732411"/>
                    <a:gd name="connsiteY5-942" fmla="*/ 11404 h 312645"/>
                    <a:gd name="connsiteX6-943" fmla="*/ 184686 w 732411"/>
                    <a:gd name="connsiteY6-944" fmla="*/ 54267 h 312645"/>
                    <a:gd name="connsiteX7-945" fmla="*/ 181511 w 732411"/>
                    <a:gd name="connsiteY7-946" fmla="*/ 78080 h 312645"/>
                    <a:gd name="connsiteX8-947" fmla="*/ 230723 w 732411"/>
                    <a:gd name="connsiteY8-948" fmla="*/ 27280 h 312645"/>
                    <a:gd name="connsiteX9-949" fmla="*/ 352961 w 732411"/>
                    <a:gd name="connsiteY9-950" fmla="*/ 9817 h 312645"/>
                    <a:gd name="connsiteX10-951" fmla="*/ 506948 w 732411"/>
                    <a:gd name="connsiteY10-952" fmla="*/ 70143 h 312645"/>
                    <a:gd name="connsiteX11-953" fmla="*/ 575211 w 732411"/>
                    <a:gd name="connsiteY11-954" fmla="*/ 149517 h 312645"/>
                    <a:gd name="connsiteX12-955" fmla="*/ 643474 w 732411"/>
                    <a:gd name="connsiteY12-956" fmla="*/ 214604 h 312645"/>
                    <a:gd name="connsiteX13-957" fmla="*/ 700624 w 732411"/>
                    <a:gd name="connsiteY13-958" fmla="*/ 213017 h 312645"/>
                    <a:gd name="connsiteX14-959" fmla="*/ 687924 w 732411"/>
                    <a:gd name="connsiteY14-960" fmla="*/ 136817 h 312645"/>
                    <a:gd name="connsiteX15-961" fmla="*/ 622836 w 732411"/>
                    <a:gd name="connsiteY15-962" fmla="*/ 292 h 312645"/>
                    <a:gd name="connsiteX16-963" fmla="*/ 729198 w 732411"/>
                    <a:gd name="connsiteY16-964" fmla="*/ 176505 h 312645"/>
                    <a:gd name="connsiteX17-965" fmla="*/ 699036 w 732411"/>
                    <a:gd name="connsiteY17-966" fmla="*/ 243180 h 312645"/>
                    <a:gd name="connsiteX18-967" fmla="*/ 640299 w 732411"/>
                    <a:gd name="connsiteY18-968" fmla="*/ 240005 h 312645"/>
                    <a:gd name="connsiteX19-969" fmla="*/ 564098 w 732411"/>
                    <a:gd name="connsiteY19-970" fmla="*/ 195555 h 312645"/>
                    <a:gd name="connsiteX20-971" fmla="*/ 567273 w 732411"/>
                    <a:gd name="connsiteY20-972" fmla="*/ 203492 h 312645"/>
                    <a:gd name="connsiteX21-973" fmla="*/ 514886 w 732411"/>
                    <a:gd name="connsiteY21-974" fmla="*/ 240005 h 312645"/>
                    <a:gd name="connsiteX22-975" fmla="*/ 433923 w 732411"/>
                    <a:gd name="connsiteY22-976" fmla="*/ 244767 h 312645"/>
                    <a:gd name="connsiteX23-977" fmla="*/ 352961 w 732411"/>
                    <a:gd name="connsiteY23-978" fmla="*/ 297155 h 312645"/>
                    <a:gd name="connsiteX24-979" fmla="*/ 338673 w 732411"/>
                    <a:gd name="connsiteY24-980" fmla="*/ 306679 h 312645"/>
                    <a:gd name="connsiteX25-981" fmla="*/ 383123 w 732411"/>
                    <a:gd name="connsiteY25-982" fmla="*/ 214605 h 312645"/>
                    <a:gd name="connsiteX26-983" fmla="*/ 321211 w 732411"/>
                    <a:gd name="connsiteY26-984" fmla="*/ 236830 h 312645"/>
                    <a:gd name="connsiteX27-985" fmla="*/ 238661 w 732411"/>
                    <a:gd name="connsiteY27-986" fmla="*/ 236830 h 312645"/>
                    <a:gd name="connsiteX28-987" fmla="*/ 167223 w 732411"/>
                    <a:gd name="connsiteY28-988" fmla="*/ 287629 h 312645"/>
                    <a:gd name="connsiteX29-989" fmla="*/ 200561 w 732411"/>
                    <a:gd name="connsiteY29-990" fmla="*/ 219367 h 312645"/>
                    <a:gd name="connsiteX30-991" fmla="*/ 5298 w 732411"/>
                    <a:gd name="connsiteY30-992" fmla="*/ 247942 h 312645"/>
                    <a:gd name="connsiteX0-993" fmla="*/ 5298 w 732391"/>
                    <a:gd name="connsiteY0-994" fmla="*/ 247942 h 312645"/>
                    <a:gd name="connsiteX1-995" fmla="*/ 59273 w 732391"/>
                    <a:gd name="connsiteY1-996" fmla="*/ 127292 h 312645"/>
                    <a:gd name="connsiteX2-997" fmla="*/ 100549 w 732391"/>
                    <a:gd name="connsiteY2-998" fmla="*/ 82842 h 312645"/>
                    <a:gd name="connsiteX3-999" fmla="*/ 87848 w 732391"/>
                    <a:gd name="connsiteY3-1000" fmla="*/ 55855 h 312645"/>
                    <a:gd name="connsiteX4-1001" fmla="*/ 110073 w 732391"/>
                    <a:gd name="connsiteY4-1002" fmla="*/ 11405 h 312645"/>
                    <a:gd name="connsiteX5-1003" fmla="*/ 164048 w 732391"/>
                    <a:gd name="connsiteY5-1004" fmla="*/ 11404 h 312645"/>
                    <a:gd name="connsiteX6-1005" fmla="*/ 184686 w 732391"/>
                    <a:gd name="connsiteY6-1006" fmla="*/ 54267 h 312645"/>
                    <a:gd name="connsiteX7-1007" fmla="*/ 181511 w 732391"/>
                    <a:gd name="connsiteY7-1008" fmla="*/ 78080 h 312645"/>
                    <a:gd name="connsiteX8-1009" fmla="*/ 230723 w 732391"/>
                    <a:gd name="connsiteY8-1010" fmla="*/ 27280 h 312645"/>
                    <a:gd name="connsiteX9-1011" fmla="*/ 352961 w 732391"/>
                    <a:gd name="connsiteY9-1012" fmla="*/ 9817 h 312645"/>
                    <a:gd name="connsiteX10-1013" fmla="*/ 506948 w 732391"/>
                    <a:gd name="connsiteY10-1014" fmla="*/ 70143 h 312645"/>
                    <a:gd name="connsiteX11-1015" fmla="*/ 575211 w 732391"/>
                    <a:gd name="connsiteY11-1016" fmla="*/ 149517 h 312645"/>
                    <a:gd name="connsiteX12-1017" fmla="*/ 643474 w 732391"/>
                    <a:gd name="connsiteY12-1018" fmla="*/ 214604 h 312645"/>
                    <a:gd name="connsiteX13-1019" fmla="*/ 700624 w 732391"/>
                    <a:gd name="connsiteY13-1020" fmla="*/ 213017 h 312645"/>
                    <a:gd name="connsiteX14-1021" fmla="*/ 687924 w 732391"/>
                    <a:gd name="connsiteY14-1022" fmla="*/ 136817 h 312645"/>
                    <a:gd name="connsiteX15-1023" fmla="*/ 622836 w 732391"/>
                    <a:gd name="connsiteY15-1024" fmla="*/ 292 h 312645"/>
                    <a:gd name="connsiteX16-1025" fmla="*/ 729198 w 732391"/>
                    <a:gd name="connsiteY16-1026" fmla="*/ 176505 h 312645"/>
                    <a:gd name="connsiteX17-1027" fmla="*/ 699036 w 732391"/>
                    <a:gd name="connsiteY17-1028" fmla="*/ 243180 h 312645"/>
                    <a:gd name="connsiteX18-1029" fmla="*/ 641887 w 732391"/>
                    <a:gd name="connsiteY18-1030" fmla="*/ 241592 h 312645"/>
                    <a:gd name="connsiteX19-1031" fmla="*/ 564098 w 732391"/>
                    <a:gd name="connsiteY19-1032" fmla="*/ 195555 h 312645"/>
                    <a:gd name="connsiteX20-1033" fmla="*/ 567273 w 732391"/>
                    <a:gd name="connsiteY20-1034" fmla="*/ 203492 h 312645"/>
                    <a:gd name="connsiteX21-1035" fmla="*/ 514886 w 732391"/>
                    <a:gd name="connsiteY21-1036" fmla="*/ 240005 h 312645"/>
                    <a:gd name="connsiteX22-1037" fmla="*/ 433923 w 732391"/>
                    <a:gd name="connsiteY22-1038" fmla="*/ 244767 h 312645"/>
                    <a:gd name="connsiteX23-1039" fmla="*/ 352961 w 732391"/>
                    <a:gd name="connsiteY23-1040" fmla="*/ 297155 h 312645"/>
                    <a:gd name="connsiteX24-1041" fmla="*/ 338673 w 732391"/>
                    <a:gd name="connsiteY24-1042" fmla="*/ 306679 h 312645"/>
                    <a:gd name="connsiteX25-1043" fmla="*/ 383123 w 732391"/>
                    <a:gd name="connsiteY25-1044" fmla="*/ 214605 h 312645"/>
                    <a:gd name="connsiteX26-1045" fmla="*/ 321211 w 732391"/>
                    <a:gd name="connsiteY26-1046" fmla="*/ 236830 h 312645"/>
                    <a:gd name="connsiteX27-1047" fmla="*/ 238661 w 732391"/>
                    <a:gd name="connsiteY27-1048" fmla="*/ 236830 h 312645"/>
                    <a:gd name="connsiteX28-1049" fmla="*/ 167223 w 732391"/>
                    <a:gd name="connsiteY28-1050" fmla="*/ 287629 h 312645"/>
                    <a:gd name="connsiteX29-1051" fmla="*/ 200561 w 732391"/>
                    <a:gd name="connsiteY29-1052" fmla="*/ 219367 h 312645"/>
                    <a:gd name="connsiteX30-1053" fmla="*/ 5298 w 732391"/>
                    <a:gd name="connsiteY30-1054" fmla="*/ 247942 h 312645"/>
                    <a:gd name="connsiteX0-1055" fmla="*/ 5298 w 732391"/>
                    <a:gd name="connsiteY0-1056" fmla="*/ 247942 h 312645"/>
                    <a:gd name="connsiteX1-1057" fmla="*/ 59273 w 732391"/>
                    <a:gd name="connsiteY1-1058" fmla="*/ 127292 h 312645"/>
                    <a:gd name="connsiteX2-1059" fmla="*/ 100549 w 732391"/>
                    <a:gd name="connsiteY2-1060" fmla="*/ 82842 h 312645"/>
                    <a:gd name="connsiteX3-1061" fmla="*/ 87848 w 732391"/>
                    <a:gd name="connsiteY3-1062" fmla="*/ 55855 h 312645"/>
                    <a:gd name="connsiteX4-1063" fmla="*/ 110073 w 732391"/>
                    <a:gd name="connsiteY4-1064" fmla="*/ 11405 h 312645"/>
                    <a:gd name="connsiteX5-1065" fmla="*/ 164048 w 732391"/>
                    <a:gd name="connsiteY5-1066" fmla="*/ 11404 h 312645"/>
                    <a:gd name="connsiteX6-1067" fmla="*/ 184686 w 732391"/>
                    <a:gd name="connsiteY6-1068" fmla="*/ 54267 h 312645"/>
                    <a:gd name="connsiteX7-1069" fmla="*/ 181511 w 732391"/>
                    <a:gd name="connsiteY7-1070" fmla="*/ 78080 h 312645"/>
                    <a:gd name="connsiteX8-1071" fmla="*/ 230723 w 732391"/>
                    <a:gd name="connsiteY8-1072" fmla="*/ 27280 h 312645"/>
                    <a:gd name="connsiteX9-1073" fmla="*/ 352961 w 732391"/>
                    <a:gd name="connsiteY9-1074" fmla="*/ 9817 h 312645"/>
                    <a:gd name="connsiteX10-1075" fmla="*/ 506948 w 732391"/>
                    <a:gd name="connsiteY10-1076" fmla="*/ 70143 h 312645"/>
                    <a:gd name="connsiteX11-1077" fmla="*/ 575211 w 732391"/>
                    <a:gd name="connsiteY11-1078" fmla="*/ 149517 h 312645"/>
                    <a:gd name="connsiteX12-1079" fmla="*/ 643474 w 732391"/>
                    <a:gd name="connsiteY12-1080" fmla="*/ 214604 h 312645"/>
                    <a:gd name="connsiteX13-1081" fmla="*/ 700624 w 732391"/>
                    <a:gd name="connsiteY13-1082" fmla="*/ 213017 h 312645"/>
                    <a:gd name="connsiteX14-1083" fmla="*/ 687924 w 732391"/>
                    <a:gd name="connsiteY14-1084" fmla="*/ 136817 h 312645"/>
                    <a:gd name="connsiteX15-1085" fmla="*/ 622836 w 732391"/>
                    <a:gd name="connsiteY15-1086" fmla="*/ 292 h 312645"/>
                    <a:gd name="connsiteX16-1087" fmla="*/ 729198 w 732391"/>
                    <a:gd name="connsiteY16-1088" fmla="*/ 176505 h 312645"/>
                    <a:gd name="connsiteX17-1089" fmla="*/ 699036 w 732391"/>
                    <a:gd name="connsiteY17-1090" fmla="*/ 243180 h 312645"/>
                    <a:gd name="connsiteX18-1091" fmla="*/ 641887 w 732391"/>
                    <a:gd name="connsiteY18-1092" fmla="*/ 241592 h 312645"/>
                    <a:gd name="connsiteX19-1093" fmla="*/ 564098 w 732391"/>
                    <a:gd name="connsiteY19-1094" fmla="*/ 195555 h 312645"/>
                    <a:gd name="connsiteX20-1095" fmla="*/ 578385 w 732391"/>
                    <a:gd name="connsiteY20-1096" fmla="*/ 205080 h 312645"/>
                    <a:gd name="connsiteX21-1097" fmla="*/ 514886 w 732391"/>
                    <a:gd name="connsiteY21-1098" fmla="*/ 240005 h 312645"/>
                    <a:gd name="connsiteX22-1099" fmla="*/ 433923 w 732391"/>
                    <a:gd name="connsiteY22-1100" fmla="*/ 244767 h 312645"/>
                    <a:gd name="connsiteX23-1101" fmla="*/ 352961 w 732391"/>
                    <a:gd name="connsiteY23-1102" fmla="*/ 297155 h 312645"/>
                    <a:gd name="connsiteX24-1103" fmla="*/ 338673 w 732391"/>
                    <a:gd name="connsiteY24-1104" fmla="*/ 306679 h 312645"/>
                    <a:gd name="connsiteX25-1105" fmla="*/ 383123 w 732391"/>
                    <a:gd name="connsiteY25-1106" fmla="*/ 214605 h 312645"/>
                    <a:gd name="connsiteX26-1107" fmla="*/ 321211 w 732391"/>
                    <a:gd name="connsiteY26-1108" fmla="*/ 236830 h 312645"/>
                    <a:gd name="connsiteX27-1109" fmla="*/ 238661 w 732391"/>
                    <a:gd name="connsiteY27-1110" fmla="*/ 236830 h 312645"/>
                    <a:gd name="connsiteX28-1111" fmla="*/ 167223 w 732391"/>
                    <a:gd name="connsiteY28-1112" fmla="*/ 287629 h 312645"/>
                    <a:gd name="connsiteX29-1113" fmla="*/ 200561 w 732391"/>
                    <a:gd name="connsiteY29-1114" fmla="*/ 219367 h 312645"/>
                    <a:gd name="connsiteX30-1115" fmla="*/ 5298 w 732391"/>
                    <a:gd name="connsiteY30-1116" fmla="*/ 247942 h 312645"/>
                    <a:gd name="connsiteX0-1117" fmla="*/ 5298 w 732391"/>
                    <a:gd name="connsiteY0-1118" fmla="*/ 247942 h 312645"/>
                    <a:gd name="connsiteX1-1119" fmla="*/ 59273 w 732391"/>
                    <a:gd name="connsiteY1-1120" fmla="*/ 127292 h 312645"/>
                    <a:gd name="connsiteX2-1121" fmla="*/ 100549 w 732391"/>
                    <a:gd name="connsiteY2-1122" fmla="*/ 82842 h 312645"/>
                    <a:gd name="connsiteX3-1123" fmla="*/ 87848 w 732391"/>
                    <a:gd name="connsiteY3-1124" fmla="*/ 55855 h 312645"/>
                    <a:gd name="connsiteX4-1125" fmla="*/ 110073 w 732391"/>
                    <a:gd name="connsiteY4-1126" fmla="*/ 11405 h 312645"/>
                    <a:gd name="connsiteX5-1127" fmla="*/ 164048 w 732391"/>
                    <a:gd name="connsiteY5-1128" fmla="*/ 11404 h 312645"/>
                    <a:gd name="connsiteX6-1129" fmla="*/ 184686 w 732391"/>
                    <a:gd name="connsiteY6-1130" fmla="*/ 54267 h 312645"/>
                    <a:gd name="connsiteX7-1131" fmla="*/ 181511 w 732391"/>
                    <a:gd name="connsiteY7-1132" fmla="*/ 78080 h 312645"/>
                    <a:gd name="connsiteX8-1133" fmla="*/ 230723 w 732391"/>
                    <a:gd name="connsiteY8-1134" fmla="*/ 27280 h 312645"/>
                    <a:gd name="connsiteX9-1135" fmla="*/ 352961 w 732391"/>
                    <a:gd name="connsiteY9-1136" fmla="*/ 9817 h 312645"/>
                    <a:gd name="connsiteX10-1137" fmla="*/ 506948 w 732391"/>
                    <a:gd name="connsiteY10-1138" fmla="*/ 70143 h 312645"/>
                    <a:gd name="connsiteX11-1139" fmla="*/ 579973 w 732391"/>
                    <a:gd name="connsiteY11-1140" fmla="*/ 147929 h 312645"/>
                    <a:gd name="connsiteX12-1141" fmla="*/ 643474 w 732391"/>
                    <a:gd name="connsiteY12-1142" fmla="*/ 214604 h 312645"/>
                    <a:gd name="connsiteX13-1143" fmla="*/ 700624 w 732391"/>
                    <a:gd name="connsiteY13-1144" fmla="*/ 213017 h 312645"/>
                    <a:gd name="connsiteX14-1145" fmla="*/ 687924 w 732391"/>
                    <a:gd name="connsiteY14-1146" fmla="*/ 136817 h 312645"/>
                    <a:gd name="connsiteX15-1147" fmla="*/ 622836 w 732391"/>
                    <a:gd name="connsiteY15-1148" fmla="*/ 292 h 312645"/>
                    <a:gd name="connsiteX16-1149" fmla="*/ 729198 w 732391"/>
                    <a:gd name="connsiteY16-1150" fmla="*/ 176505 h 312645"/>
                    <a:gd name="connsiteX17-1151" fmla="*/ 699036 w 732391"/>
                    <a:gd name="connsiteY17-1152" fmla="*/ 243180 h 312645"/>
                    <a:gd name="connsiteX18-1153" fmla="*/ 641887 w 732391"/>
                    <a:gd name="connsiteY18-1154" fmla="*/ 241592 h 312645"/>
                    <a:gd name="connsiteX19-1155" fmla="*/ 564098 w 732391"/>
                    <a:gd name="connsiteY19-1156" fmla="*/ 195555 h 312645"/>
                    <a:gd name="connsiteX20-1157" fmla="*/ 578385 w 732391"/>
                    <a:gd name="connsiteY20-1158" fmla="*/ 205080 h 312645"/>
                    <a:gd name="connsiteX21-1159" fmla="*/ 514886 w 732391"/>
                    <a:gd name="connsiteY21-1160" fmla="*/ 240005 h 312645"/>
                    <a:gd name="connsiteX22-1161" fmla="*/ 433923 w 732391"/>
                    <a:gd name="connsiteY22-1162" fmla="*/ 244767 h 312645"/>
                    <a:gd name="connsiteX23-1163" fmla="*/ 352961 w 732391"/>
                    <a:gd name="connsiteY23-1164" fmla="*/ 297155 h 312645"/>
                    <a:gd name="connsiteX24-1165" fmla="*/ 338673 w 732391"/>
                    <a:gd name="connsiteY24-1166" fmla="*/ 306679 h 312645"/>
                    <a:gd name="connsiteX25-1167" fmla="*/ 383123 w 732391"/>
                    <a:gd name="connsiteY25-1168" fmla="*/ 214605 h 312645"/>
                    <a:gd name="connsiteX26-1169" fmla="*/ 321211 w 732391"/>
                    <a:gd name="connsiteY26-1170" fmla="*/ 236830 h 312645"/>
                    <a:gd name="connsiteX27-1171" fmla="*/ 238661 w 732391"/>
                    <a:gd name="connsiteY27-1172" fmla="*/ 236830 h 312645"/>
                    <a:gd name="connsiteX28-1173" fmla="*/ 167223 w 732391"/>
                    <a:gd name="connsiteY28-1174" fmla="*/ 287629 h 312645"/>
                    <a:gd name="connsiteX29-1175" fmla="*/ 200561 w 732391"/>
                    <a:gd name="connsiteY29-1176" fmla="*/ 219367 h 312645"/>
                    <a:gd name="connsiteX30-1177" fmla="*/ 5298 w 732391"/>
                    <a:gd name="connsiteY30-1178" fmla="*/ 247942 h 312645"/>
                    <a:gd name="connsiteX0-1179" fmla="*/ 5298 w 732391"/>
                    <a:gd name="connsiteY0-1180" fmla="*/ 247942 h 312645"/>
                    <a:gd name="connsiteX1-1181" fmla="*/ 59273 w 732391"/>
                    <a:gd name="connsiteY1-1182" fmla="*/ 127292 h 312645"/>
                    <a:gd name="connsiteX2-1183" fmla="*/ 100549 w 732391"/>
                    <a:gd name="connsiteY2-1184" fmla="*/ 82842 h 312645"/>
                    <a:gd name="connsiteX3-1185" fmla="*/ 87848 w 732391"/>
                    <a:gd name="connsiteY3-1186" fmla="*/ 55855 h 312645"/>
                    <a:gd name="connsiteX4-1187" fmla="*/ 110073 w 732391"/>
                    <a:gd name="connsiteY4-1188" fmla="*/ 11405 h 312645"/>
                    <a:gd name="connsiteX5-1189" fmla="*/ 164048 w 732391"/>
                    <a:gd name="connsiteY5-1190" fmla="*/ 11404 h 312645"/>
                    <a:gd name="connsiteX6-1191" fmla="*/ 184686 w 732391"/>
                    <a:gd name="connsiteY6-1192" fmla="*/ 54267 h 312645"/>
                    <a:gd name="connsiteX7-1193" fmla="*/ 181511 w 732391"/>
                    <a:gd name="connsiteY7-1194" fmla="*/ 78080 h 312645"/>
                    <a:gd name="connsiteX8-1195" fmla="*/ 230723 w 732391"/>
                    <a:gd name="connsiteY8-1196" fmla="*/ 27280 h 312645"/>
                    <a:gd name="connsiteX9-1197" fmla="*/ 352961 w 732391"/>
                    <a:gd name="connsiteY9-1198" fmla="*/ 9817 h 312645"/>
                    <a:gd name="connsiteX10-1199" fmla="*/ 506948 w 732391"/>
                    <a:gd name="connsiteY10-1200" fmla="*/ 70143 h 312645"/>
                    <a:gd name="connsiteX11-1201" fmla="*/ 579973 w 732391"/>
                    <a:gd name="connsiteY11-1202" fmla="*/ 147929 h 312645"/>
                    <a:gd name="connsiteX12-1203" fmla="*/ 643474 w 732391"/>
                    <a:gd name="connsiteY12-1204" fmla="*/ 214604 h 312645"/>
                    <a:gd name="connsiteX13-1205" fmla="*/ 700624 w 732391"/>
                    <a:gd name="connsiteY13-1206" fmla="*/ 213017 h 312645"/>
                    <a:gd name="connsiteX14-1207" fmla="*/ 687924 w 732391"/>
                    <a:gd name="connsiteY14-1208" fmla="*/ 136817 h 312645"/>
                    <a:gd name="connsiteX15-1209" fmla="*/ 622836 w 732391"/>
                    <a:gd name="connsiteY15-1210" fmla="*/ 292 h 312645"/>
                    <a:gd name="connsiteX16-1211" fmla="*/ 729198 w 732391"/>
                    <a:gd name="connsiteY16-1212" fmla="*/ 176505 h 312645"/>
                    <a:gd name="connsiteX17-1213" fmla="*/ 699036 w 732391"/>
                    <a:gd name="connsiteY17-1214" fmla="*/ 243180 h 312645"/>
                    <a:gd name="connsiteX18-1215" fmla="*/ 641887 w 732391"/>
                    <a:gd name="connsiteY18-1216" fmla="*/ 241592 h 312645"/>
                    <a:gd name="connsiteX19-1217" fmla="*/ 564098 w 732391"/>
                    <a:gd name="connsiteY19-1218" fmla="*/ 195555 h 312645"/>
                    <a:gd name="connsiteX20-1219" fmla="*/ 578385 w 732391"/>
                    <a:gd name="connsiteY20-1220" fmla="*/ 205080 h 312645"/>
                    <a:gd name="connsiteX21-1221" fmla="*/ 514886 w 732391"/>
                    <a:gd name="connsiteY21-1222" fmla="*/ 240005 h 312645"/>
                    <a:gd name="connsiteX22-1223" fmla="*/ 433923 w 732391"/>
                    <a:gd name="connsiteY22-1224" fmla="*/ 244767 h 312645"/>
                    <a:gd name="connsiteX23-1225" fmla="*/ 352961 w 732391"/>
                    <a:gd name="connsiteY23-1226" fmla="*/ 297155 h 312645"/>
                    <a:gd name="connsiteX24-1227" fmla="*/ 338673 w 732391"/>
                    <a:gd name="connsiteY24-1228" fmla="*/ 306679 h 312645"/>
                    <a:gd name="connsiteX25-1229" fmla="*/ 383123 w 732391"/>
                    <a:gd name="connsiteY25-1230" fmla="*/ 214605 h 312645"/>
                    <a:gd name="connsiteX26-1231" fmla="*/ 313274 w 732391"/>
                    <a:gd name="connsiteY26-1232" fmla="*/ 236830 h 312645"/>
                    <a:gd name="connsiteX27-1233" fmla="*/ 238661 w 732391"/>
                    <a:gd name="connsiteY27-1234" fmla="*/ 236830 h 312645"/>
                    <a:gd name="connsiteX28-1235" fmla="*/ 167223 w 732391"/>
                    <a:gd name="connsiteY28-1236" fmla="*/ 287629 h 312645"/>
                    <a:gd name="connsiteX29-1237" fmla="*/ 200561 w 732391"/>
                    <a:gd name="connsiteY29-1238" fmla="*/ 219367 h 312645"/>
                    <a:gd name="connsiteX30-1239" fmla="*/ 5298 w 732391"/>
                    <a:gd name="connsiteY30-1240" fmla="*/ 247942 h 312645"/>
                    <a:gd name="connsiteX0-1241" fmla="*/ 5347 w 732440"/>
                    <a:gd name="connsiteY0-1242" fmla="*/ 247942 h 312645"/>
                    <a:gd name="connsiteX1-1243" fmla="*/ 59322 w 732440"/>
                    <a:gd name="connsiteY1-1244" fmla="*/ 127292 h 312645"/>
                    <a:gd name="connsiteX2-1245" fmla="*/ 105360 w 732440"/>
                    <a:gd name="connsiteY2-1246" fmla="*/ 79667 h 312645"/>
                    <a:gd name="connsiteX3-1247" fmla="*/ 87897 w 732440"/>
                    <a:gd name="connsiteY3-1248" fmla="*/ 55855 h 312645"/>
                    <a:gd name="connsiteX4-1249" fmla="*/ 110122 w 732440"/>
                    <a:gd name="connsiteY4-1250" fmla="*/ 11405 h 312645"/>
                    <a:gd name="connsiteX5-1251" fmla="*/ 164097 w 732440"/>
                    <a:gd name="connsiteY5-1252" fmla="*/ 11404 h 312645"/>
                    <a:gd name="connsiteX6-1253" fmla="*/ 184735 w 732440"/>
                    <a:gd name="connsiteY6-1254" fmla="*/ 54267 h 312645"/>
                    <a:gd name="connsiteX7-1255" fmla="*/ 181560 w 732440"/>
                    <a:gd name="connsiteY7-1256" fmla="*/ 78080 h 312645"/>
                    <a:gd name="connsiteX8-1257" fmla="*/ 230772 w 732440"/>
                    <a:gd name="connsiteY8-1258" fmla="*/ 27280 h 312645"/>
                    <a:gd name="connsiteX9-1259" fmla="*/ 353010 w 732440"/>
                    <a:gd name="connsiteY9-1260" fmla="*/ 9817 h 312645"/>
                    <a:gd name="connsiteX10-1261" fmla="*/ 506997 w 732440"/>
                    <a:gd name="connsiteY10-1262" fmla="*/ 70143 h 312645"/>
                    <a:gd name="connsiteX11-1263" fmla="*/ 580022 w 732440"/>
                    <a:gd name="connsiteY11-1264" fmla="*/ 147929 h 312645"/>
                    <a:gd name="connsiteX12-1265" fmla="*/ 643523 w 732440"/>
                    <a:gd name="connsiteY12-1266" fmla="*/ 214604 h 312645"/>
                    <a:gd name="connsiteX13-1267" fmla="*/ 700673 w 732440"/>
                    <a:gd name="connsiteY13-1268" fmla="*/ 213017 h 312645"/>
                    <a:gd name="connsiteX14-1269" fmla="*/ 687973 w 732440"/>
                    <a:gd name="connsiteY14-1270" fmla="*/ 136817 h 312645"/>
                    <a:gd name="connsiteX15-1271" fmla="*/ 622885 w 732440"/>
                    <a:gd name="connsiteY15-1272" fmla="*/ 292 h 312645"/>
                    <a:gd name="connsiteX16-1273" fmla="*/ 729247 w 732440"/>
                    <a:gd name="connsiteY16-1274" fmla="*/ 176505 h 312645"/>
                    <a:gd name="connsiteX17-1275" fmla="*/ 699085 w 732440"/>
                    <a:gd name="connsiteY17-1276" fmla="*/ 243180 h 312645"/>
                    <a:gd name="connsiteX18-1277" fmla="*/ 641936 w 732440"/>
                    <a:gd name="connsiteY18-1278" fmla="*/ 241592 h 312645"/>
                    <a:gd name="connsiteX19-1279" fmla="*/ 564147 w 732440"/>
                    <a:gd name="connsiteY19-1280" fmla="*/ 195555 h 312645"/>
                    <a:gd name="connsiteX20-1281" fmla="*/ 578434 w 732440"/>
                    <a:gd name="connsiteY20-1282" fmla="*/ 205080 h 312645"/>
                    <a:gd name="connsiteX21-1283" fmla="*/ 514935 w 732440"/>
                    <a:gd name="connsiteY21-1284" fmla="*/ 240005 h 312645"/>
                    <a:gd name="connsiteX22-1285" fmla="*/ 433972 w 732440"/>
                    <a:gd name="connsiteY22-1286" fmla="*/ 244767 h 312645"/>
                    <a:gd name="connsiteX23-1287" fmla="*/ 353010 w 732440"/>
                    <a:gd name="connsiteY23-1288" fmla="*/ 297155 h 312645"/>
                    <a:gd name="connsiteX24-1289" fmla="*/ 338722 w 732440"/>
                    <a:gd name="connsiteY24-1290" fmla="*/ 306679 h 312645"/>
                    <a:gd name="connsiteX25-1291" fmla="*/ 383172 w 732440"/>
                    <a:gd name="connsiteY25-1292" fmla="*/ 214605 h 312645"/>
                    <a:gd name="connsiteX26-1293" fmla="*/ 313323 w 732440"/>
                    <a:gd name="connsiteY26-1294" fmla="*/ 236830 h 312645"/>
                    <a:gd name="connsiteX27-1295" fmla="*/ 238710 w 732440"/>
                    <a:gd name="connsiteY27-1296" fmla="*/ 236830 h 312645"/>
                    <a:gd name="connsiteX28-1297" fmla="*/ 167272 w 732440"/>
                    <a:gd name="connsiteY28-1298" fmla="*/ 287629 h 312645"/>
                    <a:gd name="connsiteX29-1299" fmla="*/ 200610 w 732440"/>
                    <a:gd name="connsiteY29-1300" fmla="*/ 219367 h 312645"/>
                    <a:gd name="connsiteX30-1301" fmla="*/ 5347 w 732440"/>
                    <a:gd name="connsiteY30-1302" fmla="*/ 247942 h 312645"/>
                    <a:gd name="connsiteX0-1303" fmla="*/ 5347 w 732440"/>
                    <a:gd name="connsiteY0-1304" fmla="*/ 247942 h 312645"/>
                    <a:gd name="connsiteX1-1305" fmla="*/ 59322 w 732440"/>
                    <a:gd name="connsiteY1-1306" fmla="*/ 127292 h 312645"/>
                    <a:gd name="connsiteX2-1307" fmla="*/ 105360 w 732440"/>
                    <a:gd name="connsiteY2-1308" fmla="*/ 79667 h 312645"/>
                    <a:gd name="connsiteX3-1309" fmla="*/ 87897 w 732440"/>
                    <a:gd name="connsiteY3-1310" fmla="*/ 55855 h 312645"/>
                    <a:gd name="connsiteX4-1311" fmla="*/ 110122 w 732440"/>
                    <a:gd name="connsiteY4-1312" fmla="*/ 11405 h 312645"/>
                    <a:gd name="connsiteX5-1313" fmla="*/ 165685 w 732440"/>
                    <a:gd name="connsiteY5-1314" fmla="*/ 9816 h 312645"/>
                    <a:gd name="connsiteX6-1315" fmla="*/ 184735 w 732440"/>
                    <a:gd name="connsiteY6-1316" fmla="*/ 54267 h 312645"/>
                    <a:gd name="connsiteX7-1317" fmla="*/ 181560 w 732440"/>
                    <a:gd name="connsiteY7-1318" fmla="*/ 78080 h 312645"/>
                    <a:gd name="connsiteX8-1319" fmla="*/ 230772 w 732440"/>
                    <a:gd name="connsiteY8-1320" fmla="*/ 27280 h 312645"/>
                    <a:gd name="connsiteX9-1321" fmla="*/ 353010 w 732440"/>
                    <a:gd name="connsiteY9-1322" fmla="*/ 9817 h 312645"/>
                    <a:gd name="connsiteX10-1323" fmla="*/ 506997 w 732440"/>
                    <a:gd name="connsiteY10-1324" fmla="*/ 70143 h 312645"/>
                    <a:gd name="connsiteX11-1325" fmla="*/ 580022 w 732440"/>
                    <a:gd name="connsiteY11-1326" fmla="*/ 147929 h 312645"/>
                    <a:gd name="connsiteX12-1327" fmla="*/ 643523 w 732440"/>
                    <a:gd name="connsiteY12-1328" fmla="*/ 214604 h 312645"/>
                    <a:gd name="connsiteX13-1329" fmla="*/ 700673 w 732440"/>
                    <a:gd name="connsiteY13-1330" fmla="*/ 213017 h 312645"/>
                    <a:gd name="connsiteX14-1331" fmla="*/ 687973 w 732440"/>
                    <a:gd name="connsiteY14-1332" fmla="*/ 136817 h 312645"/>
                    <a:gd name="connsiteX15-1333" fmla="*/ 622885 w 732440"/>
                    <a:gd name="connsiteY15-1334" fmla="*/ 292 h 312645"/>
                    <a:gd name="connsiteX16-1335" fmla="*/ 729247 w 732440"/>
                    <a:gd name="connsiteY16-1336" fmla="*/ 176505 h 312645"/>
                    <a:gd name="connsiteX17-1337" fmla="*/ 699085 w 732440"/>
                    <a:gd name="connsiteY17-1338" fmla="*/ 243180 h 312645"/>
                    <a:gd name="connsiteX18-1339" fmla="*/ 641936 w 732440"/>
                    <a:gd name="connsiteY18-1340" fmla="*/ 241592 h 312645"/>
                    <a:gd name="connsiteX19-1341" fmla="*/ 564147 w 732440"/>
                    <a:gd name="connsiteY19-1342" fmla="*/ 195555 h 312645"/>
                    <a:gd name="connsiteX20-1343" fmla="*/ 578434 w 732440"/>
                    <a:gd name="connsiteY20-1344" fmla="*/ 205080 h 312645"/>
                    <a:gd name="connsiteX21-1345" fmla="*/ 514935 w 732440"/>
                    <a:gd name="connsiteY21-1346" fmla="*/ 240005 h 312645"/>
                    <a:gd name="connsiteX22-1347" fmla="*/ 433972 w 732440"/>
                    <a:gd name="connsiteY22-1348" fmla="*/ 244767 h 312645"/>
                    <a:gd name="connsiteX23-1349" fmla="*/ 353010 w 732440"/>
                    <a:gd name="connsiteY23-1350" fmla="*/ 297155 h 312645"/>
                    <a:gd name="connsiteX24-1351" fmla="*/ 338722 w 732440"/>
                    <a:gd name="connsiteY24-1352" fmla="*/ 306679 h 312645"/>
                    <a:gd name="connsiteX25-1353" fmla="*/ 383172 w 732440"/>
                    <a:gd name="connsiteY25-1354" fmla="*/ 214605 h 312645"/>
                    <a:gd name="connsiteX26-1355" fmla="*/ 313323 w 732440"/>
                    <a:gd name="connsiteY26-1356" fmla="*/ 236830 h 312645"/>
                    <a:gd name="connsiteX27-1357" fmla="*/ 238710 w 732440"/>
                    <a:gd name="connsiteY27-1358" fmla="*/ 236830 h 312645"/>
                    <a:gd name="connsiteX28-1359" fmla="*/ 167272 w 732440"/>
                    <a:gd name="connsiteY28-1360" fmla="*/ 287629 h 312645"/>
                    <a:gd name="connsiteX29-1361" fmla="*/ 200610 w 732440"/>
                    <a:gd name="connsiteY29-1362" fmla="*/ 219367 h 312645"/>
                    <a:gd name="connsiteX30-1363" fmla="*/ 5347 w 732440"/>
                    <a:gd name="connsiteY30-1364" fmla="*/ 247942 h 312645"/>
                    <a:gd name="connsiteX0-1365" fmla="*/ 5347 w 732440"/>
                    <a:gd name="connsiteY0-1366" fmla="*/ 247942 h 312645"/>
                    <a:gd name="connsiteX1-1367" fmla="*/ 59322 w 732440"/>
                    <a:gd name="connsiteY1-1368" fmla="*/ 127292 h 312645"/>
                    <a:gd name="connsiteX2-1369" fmla="*/ 105360 w 732440"/>
                    <a:gd name="connsiteY2-1370" fmla="*/ 79667 h 312645"/>
                    <a:gd name="connsiteX3-1371" fmla="*/ 87897 w 732440"/>
                    <a:gd name="connsiteY3-1372" fmla="*/ 55855 h 312645"/>
                    <a:gd name="connsiteX4-1373" fmla="*/ 110122 w 732440"/>
                    <a:gd name="connsiteY4-1374" fmla="*/ 11405 h 312645"/>
                    <a:gd name="connsiteX5-1375" fmla="*/ 165685 w 732440"/>
                    <a:gd name="connsiteY5-1376" fmla="*/ 9816 h 312645"/>
                    <a:gd name="connsiteX6-1377" fmla="*/ 184735 w 732440"/>
                    <a:gd name="connsiteY6-1378" fmla="*/ 54267 h 312645"/>
                    <a:gd name="connsiteX7-1379" fmla="*/ 181560 w 732440"/>
                    <a:gd name="connsiteY7-1380" fmla="*/ 78080 h 312645"/>
                    <a:gd name="connsiteX8-1381" fmla="*/ 230772 w 732440"/>
                    <a:gd name="connsiteY8-1382" fmla="*/ 27280 h 312645"/>
                    <a:gd name="connsiteX9-1383" fmla="*/ 353010 w 732440"/>
                    <a:gd name="connsiteY9-1384" fmla="*/ 9817 h 312645"/>
                    <a:gd name="connsiteX10-1385" fmla="*/ 506997 w 732440"/>
                    <a:gd name="connsiteY10-1386" fmla="*/ 70143 h 312645"/>
                    <a:gd name="connsiteX11-1387" fmla="*/ 580022 w 732440"/>
                    <a:gd name="connsiteY11-1388" fmla="*/ 147929 h 312645"/>
                    <a:gd name="connsiteX12-1389" fmla="*/ 643523 w 732440"/>
                    <a:gd name="connsiteY12-1390" fmla="*/ 214604 h 312645"/>
                    <a:gd name="connsiteX13-1391" fmla="*/ 700673 w 732440"/>
                    <a:gd name="connsiteY13-1392" fmla="*/ 213017 h 312645"/>
                    <a:gd name="connsiteX14-1393" fmla="*/ 687973 w 732440"/>
                    <a:gd name="connsiteY14-1394" fmla="*/ 136817 h 312645"/>
                    <a:gd name="connsiteX15-1395" fmla="*/ 622885 w 732440"/>
                    <a:gd name="connsiteY15-1396" fmla="*/ 292 h 312645"/>
                    <a:gd name="connsiteX16-1397" fmla="*/ 729247 w 732440"/>
                    <a:gd name="connsiteY16-1398" fmla="*/ 176505 h 312645"/>
                    <a:gd name="connsiteX17-1399" fmla="*/ 699085 w 732440"/>
                    <a:gd name="connsiteY17-1400" fmla="*/ 243180 h 312645"/>
                    <a:gd name="connsiteX18-1401" fmla="*/ 641936 w 732440"/>
                    <a:gd name="connsiteY18-1402" fmla="*/ 241592 h 312645"/>
                    <a:gd name="connsiteX19-1403" fmla="*/ 564147 w 732440"/>
                    <a:gd name="connsiteY19-1404" fmla="*/ 195555 h 312645"/>
                    <a:gd name="connsiteX20-1405" fmla="*/ 578434 w 732440"/>
                    <a:gd name="connsiteY20-1406" fmla="*/ 205080 h 312645"/>
                    <a:gd name="connsiteX21-1407" fmla="*/ 514935 w 732440"/>
                    <a:gd name="connsiteY21-1408" fmla="*/ 240005 h 312645"/>
                    <a:gd name="connsiteX22-1409" fmla="*/ 433972 w 732440"/>
                    <a:gd name="connsiteY22-1410" fmla="*/ 244767 h 312645"/>
                    <a:gd name="connsiteX23-1411" fmla="*/ 353010 w 732440"/>
                    <a:gd name="connsiteY23-1412" fmla="*/ 297155 h 312645"/>
                    <a:gd name="connsiteX24-1413" fmla="*/ 338722 w 732440"/>
                    <a:gd name="connsiteY24-1414" fmla="*/ 306679 h 312645"/>
                    <a:gd name="connsiteX25-1415" fmla="*/ 383172 w 732440"/>
                    <a:gd name="connsiteY25-1416" fmla="*/ 214605 h 312645"/>
                    <a:gd name="connsiteX26-1417" fmla="*/ 318085 w 732440"/>
                    <a:gd name="connsiteY26-1418" fmla="*/ 241592 h 312645"/>
                    <a:gd name="connsiteX27-1419" fmla="*/ 238710 w 732440"/>
                    <a:gd name="connsiteY27-1420" fmla="*/ 236830 h 312645"/>
                    <a:gd name="connsiteX28-1421" fmla="*/ 167272 w 732440"/>
                    <a:gd name="connsiteY28-1422" fmla="*/ 287629 h 312645"/>
                    <a:gd name="connsiteX29-1423" fmla="*/ 200610 w 732440"/>
                    <a:gd name="connsiteY29-1424" fmla="*/ 219367 h 312645"/>
                    <a:gd name="connsiteX30-1425" fmla="*/ 5347 w 732440"/>
                    <a:gd name="connsiteY30-1426" fmla="*/ 247942 h 312645"/>
                    <a:gd name="connsiteX0-1427" fmla="*/ 5347 w 732440"/>
                    <a:gd name="connsiteY0-1428" fmla="*/ 247942 h 314288"/>
                    <a:gd name="connsiteX1-1429" fmla="*/ 59322 w 732440"/>
                    <a:gd name="connsiteY1-1430" fmla="*/ 127292 h 314288"/>
                    <a:gd name="connsiteX2-1431" fmla="*/ 105360 w 732440"/>
                    <a:gd name="connsiteY2-1432" fmla="*/ 79667 h 314288"/>
                    <a:gd name="connsiteX3-1433" fmla="*/ 87897 w 732440"/>
                    <a:gd name="connsiteY3-1434" fmla="*/ 55855 h 314288"/>
                    <a:gd name="connsiteX4-1435" fmla="*/ 110122 w 732440"/>
                    <a:gd name="connsiteY4-1436" fmla="*/ 11405 h 314288"/>
                    <a:gd name="connsiteX5-1437" fmla="*/ 165685 w 732440"/>
                    <a:gd name="connsiteY5-1438" fmla="*/ 9816 h 314288"/>
                    <a:gd name="connsiteX6-1439" fmla="*/ 184735 w 732440"/>
                    <a:gd name="connsiteY6-1440" fmla="*/ 54267 h 314288"/>
                    <a:gd name="connsiteX7-1441" fmla="*/ 181560 w 732440"/>
                    <a:gd name="connsiteY7-1442" fmla="*/ 78080 h 314288"/>
                    <a:gd name="connsiteX8-1443" fmla="*/ 230772 w 732440"/>
                    <a:gd name="connsiteY8-1444" fmla="*/ 27280 h 314288"/>
                    <a:gd name="connsiteX9-1445" fmla="*/ 353010 w 732440"/>
                    <a:gd name="connsiteY9-1446" fmla="*/ 9817 h 314288"/>
                    <a:gd name="connsiteX10-1447" fmla="*/ 506997 w 732440"/>
                    <a:gd name="connsiteY10-1448" fmla="*/ 70143 h 314288"/>
                    <a:gd name="connsiteX11-1449" fmla="*/ 580022 w 732440"/>
                    <a:gd name="connsiteY11-1450" fmla="*/ 147929 h 314288"/>
                    <a:gd name="connsiteX12-1451" fmla="*/ 643523 w 732440"/>
                    <a:gd name="connsiteY12-1452" fmla="*/ 214604 h 314288"/>
                    <a:gd name="connsiteX13-1453" fmla="*/ 700673 w 732440"/>
                    <a:gd name="connsiteY13-1454" fmla="*/ 213017 h 314288"/>
                    <a:gd name="connsiteX14-1455" fmla="*/ 687973 w 732440"/>
                    <a:gd name="connsiteY14-1456" fmla="*/ 136817 h 314288"/>
                    <a:gd name="connsiteX15-1457" fmla="*/ 622885 w 732440"/>
                    <a:gd name="connsiteY15-1458" fmla="*/ 292 h 314288"/>
                    <a:gd name="connsiteX16-1459" fmla="*/ 729247 w 732440"/>
                    <a:gd name="connsiteY16-1460" fmla="*/ 176505 h 314288"/>
                    <a:gd name="connsiteX17-1461" fmla="*/ 699085 w 732440"/>
                    <a:gd name="connsiteY17-1462" fmla="*/ 243180 h 314288"/>
                    <a:gd name="connsiteX18-1463" fmla="*/ 641936 w 732440"/>
                    <a:gd name="connsiteY18-1464" fmla="*/ 241592 h 314288"/>
                    <a:gd name="connsiteX19-1465" fmla="*/ 564147 w 732440"/>
                    <a:gd name="connsiteY19-1466" fmla="*/ 195555 h 314288"/>
                    <a:gd name="connsiteX20-1467" fmla="*/ 578434 w 732440"/>
                    <a:gd name="connsiteY20-1468" fmla="*/ 205080 h 314288"/>
                    <a:gd name="connsiteX21-1469" fmla="*/ 514935 w 732440"/>
                    <a:gd name="connsiteY21-1470" fmla="*/ 240005 h 314288"/>
                    <a:gd name="connsiteX22-1471" fmla="*/ 433972 w 732440"/>
                    <a:gd name="connsiteY22-1472" fmla="*/ 244767 h 314288"/>
                    <a:gd name="connsiteX23-1473" fmla="*/ 367297 w 732440"/>
                    <a:gd name="connsiteY23-1474" fmla="*/ 301918 h 314288"/>
                    <a:gd name="connsiteX24-1475" fmla="*/ 338722 w 732440"/>
                    <a:gd name="connsiteY24-1476" fmla="*/ 306679 h 314288"/>
                    <a:gd name="connsiteX25-1477" fmla="*/ 383172 w 732440"/>
                    <a:gd name="connsiteY25-1478" fmla="*/ 214605 h 314288"/>
                    <a:gd name="connsiteX26-1479" fmla="*/ 318085 w 732440"/>
                    <a:gd name="connsiteY26-1480" fmla="*/ 241592 h 314288"/>
                    <a:gd name="connsiteX27-1481" fmla="*/ 238710 w 732440"/>
                    <a:gd name="connsiteY27-1482" fmla="*/ 236830 h 314288"/>
                    <a:gd name="connsiteX28-1483" fmla="*/ 167272 w 732440"/>
                    <a:gd name="connsiteY28-1484" fmla="*/ 287629 h 314288"/>
                    <a:gd name="connsiteX29-1485" fmla="*/ 200610 w 732440"/>
                    <a:gd name="connsiteY29-1486" fmla="*/ 219367 h 314288"/>
                    <a:gd name="connsiteX30-1487" fmla="*/ 5347 w 732440"/>
                    <a:gd name="connsiteY30-1488" fmla="*/ 247942 h 314288"/>
                    <a:gd name="connsiteX0-1489" fmla="*/ 5347 w 732769"/>
                    <a:gd name="connsiteY0-1490" fmla="*/ 247942 h 314288"/>
                    <a:gd name="connsiteX1-1491" fmla="*/ 59322 w 732769"/>
                    <a:gd name="connsiteY1-1492" fmla="*/ 127292 h 314288"/>
                    <a:gd name="connsiteX2-1493" fmla="*/ 105360 w 732769"/>
                    <a:gd name="connsiteY2-1494" fmla="*/ 79667 h 314288"/>
                    <a:gd name="connsiteX3-1495" fmla="*/ 87897 w 732769"/>
                    <a:gd name="connsiteY3-1496" fmla="*/ 55855 h 314288"/>
                    <a:gd name="connsiteX4-1497" fmla="*/ 110122 w 732769"/>
                    <a:gd name="connsiteY4-1498" fmla="*/ 11405 h 314288"/>
                    <a:gd name="connsiteX5-1499" fmla="*/ 165685 w 732769"/>
                    <a:gd name="connsiteY5-1500" fmla="*/ 9816 h 314288"/>
                    <a:gd name="connsiteX6-1501" fmla="*/ 184735 w 732769"/>
                    <a:gd name="connsiteY6-1502" fmla="*/ 54267 h 314288"/>
                    <a:gd name="connsiteX7-1503" fmla="*/ 181560 w 732769"/>
                    <a:gd name="connsiteY7-1504" fmla="*/ 78080 h 314288"/>
                    <a:gd name="connsiteX8-1505" fmla="*/ 230772 w 732769"/>
                    <a:gd name="connsiteY8-1506" fmla="*/ 27280 h 314288"/>
                    <a:gd name="connsiteX9-1507" fmla="*/ 353010 w 732769"/>
                    <a:gd name="connsiteY9-1508" fmla="*/ 9817 h 314288"/>
                    <a:gd name="connsiteX10-1509" fmla="*/ 506997 w 732769"/>
                    <a:gd name="connsiteY10-1510" fmla="*/ 70143 h 314288"/>
                    <a:gd name="connsiteX11-1511" fmla="*/ 580022 w 732769"/>
                    <a:gd name="connsiteY11-1512" fmla="*/ 147929 h 314288"/>
                    <a:gd name="connsiteX12-1513" fmla="*/ 643523 w 732769"/>
                    <a:gd name="connsiteY12-1514" fmla="*/ 214604 h 314288"/>
                    <a:gd name="connsiteX13-1515" fmla="*/ 700673 w 732769"/>
                    <a:gd name="connsiteY13-1516" fmla="*/ 213017 h 314288"/>
                    <a:gd name="connsiteX14-1517" fmla="*/ 687973 w 732769"/>
                    <a:gd name="connsiteY14-1518" fmla="*/ 136817 h 314288"/>
                    <a:gd name="connsiteX15-1519" fmla="*/ 622885 w 732769"/>
                    <a:gd name="connsiteY15-1520" fmla="*/ 292 h 314288"/>
                    <a:gd name="connsiteX16-1521" fmla="*/ 729247 w 732769"/>
                    <a:gd name="connsiteY16-1522" fmla="*/ 176505 h 314288"/>
                    <a:gd name="connsiteX17-1523" fmla="*/ 699085 w 732769"/>
                    <a:gd name="connsiteY17-1524" fmla="*/ 243180 h 314288"/>
                    <a:gd name="connsiteX18-1525" fmla="*/ 618124 w 732769"/>
                    <a:gd name="connsiteY18-1526" fmla="*/ 259055 h 314288"/>
                    <a:gd name="connsiteX19-1527" fmla="*/ 564147 w 732769"/>
                    <a:gd name="connsiteY19-1528" fmla="*/ 195555 h 314288"/>
                    <a:gd name="connsiteX20-1529" fmla="*/ 578434 w 732769"/>
                    <a:gd name="connsiteY20-1530" fmla="*/ 205080 h 314288"/>
                    <a:gd name="connsiteX21-1531" fmla="*/ 514935 w 732769"/>
                    <a:gd name="connsiteY21-1532" fmla="*/ 240005 h 314288"/>
                    <a:gd name="connsiteX22-1533" fmla="*/ 433972 w 732769"/>
                    <a:gd name="connsiteY22-1534" fmla="*/ 244767 h 314288"/>
                    <a:gd name="connsiteX23-1535" fmla="*/ 367297 w 732769"/>
                    <a:gd name="connsiteY23-1536" fmla="*/ 301918 h 314288"/>
                    <a:gd name="connsiteX24-1537" fmla="*/ 338722 w 732769"/>
                    <a:gd name="connsiteY24-1538" fmla="*/ 306679 h 314288"/>
                    <a:gd name="connsiteX25-1539" fmla="*/ 383172 w 732769"/>
                    <a:gd name="connsiteY25-1540" fmla="*/ 214605 h 314288"/>
                    <a:gd name="connsiteX26-1541" fmla="*/ 318085 w 732769"/>
                    <a:gd name="connsiteY26-1542" fmla="*/ 241592 h 314288"/>
                    <a:gd name="connsiteX27-1543" fmla="*/ 238710 w 732769"/>
                    <a:gd name="connsiteY27-1544" fmla="*/ 236830 h 314288"/>
                    <a:gd name="connsiteX28-1545" fmla="*/ 167272 w 732769"/>
                    <a:gd name="connsiteY28-1546" fmla="*/ 287629 h 314288"/>
                    <a:gd name="connsiteX29-1547" fmla="*/ 200610 w 732769"/>
                    <a:gd name="connsiteY29-1548" fmla="*/ 219367 h 314288"/>
                    <a:gd name="connsiteX30-1549" fmla="*/ 5347 w 732769"/>
                    <a:gd name="connsiteY30-1550" fmla="*/ 247942 h 314288"/>
                    <a:gd name="connsiteX0-1551" fmla="*/ 5347 w 733990"/>
                    <a:gd name="connsiteY0-1552" fmla="*/ 247942 h 314288"/>
                    <a:gd name="connsiteX1-1553" fmla="*/ 59322 w 733990"/>
                    <a:gd name="connsiteY1-1554" fmla="*/ 127292 h 314288"/>
                    <a:gd name="connsiteX2-1555" fmla="*/ 105360 w 733990"/>
                    <a:gd name="connsiteY2-1556" fmla="*/ 79667 h 314288"/>
                    <a:gd name="connsiteX3-1557" fmla="*/ 87897 w 733990"/>
                    <a:gd name="connsiteY3-1558" fmla="*/ 55855 h 314288"/>
                    <a:gd name="connsiteX4-1559" fmla="*/ 110122 w 733990"/>
                    <a:gd name="connsiteY4-1560" fmla="*/ 11405 h 314288"/>
                    <a:gd name="connsiteX5-1561" fmla="*/ 165685 w 733990"/>
                    <a:gd name="connsiteY5-1562" fmla="*/ 9816 h 314288"/>
                    <a:gd name="connsiteX6-1563" fmla="*/ 184735 w 733990"/>
                    <a:gd name="connsiteY6-1564" fmla="*/ 54267 h 314288"/>
                    <a:gd name="connsiteX7-1565" fmla="*/ 181560 w 733990"/>
                    <a:gd name="connsiteY7-1566" fmla="*/ 78080 h 314288"/>
                    <a:gd name="connsiteX8-1567" fmla="*/ 230772 w 733990"/>
                    <a:gd name="connsiteY8-1568" fmla="*/ 27280 h 314288"/>
                    <a:gd name="connsiteX9-1569" fmla="*/ 353010 w 733990"/>
                    <a:gd name="connsiteY9-1570" fmla="*/ 9817 h 314288"/>
                    <a:gd name="connsiteX10-1571" fmla="*/ 506997 w 733990"/>
                    <a:gd name="connsiteY10-1572" fmla="*/ 70143 h 314288"/>
                    <a:gd name="connsiteX11-1573" fmla="*/ 580022 w 733990"/>
                    <a:gd name="connsiteY11-1574" fmla="*/ 147929 h 314288"/>
                    <a:gd name="connsiteX12-1575" fmla="*/ 643523 w 733990"/>
                    <a:gd name="connsiteY12-1576" fmla="*/ 214604 h 314288"/>
                    <a:gd name="connsiteX13-1577" fmla="*/ 700673 w 733990"/>
                    <a:gd name="connsiteY13-1578" fmla="*/ 213017 h 314288"/>
                    <a:gd name="connsiteX14-1579" fmla="*/ 687973 w 733990"/>
                    <a:gd name="connsiteY14-1580" fmla="*/ 136817 h 314288"/>
                    <a:gd name="connsiteX15-1581" fmla="*/ 622885 w 733990"/>
                    <a:gd name="connsiteY15-1582" fmla="*/ 292 h 314288"/>
                    <a:gd name="connsiteX16-1583" fmla="*/ 729247 w 733990"/>
                    <a:gd name="connsiteY16-1584" fmla="*/ 176505 h 314288"/>
                    <a:gd name="connsiteX17-1585" fmla="*/ 437147 w 733990"/>
                    <a:gd name="connsiteY17-1586" fmla="*/ 301917 h 314288"/>
                    <a:gd name="connsiteX18-1587" fmla="*/ 618124 w 733990"/>
                    <a:gd name="connsiteY18-1588" fmla="*/ 259055 h 314288"/>
                    <a:gd name="connsiteX19-1589" fmla="*/ 564147 w 733990"/>
                    <a:gd name="connsiteY19-1590" fmla="*/ 195555 h 314288"/>
                    <a:gd name="connsiteX20-1591" fmla="*/ 578434 w 733990"/>
                    <a:gd name="connsiteY20-1592" fmla="*/ 205080 h 314288"/>
                    <a:gd name="connsiteX21-1593" fmla="*/ 514935 w 733990"/>
                    <a:gd name="connsiteY21-1594" fmla="*/ 240005 h 314288"/>
                    <a:gd name="connsiteX22-1595" fmla="*/ 433972 w 733990"/>
                    <a:gd name="connsiteY22-1596" fmla="*/ 244767 h 314288"/>
                    <a:gd name="connsiteX23-1597" fmla="*/ 367297 w 733990"/>
                    <a:gd name="connsiteY23-1598" fmla="*/ 301918 h 314288"/>
                    <a:gd name="connsiteX24-1599" fmla="*/ 338722 w 733990"/>
                    <a:gd name="connsiteY24-1600" fmla="*/ 306679 h 314288"/>
                    <a:gd name="connsiteX25-1601" fmla="*/ 383172 w 733990"/>
                    <a:gd name="connsiteY25-1602" fmla="*/ 214605 h 314288"/>
                    <a:gd name="connsiteX26-1603" fmla="*/ 318085 w 733990"/>
                    <a:gd name="connsiteY26-1604" fmla="*/ 241592 h 314288"/>
                    <a:gd name="connsiteX27-1605" fmla="*/ 238710 w 733990"/>
                    <a:gd name="connsiteY27-1606" fmla="*/ 236830 h 314288"/>
                    <a:gd name="connsiteX28-1607" fmla="*/ 167272 w 733990"/>
                    <a:gd name="connsiteY28-1608" fmla="*/ 287629 h 314288"/>
                    <a:gd name="connsiteX29-1609" fmla="*/ 200610 w 733990"/>
                    <a:gd name="connsiteY29-1610" fmla="*/ 219367 h 314288"/>
                    <a:gd name="connsiteX30-1611" fmla="*/ 5347 w 733990"/>
                    <a:gd name="connsiteY30-1612" fmla="*/ 247942 h 314288"/>
                    <a:gd name="connsiteX0-1613" fmla="*/ 5347 w 703665"/>
                    <a:gd name="connsiteY0-1614" fmla="*/ 253264 h 366665"/>
                    <a:gd name="connsiteX1-1615" fmla="*/ 59322 w 703665"/>
                    <a:gd name="connsiteY1-1616" fmla="*/ 132614 h 366665"/>
                    <a:gd name="connsiteX2-1617" fmla="*/ 105360 w 703665"/>
                    <a:gd name="connsiteY2-1618" fmla="*/ 84989 h 366665"/>
                    <a:gd name="connsiteX3-1619" fmla="*/ 87897 w 703665"/>
                    <a:gd name="connsiteY3-1620" fmla="*/ 61177 h 366665"/>
                    <a:gd name="connsiteX4-1621" fmla="*/ 110122 w 703665"/>
                    <a:gd name="connsiteY4-1622" fmla="*/ 16727 h 366665"/>
                    <a:gd name="connsiteX5-1623" fmla="*/ 165685 w 703665"/>
                    <a:gd name="connsiteY5-1624" fmla="*/ 15138 h 366665"/>
                    <a:gd name="connsiteX6-1625" fmla="*/ 184735 w 703665"/>
                    <a:gd name="connsiteY6-1626" fmla="*/ 59589 h 366665"/>
                    <a:gd name="connsiteX7-1627" fmla="*/ 181560 w 703665"/>
                    <a:gd name="connsiteY7-1628" fmla="*/ 83402 h 366665"/>
                    <a:gd name="connsiteX8-1629" fmla="*/ 230772 w 703665"/>
                    <a:gd name="connsiteY8-1630" fmla="*/ 32602 h 366665"/>
                    <a:gd name="connsiteX9-1631" fmla="*/ 353010 w 703665"/>
                    <a:gd name="connsiteY9-1632" fmla="*/ 15139 h 366665"/>
                    <a:gd name="connsiteX10-1633" fmla="*/ 506997 w 703665"/>
                    <a:gd name="connsiteY10-1634" fmla="*/ 75465 h 366665"/>
                    <a:gd name="connsiteX11-1635" fmla="*/ 580022 w 703665"/>
                    <a:gd name="connsiteY11-1636" fmla="*/ 153251 h 366665"/>
                    <a:gd name="connsiteX12-1637" fmla="*/ 643523 w 703665"/>
                    <a:gd name="connsiteY12-1638" fmla="*/ 219926 h 366665"/>
                    <a:gd name="connsiteX13-1639" fmla="*/ 700673 w 703665"/>
                    <a:gd name="connsiteY13-1640" fmla="*/ 218339 h 366665"/>
                    <a:gd name="connsiteX14-1641" fmla="*/ 687973 w 703665"/>
                    <a:gd name="connsiteY14-1642" fmla="*/ 142139 h 366665"/>
                    <a:gd name="connsiteX15-1643" fmla="*/ 622885 w 703665"/>
                    <a:gd name="connsiteY15-1644" fmla="*/ 5614 h 366665"/>
                    <a:gd name="connsiteX16-1645" fmla="*/ 470485 w 703665"/>
                    <a:gd name="connsiteY16-1646" fmla="*/ 350102 h 366665"/>
                    <a:gd name="connsiteX17-1647" fmla="*/ 437147 w 703665"/>
                    <a:gd name="connsiteY17-1648" fmla="*/ 307239 h 366665"/>
                    <a:gd name="connsiteX18-1649" fmla="*/ 618124 w 703665"/>
                    <a:gd name="connsiteY18-1650" fmla="*/ 264377 h 366665"/>
                    <a:gd name="connsiteX19-1651" fmla="*/ 564147 w 703665"/>
                    <a:gd name="connsiteY19-1652" fmla="*/ 200877 h 366665"/>
                    <a:gd name="connsiteX20-1653" fmla="*/ 578434 w 703665"/>
                    <a:gd name="connsiteY20-1654" fmla="*/ 210402 h 366665"/>
                    <a:gd name="connsiteX21-1655" fmla="*/ 514935 w 703665"/>
                    <a:gd name="connsiteY21-1656" fmla="*/ 245327 h 366665"/>
                    <a:gd name="connsiteX22-1657" fmla="*/ 433972 w 703665"/>
                    <a:gd name="connsiteY22-1658" fmla="*/ 250089 h 366665"/>
                    <a:gd name="connsiteX23-1659" fmla="*/ 367297 w 703665"/>
                    <a:gd name="connsiteY23-1660" fmla="*/ 307240 h 366665"/>
                    <a:gd name="connsiteX24-1661" fmla="*/ 338722 w 703665"/>
                    <a:gd name="connsiteY24-1662" fmla="*/ 312001 h 366665"/>
                    <a:gd name="connsiteX25-1663" fmla="*/ 383172 w 703665"/>
                    <a:gd name="connsiteY25-1664" fmla="*/ 219927 h 366665"/>
                    <a:gd name="connsiteX26-1665" fmla="*/ 318085 w 703665"/>
                    <a:gd name="connsiteY26-1666" fmla="*/ 246914 h 366665"/>
                    <a:gd name="connsiteX27-1667" fmla="*/ 238710 w 703665"/>
                    <a:gd name="connsiteY27-1668" fmla="*/ 242152 h 366665"/>
                    <a:gd name="connsiteX28-1669" fmla="*/ 167272 w 703665"/>
                    <a:gd name="connsiteY28-1670" fmla="*/ 292951 h 366665"/>
                    <a:gd name="connsiteX29-1671" fmla="*/ 200610 w 703665"/>
                    <a:gd name="connsiteY29-1672" fmla="*/ 224689 h 366665"/>
                    <a:gd name="connsiteX30-1673" fmla="*/ 5347 w 703665"/>
                    <a:gd name="connsiteY30-1674" fmla="*/ 253264 h 366665"/>
                    <a:gd name="connsiteX0-1675" fmla="*/ 5347 w 707441"/>
                    <a:gd name="connsiteY0-1676" fmla="*/ 242933 h 340825"/>
                    <a:gd name="connsiteX1-1677" fmla="*/ 59322 w 707441"/>
                    <a:gd name="connsiteY1-1678" fmla="*/ 122283 h 340825"/>
                    <a:gd name="connsiteX2-1679" fmla="*/ 105360 w 707441"/>
                    <a:gd name="connsiteY2-1680" fmla="*/ 74658 h 340825"/>
                    <a:gd name="connsiteX3-1681" fmla="*/ 87897 w 707441"/>
                    <a:gd name="connsiteY3-1682" fmla="*/ 50846 h 340825"/>
                    <a:gd name="connsiteX4-1683" fmla="*/ 110122 w 707441"/>
                    <a:gd name="connsiteY4-1684" fmla="*/ 6396 h 340825"/>
                    <a:gd name="connsiteX5-1685" fmla="*/ 165685 w 707441"/>
                    <a:gd name="connsiteY5-1686" fmla="*/ 4807 h 340825"/>
                    <a:gd name="connsiteX6-1687" fmla="*/ 184735 w 707441"/>
                    <a:gd name="connsiteY6-1688" fmla="*/ 49258 h 340825"/>
                    <a:gd name="connsiteX7-1689" fmla="*/ 181560 w 707441"/>
                    <a:gd name="connsiteY7-1690" fmla="*/ 73071 h 340825"/>
                    <a:gd name="connsiteX8-1691" fmla="*/ 230772 w 707441"/>
                    <a:gd name="connsiteY8-1692" fmla="*/ 22271 h 340825"/>
                    <a:gd name="connsiteX9-1693" fmla="*/ 353010 w 707441"/>
                    <a:gd name="connsiteY9-1694" fmla="*/ 4808 h 340825"/>
                    <a:gd name="connsiteX10-1695" fmla="*/ 506997 w 707441"/>
                    <a:gd name="connsiteY10-1696" fmla="*/ 65134 h 340825"/>
                    <a:gd name="connsiteX11-1697" fmla="*/ 580022 w 707441"/>
                    <a:gd name="connsiteY11-1698" fmla="*/ 142920 h 340825"/>
                    <a:gd name="connsiteX12-1699" fmla="*/ 643523 w 707441"/>
                    <a:gd name="connsiteY12-1700" fmla="*/ 209595 h 340825"/>
                    <a:gd name="connsiteX13-1701" fmla="*/ 700673 w 707441"/>
                    <a:gd name="connsiteY13-1702" fmla="*/ 208008 h 340825"/>
                    <a:gd name="connsiteX14-1703" fmla="*/ 687973 w 707441"/>
                    <a:gd name="connsiteY14-1704" fmla="*/ 131808 h 340825"/>
                    <a:gd name="connsiteX15-1705" fmla="*/ 692735 w 707441"/>
                    <a:gd name="connsiteY15-1706" fmla="*/ 309608 h 340825"/>
                    <a:gd name="connsiteX16-1707" fmla="*/ 470485 w 707441"/>
                    <a:gd name="connsiteY16-1708" fmla="*/ 339771 h 340825"/>
                    <a:gd name="connsiteX17-1709" fmla="*/ 437147 w 707441"/>
                    <a:gd name="connsiteY17-1710" fmla="*/ 296908 h 340825"/>
                    <a:gd name="connsiteX18-1711" fmla="*/ 618124 w 707441"/>
                    <a:gd name="connsiteY18-1712" fmla="*/ 254046 h 340825"/>
                    <a:gd name="connsiteX19-1713" fmla="*/ 564147 w 707441"/>
                    <a:gd name="connsiteY19-1714" fmla="*/ 190546 h 340825"/>
                    <a:gd name="connsiteX20-1715" fmla="*/ 578434 w 707441"/>
                    <a:gd name="connsiteY20-1716" fmla="*/ 200071 h 340825"/>
                    <a:gd name="connsiteX21-1717" fmla="*/ 514935 w 707441"/>
                    <a:gd name="connsiteY21-1718" fmla="*/ 234996 h 340825"/>
                    <a:gd name="connsiteX22-1719" fmla="*/ 433972 w 707441"/>
                    <a:gd name="connsiteY22-1720" fmla="*/ 239758 h 340825"/>
                    <a:gd name="connsiteX23-1721" fmla="*/ 367297 w 707441"/>
                    <a:gd name="connsiteY23-1722" fmla="*/ 296909 h 340825"/>
                    <a:gd name="connsiteX24-1723" fmla="*/ 338722 w 707441"/>
                    <a:gd name="connsiteY24-1724" fmla="*/ 301670 h 340825"/>
                    <a:gd name="connsiteX25-1725" fmla="*/ 383172 w 707441"/>
                    <a:gd name="connsiteY25-1726" fmla="*/ 209596 h 340825"/>
                    <a:gd name="connsiteX26-1727" fmla="*/ 318085 w 707441"/>
                    <a:gd name="connsiteY26-1728" fmla="*/ 236583 h 340825"/>
                    <a:gd name="connsiteX27-1729" fmla="*/ 238710 w 707441"/>
                    <a:gd name="connsiteY27-1730" fmla="*/ 231821 h 340825"/>
                    <a:gd name="connsiteX28-1731" fmla="*/ 167272 w 707441"/>
                    <a:gd name="connsiteY28-1732" fmla="*/ 282620 h 340825"/>
                    <a:gd name="connsiteX29-1733" fmla="*/ 200610 w 707441"/>
                    <a:gd name="connsiteY29-1734" fmla="*/ 214358 h 340825"/>
                    <a:gd name="connsiteX30-1735" fmla="*/ 5347 w 707441"/>
                    <a:gd name="connsiteY30-1736" fmla="*/ 242933 h 340825"/>
                    <a:gd name="connsiteX0-1737" fmla="*/ 5347 w 709259"/>
                    <a:gd name="connsiteY0-1738" fmla="*/ 242933 h 340825"/>
                    <a:gd name="connsiteX1-1739" fmla="*/ 59322 w 709259"/>
                    <a:gd name="connsiteY1-1740" fmla="*/ 122283 h 340825"/>
                    <a:gd name="connsiteX2-1741" fmla="*/ 105360 w 709259"/>
                    <a:gd name="connsiteY2-1742" fmla="*/ 74658 h 340825"/>
                    <a:gd name="connsiteX3-1743" fmla="*/ 87897 w 709259"/>
                    <a:gd name="connsiteY3-1744" fmla="*/ 50846 h 340825"/>
                    <a:gd name="connsiteX4-1745" fmla="*/ 110122 w 709259"/>
                    <a:gd name="connsiteY4-1746" fmla="*/ 6396 h 340825"/>
                    <a:gd name="connsiteX5-1747" fmla="*/ 165685 w 709259"/>
                    <a:gd name="connsiteY5-1748" fmla="*/ 4807 h 340825"/>
                    <a:gd name="connsiteX6-1749" fmla="*/ 184735 w 709259"/>
                    <a:gd name="connsiteY6-1750" fmla="*/ 49258 h 340825"/>
                    <a:gd name="connsiteX7-1751" fmla="*/ 181560 w 709259"/>
                    <a:gd name="connsiteY7-1752" fmla="*/ 73071 h 340825"/>
                    <a:gd name="connsiteX8-1753" fmla="*/ 230772 w 709259"/>
                    <a:gd name="connsiteY8-1754" fmla="*/ 22271 h 340825"/>
                    <a:gd name="connsiteX9-1755" fmla="*/ 353010 w 709259"/>
                    <a:gd name="connsiteY9-1756" fmla="*/ 4808 h 340825"/>
                    <a:gd name="connsiteX10-1757" fmla="*/ 506997 w 709259"/>
                    <a:gd name="connsiteY10-1758" fmla="*/ 65134 h 340825"/>
                    <a:gd name="connsiteX11-1759" fmla="*/ 580022 w 709259"/>
                    <a:gd name="connsiteY11-1760" fmla="*/ 142920 h 340825"/>
                    <a:gd name="connsiteX12-1761" fmla="*/ 643523 w 709259"/>
                    <a:gd name="connsiteY12-1762" fmla="*/ 209595 h 340825"/>
                    <a:gd name="connsiteX13-1763" fmla="*/ 648285 w 709259"/>
                    <a:gd name="connsiteY13-1764" fmla="*/ 258808 h 340825"/>
                    <a:gd name="connsiteX14-1765" fmla="*/ 687973 w 709259"/>
                    <a:gd name="connsiteY14-1766" fmla="*/ 131808 h 340825"/>
                    <a:gd name="connsiteX15-1767" fmla="*/ 692735 w 709259"/>
                    <a:gd name="connsiteY15-1768" fmla="*/ 309608 h 340825"/>
                    <a:gd name="connsiteX16-1769" fmla="*/ 470485 w 709259"/>
                    <a:gd name="connsiteY16-1770" fmla="*/ 339771 h 340825"/>
                    <a:gd name="connsiteX17-1771" fmla="*/ 437147 w 709259"/>
                    <a:gd name="connsiteY17-1772" fmla="*/ 296908 h 340825"/>
                    <a:gd name="connsiteX18-1773" fmla="*/ 618124 w 709259"/>
                    <a:gd name="connsiteY18-1774" fmla="*/ 254046 h 340825"/>
                    <a:gd name="connsiteX19-1775" fmla="*/ 564147 w 709259"/>
                    <a:gd name="connsiteY19-1776" fmla="*/ 190546 h 340825"/>
                    <a:gd name="connsiteX20-1777" fmla="*/ 578434 w 709259"/>
                    <a:gd name="connsiteY20-1778" fmla="*/ 200071 h 340825"/>
                    <a:gd name="connsiteX21-1779" fmla="*/ 514935 w 709259"/>
                    <a:gd name="connsiteY21-1780" fmla="*/ 234996 h 340825"/>
                    <a:gd name="connsiteX22-1781" fmla="*/ 433972 w 709259"/>
                    <a:gd name="connsiteY22-1782" fmla="*/ 239758 h 340825"/>
                    <a:gd name="connsiteX23-1783" fmla="*/ 367297 w 709259"/>
                    <a:gd name="connsiteY23-1784" fmla="*/ 296909 h 340825"/>
                    <a:gd name="connsiteX24-1785" fmla="*/ 338722 w 709259"/>
                    <a:gd name="connsiteY24-1786" fmla="*/ 301670 h 340825"/>
                    <a:gd name="connsiteX25-1787" fmla="*/ 383172 w 709259"/>
                    <a:gd name="connsiteY25-1788" fmla="*/ 209596 h 340825"/>
                    <a:gd name="connsiteX26-1789" fmla="*/ 318085 w 709259"/>
                    <a:gd name="connsiteY26-1790" fmla="*/ 236583 h 340825"/>
                    <a:gd name="connsiteX27-1791" fmla="*/ 238710 w 709259"/>
                    <a:gd name="connsiteY27-1792" fmla="*/ 231821 h 340825"/>
                    <a:gd name="connsiteX28-1793" fmla="*/ 167272 w 709259"/>
                    <a:gd name="connsiteY28-1794" fmla="*/ 282620 h 340825"/>
                    <a:gd name="connsiteX29-1795" fmla="*/ 200610 w 709259"/>
                    <a:gd name="connsiteY29-1796" fmla="*/ 214358 h 340825"/>
                    <a:gd name="connsiteX30-1797" fmla="*/ 5347 w 709259"/>
                    <a:gd name="connsiteY30-1798" fmla="*/ 242933 h 340825"/>
                    <a:gd name="connsiteX0-1799" fmla="*/ 5347 w 704011"/>
                    <a:gd name="connsiteY0-1800" fmla="*/ 242933 h 339912"/>
                    <a:gd name="connsiteX1-1801" fmla="*/ 59322 w 704011"/>
                    <a:gd name="connsiteY1-1802" fmla="*/ 122283 h 339912"/>
                    <a:gd name="connsiteX2-1803" fmla="*/ 105360 w 704011"/>
                    <a:gd name="connsiteY2-1804" fmla="*/ 74658 h 339912"/>
                    <a:gd name="connsiteX3-1805" fmla="*/ 87897 w 704011"/>
                    <a:gd name="connsiteY3-1806" fmla="*/ 50846 h 339912"/>
                    <a:gd name="connsiteX4-1807" fmla="*/ 110122 w 704011"/>
                    <a:gd name="connsiteY4-1808" fmla="*/ 6396 h 339912"/>
                    <a:gd name="connsiteX5-1809" fmla="*/ 165685 w 704011"/>
                    <a:gd name="connsiteY5-1810" fmla="*/ 4807 h 339912"/>
                    <a:gd name="connsiteX6-1811" fmla="*/ 184735 w 704011"/>
                    <a:gd name="connsiteY6-1812" fmla="*/ 49258 h 339912"/>
                    <a:gd name="connsiteX7-1813" fmla="*/ 181560 w 704011"/>
                    <a:gd name="connsiteY7-1814" fmla="*/ 73071 h 339912"/>
                    <a:gd name="connsiteX8-1815" fmla="*/ 230772 w 704011"/>
                    <a:gd name="connsiteY8-1816" fmla="*/ 22271 h 339912"/>
                    <a:gd name="connsiteX9-1817" fmla="*/ 353010 w 704011"/>
                    <a:gd name="connsiteY9-1818" fmla="*/ 4808 h 339912"/>
                    <a:gd name="connsiteX10-1819" fmla="*/ 506997 w 704011"/>
                    <a:gd name="connsiteY10-1820" fmla="*/ 65134 h 339912"/>
                    <a:gd name="connsiteX11-1821" fmla="*/ 580022 w 704011"/>
                    <a:gd name="connsiteY11-1822" fmla="*/ 142920 h 339912"/>
                    <a:gd name="connsiteX12-1823" fmla="*/ 643523 w 704011"/>
                    <a:gd name="connsiteY12-1824" fmla="*/ 209595 h 339912"/>
                    <a:gd name="connsiteX13-1825" fmla="*/ 648285 w 704011"/>
                    <a:gd name="connsiteY13-1826" fmla="*/ 258808 h 339912"/>
                    <a:gd name="connsiteX14-1827" fmla="*/ 668923 w 704011"/>
                    <a:gd name="connsiteY14-1828" fmla="*/ 279445 h 339912"/>
                    <a:gd name="connsiteX15-1829" fmla="*/ 692735 w 704011"/>
                    <a:gd name="connsiteY15-1830" fmla="*/ 309608 h 339912"/>
                    <a:gd name="connsiteX16-1831" fmla="*/ 470485 w 704011"/>
                    <a:gd name="connsiteY16-1832" fmla="*/ 339771 h 339912"/>
                    <a:gd name="connsiteX17-1833" fmla="*/ 437147 w 704011"/>
                    <a:gd name="connsiteY17-1834" fmla="*/ 296908 h 339912"/>
                    <a:gd name="connsiteX18-1835" fmla="*/ 618124 w 704011"/>
                    <a:gd name="connsiteY18-1836" fmla="*/ 254046 h 339912"/>
                    <a:gd name="connsiteX19-1837" fmla="*/ 564147 w 704011"/>
                    <a:gd name="connsiteY19-1838" fmla="*/ 190546 h 339912"/>
                    <a:gd name="connsiteX20-1839" fmla="*/ 578434 w 704011"/>
                    <a:gd name="connsiteY20-1840" fmla="*/ 200071 h 339912"/>
                    <a:gd name="connsiteX21-1841" fmla="*/ 514935 w 704011"/>
                    <a:gd name="connsiteY21-1842" fmla="*/ 234996 h 339912"/>
                    <a:gd name="connsiteX22-1843" fmla="*/ 433972 w 704011"/>
                    <a:gd name="connsiteY22-1844" fmla="*/ 239758 h 339912"/>
                    <a:gd name="connsiteX23-1845" fmla="*/ 367297 w 704011"/>
                    <a:gd name="connsiteY23-1846" fmla="*/ 296909 h 339912"/>
                    <a:gd name="connsiteX24-1847" fmla="*/ 338722 w 704011"/>
                    <a:gd name="connsiteY24-1848" fmla="*/ 301670 h 339912"/>
                    <a:gd name="connsiteX25-1849" fmla="*/ 383172 w 704011"/>
                    <a:gd name="connsiteY25-1850" fmla="*/ 209596 h 339912"/>
                    <a:gd name="connsiteX26-1851" fmla="*/ 318085 w 704011"/>
                    <a:gd name="connsiteY26-1852" fmla="*/ 236583 h 339912"/>
                    <a:gd name="connsiteX27-1853" fmla="*/ 238710 w 704011"/>
                    <a:gd name="connsiteY27-1854" fmla="*/ 231821 h 339912"/>
                    <a:gd name="connsiteX28-1855" fmla="*/ 167272 w 704011"/>
                    <a:gd name="connsiteY28-1856" fmla="*/ 282620 h 339912"/>
                    <a:gd name="connsiteX29-1857" fmla="*/ 200610 w 704011"/>
                    <a:gd name="connsiteY29-1858" fmla="*/ 214358 h 339912"/>
                    <a:gd name="connsiteX30-1859" fmla="*/ 5347 w 704011"/>
                    <a:gd name="connsiteY30-1860" fmla="*/ 242933 h 339912"/>
                    <a:gd name="connsiteX0-1861" fmla="*/ 5347 w 704344"/>
                    <a:gd name="connsiteY0-1862" fmla="*/ 242933 h 310017"/>
                    <a:gd name="connsiteX1-1863" fmla="*/ 59322 w 704344"/>
                    <a:gd name="connsiteY1-1864" fmla="*/ 122283 h 310017"/>
                    <a:gd name="connsiteX2-1865" fmla="*/ 105360 w 704344"/>
                    <a:gd name="connsiteY2-1866" fmla="*/ 74658 h 310017"/>
                    <a:gd name="connsiteX3-1867" fmla="*/ 87897 w 704344"/>
                    <a:gd name="connsiteY3-1868" fmla="*/ 50846 h 310017"/>
                    <a:gd name="connsiteX4-1869" fmla="*/ 110122 w 704344"/>
                    <a:gd name="connsiteY4-1870" fmla="*/ 6396 h 310017"/>
                    <a:gd name="connsiteX5-1871" fmla="*/ 165685 w 704344"/>
                    <a:gd name="connsiteY5-1872" fmla="*/ 4807 h 310017"/>
                    <a:gd name="connsiteX6-1873" fmla="*/ 184735 w 704344"/>
                    <a:gd name="connsiteY6-1874" fmla="*/ 49258 h 310017"/>
                    <a:gd name="connsiteX7-1875" fmla="*/ 181560 w 704344"/>
                    <a:gd name="connsiteY7-1876" fmla="*/ 73071 h 310017"/>
                    <a:gd name="connsiteX8-1877" fmla="*/ 230772 w 704344"/>
                    <a:gd name="connsiteY8-1878" fmla="*/ 22271 h 310017"/>
                    <a:gd name="connsiteX9-1879" fmla="*/ 353010 w 704344"/>
                    <a:gd name="connsiteY9-1880" fmla="*/ 4808 h 310017"/>
                    <a:gd name="connsiteX10-1881" fmla="*/ 506997 w 704344"/>
                    <a:gd name="connsiteY10-1882" fmla="*/ 65134 h 310017"/>
                    <a:gd name="connsiteX11-1883" fmla="*/ 580022 w 704344"/>
                    <a:gd name="connsiteY11-1884" fmla="*/ 142920 h 310017"/>
                    <a:gd name="connsiteX12-1885" fmla="*/ 643523 w 704344"/>
                    <a:gd name="connsiteY12-1886" fmla="*/ 209595 h 310017"/>
                    <a:gd name="connsiteX13-1887" fmla="*/ 648285 w 704344"/>
                    <a:gd name="connsiteY13-1888" fmla="*/ 258808 h 310017"/>
                    <a:gd name="connsiteX14-1889" fmla="*/ 668923 w 704344"/>
                    <a:gd name="connsiteY14-1890" fmla="*/ 279445 h 310017"/>
                    <a:gd name="connsiteX15-1891" fmla="*/ 692735 w 704344"/>
                    <a:gd name="connsiteY15-1892" fmla="*/ 309608 h 310017"/>
                    <a:gd name="connsiteX16-1893" fmla="*/ 465723 w 704344"/>
                    <a:gd name="connsiteY16-1894" fmla="*/ 296908 h 310017"/>
                    <a:gd name="connsiteX17-1895" fmla="*/ 437147 w 704344"/>
                    <a:gd name="connsiteY17-1896" fmla="*/ 296908 h 310017"/>
                    <a:gd name="connsiteX18-1897" fmla="*/ 618124 w 704344"/>
                    <a:gd name="connsiteY18-1898" fmla="*/ 254046 h 310017"/>
                    <a:gd name="connsiteX19-1899" fmla="*/ 564147 w 704344"/>
                    <a:gd name="connsiteY19-1900" fmla="*/ 190546 h 310017"/>
                    <a:gd name="connsiteX20-1901" fmla="*/ 578434 w 704344"/>
                    <a:gd name="connsiteY20-1902" fmla="*/ 200071 h 310017"/>
                    <a:gd name="connsiteX21-1903" fmla="*/ 514935 w 704344"/>
                    <a:gd name="connsiteY21-1904" fmla="*/ 234996 h 310017"/>
                    <a:gd name="connsiteX22-1905" fmla="*/ 433972 w 704344"/>
                    <a:gd name="connsiteY22-1906" fmla="*/ 239758 h 310017"/>
                    <a:gd name="connsiteX23-1907" fmla="*/ 367297 w 704344"/>
                    <a:gd name="connsiteY23-1908" fmla="*/ 296909 h 310017"/>
                    <a:gd name="connsiteX24-1909" fmla="*/ 338722 w 704344"/>
                    <a:gd name="connsiteY24-1910" fmla="*/ 301670 h 310017"/>
                    <a:gd name="connsiteX25-1911" fmla="*/ 383172 w 704344"/>
                    <a:gd name="connsiteY25-1912" fmla="*/ 209596 h 310017"/>
                    <a:gd name="connsiteX26-1913" fmla="*/ 318085 w 704344"/>
                    <a:gd name="connsiteY26-1914" fmla="*/ 236583 h 310017"/>
                    <a:gd name="connsiteX27-1915" fmla="*/ 238710 w 704344"/>
                    <a:gd name="connsiteY27-1916" fmla="*/ 231821 h 310017"/>
                    <a:gd name="connsiteX28-1917" fmla="*/ 167272 w 704344"/>
                    <a:gd name="connsiteY28-1918" fmla="*/ 282620 h 310017"/>
                    <a:gd name="connsiteX29-1919" fmla="*/ 200610 w 704344"/>
                    <a:gd name="connsiteY29-1920" fmla="*/ 214358 h 310017"/>
                    <a:gd name="connsiteX30-1921" fmla="*/ 5347 w 704344"/>
                    <a:gd name="connsiteY30-1922" fmla="*/ 242933 h 310017"/>
                    <a:gd name="connsiteX0-1923" fmla="*/ 5347 w 704344"/>
                    <a:gd name="connsiteY0-1924" fmla="*/ 242933 h 310069"/>
                    <a:gd name="connsiteX1-1925" fmla="*/ 59322 w 704344"/>
                    <a:gd name="connsiteY1-1926" fmla="*/ 122283 h 310069"/>
                    <a:gd name="connsiteX2-1927" fmla="*/ 105360 w 704344"/>
                    <a:gd name="connsiteY2-1928" fmla="*/ 74658 h 310069"/>
                    <a:gd name="connsiteX3-1929" fmla="*/ 87897 w 704344"/>
                    <a:gd name="connsiteY3-1930" fmla="*/ 50846 h 310069"/>
                    <a:gd name="connsiteX4-1931" fmla="*/ 110122 w 704344"/>
                    <a:gd name="connsiteY4-1932" fmla="*/ 6396 h 310069"/>
                    <a:gd name="connsiteX5-1933" fmla="*/ 165685 w 704344"/>
                    <a:gd name="connsiteY5-1934" fmla="*/ 4807 h 310069"/>
                    <a:gd name="connsiteX6-1935" fmla="*/ 184735 w 704344"/>
                    <a:gd name="connsiteY6-1936" fmla="*/ 49258 h 310069"/>
                    <a:gd name="connsiteX7-1937" fmla="*/ 181560 w 704344"/>
                    <a:gd name="connsiteY7-1938" fmla="*/ 73071 h 310069"/>
                    <a:gd name="connsiteX8-1939" fmla="*/ 230772 w 704344"/>
                    <a:gd name="connsiteY8-1940" fmla="*/ 22271 h 310069"/>
                    <a:gd name="connsiteX9-1941" fmla="*/ 353010 w 704344"/>
                    <a:gd name="connsiteY9-1942" fmla="*/ 4808 h 310069"/>
                    <a:gd name="connsiteX10-1943" fmla="*/ 506997 w 704344"/>
                    <a:gd name="connsiteY10-1944" fmla="*/ 65134 h 310069"/>
                    <a:gd name="connsiteX11-1945" fmla="*/ 580022 w 704344"/>
                    <a:gd name="connsiteY11-1946" fmla="*/ 142920 h 310069"/>
                    <a:gd name="connsiteX12-1947" fmla="*/ 643523 w 704344"/>
                    <a:gd name="connsiteY12-1948" fmla="*/ 209595 h 310069"/>
                    <a:gd name="connsiteX13-1949" fmla="*/ 648285 w 704344"/>
                    <a:gd name="connsiteY13-1950" fmla="*/ 258808 h 310069"/>
                    <a:gd name="connsiteX14-1951" fmla="*/ 668923 w 704344"/>
                    <a:gd name="connsiteY14-1952" fmla="*/ 279445 h 310069"/>
                    <a:gd name="connsiteX15-1953" fmla="*/ 692735 w 704344"/>
                    <a:gd name="connsiteY15-1954" fmla="*/ 309608 h 310069"/>
                    <a:gd name="connsiteX16-1955" fmla="*/ 465723 w 704344"/>
                    <a:gd name="connsiteY16-1956" fmla="*/ 296908 h 310069"/>
                    <a:gd name="connsiteX17-1957" fmla="*/ 427622 w 704344"/>
                    <a:gd name="connsiteY17-1958" fmla="*/ 285796 h 310069"/>
                    <a:gd name="connsiteX18-1959" fmla="*/ 618124 w 704344"/>
                    <a:gd name="connsiteY18-1960" fmla="*/ 254046 h 310069"/>
                    <a:gd name="connsiteX19-1961" fmla="*/ 564147 w 704344"/>
                    <a:gd name="connsiteY19-1962" fmla="*/ 190546 h 310069"/>
                    <a:gd name="connsiteX20-1963" fmla="*/ 578434 w 704344"/>
                    <a:gd name="connsiteY20-1964" fmla="*/ 200071 h 310069"/>
                    <a:gd name="connsiteX21-1965" fmla="*/ 514935 w 704344"/>
                    <a:gd name="connsiteY21-1966" fmla="*/ 234996 h 310069"/>
                    <a:gd name="connsiteX22-1967" fmla="*/ 433972 w 704344"/>
                    <a:gd name="connsiteY22-1968" fmla="*/ 239758 h 310069"/>
                    <a:gd name="connsiteX23-1969" fmla="*/ 367297 w 704344"/>
                    <a:gd name="connsiteY23-1970" fmla="*/ 296909 h 310069"/>
                    <a:gd name="connsiteX24-1971" fmla="*/ 338722 w 704344"/>
                    <a:gd name="connsiteY24-1972" fmla="*/ 301670 h 310069"/>
                    <a:gd name="connsiteX25-1973" fmla="*/ 383172 w 704344"/>
                    <a:gd name="connsiteY25-1974" fmla="*/ 209596 h 310069"/>
                    <a:gd name="connsiteX26-1975" fmla="*/ 318085 w 704344"/>
                    <a:gd name="connsiteY26-1976" fmla="*/ 236583 h 310069"/>
                    <a:gd name="connsiteX27-1977" fmla="*/ 238710 w 704344"/>
                    <a:gd name="connsiteY27-1978" fmla="*/ 231821 h 310069"/>
                    <a:gd name="connsiteX28-1979" fmla="*/ 167272 w 704344"/>
                    <a:gd name="connsiteY28-1980" fmla="*/ 282620 h 310069"/>
                    <a:gd name="connsiteX29-1981" fmla="*/ 200610 w 704344"/>
                    <a:gd name="connsiteY29-1982" fmla="*/ 214358 h 310069"/>
                    <a:gd name="connsiteX30-1983" fmla="*/ 5347 w 704344"/>
                    <a:gd name="connsiteY30-1984" fmla="*/ 242933 h 310069"/>
                    <a:gd name="connsiteX0-1985" fmla="*/ 5347 w 670502"/>
                    <a:gd name="connsiteY0-1986" fmla="*/ 242933 h 309279"/>
                    <a:gd name="connsiteX1-1987" fmla="*/ 59322 w 670502"/>
                    <a:gd name="connsiteY1-1988" fmla="*/ 122283 h 309279"/>
                    <a:gd name="connsiteX2-1989" fmla="*/ 105360 w 670502"/>
                    <a:gd name="connsiteY2-1990" fmla="*/ 74658 h 309279"/>
                    <a:gd name="connsiteX3-1991" fmla="*/ 87897 w 670502"/>
                    <a:gd name="connsiteY3-1992" fmla="*/ 50846 h 309279"/>
                    <a:gd name="connsiteX4-1993" fmla="*/ 110122 w 670502"/>
                    <a:gd name="connsiteY4-1994" fmla="*/ 6396 h 309279"/>
                    <a:gd name="connsiteX5-1995" fmla="*/ 165685 w 670502"/>
                    <a:gd name="connsiteY5-1996" fmla="*/ 4807 h 309279"/>
                    <a:gd name="connsiteX6-1997" fmla="*/ 184735 w 670502"/>
                    <a:gd name="connsiteY6-1998" fmla="*/ 49258 h 309279"/>
                    <a:gd name="connsiteX7-1999" fmla="*/ 181560 w 670502"/>
                    <a:gd name="connsiteY7-2000" fmla="*/ 73071 h 309279"/>
                    <a:gd name="connsiteX8-2001" fmla="*/ 230772 w 670502"/>
                    <a:gd name="connsiteY8-2002" fmla="*/ 22271 h 309279"/>
                    <a:gd name="connsiteX9-2003" fmla="*/ 353010 w 670502"/>
                    <a:gd name="connsiteY9-2004" fmla="*/ 4808 h 309279"/>
                    <a:gd name="connsiteX10-2005" fmla="*/ 506997 w 670502"/>
                    <a:gd name="connsiteY10-2006" fmla="*/ 65134 h 309279"/>
                    <a:gd name="connsiteX11-2007" fmla="*/ 580022 w 670502"/>
                    <a:gd name="connsiteY11-2008" fmla="*/ 142920 h 309279"/>
                    <a:gd name="connsiteX12-2009" fmla="*/ 643523 w 670502"/>
                    <a:gd name="connsiteY12-2010" fmla="*/ 209595 h 309279"/>
                    <a:gd name="connsiteX13-2011" fmla="*/ 648285 w 670502"/>
                    <a:gd name="connsiteY13-2012" fmla="*/ 258808 h 309279"/>
                    <a:gd name="connsiteX14-2013" fmla="*/ 668923 w 670502"/>
                    <a:gd name="connsiteY14-2014" fmla="*/ 279445 h 309279"/>
                    <a:gd name="connsiteX15-2015" fmla="*/ 600660 w 670502"/>
                    <a:gd name="connsiteY15-2016" fmla="*/ 293733 h 309279"/>
                    <a:gd name="connsiteX16-2017" fmla="*/ 465723 w 670502"/>
                    <a:gd name="connsiteY16-2018" fmla="*/ 296908 h 309279"/>
                    <a:gd name="connsiteX17-2019" fmla="*/ 427622 w 670502"/>
                    <a:gd name="connsiteY17-2020" fmla="*/ 285796 h 309279"/>
                    <a:gd name="connsiteX18-2021" fmla="*/ 618124 w 670502"/>
                    <a:gd name="connsiteY18-2022" fmla="*/ 254046 h 309279"/>
                    <a:gd name="connsiteX19-2023" fmla="*/ 564147 w 670502"/>
                    <a:gd name="connsiteY19-2024" fmla="*/ 190546 h 309279"/>
                    <a:gd name="connsiteX20-2025" fmla="*/ 578434 w 670502"/>
                    <a:gd name="connsiteY20-2026" fmla="*/ 200071 h 309279"/>
                    <a:gd name="connsiteX21-2027" fmla="*/ 514935 w 670502"/>
                    <a:gd name="connsiteY21-2028" fmla="*/ 234996 h 309279"/>
                    <a:gd name="connsiteX22-2029" fmla="*/ 433972 w 670502"/>
                    <a:gd name="connsiteY22-2030" fmla="*/ 239758 h 309279"/>
                    <a:gd name="connsiteX23-2031" fmla="*/ 367297 w 670502"/>
                    <a:gd name="connsiteY23-2032" fmla="*/ 296909 h 309279"/>
                    <a:gd name="connsiteX24-2033" fmla="*/ 338722 w 670502"/>
                    <a:gd name="connsiteY24-2034" fmla="*/ 301670 h 309279"/>
                    <a:gd name="connsiteX25-2035" fmla="*/ 383172 w 670502"/>
                    <a:gd name="connsiteY25-2036" fmla="*/ 209596 h 309279"/>
                    <a:gd name="connsiteX26-2037" fmla="*/ 318085 w 670502"/>
                    <a:gd name="connsiteY26-2038" fmla="*/ 236583 h 309279"/>
                    <a:gd name="connsiteX27-2039" fmla="*/ 238710 w 670502"/>
                    <a:gd name="connsiteY27-2040" fmla="*/ 231821 h 309279"/>
                    <a:gd name="connsiteX28-2041" fmla="*/ 167272 w 670502"/>
                    <a:gd name="connsiteY28-2042" fmla="*/ 282620 h 309279"/>
                    <a:gd name="connsiteX29-2043" fmla="*/ 200610 w 670502"/>
                    <a:gd name="connsiteY29-2044" fmla="*/ 214358 h 309279"/>
                    <a:gd name="connsiteX30-2045" fmla="*/ 5347 w 670502"/>
                    <a:gd name="connsiteY30-2046" fmla="*/ 242933 h 309279"/>
                    <a:gd name="connsiteX0-2047" fmla="*/ 5347 w 650964"/>
                    <a:gd name="connsiteY0-2048" fmla="*/ 242933 h 309279"/>
                    <a:gd name="connsiteX1-2049" fmla="*/ 59322 w 650964"/>
                    <a:gd name="connsiteY1-2050" fmla="*/ 122283 h 309279"/>
                    <a:gd name="connsiteX2-2051" fmla="*/ 105360 w 650964"/>
                    <a:gd name="connsiteY2-2052" fmla="*/ 74658 h 309279"/>
                    <a:gd name="connsiteX3-2053" fmla="*/ 87897 w 650964"/>
                    <a:gd name="connsiteY3-2054" fmla="*/ 50846 h 309279"/>
                    <a:gd name="connsiteX4-2055" fmla="*/ 110122 w 650964"/>
                    <a:gd name="connsiteY4-2056" fmla="*/ 6396 h 309279"/>
                    <a:gd name="connsiteX5-2057" fmla="*/ 165685 w 650964"/>
                    <a:gd name="connsiteY5-2058" fmla="*/ 4807 h 309279"/>
                    <a:gd name="connsiteX6-2059" fmla="*/ 184735 w 650964"/>
                    <a:gd name="connsiteY6-2060" fmla="*/ 49258 h 309279"/>
                    <a:gd name="connsiteX7-2061" fmla="*/ 181560 w 650964"/>
                    <a:gd name="connsiteY7-2062" fmla="*/ 73071 h 309279"/>
                    <a:gd name="connsiteX8-2063" fmla="*/ 230772 w 650964"/>
                    <a:gd name="connsiteY8-2064" fmla="*/ 22271 h 309279"/>
                    <a:gd name="connsiteX9-2065" fmla="*/ 353010 w 650964"/>
                    <a:gd name="connsiteY9-2066" fmla="*/ 4808 h 309279"/>
                    <a:gd name="connsiteX10-2067" fmla="*/ 506997 w 650964"/>
                    <a:gd name="connsiteY10-2068" fmla="*/ 65134 h 309279"/>
                    <a:gd name="connsiteX11-2069" fmla="*/ 580022 w 650964"/>
                    <a:gd name="connsiteY11-2070" fmla="*/ 142920 h 309279"/>
                    <a:gd name="connsiteX12-2071" fmla="*/ 643523 w 650964"/>
                    <a:gd name="connsiteY12-2072" fmla="*/ 209595 h 309279"/>
                    <a:gd name="connsiteX13-2073" fmla="*/ 648285 w 650964"/>
                    <a:gd name="connsiteY13-2074" fmla="*/ 258808 h 309279"/>
                    <a:gd name="connsiteX14-2075" fmla="*/ 630823 w 650964"/>
                    <a:gd name="connsiteY14-2076" fmla="*/ 274683 h 309279"/>
                    <a:gd name="connsiteX15-2077" fmla="*/ 600660 w 650964"/>
                    <a:gd name="connsiteY15-2078" fmla="*/ 293733 h 309279"/>
                    <a:gd name="connsiteX16-2079" fmla="*/ 465723 w 650964"/>
                    <a:gd name="connsiteY16-2080" fmla="*/ 296908 h 309279"/>
                    <a:gd name="connsiteX17-2081" fmla="*/ 427622 w 650964"/>
                    <a:gd name="connsiteY17-2082" fmla="*/ 285796 h 309279"/>
                    <a:gd name="connsiteX18-2083" fmla="*/ 618124 w 650964"/>
                    <a:gd name="connsiteY18-2084" fmla="*/ 254046 h 309279"/>
                    <a:gd name="connsiteX19-2085" fmla="*/ 564147 w 650964"/>
                    <a:gd name="connsiteY19-2086" fmla="*/ 190546 h 309279"/>
                    <a:gd name="connsiteX20-2087" fmla="*/ 578434 w 650964"/>
                    <a:gd name="connsiteY20-2088" fmla="*/ 200071 h 309279"/>
                    <a:gd name="connsiteX21-2089" fmla="*/ 514935 w 650964"/>
                    <a:gd name="connsiteY21-2090" fmla="*/ 234996 h 309279"/>
                    <a:gd name="connsiteX22-2091" fmla="*/ 433972 w 650964"/>
                    <a:gd name="connsiteY22-2092" fmla="*/ 239758 h 309279"/>
                    <a:gd name="connsiteX23-2093" fmla="*/ 367297 w 650964"/>
                    <a:gd name="connsiteY23-2094" fmla="*/ 296909 h 309279"/>
                    <a:gd name="connsiteX24-2095" fmla="*/ 338722 w 650964"/>
                    <a:gd name="connsiteY24-2096" fmla="*/ 301670 h 309279"/>
                    <a:gd name="connsiteX25-2097" fmla="*/ 383172 w 650964"/>
                    <a:gd name="connsiteY25-2098" fmla="*/ 209596 h 309279"/>
                    <a:gd name="connsiteX26-2099" fmla="*/ 318085 w 650964"/>
                    <a:gd name="connsiteY26-2100" fmla="*/ 236583 h 309279"/>
                    <a:gd name="connsiteX27-2101" fmla="*/ 238710 w 650964"/>
                    <a:gd name="connsiteY27-2102" fmla="*/ 231821 h 309279"/>
                    <a:gd name="connsiteX28-2103" fmla="*/ 167272 w 650964"/>
                    <a:gd name="connsiteY28-2104" fmla="*/ 282620 h 309279"/>
                    <a:gd name="connsiteX29-2105" fmla="*/ 200610 w 650964"/>
                    <a:gd name="connsiteY29-2106" fmla="*/ 214358 h 309279"/>
                    <a:gd name="connsiteX30-2107" fmla="*/ 5347 w 650964"/>
                    <a:gd name="connsiteY30-2108" fmla="*/ 242933 h 309279"/>
                    <a:gd name="connsiteX0-2109" fmla="*/ 5347 w 650964"/>
                    <a:gd name="connsiteY0-2110" fmla="*/ 242933 h 309279"/>
                    <a:gd name="connsiteX1-2111" fmla="*/ 59322 w 650964"/>
                    <a:gd name="connsiteY1-2112" fmla="*/ 122283 h 309279"/>
                    <a:gd name="connsiteX2-2113" fmla="*/ 105360 w 650964"/>
                    <a:gd name="connsiteY2-2114" fmla="*/ 74658 h 309279"/>
                    <a:gd name="connsiteX3-2115" fmla="*/ 87897 w 650964"/>
                    <a:gd name="connsiteY3-2116" fmla="*/ 50846 h 309279"/>
                    <a:gd name="connsiteX4-2117" fmla="*/ 110122 w 650964"/>
                    <a:gd name="connsiteY4-2118" fmla="*/ 6396 h 309279"/>
                    <a:gd name="connsiteX5-2119" fmla="*/ 165685 w 650964"/>
                    <a:gd name="connsiteY5-2120" fmla="*/ 4807 h 309279"/>
                    <a:gd name="connsiteX6-2121" fmla="*/ 184735 w 650964"/>
                    <a:gd name="connsiteY6-2122" fmla="*/ 49258 h 309279"/>
                    <a:gd name="connsiteX7-2123" fmla="*/ 181560 w 650964"/>
                    <a:gd name="connsiteY7-2124" fmla="*/ 73071 h 309279"/>
                    <a:gd name="connsiteX8-2125" fmla="*/ 230772 w 650964"/>
                    <a:gd name="connsiteY8-2126" fmla="*/ 22271 h 309279"/>
                    <a:gd name="connsiteX9-2127" fmla="*/ 353010 w 650964"/>
                    <a:gd name="connsiteY9-2128" fmla="*/ 4808 h 309279"/>
                    <a:gd name="connsiteX10-2129" fmla="*/ 506997 w 650964"/>
                    <a:gd name="connsiteY10-2130" fmla="*/ 65134 h 309279"/>
                    <a:gd name="connsiteX11-2131" fmla="*/ 580022 w 650964"/>
                    <a:gd name="connsiteY11-2132" fmla="*/ 142920 h 309279"/>
                    <a:gd name="connsiteX12-2133" fmla="*/ 643523 w 650964"/>
                    <a:gd name="connsiteY12-2134" fmla="*/ 209595 h 309279"/>
                    <a:gd name="connsiteX13-2135" fmla="*/ 648285 w 650964"/>
                    <a:gd name="connsiteY13-2136" fmla="*/ 258808 h 309279"/>
                    <a:gd name="connsiteX14-2137" fmla="*/ 630823 w 650964"/>
                    <a:gd name="connsiteY14-2138" fmla="*/ 274683 h 309279"/>
                    <a:gd name="connsiteX15-2139" fmla="*/ 584785 w 650964"/>
                    <a:gd name="connsiteY15-2140" fmla="*/ 285796 h 309279"/>
                    <a:gd name="connsiteX16-2141" fmla="*/ 465723 w 650964"/>
                    <a:gd name="connsiteY16-2142" fmla="*/ 296908 h 309279"/>
                    <a:gd name="connsiteX17-2143" fmla="*/ 427622 w 650964"/>
                    <a:gd name="connsiteY17-2144" fmla="*/ 285796 h 309279"/>
                    <a:gd name="connsiteX18-2145" fmla="*/ 618124 w 650964"/>
                    <a:gd name="connsiteY18-2146" fmla="*/ 254046 h 309279"/>
                    <a:gd name="connsiteX19-2147" fmla="*/ 564147 w 650964"/>
                    <a:gd name="connsiteY19-2148" fmla="*/ 190546 h 309279"/>
                    <a:gd name="connsiteX20-2149" fmla="*/ 578434 w 650964"/>
                    <a:gd name="connsiteY20-2150" fmla="*/ 200071 h 309279"/>
                    <a:gd name="connsiteX21-2151" fmla="*/ 514935 w 650964"/>
                    <a:gd name="connsiteY21-2152" fmla="*/ 234996 h 309279"/>
                    <a:gd name="connsiteX22-2153" fmla="*/ 433972 w 650964"/>
                    <a:gd name="connsiteY22-2154" fmla="*/ 239758 h 309279"/>
                    <a:gd name="connsiteX23-2155" fmla="*/ 367297 w 650964"/>
                    <a:gd name="connsiteY23-2156" fmla="*/ 296909 h 309279"/>
                    <a:gd name="connsiteX24-2157" fmla="*/ 338722 w 650964"/>
                    <a:gd name="connsiteY24-2158" fmla="*/ 301670 h 309279"/>
                    <a:gd name="connsiteX25-2159" fmla="*/ 383172 w 650964"/>
                    <a:gd name="connsiteY25-2160" fmla="*/ 209596 h 309279"/>
                    <a:gd name="connsiteX26-2161" fmla="*/ 318085 w 650964"/>
                    <a:gd name="connsiteY26-2162" fmla="*/ 236583 h 309279"/>
                    <a:gd name="connsiteX27-2163" fmla="*/ 238710 w 650964"/>
                    <a:gd name="connsiteY27-2164" fmla="*/ 231821 h 309279"/>
                    <a:gd name="connsiteX28-2165" fmla="*/ 167272 w 650964"/>
                    <a:gd name="connsiteY28-2166" fmla="*/ 282620 h 309279"/>
                    <a:gd name="connsiteX29-2167" fmla="*/ 200610 w 650964"/>
                    <a:gd name="connsiteY29-2168" fmla="*/ 214358 h 309279"/>
                    <a:gd name="connsiteX30-2169" fmla="*/ 5347 w 650964"/>
                    <a:gd name="connsiteY30-2170" fmla="*/ 242933 h 309279"/>
                    <a:gd name="connsiteX0-2171" fmla="*/ 5347 w 646846"/>
                    <a:gd name="connsiteY0-2172" fmla="*/ 242933 h 309279"/>
                    <a:gd name="connsiteX1-2173" fmla="*/ 59322 w 646846"/>
                    <a:gd name="connsiteY1-2174" fmla="*/ 122283 h 309279"/>
                    <a:gd name="connsiteX2-2175" fmla="*/ 105360 w 646846"/>
                    <a:gd name="connsiteY2-2176" fmla="*/ 74658 h 309279"/>
                    <a:gd name="connsiteX3-2177" fmla="*/ 87897 w 646846"/>
                    <a:gd name="connsiteY3-2178" fmla="*/ 50846 h 309279"/>
                    <a:gd name="connsiteX4-2179" fmla="*/ 110122 w 646846"/>
                    <a:gd name="connsiteY4-2180" fmla="*/ 6396 h 309279"/>
                    <a:gd name="connsiteX5-2181" fmla="*/ 165685 w 646846"/>
                    <a:gd name="connsiteY5-2182" fmla="*/ 4807 h 309279"/>
                    <a:gd name="connsiteX6-2183" fmla="*/ 184735 w 646846"/>
                    <a:gd name="connsiteY6-2184" fmla="*/ 49258 h 309279"/>
                    <a:gd name="connsiteX7-2185" fmla="*/ 181560 w 646846"/>
                    <a:gd name="connsiteY7-2186" fmla="*/ 73071 h 309279"/>
                    <a:gd name="connsiteX8-2187" fmla="*/ 230772 w 646846"/>
                    <a:gd name="connsiteY8-2188" fmla="*/ 22271 h 309279"/>
                    <a:gd name="connsiteX9-2189" fmla="*/ 353010 w 646846"/>
                    <a:gd name="connsiteY9-2190" fmla="*/ 4808 h 309279"/>
                    <a:gd name="connsiteX10-2191" fmla="*/ 506997 w 646846"/>
                    <a:gd name="connsiteY10-2192" fmla="*/ 65134 h 309279"/>
                    <a:gd name="connsiteX11-2193" fmla="*/ 580022 w 646846"/>
                    <a:gd name="connsiteY11-2194" fmla="*/ 142920 h 309279"/>
                    <a:gd name="connsiteX12-2195" fmla="*/ 643523 w 646846"/>
                    <a:gd name="connsiteY12-2196" fmla="*/ 209595 h 309279"/>
                    <a:gd name="connsiteX13-2197" fmla="*/ 637172 w 646846"/>
                    <a:gd name="connsiteY13-2198" fmla="*/ 258808 h 309279"/>
                    <a:gd name="connsiteX14-2199" fmla="*/ 630823 w 646846"/>
                    <a:gd name="connsiteY14-2200" fmla="*/ 274683 h 309279"/>
                    <a:gd name="connsiteX15-2201" fmla="*/ 584785 w 646846"/>
                    <a:gd name="connsiteY15-2202" fmla="*/ 285796 h 309279"/>
                    <a:gd name="connsiteX16-2203" fmla="*/ 465723 w 646846"/>
                    <a:gd name="connsiteY16-2204" fmla="*/ 296908 h 309279"/>
                    <a:gd name="connsiteX17-2205" fmla="*/ 427622 w 646846"/>
                    <a:gd name="connsiteY17-2206" fmla="*/ 285796 h 309279"/>
                    <a:gd name="connsiteX18-2207" fmla="*/ 618124 w 646846"/>
                    <a:gd name="connsiteY18-2208" fmla="*/ 254046 h 309279"/>
                    <a:gd name="connsiteX19-2209" fmla="*/ 564147 w 646846"/>
                    <a:gd name="connsiteY19-2210" fmla="*/ 190546 h 309279"/>
                    <a:gd name="connsiteX20-2211" fmla="*/ 578434 w 646846"/>
                    <a:gd name="connsiteY20-2212" fmla="*/ 200071 h 309279"/>
                    <a:gd name="connsiteX21-2213" fmla="*/ 514935 w 646846"/>
                    <a:gd name="connsiteY21-2214" fmla="*/ 234996 h 309279"/>
                    <a:gd name="connsiteX22-2215" fmla="*/ 433972 w 646846"/>
                    <a:gd name="connsiteY22-2216" fmla="*/ 239758 h 309279"/>
                    <a:gd name="connsiteX23-2217" fmla="*/ 367297 w 646846"/>
                    <a:gd name="connsiteY23-2218" fmla="*/ 296909 h 309279"/>
                    <a:gd name="connsiteX24-2219" fmla="*/ 338722 w 646846"/>
                    <a:gd name="connsiteY24-2220" fmla="*/ 301670 h 309279"/>
                    <a:gd name="connsiteX25-2221" fmla="*/ 383172 w 646846"/>
                    <a:gd name="connsiteY25-2222" fmla="*/ 209596 h 309279"/>
                    <a:gd name="connsiteX26-2223" fmla="*/ 318085 w 646846"/>
                    <a:gd name="connsiteY26-2224" fmla="*/ 236583 h 309279"/>
                    <a:gd name="connsiteX27-2225" fmla="*/ 238710 w 646846"/>
                    <a:gd name="connsiteY27-2226" fmla="*/ 231821 h 309279"/>
                    <a:gd name="connsiteX28-2227" fmla="*/ 167272 w 646846"/>
                    <a:gd name="connsiteY28-2228" fmla="*/ 282620 h 309279"/>
                    <a:gd name="connsiteX29-2229" fmla="*/ 200610 w 646846"/>
                    <a:gd name="connsiteY29-2230" fmla="*/ 214358 h 309279"/>
                    <a:gd name="connsiteX30-2231" fmla="*/ 5347 w 646846"/>
                    <a:gd name="connsiteY30-2232" fmla="*/ 242933 h 309279"/>
                    <a:gd name="connsiteX0-2233" fmla="*/ 5347 w 639415"/>
                    <a:gd name="connsiteY0-2234" fmla="*/ 242933 h 309279"/>
                    <a:gd name="connsiteX1-2235" fmla="*/ 59322 w 639415"/>
                    <a:gd name="connsiteY1-2236" fmla="*/ 122283 h 309279"/>
                    <a:gd name="connsiteX2-2237" fmla="*/ 105360 w 639415"/>
                    <a:gd name="connsiteY2-2238" fmla="*/ 74658 h 309279"/>
                    <a:gd name="connsiteX3-2239" fmla="*/ 87897 w 639415"/>
                    <a:gd name="connsiteY3-2240" fmla="*/ 50846 h 309279"/>
                    <a:gd name="connsiteX4-2241" fmla="*/ 110122 w 639415"/>
                    <a:gd name="connsiteY4-2242" fmla="*/ 6396 h 309279"/>
                    <a:gd name="connsiteX5-2243" fmla="*/ 165685 w 639415"/>
                    <a:gd name="connsiteY5-2244" fmla="*/ 4807 h 309279"/>
                    <a:gd name="connsiteX6-2245" fmla="*/ 184735 w 639415"/>
                    <a:gd name="connsiteY6-2246" fmla="*/ 49258 h 309279"/>
                    <a:gd name="connsiteX7-2247" fmla="*/ 181560 w 639415"/>
                    <a:gd name="connsiteY7-2248" fmla="*/ 73071 h 309279"/>
                    <a:gd name="connsiteX8-2249" fmla="*/ 230772 w 639415"/>
                    <a:gd name="connsiteY8-2250" fmla="*/ 22271 h 309279"/>
                    <a:gd name="connsiteX9-2251" fmla="*/ 353010 w 639415"/>
                    <a:gd name="connsiteY9-2252" fmla="*/ 4808 h 309279"/>
                    <a:gd name="connsiteX10-2253" fmla="*/ 506997 w 639415"/>
                    <a:gd name="connsiteY10-2254" fmla="*/ 65134 h 309279"/>
                    <a:gd name="connsiteX11-2255" fmla="*/ 580022 w 639415"/>
                    <a:gd name="connsiteY11-2256" fmla="*/ 142920 h 309279"/>
                    <a:gd name="connsiteX12-2257" fmla="*/ 633998 w 639415"/>
                    <a:gd name="connsiteY12-2258" fmla="*/ 209595 h 309279"/>
                    <a:gd name="connsiteX13-2259" fmla="*/ 637172 w 639415"/>
                    <a:gd name="connsiteY13-2260" fmla="*/ 258808 h 309279"/>
                    <a:gd name="connsiteX14-2261" fmla="*/ 630823 w 639415"/>
                    <a:gd name="connsiteY14-2262" fmla="*/ 274683 h 309279"/>
                    <a:gd name="connsiteX15-2263" fmla="*/ 584785 w 639415"/>
                    <a:gd name="connsiteY15-2264" fmla="*/ 285796 h 309279"/>
                    <a:gd name="connsiteX16-2265" fmla="*/ 465723 w 639415"/>
                    <a:gd name="connsiteY16-2266" fmla="*/ 296908 h 309279"/>
                    <a:gd name="connsiteX17-2267" fmla="*/ 427622 w 639415"/>
                    <a:gd name="connsiteY17-2268" fmla="*/ 285796 h 309279"/>
                    <a:gd name="connsiteX18-2269" fmla="*/ 618124 w 639415"/>
                    <a:gd name="connsiteY18-2270" fmla="*/ 254046 h 309279"/>
                    <a:gd name="connsiteX19-2271" fmla="*/ 564147 w 639415"/>
                    <a:gd name="connsiteY19-2272" fmla="*/ 190546 h 309279"/>
                    <a:gd name="connsiteX20-2273" fmla="*/ 578434 w 639415"/>
                    <a:gd name="connsiteY20-2274" fmla="*/ 200071 h 309279"/>
                    <a:gd name="connsiteX21-2275" fmla="*/ 514935 w 639415"/>
                    <a:gd name="connsiteY21-2276" fmla="*/ 234996 h 309279"/>
                    <a:gd name="connsiteX22-2277" fmla="*/ 433972 w 639415"/>
                    <a:gd name="connsiteY22-2278" fmla="*/ 239758 h 309279"/>
                    <a:gd name="connsiteX23-2279" fmla="*/ 367297 w 639415"/>
                    <a:gd name="connsiteY23-2280" fmla="*/ 296909 h 309279"/>
                    <a:gd name="connsiteX24-2281" fmla="*/ 338722 w 639415"/>
                    <a:gd name="connsiteY24-2282" fmla="*/ 301670 h 309279"/>
                    <a:gd name="connsiteX25-2283" fmla="*/ 383172 w 639415"/>
                    <a:gd name="connsiteY25-2284" fmla="*/ 209596 h 309279"/>
                    <a:gd name="connsiteX26-2285" fmla="*/ 318085 w 639415"/>
                    <a:gd name="connsiteY26-2286" fmla="*/ 236583 h 309279"/>
                    <a:gd name="connsiteX27-2287" fmla="*/ 238710 w 639415"/>
                    <a:gd name="connsiteY27-2288" fmla="*/ 231821 h 309279"/>
                    <a:gd name="connsiteX28-2289" fmla="*/ 167272 w 639415"/>
                    <a:gd name="connsiteY28-2290" fmla="*/ 282620 h 309279"/>
                    <a:gd name="connsiteX29-2291" fmla="*/ 200610 w 639415"/>
                    <a:gd name="connsiteY29-2292" fmla="*/ 214358 h 309279"/>
                    <a:gd name="connsiteX30-2293" fmla="*/ 5347 w 639415"/>
                    <a:gd name="connsiteY30-2294" fmla="*/ 242933 h 309279"/>
                    <a:gd name="connsiteX0-2295" fmla="*/ 5347 w 640991"/>
                    <a:gd name="connsiteY0-2296" fmla="*/ 242933 h 309279"/>
                    <a:gd name="connsiteX1-2297" fmla="*/ 59322 w 640991"/>
                    <a:gd name="connsiteY1-2298" fmla="*/ 122283 h 309279"/>
                    <a:gd name="connsiteX2-2299" fmla="*/ 105360 w 640991"/>
                    <a:gd name="connsiteY2-2300" fmla="*/ 74658 h 309279"/>
                    <a:gd name="connsiteX3-2301" fmla="*/ 87897 w 640991"/>
                    <a:gd name="connsiteY3-2302" fmla="*/ 50846 h 309279"/>
                    <a:gd name="connsiteX4-2303" fmla="*/ 110122 w 640991"/>
                    <a:gd name="connsiteY4-2304" fmla="*/ 6396 h 309279"/>
                    <a:gd name="connsiteX5-2305" fmla="*/ 165685 w 640991"/>
                    <a:gd name="connsiteY5-2306" fmla="*/ 4807 h 309279"/>
                    <a:gd name="connsiteX6-2307" fmla="*/ 184735 w 640991"/>
                    <a:gd name="connsiteY6-2308" fmla="*/ 49258 h 309279"/>
                    <a:gd name="connsiteX7-2309" fmla="*/ 181560 w 640991"/>
                    <a:gd name="connsiteY7-2310" fmla="*/ 73071 h 309279"/>
                    <a:gd name="connsiteX8-2311" fmla="*/ 230772 w 640991"/>
                    <a:gd name="connsiteY8-2312" fmla="*/ 22271 h 309279"/>
                    <a:gd name="connsiteX9-2313" fmla="*/ 353010 w 640991"/>
                    <a:gd name="connsiteY9-2314" fmla="*/ 4808 h 309279"/>
                    <a:gd name="connsiteX10-2315" fmla="*/ 506997 w 640991"/>
                    <a:gd name="connsiteY10-2316" fmla="*/ 65134 h 309279"/>
                    <a:gd name="connsiteX11-2317" fmla="*/ 580022 w 640991"/>
                    <a:gd name="connsiteY11-2318" fmla="*/ 142920 h 309279"/>
                    <a:gd name="connsiteX12-2319" fmla="*/ 633998 w 640991"/>
                    <a:gd name="connsiteY12-2320" fmla="*/ 209595 h 309279"/>
                    <a:gd name="connsiteX13-2321" fmla="*/ 637172 w 640991"/>
                    <a:gd name="connsiteY13-2322" fmla="*/ 258808 h 309279"/>
                    <a:gd name="connsiteX14-2323" fmla="*/ 630823 w 640991"/>
                    <a:gd name="connsiteY14-2324" fmla="*/ 274683 h 309279"/>
                    <a:gd name="connsiteX15-2325" fmla="*/ 584785 w 640991"/>
                    <a:gd name="connsiteY15-2326" fmla="*/ 285796 h 309279"/>
                    <a:gd name="connsiteX16-2327" fmla="*/ 465723 w 640991"/>
                    <a:gd name="connsiteY16-2328" fmla="*/ 296908 h 309279"/>
                    <a:gd name="connsiteX17-2329" fmla="*/ 427622 w 640991"/>
                    <a:gd name="connsiteY17-2330" fmla="*/ 285796 h 309279"/>
                    <a:gd name="connsiteX18-2331" fmla="*/ 637174 w 640991"/>
                    <a:gd name="connsiteY18-2332" fmla="*/ 247696 h 309279"/>
                    <a:gd name="connsiteX19-2333" fmla="*/ 564147 w 640991"/>
                    <a:gd name="connsiteY19-2334" fmla="*/ 190546 h 309279"/>
                    <a:gd name="connsiteX20-2335" fmla="*/ 578434 w 640991"/>
                    <a:gd name="connsiteY20-2336" fmla="*/ 200071 h 309279"/>
                    <a:gd name="connsiteX21-2337" fmla="*/ 514935 w 640991"/>
                    <a:gd name="connsiteY21-2338" fmla="*/ 234996 h 309279"/>
                    <a:gd name="connsiteX22-2339" fmla="*/ 433972 w 640991"/>
                    <a:gd name="connsiteY22-2340" fmla="*/ 239758 h 309279"/>
                    <a:gd name="connsiteX23-2341" fmla="*/ 367297 w 640991"/>
                    <a:gd name="connsiteY23-2342" fmla="*/ 296909 h 309279"/>
                    <a:gd name="connsiteX24-2343" fmla="*/ 338722 w 640991"/>
                    <a:gd name="connsiteY24-2344" fmla="*/ 301670 h 309279"/>
                    <a:gd name="connsiteX25-2345" fmla="*/ 383172 w 640991"/>
                    <a:gd name="connsiteY25-2346" fmla="*/ 209596 h 309279"/>
                    <a:gd name="connsiteX26-2347" fmla="*/ 318085 w 640991"/>
                    <a:gd name="connsiteY26-2348" fmla="*/ 236583 h 309279"/>
                    <a:gd name="connsiteX27-2349" fmla="*/ 238710 w 640991"/>
                    <a:gd name="connsiteY27-2350" fmla="*/ 231821 h 309279"/>
                    <a:gd name="connsiteX28-2351" fmla="*/ 167272 w 640991"/>
                    <a:gd name="connsiteY28-2352" fmla="*/ 282620 h 309279"/>
                    <a:gd name="connsiteX29-2353" fmla="*/ 200610 w 640991"/>
                    <a:gd name="connsiteY29-2354" fmla="*/ 214358 h 309279"/>
                    <a:gd name="connsiteX30-2355" fmla="*/ 5347 w 640991"/>
                    <a:gd name="connsiteY30-2356" fmla="*/ 242933 h 309279"/>
                    <a:gd name="connsiteX0-2357" fmla="*/ 5347 w 639415"/>
                    <a:gd name="connsiteY0-2358" fmla="*/ 242933 h 309279"/>
                    <a:gd name="connsiteX1-2359" fmla="*/ 59322 w 639415"/>
                    <a:gd name="connsiteY1-2360" fmla="*/ 122283 h 309279"/>
                    <a:gd name="connsiteX2-2361" fmla="*/ 105360 w 639415"/>
                    <a:gd name="connsiteY2-2362" fmla="*/ 74658 h 309279"/>
                    <a:gd name="connsiteX3-2363" fmla="*/ 87897 w 639415"/>
                    <a:gd name="connsiteY3-2364" fmla="*/ 50846 h 309279"/>
                    <a:gd name="connsiteX4-2365" fmla="*/ 110122 w 639415"/>
                    <a:gd name="connsiteY4-2366" fmla="*/ 6396 h 309279"/>
                    <a:gd name="connsiteX5-2367" fmla="*/ 165685 w 639415"/>
                    <a:gd name="connsiteY5-2368" fmla="*/ 4807 h 309279"/>
                    <a:gd name="connsiteX6-2369" fmla="*/ 184735 w 639415"/>
                    <a:gd name="connsiteY6-2370" fmla="*/ 49258 h 309279"/>
                    <a:gd name="connsiteX7-2371" fmla="*/ 181560 w 639415"/>
                    <a:gd name="connsiteY7-2372" fmla="*/ 73071 h 309279"/>
                    <a:gd name="connsiteX8-2373" fmla="*/ 230772 w 639415"/>
                    <a:gd name="connsiteY8-2374" fmla="*/ 22271 h 309279"/>
                    <a:gd name="connsiteX9-2375" fmla="*/ 353010 w 639415"/>
                    <a:gd name="connsiteY9-2376" fmla="*/ 4808 h 309279"/>
                    <a:gd name="connsiteX10-2377" fmla="*/ 506997 w 639415"/>
                    <a:gd name="connsiteY10-2378" fmla="*/ 65134 h 309279"/>
                    <a:gd name="connsiteX11-2379" fmla="*/ 580022 w 639415"/>
                    <a:gd name="connsiteY11-2380" fmla="*/ 142920 h 309279"/>
                    <a:gd name="connsiteX12-2381" fmla="*/ 633998 w 639415"/>
                    <a:gd name="connsiteY12-2382" fmla="*/ 209595 h 309279"/>
                    <a:gd name="connsiteX13-2383" fmla="*/ 637172 w 639415"/>
                    <a:gd name="connsiteY13-2384" fmla="*/ 258808 h 309279"/>
                    <a:gd name="connsiteX14-2385" fmla="*/ 630823 w 639415"/>
                    <a:gd name="connsiteY14-2386" fmla="*/ 274683 h 309279"/>
                    <a:gd name="connsiteX15-2387" fmla="*/ 584785 w 639415"/>
                    <a:gd name="connsiteY15-2388" fmla="*/ 285796 h 309279"/>
                    <a:gd name="connsiteX16-2389" fmla="*/ 465723 w 639415"/>
                    <a:gd name="connsiteY16-2390" fmla="*/ 296908 h 309279"/>
                    <a:gd name="connsiteX17-2391" fmla="*/ 427622 w 639415"/>
                    <a:gd name="connsiteY17-2392" fmla="*/ 285796 h 309279"/>
                    <a:gd name="connsiteX18-2393" fmla="*/ 637174 w 639415"/>
                    <a:gd name="connsiteY18-2394" fmla="*/ 247696 h 309279"/>
                    <a:gd name="connsiteX19-2395" fmla="*/ 564147 w 639415"/>
                    <a:gd name="connsiteY19-2396" fmla="*/ 190546 h 309279"/>
                    <a:gd name="connsiteX20-2397" fmla="*/ 578434 w 639415"/>
                    <a:gd name="connsiteY20-2398" fmla="*/ 200071 h 309279"/>
                    <a:gd name="connsiteX21-2399" fmla="*/ 514935 w 639415"/>
                    <a:gd name="connsiteY21-2400" fmla="*/ 234996 h 309279"/>
                    <a:gd name="connsiteX22-2401" fmla="*/ 433972 w 639415"/>
                    <a:gd name="connsiteY22-2402" fmla="*/ 239758 h 309279"/>
                    <a:gd name="connsiteX23-2403" fmla="*/ 367297 w 639415"/>
                    <a:gd name="connsiteY23-2404" fmla="*/ 296909 h 309279"/>
                    <a:gd name="connsiteX24-2405" fmla="*/ 338722 w 639415"/>
                    <a:gd name="connsiteY24-2406" fmla="*/ 301670 h 309279"/>
                    <a:gd name="connsiteX25-2407" fmla="*/ 383172 w 639415"/>
                    <a:gd name="connsiteY25-2408" fmla="*/ 209596 h 309279"/>
                    <a:gd name="connsiteX26-2409" fmla="*/ 318085 w 639415"/>
                    <a:gd name="connsiteY26-2410" fmla="*/ 236583 h 309279"/>
                    <a:gd name="connsiteX27-2411" fmla="*/ 238710 w 639415"/>
                    <a:gd name="connsiteY27-2412" fmla="*/ 231821 h 309279"/>
                    <a:gd name="connsiteX28-2413" fmla="*/ 167272 w 639415"/>
                    <a:gd name="connsiteY28-2414" fmla="*/ 282620 h 309279"/>
                    <a:gd name="connsiteX29-2415" fmla="*/ 200610 w 639415"/>
                    <a:gd name="connsiteY29-2416" fmla="*/ 214358 h 309279"/>
                    <a:gd name="connsiteX30-2417" fmla="*/ 5347 w 639415"/>
                    <a:gd name="connsiteY30-2418" fmla="*/ 242933 h 309279"/>
                    <a:gd name="connsiteX0-2419" fmla="*/ 5347 w 639415"/>
                    <a:gd name="connsiteY0-2420" fmla="*/ 242933 h 309279"/>
                    <a:gd name="connsiteX1-2421" fmla="*/ 59322 w 639415"/>
                    <a:gd name="connsiteY1-2422" fmla="*/ 122283 h 309279"/>
                    <a:gd name="connsiteX2-2423" fmla="*/ 105360 w 639415"/>
                    <a:gd name="connsiteY2-2424" fmla="*/ 74658 h 309279"/>
                    <a:gd name="connsiteX3-2425" fmla="*/ 87897 w 639415"/>
                    <a:gd name="connsiteY3-2426" fmla="*/ 50846 h 309279"/>
                    <a:gd name="connsiteX4-2427" fmla="*/ 110122 w 639415"/>
                    <a:gd name="connsiteY4-2428" fmla="*/ 6396 h 309279"/>
                    <a:gd name="connsiteX5-2429" fmla="*/ 165685 w 639415"/>
                    <a:gd name="connsiteY5-2430" fmla="*/ 4807 h 309279"/>
                    <a:gd name="connsiteX6-2431" fmla="*/ 184735 w 639415"/>
                    <a:gd name="connsiteY6-2432" fmla="*/ 49258 h 309279"/>
                    <a:gd name="connsiteX7-2433" fmla="*/ 181560 w 639415"/>
                    <a:gd name="connsiteY7-2434" fmla="*/ 73071 h 309279"/>
                    <a:gd name="connsiteX8-2435" fmla="*/ 230772 w 639415"/>
                    <a:gd name="connsiteY8-2436" fmla="*/ 22271 h 309279"/>
                    <a:gd name="connsiteX9-2437" fmla="*/ 353010 w 639415"/>
                    <a:gd name="connsiteY9-2438" fmla="*/ 4808 h 309279"/>
                    <a:gd name="connsiteX10-2439" fmla="*/ 506997 w 639415"/>
                    <a:gd name="connsiteY10-2440" fmla="*/ 65134 h 309279"/>
                    <a:gd name="connsiteX11-2441" fmla="*/ 580022 w 639415"/>
                    <a:gd name="connsiteY11-2442" fmla="*/ 142920 h 309279"/>
                    <a:gd name="connsiteX12-2443" fmla="*/ 633998 w 639415"/>
                    <a:gd name="connsiteY12-2444" fmla="*/ 209595 h 309279"/>
                    <a:gd name="connsiteX13-2445" fmla="*/ 637172 w 639415"/>
                    <a:gd name="connsiteY13-2446" fmla="*/ 258808 h 309279"/>
                    <a:gd name="connsiteX14-2447" fmla="*/ 630823 w 639415"/>
                    <a:gd name="connsiteY14-2448" fmla="*/ 274683 h 309279"/>
                    <a:gd name="connsiteX15-2449" fmla="*/ 591135 w 639415"/>
                    <a:gd name="connsiteY15-2450" fmla="*/ 293733 h 309279"/>
                    <a:gd name="connsiteX16-2451" fmla="*/ 465723 w 639415"/>
                    <a:gd name="connsiteY16-2452" fmla="*/ 296908 h 309279"/>
                    <a:gd name="connsiteX17-2453" fmla="*/ 427622 w 639415"/>
                    <a:gd name="connsiteY17-2454" fmla="*/ 285796 h 309279"/>
                    <a:gd name="connsiteX18-2455" fmla="*/ 637174 w 639415"/>
                    <a:gd name="connsiteY18-2456" fmla="*/ 247696 h 309279"/>
                    <a:gd name="connsiteX19-2457" fmla="*/ 564147 w 639415"/>
                    <a:gd name="connsiteY19-2458" fmla="*/ 190546 h 309279"/>
                    <a:gd name="connsiteX20-2459" fmla="*/ 578434 w 639415"/>
                    <a:gd name="connsiteY20-2460" fmla="*/ 200071 h 309279"/>
                    <a:gd name="connsiteX21-2461" fmla="*/ 514935 w 639415"/>
                    <a:gd name="connsiteY21-2462" fmla="*/ 234996 h 309279"/>
                    <a:gd name="connsiteX22-2463" fmla="*/ 433972 w 639415"/>
                    <a:gd name="connsiteY22-2464" fmla="*/ 239758 h 309279"/>
                    <a:gd name="connsiteX23-2465" fmla="*/ 367297 w 639415"/>
                    <a:gd name="connsiteY23-2466" fmla="*/ 296909 h 309279"/>
                    <a:gd name="connsiteX24-2467" fmla="*/ 338722 w 639415"/>
                    <a:gd name="connsiteY24-2468" fmla="*/ 301670 h 309279"/>
                    <a:gd name="connsiteX25-2469" fmla="*/ 383172 w 639415"/>
                    <a:gd name="connsiteY25-2470" fmla="*/ 209596 h 309279"/>
                    <a:gd name="connsiteX26-2471" fmla="*/ 318085 w 639415"/>
                    <a:gd name="connsiteY26-2472" fmla="*/ 236583 h 309279"/>
                    <a:gd name="connsiteX27-2473" fmla="*/ 238710 w 639415"/>
                    <a:gd name="connsiteY27-2474" fmla="*/ 231821 h 309279"/>
                    <a:gd name="connsiteX28-2475" fmla="*/ 167272 w 639415"/>
                    <a:gd name="connsiteY28-2476" fmla="*/ 282620 h 309279"/>
                    <a:gd name="connsiteX29-2477" fmla="*/ 200610 w 639415"/>
                    <a:gd name="connsiteY29-2478" fmla="*/ 214358 h 309279"/>
                    <a:gd name="connsiteX30-2479" fmla="*/ 5347 w 639415"/>
                    <a:gd name="connsiteY30-2480" fmla="*/ 242933 h 309279"/>
                    <a:gd name="connsiteX0-2481" fmla="*/ 5347 w 639415"/>
                    <a:gd name="connsiteY0-2482" fmla="*/ 242933 h 309279"/>
                    <a:gd name="connsiteX1-2483" fmla="*/ 59322 w 639415"/>
                    <a:gd name="connsiteY1-2484" fmla="*/ 122283 h 309279"/>
                    <a:gd name="connsiteX2-2485" fmla="*/ 105360 w 639415"/>
                    <a:gd name="connsiteY2-2486" fmla="*/ 74658 h 309279"/>
                    <a:gd name="connsiteX3-2487" fmla="*/ 87897 w 639415"/>
                    <a:gd name="connsiteY3-2488" fmla="*/ 50846 h 309279"/>
                    <a:gd name="connsiteX4-2489" fmla="*/ 110122 w 639415"/>
                    <a:gd name="connsiteY4-2490" fmla="*/ 6396 h 309279"/>
                    <a:gd name="connsiteX5-2491" fmla="*/ 165685 w 639415"/>
                    <a:gd name="connsiteY5-2492" fmla="*/ 4807 h 309279"/>
                    <a:gd name="connsiteX6-2493" fmla="*/ 184735 w 639415"/>
                    <a:gd name="connsiteY6-2494" fmla="*/ 49258 h 309279"/>
                    <a:gd name="connsiteX7-2495" fmla="*/ 181560 w 639415"/>
                    <a:gd name="connsiteY7-2496" fmla="*/ 73071 h 309279"/>
                    <a:gd name="connsiteX8-2497" fmla="*/ 230772 w 639415"/>
                    <a:gd name="connsiteY8-2498" fmla="*/ 22271 h 309279"/>
                    <a:gd name="connsiteX9-2499" fmla="*/ 353010 w 639415"/>
                    <a:gd name="connsiteY9-2500" fmla="*/ 4808 h 309279"/>
                    <a:gd name="connsiteX10-2501" fmla="*/ 506997 w 639415"/>
                    <a:gd name="connsiteY10-2502" fmla="*/ 65134 h 309279"/>
                    <a:gd name="connsiteX11-2503" fmla="*/ 580022 w 639415"/>
                    <a:gd name="connsiteY11-2504" fmla="*/ 142920 h 309279"/>
                    <a:gd name="connsiteX12-2505" fmla="*/ 633998 w 639415"/>
                    <a:gd name="connsiteY12-2506" fmla="*/ 209595 h 309279"/>
                    <a:gd name="connsiteX13-2507" fmla="*/ 637172 w 639415"/>
                    <a:gd name="connsiteY13-2508" fmla="*/ 258808 h 309279"/>
                    <a:gd name="connsiteX14-2509" fmla="*/ 630823 w 639415"/>
                    <a:gd name="connsiteY14-2510" fmla="*/ 274683 h 309279"/>
                    <a:gd name="connsiteX15-2511" fmla="*/ 591135 w 639415"/>
                    <a:gd name="connsiteY15-2512" fmla="*/ 293733 h 309279"/>
                    <a:gd name="connsiteX16-2513" fmla="*/ 465723 w 639415"/>
                    <a:gd name="connsiteY16-2514" fmla="*/ 296908 h 309279"/>
                    <a:gd name="connsiteX17-2515" fmla="*/ 427622 w 639415"/>
                    <a:gd name="connsiteY17-2516" fmla="*/ 285796 h 309279"/>
                    <a:gd name="connsiteX18-2517" fmla="*/ 622887 w 639415"/>
                    <a:gd name="connsiteY18-2518" fmla="*/ 250871 h 309279"/>
                    <a:gd name="connsiteX19-2519" fmla="*/ 564147 w 639415"/>
                    <a:gd name="connsiteY19-2520" fmla="*/ 190546 h 309279"/>
                    <a:gd name="connsiteX20-2521" fmla="*/ 578434 w 639415"/>
                    <a:gd name="connsiteY20-2522" fmla="*/ 200071 h 309279"/>
                    <a:gd name="connsiteX21-2523" fmla="*/ 514935 w 639415"/>
                    <a:gd name="connsiteY21-2524" fmla="*/ 234996 h 309279"/>
                    <a:gd name="connsiteX22-2525" fmla="*/ 433972 w 639415"/>
                    <a:gd name="connsiteY22-2526" fmla="*/ 239758 h 309279"/>
                    <a:gd name="connsiteX23-2527" fmla="*/ 367297 w 639415"/>
                    <a:gd name="connsiteY23-2528" fmla="*/ 296909 h 309279"/>
                    <a:gd name="connsiteX24-2529" fmla="*/ 338722 w 639415"/>
                    <a:gd name="connsiteY24-2530" fmla="*/ 301670 h 309279"/>
                    <a:gd name="connsiteX25-2531" fmla="*/ 383172 w 639415"/>
                    <a:gd name="connsiteY25-2532" fmla="*/ 209596 h 309279"/>
                    <a:gd name="connsiteX26-2533" fmla="*/ 318085 w 639415"/>
                    <a:gd name="connsiteY26-2534" fmla="*/ 236583 h 309279"/>
                    <a:gd name="connsiteX27-2535" fmla="*/ 238710 w 639415"/>
                    <a:gd name="connsiteY27-2536" fmla="*/ 231821 h 309279"/>
                    <a:gd name="connsiteX28-2537" fmla="*/ 167272 w 639415"/>
                    <a:gd name="connsiteY28-2538" fmla="*/ 282620 h 309279"/>
                    <a:gd name="connsiteX29-2539" fmla="*/ 200610 w 639415"/>
                    <a:gd name="connsiteY29-2540" fmla="*/ 214358 h 309279"/>
                    <a:gd name="connsiteX30-2541" fmla="*/ 5347 w 639415"/>
                    <a:gd name="connsiteY30-2542" fmla="*/ 242933 h 309279"/>
                    <a:gd name="connsiteX0-2543" fmla="*/ 5347 w 649642"/>
                    <a:gd name="connsiteY0-2544" fmla="*/ 242933 h 309279"/>
                    <a:gd name="connsiteX1-2545" fmla="*/ 59322 w 649642"/>
                    <a:gd name="connsiteY1-2546" fmla="*/ 122283 h 309279"/>
                    <a:gd name="connsiteX2-2547" fmla="*/ 105360 w 649642"/>
                    <a:gd name="connsiteY2-2548" fmla="*/ 74658 h 309279"/>
                    <a:gd name="connsiteX3-2549" fmla="*/ 87897 w 649642"/>
                    <a:gd name="connsiteY3-2550" fmla="*/ 50846 h 309279"/>
                    <a:gd name="connsiteX4-2551" fmla="*/ 110122 w 649642"/>
                    <a:gd name="connsiteY4-2552" fmla="*/ 6396 h 309279"/>
                    <a:gd name="connsiteX5-2553" fmla="*/ 165685 w 649642"/>
                    <a:gd name="connsiteY5-2554" fmla="*/ 4807 h 309279"/>
                    <a:gd name="connsiteX6-2555" fmla="*/ 184735 w 649642"/>
                    <a:gd name="connsiteY6-2556" fmla="*/ 49258 h 309279"/>
                    <a:gd name="connsiteX7-2557" fmla="*/ 181560 w 649642"/>
                    <a:gd name="connsiteY7-2558" fmla="*/ 73071 h 309279"/>
                    <a:gd name="connsiteX8-2559" fmla="*/ 230772 w 649642"/>
                    <a:gd name="connsiteY8-2560" fmla="*/ 22271 h 309279"/>
                    <a:gd name="connsiteX9-2561" fmla="*/ 353010 w 649642"/>
                    <a:gd name="connsiteY9-2562" fmla="*/ 4808 h 309279"/>
                    <a:gd name="connsiteX10-2563" fmla="*/ 506997 w 649642"/>
                    <a:gd name="connsiteY10-2564" fmla="*/ 65134 h 309279"/>
                    <a:gd name="connsiteX11-2565" fmla="*/ 580022 w 649642"/>
                    <a:gd name="connsiteY11-2566" fmla="*/ 142920 h 309279"/>
                    <a:gd name="connsiteX12-2567" fmla="*/ 646698 w 649642"/>
                    <a:gd name="connsiteY12-2568" fmla="*/ 211182 h 309279"/>
                    <a:gd name="connsiteX13-2569" fmla="*/ 637172 w 649642"/>
                    <a:gd name="connsiteY13-2570" fmla="*/ 258808 h 309279"/>
                    <a:gd name="connsiteX14-2571" fmla="*/ 630823 w 649642"/>
                    <a:gd name="connsiteY14-2572" fmla="*/ 274683 h 309279"/>
                    <a:gd name="connsiteX15-2573" fmla="*/ 591135 w 649642"/>
                    <a:gd name="connsiteY15-2574" fmla="*/ 293733 h 309279"/>
                    <a:gd name="connsiteX16-2575" fmla="*/ 465723 w 649642"/>
                    <a:gd name="connsiteY16-2576" fmla="*/ 296908 h 309279"/>
                    <a:gd name="connsiteX17-2577" fmla="*/ 427622 w 649642"/>
                    <a:gd name="connsiteY17-2578" fmla="*/ 285796 h 309279"/>
                    <a:gd name="connsiteX18-2579" fmla="*/ 622887 w 649642"/>
                    <a:gd name="connsiteY18-2580" fmla="*/ 250871 h 309279"/>
                    <a:gd name="connsiteX19-2581" fmla="*/ 564147 w 649642"/>
                    <a:gd name="connsiteY19-2582" fmla="*/ 190546 h 309279"/>
                    <a:gd name="connsiteX20-2583" fmla="*/ 578434 w 649642"/>
                    <a:gd name="connsiteY20-2584" fmla="*/ 200071 h 309279"/>
                    <a:gd name="connsiteX21-2585" fmla="*/ 514935 w 649642"/>
                    <a:gd name="connsiteY21-2586" fmla="*/ 234996 h 309279"/>
                    <a:gd name="connsiteX22-2587" fmla="*/ 433972 w 649642"/>
                    <a:gd name="connsiteY22-2588" fmla="*/ 239758 h 309279"/>
                    <a:gd name="connsiteX23-2589" fmla="*/ 367297 w 649642"/>
                    <a:gd name="connsiteY23-2590" fmla="*/ 296909 h 309279"/>
                    <a:gd name="connsiteX24-2591" fmla="*/ 338722 w 649642"/>
                    <a:gd name="connsiteY24-2592" fmla="*/ 301670 h 309279"/>
                    <a:gd name="connsiteX25-2593" fmla="*/ 383172 w 649642"/>
                    <a:gd name="connsiteY25-2594" fmla="*/ 209596 h 309279"/>
                    <a:gd name="connsiteX26-2595" fmla="*/ 318085 w 649642"/>
                    <a:gd name="connsiteY26-2596" fmla="*/ 236583 h 309279"/>
                    <a:gd name="connsiteX27-2597" fmla="*/ 238710 w 649642"/>
                    <a:gd name="connsiteY27-2598" fmla="*/ 231821 h 309279"/>
                    <a:gd name="connsiteX28-2599" fmla="*/ 167272 w 649642"/>
                    <a:gd name="connsiteY28-2600" fmla="*/ 282620 h 309279"/>
                    <a:gd name="connsiteX29-2601" fmla="*/ 200610 w 649642"/>
                    <a:gd name="connsiteY29-2602" fmla="*/ 214358 h 309279"/>
                    <a:gd name="connsiteX30-2603" fmla="*/ 5347 w 649642"/>
                    <a:gd name="connsiteY30-2604" fmla="*/ 242933 h 309279"/>
                    <a:gd name="connsiteX0-2605" fmla="*/ 5347 w 649642"/>
                    <a:gd name="connsiteY0-2606" fmla="*/ 242933 h 309279"/>
                    <a:gd name="connsiteX1-2607" fmla="*/ 59322 w 649642"/>
                    <a:gd name="connsiteY1-2608" fmla="*/ 122283 h 309279"/>
                    <a:gd name="connsiteX2-2609" fmla="*/ 105360 w 649642"/>
                    <a:gd name="connsiteY2-2610" fmla="*/ 74658 h 309279"/>
                    <a:gd name="connsiteX3-2611" fmla="*/ 87897 w 649642"/>
                    <a:gd name="connsiteY3-2612" fmla="*/ 50846 h 309279"/>
                    <a:gd name="connsiteX4-2613" fmla="*/ 110122 w 649642"/>
                    <a:gd name="connsiteY4-2614" fmla="*/ 6396 h 309279"/>
                    <a:gd name="connsiteX5-2615" fmla="*/ 165685 w 649642"/>
                    <a:gd name="connsiteY5-2616" fmla="*/ 4807 h 309279"/>
                    <a:gd name="connsiteX6-2617" fmla="*/ 184735 w 649642"/>
                    <a:gd name="connsiteY6-2618" fmla="*/ 49258 h 309279"/>
                    <a:gd name="connsiteX7-2619" fmla="*/ 181560 w 649642"/>
                    <a:gd name="connsiteY7-2620" fmla="*/ 73071 h 309279"/>
                    <a:gd name="connsiteX8-2621" fmla="*/ 230772 w 649642"/>
                    <a:gd name="connsiteY8-2622" fmla="*/ 22271 h 309279"/>
                    <a:gd name="connsiteX9-2623" fmla="*/ 353010 w 649642"/>
                    <a:gd name="connsiteY9-2624" fmla="*/ 4808 h 309279"/>
                    <a:gd name="connsiteX10-2625" fmla="*/ 506997 w 649642"/>
                    <a:gd name="connsiteY10-2626" fmla="*/ 65134 h 309279"/>
                    <a:gd name="connsiteX11-2627" fmla="*/ 580022 w 649642"/>
                    <a:gd name="connsiteY11-2628" fmla="*/ 142920 h 309279"/>
                    <a:gd name="connsiteX12-2629" fmla="*/ 646698 w 649642"/>
                    <a:gd name="connsiteY12-2630" fmla="*/ 211182 h 309279"/>
                    <a:gd name="connsiteX13-2631" fmla="*/ 637172 w 649642"/>
                    <a:gd name="connsiteY13-2632" fmla="*/ 258808 h 309279"/>
                    <a:gd name="connsiteX14-2633" fmla="*/ 630823 w 649642"/>
                    <a:gd name="connsiteY14-2634" fmla="*/ 274683 h 309279"/>
                    <a:gd name="connsiteX15-2635" fmla="*/ 591135 w 649642"/>
                    <a:gd name="connsiteY15-2636" fmla="*/ 293733 h 309279"/>
                    <a:gd name="connsiteX16-2637" fmla="*/ 465723 w 649642"/>
                    <a:gd name="connsiteY16-2638" fmla="*/ 296908 h 309279"/>
                    <a:gd name="connsiteX17-2639" fmla="*/ 427622 w 649642"/>
                    <a:gd name="connsiteY17-2640" fmla="*/ 285796 h 309279"/>
                    <a:gd name="connsiteX18-2641" fmla="*/ 634000 w 649642"/>
                    <a:gd name="connsiteY18-2642" fmla="*/ 242934 h 309279"/>
                    <a:gd name="connsiteX19-2643" fmla="*/ 564147 w 649642"/>
                    <a:gd name="connsiteY19-2644" fmla="*/ 190546 h 309279"/>
                    <a:gd name="connsiteX20-2645" fmla="*/ 578434 w 649642"/>
                    <a:gd name="connsiteY20-2646" fmla="*/ 200071 h 309279"/>
                    <a:gd name="connsiteX21-2647" fmla="*/ 514935 w 649642"/>
                    <a:gd name="connsiteY21-2648" fmla="*/ 234996 h 309279"/>
                    <a:gd name="connsiteX22-2649" fmla="*/ 433972 w 649642"/>
                    <a:gd name="connsiteY22-2650" fmla="*/ 239758 h 309279"/>
                    <a:gd name="connsiteX23-2651" fmla="*/ 367297 w 649642"/>
                    <a:gd name="connsiteY23-2652" fmla="*/ 296909 h 309279"/>
                    <a:gd name="connsiteX24-2653" fmla="*/ 338722 w 649642"/>
                    <a:gd name="connsiteY24-2654" fmla="*/ 301670 h 309279"/>
                    <a:gd name="connsiteX25-2655" fmla="*/ 383172 w 649642"/>
                    <a:gd name="connsiteY25-2656" fmla="*/ 209596 h 309279"/>
                    <a:gd name="connsiteX26-2657" fmla="*/ 318085 w 649642"/>
                    <a:gd name="connsiteY26-2658" fmla="*/ 236583 h 309279"/>
                    <a:gd name="connsiteX27-2659" fmla="*/ 238710 w 649642"/>
                    <a:gd name="connsiteY27-2660" fmla="*/ 231821 h 309279"/>
                    <a:gd name="connsiteX28-2661" fmla="*/ 167272 w 649642"/>
                    <a:gd name="connsiteY28-2662" fmla="*/ 282620 h 309279"/>
                    <a:gd name="connsiteX29-2663" fmla="*/ 200610 w 649642"/>
                    <a:gd name="connsiteY29-2664" fmla="*/ 214358 h 309279"/>
                    <a:gd name="connsiteX30-2665" fmla="*/ 5347 w 649642"/>
                    <a:gd name="connsiteY30-2666" fmla="*/ 242933 h 309279"/>
                    <a:gd name="connsiteX0-2667" fmla="*/ 5347 w 649642"/>
                    <a:gd name="connsiteY0-2668" fmla="*/ 242933 h 309279"/>
                    <a:gd name="connsiteX1-2669" fmla="*/ 59322 w 649642"/>
                    <a:gd name="connsiteY1-2670" fmla="*/ 122283 h 309279"/>
                    <a:gd name="connsiteX2-2671" fmla="*/ 105360 w 649642"/>
                    <a:gd name="connsiteY2-2672" fmla="*/ 74658 h 309279"/>
                    <a:gd name="connsiteX3-2673" fmla="*/ 87897 w 649642"/>
                    <a:gd name="connsiteY3-2674" fmla="*/ 50846 h 309279"/>
                    <a:gd name="connsiteX4-2675" fmla="*/ 110122 w 649642"/>
                    <a:gd name="connsiteY4-2676" fmla="*/ 6396 h 309279"/>
                    <a:gd name="connsiteX5-2677" fmla="*/ 165685 w 649642"/>
                    <a:gd name="connsiteY5-2678" fmla="*/ 4807 h 309279"/>
                    <a:gd name="connsiteX6-2679" fmla="*/ 184735 w 649642"/>
                    <a:gd name="connsiteY6-2680" fmla="*/ 49258 h 309279"/>
                    <a:gd name="connsiteX7-2681" fmla="*/ 181560 w 649642"/>
                    <a:gd name="connsiteY7-2682" fmla="*/ 73071 h 309279"/>
                    <a:gd name="connsiteX8-2683" fmla="*/ 230772 w 649642"/>
                    <a:gd name="connsiteY8-2684" fmla="*/ 22271 h 309279"/>
                    <a:gd name="connsiteX9-2685" fmla="*/ 353010 w 649642"/>
                    <a:gd name="connsiteY9-2686" fmla="*/ 4808 h 309279"/>
                    <a:gd name="connsiteX10-2687" fmla="*/ 506997 w 649642"/>
                    <a:gd name="connsiteY10-2688" fmla="*/ 65134 h 309279"/>
                    <a:gd name="connsiteX11-2689" fmla="*/ 580022 w 649642"/>
                    <a:gd name="connsiteY11-2690" fmla="*/ 142920 h 309279"/>
                    <a:gd name="connsiteX12-2691" fmla="*/ 646698 w 649642"/>
                    <a:gd name="connsiteY12-2692" fmla="*/ 211182 h 309279"/>
                    <a:gd name="connsiteX13-2693" fmla="*/ 637172 w 649642"/>
                    <a:gd name="connsiteY13-2694" fmla="*/ 258808 h 309279"/>
                    <a:gd name="connsiteX14-2695" fmla="*/ 630823 w 649642"/>
                    <a:gd name="connsiteY14-2696" fmla="*/ 274683 h 309279"/>
                    <a:gd name="connsiteX15-2697" fmla="*/ 591135 w 649642"/>
                    <a:gd name="connsiteY15-2698" fmla="*/ 293733 h 309279"/>
                    <a:gd name="connsiteX16-2699" fmla="*/ 465723 w 649642"/>
                    <a:gd name="connsiteY16-2700" fmla="*/ 296908 h 309279"/>
                    <a:gd name="connsiteX17-2701" fmla="*/ 427622 w 649642"/>
                    <a:gd name="connsiteY17-2702" fmla="*/ 285796 h 309279"/>
                    <a:gd name="connsiteX18-2703" fmla="*/ 634000 w 649642"/>
                    <a:gd name="connsiteY18-2704" fmla="*/ 242934 h 309279"/>
                    <a:gd name="connsiteX19-2705" fmla="*/ 564147 w 649642"/>
                    <a:gd name="connsiteY19-2706" fmla="*/ 190546 h 309279"/>
                    <a:gd name="connsiteX20-2707" fmla="*/ 578434 w 649642"/>
                    <a:gd name="connsiteY20-2708" fmla="*/ 200071 h 309279"/>
                    <a:gd name="connsiteX21-2709" fmla="*/ 514935 w 649642"/>
                    <a:gd name="connsiteY21-2710" fmla="*/ 234996 h 309279"/>
                    <a:gd name="connsiteX22-2711" fmla="*/ 433972 w 649642"/>
                    <a:gd name="connsiteY22-2712" fmla="*/ 239758 h 309279"/>
                    <a:gd name="connsiteX23-2713" fmla="*/ 367297 w 649642"/>
                    <a:gd name="connsiteY23-2714" fmla="*/ 296909 h 309279"/>
                    <a:gd name="connsiteX24-2715" fmla="*/ 338722 w 649642"/>
                    <a:gd name="connsiteY24-2716" fmla="*/ 301670 h 309279"/>
                    <a:gd name="connsiteX25-2717" fmla="*/ 383172 w 649642"/>
                    <a:gd name="connsiteY25-2718" fmla="*/ 209596 h 309279"/>
                    <a:gd name="connsiteX26-2719" fmla="*/ 318085 w 649642"/>
                    <a:gd name="connsiteY26-2720" fmla="*/ 236583 h 309279"/>
                    <a:gd name="connsiteX27-2721" fmla="*/ 238710 w 649642"/>
                    <a:gd name="connsiteY27-2722" fmla="*/ 231821 h 309279"/>
                    <a:gd name="connsiteX28-2723" fmla="*/ 167272 w 649642"/>
                    <a:gd name="connsiteY28-2724" fmla="*/ 282620 h 309279"/>
                    <a:gd name="connsiteX29-2725" fmla="*/ 200610 w 649642"/>
                    <a:gd name="connsiteY29-2726" fmla="*/ 214358 h 309279"/>
                    <a:gd name="connsiteX30-2727" fmla="*/ 5347 w 649642"/>
                    <a:gd name="connsiteY30-2728" fmla="*/ 242933 h 309279"/>
                    <a:gd name="connsiteX0-2729" fmla="*/ 5347 w 652214"/>
                    <a:gd name="connsiteY0-2730" fmla="*/ 242933 h 309279"/>
                    <a:gd name="connsiteX1-2731" fmla="*/ 59322 w 652214"/>
                    <a:gd name="connsiteY1-2732" fmla="*/ 122283 h 309279"/>
                    <a:gd name="connsiteX2-2733" fmla="*/ 105360 w 652214"/>
                    <a:gd name="connsiteY2-2734" fmla="*/ 74658 h 309279"/>
                    <a:gd name="connsiteX3-2735" fmla="*/ 87897 w 652214"/>
                    <a:gd name="connsiteY3-2736" fmla="*/ 50846 h 309279"/>
                    <a:gd name="connsiteX4-2737" fmla="*/ 110122 w 652214"/>
                    <a:gd name="connsiteY4-2738" fmla="*/ 6396 h 309279"/>
                    <a:gd name="connsiteX5-2739" fmla="*/ 165685 w 652214"/>
                    <a:gd name="connsiteY5-2740" fmla="*/ 4807 h 309279"/>
                    <a:gd name="connsiteX6-2741" fmla="*/ 184735 w 652214"/>
                    <a:gd name="connsiteY6-2742" fmla="*/ 49258 h 309279"/>
                    <a:gd name="connsiteX7-2743" fmla="*/ 181560 w 652214"/>
                    <a:gd name="connsiteY7-2744" fmla="*/ 73071 h 309279"/>
                    <a:gd name="connsiteX8-2745" fmla="*/ 230772 w 652214"/>
                    <a:gd name="connsiteY8-2746" fmla="*/ 22271 h 309279"/>
                    <a:gd name="connsiteX9-2747" fmla="*/ 353010 w 652214"/>
                    <a:gd name="connsiteY9-2748" fmla="*/ 4808 h 309279"/>
                    <a:gd name="connsiteX10-2749" fmla="*/ 506997 w 652214"/>
                    <a:gd name="connsiteY10-2750" fmla="*/ 65134 h 309279"/>
                    <a:gd name="connsiteX11-2751" fmla="*/ 580022 w 652214"/>
                    <a:gd name="connsiteY11-2752" fmla="*/ 142920 h 309279"/>
                    <a:gd name="connsiteX12-2753" fmla="*/ 646698 w 652214"/>
                    <a:gd name="connsiteY12-2754" fmla="*/ 211182 h 309279"/>
                    <a:gd name="connsiteX13-2755" fmla="*/ 637172 w 652214"/>
                    <a:gd name="connsiteY13-2756" fmla="*/ 258808 h 309279"/>
                    <a:gd name="connsiteX14-2757" fmla="*/ 630823 w 652214"/>
                    <a:gd name="connsiteY14-2758" fmla="*/ 274683 h 309279"/>
                    <a:gd name="connsiteX15-2759" fmla="*/ 591135 w 652214"/>
                    <a:gd name="connsiteY15-2760" fmla="*/ 293733 h 309279"/>
                    <a:gd name="connsiteX16-2761" fmla="*/ 465723 w 652214"/>
                    <a:gd name="connsiteY16-2762" fmla="*/ 296908 h 309279"/>
                    <a:gd name="connsiteX17-2763" fmla="*/ 427622 w 652214"/>
                    <a:gd name="connsiteY17-2764" fmla="*/ 285796 h 309279"/>
                    <a:gd name="connsiteX18-2765" fmla="*/ 634000 w 652214"/>
                    <a:gd name="connsiteY18-2766" fmla="*/ 242934 h 309279"/>
                    <a:gd name="connsiteX19-2767" fmla="*/ 633996 w 652214"/>
                    <a:gd name="connsiteY19-2768" fmla="*/ 220708 h 309279"/>
                    <a:gd name="connsiteX20-2769" fmla="*/ 564147 w 652214"/>
                    <a:gd name="connsiteY20-2770" fmla="*/ 190546 h 309279"/>
                    <a:gd name="connsiteX21-2771" fmla="*/ 578434 w 652214"/>
                    <a:gd name="connsiteY21-2772" fmla="*/ 200071 h 309279"/>
                    <a:gd name="connsiteX22-2773" fmla="*/ 514935 w 652214"/>
                    <a:gd name="connsiteY22-2774" fmla="*/ 234996 h 309279"/>
                    <a:gd name="connsiteX23-2775" fmla="*/ 433972 w 652214"/>
                    <a:gd name="connsiteY23-2776" fmla="*/ 239758 h 309279"/>
                    <a:gd name="connsiteX24-2777" fmla="*/ 367297 w 652214"/>
                    <a:gd name="connsiteY24-2778" fmla="*/ 296909 h 309279"/>
                    <a:gd name="connsiteX25-2779" fmla="*/ 338722 w 652214"/>
                    <a:gd name="connsiteY25-2780" fmla="*/ 301670 h 309279"/>
                    <a:gd name="connsiteX26-2781" fmla="*/ 383172 w 652214"/>
                    <a:gd name="connsiteY26-2782" fmla="*/ 209596 h 309279"/>
                    <a:gd name="connsiteX27-2783" fmla="*/ 318085 w 652214"/>
                    <a:gd name="connsiteY27-2784" fmla="*/ 236583 h 309279"/>
                    <a:gd name="connsiteX28-2785" fmla="*/ 238710 w 652214"/>
                    <a:gd name="connsiteY28-2786" fmla="*/ 231821 h 309279"/>
                    <a:gd name="connsiteX29-2787" fmla="*/ 167272 w 652214"/>
                    <a:gd name="connsiteY29-2788" fmla="*/ 282620 h 309279"/>
                    <a:gd name="connsiteX30-2789" fmla="*/ 200610 w 652214"/>
                    <a:gd name="connsiteY30-2790" fmla="*/ 214358 h 309279"/>
                    <a:gd name="connsiteX31" fmla="*/ 5347 w 652214"/>
                    <a:gd name="connsiteY31" fmla="*/ 242933 h 309279"/>
                    <a:gd name="connsiteX0-2791" fmla="*/ 5347 w 650353"/>
                    <a:gd name="connsiteY0-2792" fmla="*/ 242933 h 309279"/>
                    <a:gd name="connsiteX1-2793" fmla="*/ 59322 w 650353"/>
                    <a:gd name="connsiteY1-2794" fmla="*/ 122283 h 309279"/>
                    <a:gd name="connsiteX2-2795" fmla="*/ 105360 w 650353"/>
                    <a:gd name="connsiteY2-2796" fmla="*/ 74658 h 309279"/>
                    <a:gd name="connsiteX3-2797" fmla="*/ 87897 w 650353"/>
                    <a:gd name="connsiteY3-2798" fmla="*/ 50846 h 309279"/>
                    <a:gd name="connsiteX4-2799" fmla="*/ 110122 w 650353"/>
                    <a:gd name="connsiteY4-2800" fmla="*/ 6396 h 309279"/>
                    <a:gd name="connsiteX5-2801" fmla="*/ 165685 w 650353"/>
                    <a:gd name="connsiteY5-2802" fmla="*/ 4807 h 309279"/>
                    <a:gd name="connsiteX6-2803" fmla="*/ 184735 w 650353"/>
                    <a:gd name="connsiteY6-2804" fmla="*/ 49258 h 309279"/>
                    <a:gd name="connsiteX7-2805" fmla="*/ 181560 w 650353"/>
                    <a:gd name="connsiteY7-2806" fmla="*/ 73071 h 309279"/>
                    <a:gd name="connsiteX8-2807" fmla="*/ 230772 w 650353"/>
                    <a:gd name="connsiteY8-2808" fmla="*/ 22271 h 309279"/>
                    <a:gd name="connsiteX9-2809" fmla="*/ 353010 w 650353"/>
                    <a:gd name="connsiteY9-2810" fmla="*/ 4808 h 309279"/>
                    <a:gd name="connsiteX10-2811" fmla="*/ 506997 w 650353"/>
                    <a:gd name="connsiteY10-2812" fmla="*/ 65134 h 309279"/>
                    <a:gd name="connsiteX11-2813" fmla="*/ 580022 w 650353"/>
                    <a:gd name="connsiteY11-2814" fmla="*/ 142920 h 309279"/>
                    <a:gd name="connsiteX12-2815" fmla="*/ 646698 w 650353"/>
                    <a:gd name="connsiteY12-2816" fmla="*/ 211182 h 309279"/>
                    <a:gd name="connsiteX13-2817" fmla="*/ 637172 w 650353"/>
                    <a:gd name="connsiteY13-2818" fmla="*/ 258808 h 309279"/>
                    <a:gd name="connsiteX14-2819" fmla="*/ 630823 w 650353"/>
                    <a:gd name="connsiteY14-2820" fmla="*/ 274683 h 309279"/>
                    <a:gd name="connsiteX15-2821" fmla="*/ 591135 w 650353"/>
                    <a:gd name="connsiteY15-2822" fmla="*/ 293733 h 309279"/>
                    <a:gd name="connsiteX16-2823" fmla="*/ 465723 w 650353"/>
                    <a:gd name="connsiteY16-2824" fmla="*/ 296908 h 309279"/>
                    <a:gd name="connsiteX17-2825" fmla="*/ 427622 w 650353"/>
                    <a:gd name="connsiteY17-2826" fmla="*/ 285796 h 309279"/>
                    <a:gd name="connsiteX18-2827" fmla="*/ 634000 w 650353"/>
                    <a:gd name="connsiteY18-2828" fmla="*/ 242934 h 309279"/>
                    <a:gd name="connsiteX19-2829" fmla="*/ 629234 w 650353"/>
                    <a:gd name="connsiteY19-2830" fmla="*/ 223883 h 309279"/>
                    <a:gd name="connsiteX20-2831" fmla="*/ 564147 w 650353"/>
                    <a:gd name="connsiteY20-2832" fmla="*/ 190546 h 309279"/>
                    <a:gd name="connsiteX21-2833" fmla="*/ 578434 w 650353"/>
                    <a:gd name="connsiteY21-2834" fmla="*/ 200071 h 309279"/>
                    <a:gd name="connsiteX22-2835" fmla="*/ 514935 w 650353"/>
                    <a:gd name="connsiteY22-2836" fmla="*/ 234996 h 309279"/>
                    <a:gd name="connsiteX23-2837" fmla="*/ 433972 w 650353"/>
                    <a:gd name="connsiteY23-2838" fmla="*/ 239758 h 309279"/>
                    <a:gd name="connsiteX24-2839" fmla="*/ 367297 w 650353"/>
                    <a:gd name="connsiteY24-2840" fmla="*/ 296909 h 309279"/>
                    <a:gd name="connsiteX25-2841" fmla="*/ 338722 w 650353"/>
                    <a:gd name="connsiteY25-2842" fmla="*/ 301670 h 309279"/>
                    <a:gd name="connsiteX26-2843" fmla="*/ 383172 w 650353"/>
                    <a:gd name="connsiteY26-2844" fmla="*/ 209596 h 309279"/>
                    <a:gd name="connsiteX27-2845" fmla="*/ 318085 w 650353"/>
                    <a:gd name="connsiteY27-2846" fmla="*/ 236583 h 309279"/>
                    <a:gd name="connsiteX28-2847" fmla="*/ 238710 w 650353"/>
                    <a:gd name="connsiteY28-2848" fmla="*/ 231821 h 309279"/>
                    <a:gd name="connsiteX29-2849" fmla="*/ 167272 w 650353"/>
                    <a:gd name="connsiteY29-2850" fmla="*/ 282620 h 309279"/>
                    <a:gd name="connsiteX30-2851" fmla="*/ 200610 w 650353"/>
                    <a:gd name="connsiteY30-2852" fmla="*/ 214358 h 309279"/>
                    <a:gd name="connsiteX31-2853" fmla="*/ 5347 w 650353"/>
                    <a:gd name="connsiteY31-2854" fmla="*/ 242933 h 309279"/>
                    <a:gd name="connsiteX0-2855" fmla="*/ 5347 w 650353"/>
                    <a:gd name="connsiteY0-2856" fmla="*/ 242933 h 309279"/>
                    <a:gd name="connsiteX1-2857" fmla="*/ 59322 w 650353"/>
                    <a:gd name="connsiteY1-2858" fmla="*/ 122283 h 309279"/>
                    <a:gd name="connsiteX2-2859" fmla="*/ 105360 w 650353"/>
                    <a:gd name="connsiteY2-2860" fmla="*/ 74658 h 309279"/>
                    <a:gd name="connsiteX3-2861" fmla="*/ 87897 w 650353"/>
                    <a:gd name="connsiteY3-2862" fmla="*/ 50846 h 309279"/>
                    <a:gd name="connsiteX4-2863" fmla="*/ 110122 w 650353"/>
                    <a:gd name="connsiteY4-2864" fmla="*/ 6396 h 309279"/>
                    <a:gd name="connsiteX5-2865" fmla="*/ 165685 w 650353"/>
                    <a:gd name="connsiteY5-2866" fmla="*/ 4807 h 309279"/>
                    <a:gd name="connsiteX6-2867" fmla="*/ 184735 w 650353"/>
                    <a:gd name="connsiteY6-2868" fmla="*/ 49258 h 309279"/>
                    <a:gd name="connsiteX7-2869" fmla="*/ 181560 w 650353"/>
                    <a:gd name="connsiteY7-2870" fmla="*/ 73071 h 309279"/>
                    <a:gd name="connsiteX8-2871" fmla="*/ 230772 w 650353"/>
                    <a:gd name="connsiteY8-2872" fmla="*/ 22271 h 309279"/>
                    <a:gd name="connsiteX9-2873" fmla="*/ 353010 w 650353"/>
                    <a:gd name="connsiteY9-2874" fmla="*/ 4808 h 309279"/>
                    <a:gd name="connsiteX10-2875" fmla="*/ 506997 w 650353"/>
                    <a:gd name="connsiteY10-2876" fmla="*/ 65134 h 309279"/>
                    <a:gd name="connsiteX11-2877" fmla="*/ 580022 w 650353"/>
                    <a:gd name="connsiteY11-2878" fmla="*/ 142920 h 309279"/>
                    <a:gd name="connsiteX12-2879" fmla="*/ 646698 w 650353"/>
                    <a:gd name="connsiteY12-2880" fmla="*/ 211182 h 309279"/>
                    <a:gd name="connsiteX13-2881" fmla="*/ 640347 w 650353"/>
                    <a:gd name="connsiteY13-2882" fmla="*/ 254045 h 309279"/>
                    <a:gd name="connsiteX14-2883" fmla="*/ 630823 w 650353"/>
                    <a:gd name="connsiteY14-2884" fmla="*/ 274683 h 309279"/>
                    <a:gd name="connsiteX15-2885" fmla="*/ 591135 w 650353"/>
                    <a:gd name="connsiteY15-2886" fmla="*/ 293733 h 309279"/>
                    <a:gd name="connsiteX16-2887" fmla="*/ 465723 w 650353"/>
                    <a:gd name="connsiteY16-2888" fmla="*/ 296908 h 309279"/>
                    <a:gd name="connsiteX17-2889" fmla="*/ 427622 w 650353"/>
                    <a:gd name="connsiteY17-2890" fmla="*/ 285796 h 309279"/>
                    <a:gd name="connsiteX18-2891" fmla="*/ 634000 w 650353"/>
                    <a:gd name="connsiteY18-2892" fmla="*/ 242934 h 309279"/>
                    <a:gd name="connsiteX19-2893" fmla="*/ 629234 w 650353"/>
                    <a:gd name="connsiteY19-2894" fmla="*/ 223883 h 309279"/>
                    <a:gd name="connsiteX20-2895" fmla="*/ 564147 w 650353"/>
                    <a:gd name="connsiteY20-2896" fmla="*/ 190546 h 309279"/>
                    <a:gd name="connsiteX21-2897" fmla="*/ 578434 w 650353"/>
                    <a:gd name="connsiteY21-2898" fmla="*/ 200071 h 309279"/>
                    <a:gd name="connsiteX22-2899" fmla="*/ 514935 w 650353"/>
                    <a:gd name="connsiteY22-2900" fmla="*/ 234996 h 309279"/>
                    <a:gd name="connsiteX23-2901" fmla="*/ 433972 w 650353"/>
                    <a:gd name="connsiteY23-2902" fmla="*/ 239758 h 309279"/>
                    <a:gd name="connsiteX24-2903" fmla="*/ 367297 w 650353"/>
                    <a:gd name="connsiteY24-2904" fmla="*/ 296909 h 309279"/>
                    <a:gd name="connsiteX25-2905" fmla="*/ 338722 w 650353"/>
                    <a:gd name="connsiteY25-2906" fmla="*/ 301670 h 309279"/>
                    <a:gd name="connsiteX26-2907" fmla="*/ 383172 w 650353"/>
                    <a:gd name="connsiteY26-2908" fmla="*/ 209596 h 309279"/>
                    <a:gd name="connsiteX27-2909" fmla="*/ 318085 w 650353"/>
                    <a:gd name="connsiteY27-2910" fmla="*/ 236583 h 309279"/>
                    <a:gd name="connsiteX28-2911" fmla="*/ 238710 w 650353"/>
                    <a:gd name="connsiteY28-2912" fmla="*/ 231821 h 309279"/>
                    <a:gd name="connsiteX29-2913" fmla="*/ 167272 w 650353"/>
                    <a:gd name="connsiteY29-2914" fmla="*/ 282620 h 309279"/>
                    <a:gd name="connsiteX30-2915" fmla="*/ 200610 w 650353"/>
                    <a:gd name="connsiteY30-2916" fmla="*/ 214358 h 309279"/>
                    <a:gd name="connsiteX31-2917" fmla="*/ 5347 w 650353"/>
                    <a:gd name="connsiteY31-2918" fmla="*/ 242933 h 309279"/>
                    <a:gd name="connsiteX0-2919" fmla="*/ 5347 w 650324"/>
                    <a:gd name="connsiteY0-2920" fmla="*/ 242933 h 309279"/>
                    <a:gd name="connsiteX1-2921" fmla="*/ 59322 w 650324"/>
                    <a:gd name="connsiteY1-2922" fmla="*/ 122283 h 309279"/>
                    <a:gd name="connsiteX2-2923" fmla="*/ 105360 w 650324"/>
                    <a:gd name="connsiteY2-2924" fmla="*/ 74658 h 309279"/>
                    <a:gd name="connsiteX3-2925" fmla="*/ 87897 w 650324"/>
                    <a:gd name="connsiteY3-2926" fmla="*/ 50846 h 309279"/>
                    <a:gd name="connsiteX4-2927" fmla="*/ 110122 w 650324"/>
                    <a:gd name="connsiteY4-2928" fmla="*/ 6396 h 309279"/>
                    <a:gd name="connsiteX5-2929" fmla="*/ 165685 w 650324"/>
                    <a:gd name="connsiteY5-2930" fmla="*/ 4807 h 309279"/>
                    <a:gd name="connsiteX6-2931" fmla="*/ 184735 w 650324"/>
                    <a:gd name="connsiteY6-2932" fmla="*/ 49258 h 309279"/>
                    <a:gd name="connsiteX7-2933" fmla="*/ 181560 w 650324"/>
                    <a:gd name="connsiteY7-2934" fmla="*/ 73071 h 309279"/>
                    <a:gd name="connsiteX8-2935" fmla="*/ 230772 w 650324"/>
                    <a:gd name="connsiteY8-2936" fmla="*/ 22271 h 309279"/>
                    <a:gd name="connsiteX9-2937" fmla="*/ 353010 w 650324"/>
                    <a:gd name="connsiteY9-2938" fmla="*/ 4808 h 309279"/>
                    <a:gd name="connsiteX10-2939" fmla="*/ 506997 w 650324"/>
                    <a:gd name="connsiteY10-2940" fmla="*/ 65134 h 309279"/>
                    <a:gd name="connsiteX11-2941" fmla="*/ 580022 w 650324"/>
                    <a:gd name="connsiteY11-2942" fmla="*/ 142920 h 309279"/>
                    <a:gd name="connsiteX12-2943" fmla="*/ 646698 w 650324"/>
                    <a:gd name="connsiteY12-2944" fmla="*/ 211182 h 309279"/>
                    <a:gd name="connsiteX13-2945" fmla="*/ 640347 w 650324"/>
                    <a:gd name="connsiteY13-2946" fmla="*/ 254045 h 309279"/>
                    <a:gd name="connsiteX14-2947" fmla="*/ 630823 w 650324"/>
                    <a:gd name="connsiteY14-2948" fmla="*/ 274683 h 309279"/>
                    <a:gd name="connsiteX15-2949" fmla="*/ 591135 w 650324"/>
                    <a:gd name="connsiteY15-2950" fmla="*/ 293733 h 309279"/>
                    <a:gd name="connsiteX16-2951" fmla="*/ 465723 w 650324"/>
                    <a:gd name="connsiteY16-2952" fmla="*/ 296908 h 309279"/>
                    <a:gd name="connsiteX17-2953" fmla="*/ 572085 w 650324"/>
                    <a:gd name="connsiteY17-2954" fmla="*/ 273096 h 309279"/>
                    <a:gd name="connsiteX18-2955" fmla="*/ 634000 w 650324"/>
                    <a:gd name="connsiteY18-2956" fmla="*/ 242934 h 309279"/>
                    <a:gd name="connsiteX19-2957" fmla="*/ 629234 w 650324"/>
                    <a:gd name="connsiteY19-2958" fmla="*/ 223883 h 309279"/>
                    <a:gd name="connsiteX20-2959" fmla="*/ 564147 w 650324"/>
                    <a:gd name="connsiteY20-2960" fmla="*/ 190546 h 309279"/>
                    <a:gd name="connsiteX21-2961" fmla="*/ 578434 w 650324"/>
                    <a:gd name="connsiteY21-2962" fmla="*/ 200071 h 309279"/>
                    <a:gd name="connsiteX22-2963" fmla="*/ 514935 w 650324"/>
                    <a:gd name="connsiteY22-2964" fmla="*/ 234996 h 309279"/>
                    <a:gd name="connsiteX23-2965" fmla="*/ 433972 w 650324"/>
                    <a:gd name="connsiteY23-2966" fmla="*/ 239758 h 309279"/>
                    <a:gd name="connsiteX24-2967" fmla="*/ 367297 w 650324"/>
                    <a:gd name="connsiteY24-2968" fmla="*/ 296909 h 309279"/>
                    <a:gd name="connsiteX25-2969" fmla="*/ 338722 w 650324"/>
                    <a:gd name="connsiteY25-2970" fmla="*/ 301670 h 309279"/>
                    <a:gd name="connsiteX26-2971" fmla="*/ 383172 w 650324"/>
                    <a:gd name="connsiteY26-2972" fmla="*/ 209596 h 309279"/>
                    <a:gd name="connsiteX27-2973" fmla="*/ 318085 w 650324"/>
                    <a:gd name="connsiteY27-2974" fmla="*/ 236583 h 309279"/>
                    <a:gd name="connsiteX28-2975" fmla="*/ 238710 w 650324"/>
                    <a:gd name="connsiteY28-2976" fmla="*/ 231821 h 309279"/>
                    <a:gd name="connsiteX29-2977" fmla="*/ 167272 w 650324"/>
                    <a:gd name="connsiteY29-2978" fmla="*/ 282620 h 309279"/>
                    <a:gd name="connsiteX30-2979" fmla="*/ 200610 w 650324"/>
                    <a:gd name="connsiteY30-2980" fmla="*/ 214358 h 309279"/>
                    <a:gd name="connsiteX31-2981" fmla="*/ 5347 w 650324"/>
                    <a:gd name="connsiteY31-2982" fmla="*/ 242933 h 309279"/>
                    <a:gd name="connsiteX0-2983" fmla="*/ 5347 w 650324"/>
                    <a:gd name="connsiteY0-2984" fmla="*/ 242933 h 309279"/>
                    <a:gd name="connsiteX1-2985" fmla="*/ 59322 w 650324"/>
                    <a:gd name="connsiteY1-2986" fmla="*/ 122283 h 309279"/>
                    <a:gd name="connsiteX2-2987" fmla="*/ 105360 w 650324"/>
                    <a:gd name="connsiteY2-2988" fmla="*/ 74658 h 309279"/>
                    <a:gd name="connsiteX3-2989" fmla="*/ 87897 w 650324"/>
                    <a:gd name="connsiteY3-2990" fmla="*/ 50846 h 309279"/>
                    <a:gd name="connsiteX4-2991" fmla="*/ 110122 w 650324"/>
                    <a:gd name="connsiteY4-2992" fmla="*/ 6396 h 309279"/>
                    <a:gd name="connsiteX5-2993" fmla="*/ 165685 w 650324"/>
                    <a:gd name="connsiteY5-2994" fmla="*/ 4807 h 309279"/>
                    <a:gd name="connsiteX6-2995" fmla="*/ 184735 w 650324"/>
                    <a:gd name="connsiteY6-2996" fmla="*/ 49258 h 309279"/>
                    <a:gd name="connsiteX7-2997" fmla="*/ 181560 w 650324"/>
                    <a:gd name="connsiteY7-2998" fmla="*/ 73071 h 309279"/>
                    <a:gd name="connsiteX8-2999" fmla="*/ 230772 w 650324"/>
                    <a:gd name="connsiteY8-3000" fmla="*/ 22271 h 309279"/>
                    <a:gd name="connsiteX9-3001" fmla="*/ 353010 w 650324"/>
                    <a:gd name="connsiteY9-3002" fmla="*/ 4808 h 309279"/>
                    <a:gd name="connsiteX10-3003" fmla="*/ 506997 w 650324"/>
                    <a:gd name="connsiteY10-3004" fmla="*/ 65134 h 309279"/>
                    <a:gd name="connsiteX11-3005" fmla="*/ 580022 w 650324"/>
                    <a:gd name="connsiteY11-3006" fmla="*/ 142920 h 309279"/>
                    <a:gd name="connsiteX12-3007" fmla="*/ 646698 w 650324"/>
                    <a:gd name="connsiteY12-3008" fmla="*/ 211182 h 309279"/>
                    <a:gd name="connsiteX13-3009" fmla="*/ 640347 w 650324"/>
                    <a:gd name="connsiteY13-3010" fmla="*/ 254045 h 309279"/>
                    <a:gd name="connsiteX14-3011" fmla="*/ 630823 w 650324"/>
                    <a:gd name="connsiteY14-3012" fmla="*/ 274683 h 309279"/>
                    <a:gd name="connsiteX15-3013" fmla="*/ 591135 w 650324"/>
                    <a:gd name="connsiteY15-3014" fmla="*/ 293733 h 309279"/>
                    <a:gd name="connsiteX16-3015" fmla="*/ 430798 w 650324"/>
                    <a:gd name="connsiteY16-3016" fmla="*/ 284208 h 309279"/>
                    <a:gd name="connsiteX17-3017" fmla="*/ 572085 w 650324"/>
                    <a:gd name="connsiteY17-3018" fmla="*/ 273096 h 309279"/>
                    <a:gd name="connsiteX18-3019" fmla="*/ 634000 w 650324"/>
                    <a:gd name="connsiteY18-3020" fmla="*/ 242934 h 309279"/>
                    <a:gd name="connsiteX19-3021" fmla="*/ 629234 w 650324"/>
                    <a:gd name="connsiteY19-3022" fmla="*/ 223883 h 309279"/>
                    <a:gd name="connsiteX20-3023" fmla="*/ 564147 w 650324"/>
                    <a:gd name="connsiteY20-3024" fmla="*/ 190546 h 309279"/>
                    <a:gd name="connsiteX21-3025" fmla="*/ 578434 w 650324"/>
                    <a:gd name="connsiteY21-3026" fmla="*/ 200071 h 309279"/>
                    <a:gd name="connsiteX22-3027" fmla="*/ 514935 w 650324"/>
                    <a:gd name="connsiteY22-3028" fmla="*/ 234996 h 309279"/>
                    <a:gd name="connsiteX23-3029" fmla="*/ 433972 w 650324"/>
                    <a:gd name="connsiteY23-3030" fmla="*/ 239758 h 309279"/>
                    <a:gd name="connsiteX24-3031" fmla="*/ 367297 w 650324"/>
                    <a:gd name="connsiteY24-3032" fmla="*/ 296909 h 309279"/>
                    <a:gd name="connsiteX25-3033" fmla="*/ 338722 w 650324"/>
                    <a:gd name="connsiteY25-3034" fmla="*/ 301670 h 309279"/>
                    <a:gd name="connsiteX26-3035" fmla="*/ 383172 w 650324"/>
                    <a:gd name="connsiteY26-3036" fmla="*/ 209596 h 309279"/>
                    <a:gd name="connsiteX27-3037" fmla="*/ 318085 w 650324"/>
                    <a:gd name="connsiteY27-3038" fmla="*/ 236583 h 309279"/>
                    <a:gd name="connsiteX28-3039" fmla="*/ 238710 w 650324"/>
                    <a:gd name="connsiteY28-3040" fmla="*/ 231821 h 309279"/>
                    <a:gd name="connsiteX29-3041" fmla="*/ 167272 w 650324"/>
                    <a:gd name="connsiteY29-3042" fmla="*/ 282620 h 309279"/>
                    <a:gd name="connsiteX30-3043" fmla="*/ 200610 w 650324"/>
                    <a:gd name="connsiteY30-3044" fmla="*/ 214358 h 309279"/>
                    <a:gd name="connsiteX31-3045" fmla="*/ 5347 w 650324"/>
                    <a:gd name="connsiteY31-3046" fmla="*/ 242933 h 309279"/>
                    <a:gd name="connsiteX0-3047" fmla="*/ 5347 w 650578"/>
                    <a:gd name="connsiteY0-3048" fmla="*/ 242933 h 309279"/>
                    <a:gd name="connsiteX1-3049" fmla="*/ 59322 w 650578"/>
                    <a:gd name="connsiteY1-3050" fmla="*/ 122283 h 309279"/>
                    <a:gd name="connsiteX2-3051" fmla="*/ 105360 w 650578"/>
                    <a:gd name="connsiteY2-3052" fmla="*/ 74658 h 309279"/>
                    <a:gd name="connsiteX3-3053" fmla="*/ 87897 w 650578"/>
                    <a:gd name="connsiteY3-3054" fmla="*/ 50846 h 309279"/>
                    <a:gd name="connsiteX4-3055" fmla="*/ 110122 w 650578"/>
                    <a:gd name="connsiteY4-3056" fmla="*/ 6396 h 309279"/>
                    <a:gd name="connsiteX5-3057" fmla="*/ 165685 w 650578"/>
                    <a:gd name="connsiteY5-3058" fmla="*/ 4807 h 309279"/>
                    <a:gd name="connsiteX6-3059" fmla="*/ 184735 w 650578"/>
                    <a:gd name="connsiteY6-3060" fmla="*/ 49258 h 309279"/>
                    <a:gd name="connsiteX7-3061" fmla="*/ 181560 w 650578"/>
                    <a:gd name="connsiteY7-3062" fmla="*/ 73071 h 309279"/>
                    <a:gd name="connsiteX8-3063" fmla="*/ 230772 w 650578"/>
                    <a:gd name="connsiteY8-3064" fmla="*/ 22271 h 309279"/>
                    <a:gd name="connsiteX9-3065" fmla="*/ 353010 w 650578"/>
                    <a:gd name="connsiteY9-3066" fmla="*/ 4808 h 309279"/>
                    <a:gd name="connsiteX10-3067" fmla="*/ 506997 w 650578"/>
                    <a:gd name="connsiteY10-3068" fmla="*/ 65134 h 309279"/>
                    <a:gd name="connsiteX11-3069" fmla="*/ 580022 w 650578"/>
                    <a:gd name="connsiteY11-3070" fmla="*/ 142920 h 309279"/>
                    <a:gd name="connsiteX12-3071" fmla="*/ 646698 w 650578"/>
                    <a:gd name="connsiteY12-3072" fmla="*/ 211182 h 309279"/>
                    <a:gd name="connsiteX13-3073" fmla="*/ 640347 w 650578"/>
                    <a:gd name="connsiteY13-3074" fmla="*/ 254045 h 309279"/>
                    <a:gd name="connsiteX14-3075" fmla="*/ 621298 w 650578"/>
                    <a:gd name="connsiteY14-3076" fmla="*/ 274683 h 309279"/>
                    <a:gd name="connsiteX15-3077" fmla="*/ 591135 w 650578"/>
                    <a:gd name="connsiteY15-3078" fmla="*/ 293733 h 309279"/>
                    <a:gd name="connsiteX16-3079" fmla="*/ 430798 w 650578"/>
                    <a:gd name="connsiteY16-3080" fmla="*/ 284208 h 309279"/>
                    <a:gd name="connsiteX17-3081" fmla="*/ 572085 w 650578"/>
                    <a:gd name="connsiteY17-3082" fmla="*/ 273096 h 309279"/>
                    <a:gd name="connsiteX18-3083" fmla="*/ 634000 w 650578"/>
                    <a:gd name="connsiteY18-3084" fmla="*/ 242934 h 309279"/>
                    <a:gd name="connsiteX19-3085" fmla="*/ 629234 w 650578"/>
                    <a:gd name="connsiteY19-3086" fmla="*/ 223883 h 309279"/>
                    <a:gd name="connsiteX20-3087" fmla="*/ 564147 w 650578"/>
                    <a:gd name="connsiteY20-3088" fmla="*/ 190546 h 309279"/>
                    <a:gd name="connsiteX21-3089" fmla="*/ 578434 w 650578"/>
                    <a:gd name="connsiteY21-3090" fmla="*/ 200071 h 309279"/>
                    <a:gd name="connsiteX22-3091" fmla="*/ 514935 w 650578"/>
                    <a:gd name="connsiteY22-3092" fmla="*/ 234996 h 309279"/>
                    <a:gd name="connsiteX23-3093" fmla="*/ 433972 w 650578"/>
                    <a:gd name="connsiteY23-3094" fmla="*/ 239758 h 309279"/>
                    <a:gd name="connsiteX24-3095" fmla="*/ 367297 w 650578"/>
                    <a:gd name="connsiteY24-3096" fmla="*/ 296909 h 309279"/>
                    <a:gd name="connsiteX25-3097" fmla="*/ 338722 w 650578"/>
                    <a:gd name="connsiteY25-3098" fmla="*/ 301670 h 309279"/>
                    <a:gd name="connsiteX26-3099" fmla="*/ 383172 w 650578"/>
                    <a:gd name="connsiteY26-3100" fmla="*/ 209596 h 309279"/>
                    <a:gd name="connsiteX27-3101" fmla="*/ 318085 w 650578"/>
                    <a:gd name="connsiteY27-3102" fmla="*/ 236583 h 309279"/>
                    <a:gd name="connsiteX28-3103" fmla="*/ 238710 w 650578"/>
                    <a:gd name="connsiteY28-3104" fmla="*/ 231821 h 309279"/>
                    <a:gd name="connsiteX29-3105" fmla="*/ 167272 w 650578"/>
                    <a:gd name="connsiteY29-3106" fmla="*/ 282620 h 309279"/>
                    <a:gd name="connsiteX30-3107" fmla="*/ 200610 w 650578"/>
                    <a:gd name="connsiteY30-3108" fmla="*/ 214358 h 309279"/>
                    <a:gd name="connsiteX31-3109" fmla="*/ 5347 w 650578"/>
                    <a:gd name="connsiteY31-3110" fmla="*/ 242933 h 309279"/>
                    <a:gd name="connsiteX0-3111" fmla="*/ 5347 w 650578"/>
                    <a:gd name="connsiteY0-3112" fmla="*/ 242933 h 309279"/>
                    <a:gd name="connsiteX1-3113" fmla="*/ 59322 w 650578"/>
                    <a:gd name="connsiteY1-3114" fmla="*/ 122283 h 309279"/>
                    <a:gd name="connsiteX2-3115" fmla="*/ 105360 w 650578"/>
                    <a:gd name="connsiteY2-3116" fmla="*/ 74658 h 309279"/>
                    <a:gd name="connsiteX3-3117" fmla="*/ 87897 w 650578"/>
                    <a:gd name="connsiteY3-3118" fmla="*/ 50846 h 309279"/>
                    <a:gd name="connsiteX4-3119" fmla="*/ 110122 w 650578"/>
                    <a:gd name="connsiteY4-3120" fmla="*/ 6396 h 309279"/>
                    <a:gd name="connsiteX5-3121" fmla="*/ 165685 w 650578"/>
                    <a:gd name="connsiteY5-3122" fmla="*/ 4807 h 309279"/>
                    <a:gd name="connsiteX6-3123" fmla="*/ 184735 w 650578"/>
                    <a:gd name="connsiteY6-3124" fmla="*/ 49258 h 309279"/>
                    <a:gd name="connsiteX7-3125" fmla="*/ 181560 w 650578"/>
                    <a:gd name="connsiteY7-3126" fmla="*/ 73071 h 309279"/>
                    <a:gd name="connsiteX8-3127" fmla="*/ 230772 w 650578"/>
                    <a:gd name="connsiteY8-3128" fmla="*/ 22271 h 309279"/>
                    <a:gd name="connsiteX9-3129" fmla="*/ 353010 w 650578"/>
                    <a:gd name="connsiteY9-3130" fmla="*/ 4808 h 309279"/>
                    <a:gd name="connsiteX10-3131" fmla="*/ 506997 w 650578"/>
                    <a:gd name="connsiteY10-3132" fmla="*/ 65134 h 309279"/>
                    <a:gd name="connsiteX11-3133" fmla="*/ 580022 w 650578"/>
                    <a:gd name="connsiteY11-3134" fmla="*/ 142920 h 309279"/>
                    <a:gd name="connsiteX12-3135" fmla="*/ 646698 w 650578"/>
                    <a:gd name="connsiteY12-3136" fmla="*/ 211182 h 309279"/>
                    <a:gd name="connsiteX13-3137" fmla="*/ 640347 w 650578"/>
                    <a:gd name="connsiteY13-3138" fmla="*/ 254045 h 309279"/>
                    <a:gd name="connsiteX14-3139" fmla="*/ 621298 w 650578"/>
                    <a:gd name="connsiteY14-3140" fmla="*/ 274683 h 309279"/>
                    <a:gd name="connsiteX15-3141" fmla="*/ 581610 w 650578"/>
                    <a:gd name="connsiteY15-3142" fmla="*/ 287383 h 309279"/>
                    <a:gd name="connsiteX16-3143" fmla="*/ 430798 w 650578"/>
                    <a:gd name="connsiteY16-3144" fmla="*/ 284208 h 309279"/>
                    <a:gd name="connsiteX17-3145" fmla="*/ 572085 w 650578"/>
                    <a:gd name="connsiteY17-3146" fmla="*/ 273096 h 309279"/>
                    <a:gd name="connsiteX18-3147" fmla="*/ 634000 w 650578"/>
                    <a:gd name="connsiteY18-3148" fmla="*/ 242934 h 309279"/>
                    <a:gd name="connsiteX19-3149" fmla="*/ 629234 w 650578"/>
                    <a:gd name="connsiteY19-3150" fmla="*/ 223883 h 309279"/>
                    <a:gd name="connsiteX20-3151" fmla="*/ 564147 w 650578"/>
                    <a:gd name="connsiteY20-3152" fmla="*/ 190546 h 309279"/>
                    <a:gd name="connsiteX21-3153" fmla="*/ 578434 w 650578"/>
                    <a:gd name="connsiteY21-3154" fmla="*/ 200071 h 309279"/>
                    <a:gd name="connsiteX22-3155" fmla="*/ 514935 w 650578"/>
                    <a:gd name="connsiteY22-3156" fmla="*/ 234996 h 309279"/>
                    <a:gd name="connsiteX23-3157" fmla="*/ 433972 w 650578"/>
                    <a:gd name="connsiteY23-3158" fmla="*/ 239758 h 309279"/>
                    <a:gd name="connsiteX24-3159" fmla="*/ 367297 w 650578"/>
                    <a:gd name="connsiteY24-3160" fmla="*/ 296909 h 309279"/>
                    <a:gd name="connsiteX25-3161" fmla="*/ 338722 w 650578"/>
                    <a:gd name="connsiteY25-3162" fmla="*/ 301670 h 309279"/>
                    <a:gd name="connsiteX26-3163" fmla="*/ 383172 w 650578"/>
                    <a:gd name="connsiteY26-3164" fmla="*/ 209596 h 309279"/>
                    <a:gd name="connsiteX27-3165" fmla="*/ 318085 w 650578"/>
                    <a:gd name="connsiteY27-3166" fmla="*/ 236583 h 309279"/>
                    <a:gd name="connsiteX28-3167" fmla="*/ 238710 w 650578"/>
                    <a:gd name="connsiteY28-3168" fmla="*/ 231821 h 309279"/>
                    <a:gd name="connsiteX29-3169" fmla="*/ 167272 w 650578"/>
                    <a:gd name="connsiteY29-3170" fmla="*/ 282620 h 309279"/>
                    <a:gd name="connsiteX30-3171" fmla="*/ 200610 w 650578"/>
                    <a:gd name="connsiteY30-3172" fmla="*/ 214358 h 309279"/>
                    <a:gd name="connsiteX31-3173" fmla="*/ 5347 w 650578"/>
                    <a:gd name="connsiteY31-3174" fmla="*/ 242933 h 309279"/>
                    <a:gd name="connsiteX0-3175" fmla="*/ 5347 w 643530"/>
                    <a:gd name="connsiteY0-3176" fmla="*/ 242933 h 309279"/>
                    <a:gd name="connsiteX1-3177" fmla="*/ 59322 w 643530"/>
                    <a:gd name="connsiteY1-3178" fmla="*/ 122283 h 309279"/>
                    <a:gd name="connsiteX2-3179" fmla="*/ 105360 w 643530"/>
                    <a:gd name="connsiteY2-3180" fmla="*/ 74658 h 309279"/>
                    <a:gd name="connsiteX3-3181" fmla="*/ 87897 w 643530"/>
                    <a:gd name="connsiteY3-3182" fmla="*/ 50846 h 309279"/>
                    <a:gd name="connsiteX4-3183" fmla="*/ 110122 w 643530"/>
                    <a:gd name="connsiteY4-3184" fmla="*/ 6396 h 309279"/>
                    <a:gd name="connsiteX5-3185" fmla="*/ 165685 w 643530"/>
                    <a:gd name="connsiteY5-3186" fmla="*/ 4807 h 309279"/>
                    <a:gd name="connsiteX6-3187" fmla="*/ 184735 w 643530"/>
                    <a:gd name="connsiteY6-3188" fmla="*/ 49258 h 309279"/>
                    <a:gd name="connsiteX7-3189" fmla="*/ 181560 w 643530"/>
                    <a:gd name="connsiteY7-3190" fmla="*/ 73071 h 309279"/>
                    <a:gd name="connsiteX8-3191" fmla="*/ 230772 w 643530"/>
                    <a:gd name="connsiteY8-3192" fmla="*/ 22271 h 309279"/>
                    <a:gd name="connsiteX9-3193" fmla="*/ 353010 w 643530"/>
                    <a:gd name="connsiteY9-3194" fmla="*/ 4808 h 309279"/>
                    <a:gd name="connsiteX10-3195" fmla="*/ 506997 w 643530"/>
                    <a:gd name="connsiteY10-3196" fmla="*/ 65134 h 309279"/>
                    <a:gd name="connsiteX11-3197" fmla="*/ 580022 w 643530"/>
                    <a:gd name="connsiteY11-3198" fmla="*/ 142920 h 309279"/>
                    <a:gd name="connsiteX12-3199" fmla="*/ 637173 w 643530"/>
                    <a:gd name="connsiteY12-3200" fmla="*/ 215945 h 309279"/>
                    <a:gd name="connsiteX13-3201" fmla="*/ 640347 w 643530"/>
                    <a:gd name="connsiteY13-3202" fmla="*/ 254045 h 309279"/>
                    <a:gd name="connsiteX14-3203" fmla="*/ 621298 w 643530"/>
                    <a:gd name="connsiteY14-3204" fmla="*/ 274683 h 309279"/>
                    <a:gd name="connsiteX15-3205" fmla="*/ 581610 w 643530"/>
                    <a:gd name="connsiteY15-3206" fmla="*/ 287383 h 309279"/>
                    <a:gd name="connsiteX16-3207" fmla="*/ 430798 w 643530"/>
                    <a:gd name="connsiteY16-3208" fmla="*/ 284208 h 309279"/>
                    <a:gd name="connsiteX17-3209" fmla="*/ 572085 w 643530"/>
                    <a:gd name="connsiteY17-3210" fmla="*/ 273096 h 309279"/>
                    <a:gd name="connsiteX18-3211" fmla="*/ 634000 w 643530"/>
                    <a:gd name="connsiteY18-3212" fmla="*/ 242934 h 309279"/>
                    <a:gd name="connsiteX19-3213" fmla="*/ 629234 w 643530"/>
                    <a:gd name="connsiteY19-3214" fmla="*/ 223883 h 309279"/>
                    <a:gd name="connsiteX20-3215" fmla="*/ 564147 w 643530"/>
                    <a:gd name="connsiteY20-3216" fmla="*/ 190546 h 309279"/>
                    <a:gd name="connsiteX21-3217" fmla="*/ 578434 w 643530"/>
                    <a:gd name="connsiteY21-3218" fmla="*/ 200071 h 309279"/>
                    <a:gd name="connsiteX22-3219" fmla="*/ 514935 w 643530"/>
                    <a:gd name="connsiteY22-3220" fmla="*/ 234996 h 309279"/>
                    <a:gd name="connsiteX23-3221" fmla="*/ 433972 w 643530"/>
                    <a:gd name="connsiteY23-3222" fmla="*/ 239758 h 309279"/>
                    <a:gd name="connsiteX24-3223" fmla="*/ 367297 w 643530"/>
                    <a:gd name="connsiteY24-3224" fmla="*/ 296909 h 309279"/>
                    <a:gd name="connsiteX25-3225" fmla="*/ 338722 w 643530"/>
                    <a:gd name="connsiteY25-3226" fmla="*/ 301670 h 309279"/>
                    <a:gd name="connsiteX26-3227" fmla="*/ 383172 w 643530"/>
                    <a:gd name="connsiteY26-3228" fmla="*/ 209596 h 309279"/>
                    <a:gd name="connsiteX27-3229" fmla="*/ 318085 w 643530"/>
                    <a:gd name="connsiteY27-3230" fmla="*/ 236583 h 309279"/>
                    <a:gd name="connsiteX28-3231" fmla="*/ 238710 w 643530"/>
                    <a:gd name="connsiteY28-3232" fmla="*/ 231821 h 309279"/>
                    <a:gd name="connsiteX29-3233" fmla="*/ 167272 w 643530"/>
                    <a:gd name="connsiteY29-3234" fmla="*/ 282620 h 309279"/>
                    <a:gd name="connsiteX30-3235" fmla="*/ 200610 w 643530"/>
                    <a:gd name="connsiteY30-3236" fmla="*/ 214358 h 309279"/>
                    <a:gd name="connsiteX31-3237" fmla="*/ 5347 w 643530"/>
                    <a:gd name="connsiteY31-3238" fmla="*/ 242933 h 309279"/>
                    <a:gd name="connsiteX0-3239" fmla="*/ 5347 w 644227"/>
                    <a:gd name="connsiteY0-3240" fmla="*/ 242933 h 309279"/>
                    <a:gd name="connsiteX1-3241" fmla="*/ 59322 w 644227"/>
                    <a:gd name="connsiteY1-3242" fmla="*/ 122283 h 309279"/>
                    <a:gd name="connsiteX2-3243" fmla="*/ 105360 w 644227"/>
                    <a:gd name="connsiteY2-3244" fmla="*/ 74658 h 309279"/>
                    <a:gd name="connsiteX3-3245" fmla="*/ 87897 w 644227"/>
                    <a:gd name="connsiteY3-3246" fmla="*/ 50846 h 309279"/>
                    <a:gd name="connsiteX4-3247" fmla="*/ 110122 w 644227"/>
                    <a:gd name="connsiteY4-3248" fmla="*/ 6396 h 309279"/>
                    <a:gd name="connsiteX5-3249" fmla="*/ 165685 w 644227"/>
                    <a:gd name="connsiteY5-3250" fmla="*/ 4807 h 309279"/>
                    <a:gd name="connsiteX6-3251" fmla="*/ 184735 w 644227"/>
                    <a:gd name="connsiteY6-3252" fmla="*/ 49258 h 309279"/>
                    <a:gd name="connsiteX7-3253" fmla="*/ 181560 w 644227"/>
                    <a:gd name="connsiteY7-3254" fmla="*/ 73071 h 309279"/>
                    <a:gd name="connsiteX8-3255" fmla="*/ 230772 w 644227"/>
                    <a:gd name="connsiteY8-3256" fmla="*/ 22271 h 309279"/>
                    <a:gd name="connsiteX9-3257" fmla="*/ 353010 w 644227"/>
                    <a:gd name="connsiteY9-3258" fmla="*/ 4808 h 309279"/>
                    <a:gd name="connsiteX10-3259" fmla="*/ 506997 w 644227"/>
                    <a:gd name="connsiteY10-3260" fmla="*/ 65134 h 309279"/>
                    <a:gd name="connsiteX11-3261" fmla="*/ 580022 w 644227"/>
                    <a:gd name="connsiteY11-3262" fmla="*/ 142920 h 309279"/>
                    <a:gd name="connsiteX12-3263" fmla="*/ 637173 w 644227"/>
                    <a:gd name="connsiteY12-3264" fmla="*/ 215945 h 309279"/>
                    <a:gd name="connsiteX13-3265" fmla="*/ 640347 w 644227"/>
                    <a:gd name="connsiteY13-3266" fmla="*/ 254045 h 309279"/>
                    <a:gd name="connsiteX14-3267" fmla="*/ 621298 w 644227"/>
                    <a:gd name="connsiteY14-3268" fmla="*/ 274683 h 309279"/>
                    <a:gd name="connsiteX15-3269" fmla="*/ 581610 w 644227"/>
                    <a:gd name="connsiteY15-3270" fmla="*/ 287383 h 309279"/>
                    <a:gd name="connsiteX16-3271" fmla="*/ 430798 w 644227"/>
                    <a:gd name="connsiteY16-3272" fmla="*/ 284208 h 309279"/>
                    <a:gd name="connsiteX17-3273" fmla="*/ 572085 w 644227"/>
                    <a:gd name="connsiteY17-3274" fmla="*/ 273096 h 309279"/>
                    <a:gd name="connsiteX18-3275" fmla="*/ 634000 w 644227"/>
                    <a:gd name="connsiteY18-3276" fmla="*/ 242934 h 309279"/>
                    <a:gd name="connsiteX19-3277" fmla="*/ 637171 w 644227"/>
                    <a:gd name="connsiteY19-3278" fmla="*/ 217533 h 309279"/>
                    <a:gd name="connsiteX20-3279" fmla="*/ 564147 w 644227"/>
                    <a:gd name="connsiteY20-3280" fmla="*/ 190546 h 309279"/>
                    <a:gd name="connsiteX21-3281" fmla="*/ 578434 w 644227"/>
                    <a:gd name="connsiteY21-3282" fmla="*/ 200071 h 309279"/>
                    <a:gd name="connsiteX22-3283" fmla="*/ 514935 w 644227"/>
                    <a:gd name="connsiteY22-3284" fmla="*/ 234996 h 309279"/>
                    <a:gd name="connsiteX23-3285" fmla="*/ 433972 w 644227"/>
                    <a:gd name="connsiteY23-3286" fmla="*/ 239758 h 309279"/>
                    <a:gd name="connsiteX24-3287" fmla="*/ 367297 w 644227"/>
                    <a:gd name="connsiteY24-3288" fmla="*/ 296909 h 309279"/>
                    <a:gd name="connsiteX25-3289" fmla="*/ 338722 w 644227"/>
                    <a:gd name="connsiteY25-3290" fmla="*/ 301670 h 309279"/>
                    <a:gd name="connsiteX26-3291" fmla="*/ 383172 w 644227"/>
                    <a:gd name="connsiteY26-3292" fmla="*/ 209596 h 309279"/>
                    <a:gd name="connsiteX27-3293" fmla="*/ 318085 w 644227"/>
                    <a:gd name="connsiteY27-3294" fmla="*/ 236583 h 309279"/>
                    <a:gd name="connsiteX28-3295" fmla="*/ 238710 w 644227"/>
                    <a:gd name="connsiteY28-3296" fmla="*/ 231821 h 309279"/>
                    <a:gd name="connsiteX29-3297" fmla="*/ 167272 w 644227"/>
                    <a:gd name="connsiteY29-3298" fmla="*/ 282620 h 309279"/>
                    <a:gd name="connsiteX30-3299" fmla="*/ 200610 w 644227"/>
                    <a:gd name="connsiteY30-3300" fmla="*/ 214358 h 309279"/>
                    <a:gd name="connsiteX31-3301" fmla="*/ 5347 w 644227"/>
                    <a:gd name="connsiteY31-3302" fmla="*/ 242933 h 309279"/>
                    <a:gd name="connsiteX0-3303" fmla="*/ 5347 w 643530"/>
                    <a:gd name="connsiteY0-3304" fmla="*/ 242933 h 309279"/>
                    <a:gd name="connsiteX1-3305" fmla="*/ 59322 w 643530"/>
                    <a:gd name="connsiteY1-3306" fmla="*/ 122283 h 309279"/>
                    <a:gd name="connsiteX2-3307" fmla="*/ 105360 w 643530"/>
                    <a:gd name="connsiteY2-3308" fmla="*/ 74658 h 309279"/>
                    <a:gd name="connsiteX3-3309" fmla="*/ 87897 w 643530"/>
                    <a:gd name="connsiteY3-3310" fmla="*/ 50846 h 309279"/>
                    <a:gd name="connsiteX4-3311" fmla="*/ 110122 w 643530"/>
                    <a:gd name="connsiteY4-3312" fmla="*/ 6396 h 309279"/>
                    <a:gd name="connsiteX5-3313" fmla="*/ 165685 w 643530"/>
                    <a:gd name="connsiteY5-3314" fmla="*/ 4807 h 309279"/>
                    <a:gd name="connsiteX6-3315" fmla="*/ 184735 w 643530"/>
                    <a:gd name="connsiteY6-3316" fmla="*/ 49258 h 309279"/>
                    <a:gd name="connsiteX7-3317" fmla="*/ 181560 w 643530"/>
                    <a:gd name="connsiteY7-3318" fmla="*/ 73071 h 309279"/>
                    <a:gd name="connsiteX8-3319" fmla="*/ 230772 w 643530"/>
                    <a:gd name="connsiteY8-3320" fmla="*/ 22271 h 309279"/>
                    <a:gd name="connsiteX9-3321" fmla="*/ 353010 w 643530"/>
                    <a:gd name="connsiteY9-3322" fmla="*/ 4808 h 309279"/>
                    <a:gd name="connsiteX10-3323" fmla="*/ 506997 w 643530"/>
                    <a:gd name="connsiteY10-3324" fmla="*/ 65134 h 309279"/>
                    <a:gd name="connsiteX11-3325" fmla="*/ 580022 w 643530"/>
                    <a:gd name="connsiteY11-3326" fmla="*/ 142920 h 309279"/>
                    <a:gd name="connsiteX12-3327" fmla="*/ 637173 w 643530"/>
                    <a:gd name="connsiteY12-3328" fmla="*/ 215945 h 309279"/>
                    <a:gd name="connsiteX13-3329" fmla="*/ 640347 w 643530"/>
                    <a:gd name="connsiteY13-3330" fmla="*/ 254045 h 309279"/>
                    <a:gd name="connsiteX14-3331" fmla="*/ 621298 w 643530"/>
                    <a:gd name="connsiteY14-3332" fmla="*/ 274683 h 309279"/>
                    <a:gd name="connsiteX15-3333" fmla="*/ 581610 w 643530"/>
                    <a:gd name="connsiteY15-3334" fmla="*/ 287383 h 309279"/>
                    <a:gd name="connsiteX16-3335" fmla="*/ 430798 w 643530"/>
                    <a:gd name="connsiteY16-3336" fmla="*/ 284208 h 309279"/>
                    <a:gd name="connsiteX17-3337" fmla="*/ 572085 w 643530"/>
                    <a:gd name="connsiteY17-3338" fmla="*/ 273096 h 309279"/>
                    <a:gd name="connsiteX18-3339" fmla="*/ 634000 w 643530"/>
                    <a:gd name="connsiteY18-3340" fmla="*/ 242934 h 309279"/>
                    <a:gd name="connsiteX19-3341" fmla="*/ 613358 w 643530"/>
                    <a:gd name="connsiteY19-3342" fmla="*/ 225471 h 309279"/>
                    <a:gd name="connsiteX20-3343" fmla="*/ 564147 w 643530"/>
                    <a:gd name="connsiteY20-3344" fmla="*/ 190546 h 309279"/>
                    <a:gd name="connsiteX21-3345" fmla="*/ 578434 w 643530"/>
                    <a:gd name="connsiteY21-3346" fmla="*/ 200071 h 309279"/>
                    <a:gd name="connsiteX22-3347" fmla="*/ 514935 w 643530"/>
                    <a:gd name="connsiteY22-3348" fmla="*/ 234996 h 309279"/>
                    <a:gd name="connsiteX23-3349" fmla="*/ 433972 w 643530"/>
                    <a:gd name="connsiteY23-3350" fmla="*/ 239758 h 309279"/>
                    <a:gd name="connsiteX24-3351" fmla="*/ 367297 w 643530"/>
                    <a:gd name="connsiteY24-3352" fmla="*/ 296909 h 309279"/>
                    <a:gd name="connsiteX25-3353" fmla="*/ 338722 w 643530"/>
                    <a:gd name="connsiteY25-3354" fmla="*/ 301670 h 309279"/>
                    <a:gd name="connsiteX26-3355" fmla="*/ 383172 w 643530"/>
                    <a:gd name="connsiteY26-3356" fmla="*/ 209596 h 309279"/>
                    <a:gd name="connsiteX27-3357" fmla="*/ 318085 w 643530"/>
                    <a:gd name="connsiteY27-3358" fmla="*/ 236583 h 309279"/>
                    <a:gd name="connsiteX28-3359" fmla="*/ 238710 w 643530"/>
                    <a:gd name="connsiteY28-3360" fmla="*/ 231821 h 309279"/>
                    <a:gd name="connsiteX29-3361" fmla="*/ 167272 w 643530"/>
                    <a:gd name="connsiteY29-3362" fmla="*/ 282620 h 309279"/>
                    <a:gd name="connsiteX30-3363" fmla="*/ 200610 w 643530"/>
                    <a:gd name="connsiteY30-3364" fmla="*/ 214358 h 309279"/>
                    <a:gd name="connsiteX31-3365" fmla="*/ 5347 w 643530"/>
                    <a:gd name="connsiteY31-3366" fmla="*/ 242933 h 309279"/>
                    <a:gd name="connsiteX0-3367" fmla="*/ 5347 w 643530"/>
                    <a:gd name="connsiteY0-3368" fmla="*/ 242933 h 309279"/>
                    <a:gd name="connsiteX1-3369" fmla="*/ 59322 w 643530"/>
                    <a:gd name="connsiteY1-3370" fmla="*/ 122283 h 309279"/>
                    <a:gd name="connsiteX2-3371" fmla="*/ 105360 w 643530"/>
                    <a:gd name="connsiteY2-3372" fmla="*/ 74658 h 309279"/>
                    <a:gd name="connsiteX3-3373" fmla="*/ 87897 w 643530"/>
                    <a:gd name="connsiteY3-3374" fmla="*/ 50846 h 309279"/>
                    <a:gd name="connsiteX4-3375" fmla="*/ 110122 w 643530"/>
                    <a:gd name="connsiteY4-3376" fmla="*/ 6396 h 309279"/>
                    <a:gd name="connsiteX5-3377" fmla="*/ 165685 w 643530"/>
                    <a:gd name="connsiteY5-3378" fmla="*/ 4807 h 309279"/>
                    <a:gd name="connsiteX6-3379" fmla="*/ 184735 w 643530"/>
                    <a:gd name="connsiteY6-3380" fmla="*/ 49258 h 309279"/>
                    <a:gd name="connsiteX7-3381" fmla="*/ 181560 w 643530"/>
                    <a:gd name="connsiteY7-3382" fmla="*/ 73071 h 309279"/>
                    <a:gd name="connsiteX8-3383" fmla="*/ 230772 w 643530"/>
                    <a:gd name="connsiteY8-3384" fmla="*/ 22271 h 309279"/>
                    <a:gd name="connsiteX9-3385" fmla="*/ 353010 w 643530"/>
                    <a:gd name="connsiteY9-3386" fmla="*/ 4808 h 309279"/>
                    <a:gd name="connsiteX10-3387" fmla="*/ 506997 w 643530"/>
                    <a:gd name="connsiteY10-3388" fmla="*/ 65134 h 309279"/>
                    <a:gd name="connsiteX11-3389" fmla="*/ 580022 w 643530"/>
                    <a:gd name="connsiteY11-3390" fmla="*/ 142920 h 309279"/>
                    <a:gd name="connsiteX12-3391" fmla="*/ 637173 w 643530"/>
                    <a:gd name="connsiteY12-3392" fmla="*/ 215945 h 309279"/>
                    <a:gd name="connsiteX13-3393" fmla="*/ 640347 w 643530"/>
                    <a:gd name="connsiteY13-3394" fmla="*/ 254045 h 309279"/>
                    <a:gd name="connsiteX14-3395" fmla="*/ 621298 w 643530"/>
                    <a:gd name="connsiteY14-3396" fmla="*/ 274683 h 309279"/>
                    <a:gd name="connsiteX15-3397" fmla="*/ 581610 w 643530"/>
                    <a:gd name="connsiteY15-3398" fmla="*/ 287383 h 309279"/>
                    <a:gd name="connsiteX16-3399" fmla="*/ 430798 w 643530"/>
                    <a:gd name="connsiteY16-3400" fmla="*/ 284208 h 309279"/>
                    <a:gd name="connsiteX17-3401" fmla="*/ 572085 w 643530"/>
                    <a:gd name="connsiteY17-3402" fmla="*/ 273096 h 309279"/>
                    <a:gd name="connsiteX18-3403" fmla="*/ 616538 w 643530"/>
                    <a:gd name="connsiteY18-3404" fmla="*/ 244522 h 309279"/>
                    <a:gd name="connsiteX19-3405" fmla="*/ 613358 w 643530"/>
                    <a:gd name="connsiteY19-3406" fmla="*/ 225471 h 309279"/>
                    <a:gd name="connsiteX20-3407" fmla="*/ 564147 w 643530"/>
                    <a:gd name="connsiteY20-3408" fmla="*/ 190546 h 309279"/>
                    <a:gd name="connsiteX21-3409" fmla="*/ 578434 w 643530"/>
                    <a:gd name="connsiteY21-3410" fmla="*/ 200071 h 309279"/>
                    <a:gd name="connsiteX22-3411" fmla="*/ 514935 w 643530"/>
                    <a:gd name="connsiteY22-3412" fmla="*/ 234996 h 309279"/>
                    <a:gd name="connsiteX23-3413" fmla="*/ 433972 w 643530"/>
                    <a:gd name="connsiteY23-3414" fmla="*/ 239758 h 309279"/>
                    <a:gd name="connsiteX24-3415" fmla="*/ 367297 w 643530"/>
                    <a:gd name="connsiteY24-3416" fmla="*/ 296909 h 309279"/>
                    <a:gd name="connsiteX25-3417" fmla="*/ 338722 w 643530"/>
                    <a:gd name="connsiteY25-3418" fmla="*/ 301670 h 309279"/>
                    <a:gd name="connsiteX26-3419" fmla="*/ 383172 w 643530"/>
                    <a:gd name="connsiteY26-3420" fmla="*/ 209596 h 309279"/>
                    <a:gd name="connsiteX27-3421" fmla="*/ 318085 w 643530"/>
                    <a:gd name="connsiteY27-3422" fmla="*/ 236583 h 309279"/>
                    <a:gd name="connsiteX28-3423" fmla="*/ 238710 w 643530"/>
                    <a:gd name="connsiteY28-3424" fmla="*/ 231821 h 309279"/>
                    <a:gd name="connsiteX29-3425" fmla="*/ 167272 w 643530"/>
                    <a:gd name="connsiteY29-3426" fmla="*/ 282620 h 309279"/>
                    <a:gd name="connsiteX30-3427" fmla="*/ 200610 w 643530"/>
                    <a:gd name="connsiteY30-3428" fmla="*/ 214358 h 309279"/>
                    <a:gd name="connsiteX31-3429" fmla="*/ 5347 w 643530"/>
                    <a:gd name="connsiteY31-3430" fmla="*/ 242933 h 309279"/>
                    <a:gd name="connsiteX0-3431" fmla="*/ 5347 w 643530"/>
                    <a:gd name="connsiteY0-3432" fmla="*/ 242933 h 309279"/>
                    <a:gd name="connsiteX1-3433" fmla="*/ 59322 w 643530"/>
                    <a:gd name="connsiteY1-3434" fmla="*/ 122283 h 309279"/>
                    <a:gd name="connsiteX2-3435" fmla="*/ 105360 w 643530"/>
                    <a:gd name="connsiteY2-3436" fmla="*/ 74658 h 309279"/>
                    <a:gd name="connsiteX3-3437" fmla="*/ 87897 w 643530"/>
                    <a:gd name="connsiteY3-3438" fmla="*/ 50846 h 309279"/>
                    <a:gd name="connsiteX4-3439" fmla="*/ 110122 w 643530"/>
                    <a:gd name="connsiteY4-3440" fmla="*/ 6396 h 309279"/>
                    <a:gd name="connsiteX5-3441" fmla="*/ 165685 w 643530"/>
                    <a:gd name="connsiteY5-3442" fmla="*/ 4807 h 309279"/>
                    <a:gd name="connsiteX6-3443" fmla="*/ 184735 w 643530"/>
                    <a:gd name="connsiteY6-3444" fmla="*/ 49258 h 309279"/>
                    <a:gd name="connsiteX7-3445" fmla="*/ 181560 w 643530"/>
                    <a:gd name="connsiteY7-3446" fmla="*/ 73071 h 309279"/>
                    <a:gd name="connsiteX8-3447" fmla="*/ 230772 w 643530"/>
                    <a:gd name="connsiteY8-3448" fmla="*/ 22271 h 309279"/>
                    <a:gd name="connsiteX9-3449" fmla="*/ 353010 w 643530"/>
                    <a:gd name="connsiteY9-3450" fmla="*/ 4808 h 309279"/>
                    <a:gd name="connsiteX10-3451" fmla="*/ 506997 w 643530"/>
                    <a:gd name="connsiteY10-3452" fmla="*/ 65134 h 309279"/>
                    <a:gd name="connsiteX11-3453" fmla="*/ 580022 w 643530"/>
                    <a:gd name="connsiteY11-3454" fmla="*/ 142920 h 309279"/>
                    <a:gd name="connsiteX12-3455" fmla="*/ 637173 w 643530"/>
                    <a:gd name="connsiteY12-3456" fmla="*/ 215945 h 309279"/>
                    <a:gd name="connsiteX13-3457" fmla="*/ 640347 w 643530"/>
                    <a:gd name="connsiteY13-3458" fmla="*/ 254045 h 309279"/>
                    <a:gd name="connsiteX14-3459" fmla="*/ 621298 w 643530"/>
                    <a:gd name="connsiteY14-3460" fmla="*/ 274683 h 309279"/>
                    <a:gd name="connsiteX15-3461" fmla="*/ 581610 w 643530"/>
                    <a:gd name="connsiteY15-3462" fmla="*/ 287383 h 309279"/>
                    <a:gd name="connsiteX16-3463" fmla="*/ 430798 w 643530"/>
                    <a:gd name="connsiteY16-3464" fmla="*/ 284208 h 309279"/>
                    <a:gd name="connsiteX17-3465" fmla="*/ 572085 w 643530"/>
                    <a:gd name="connsiteY17-3466" fmla="*/ 273096 h 309279"/>
                    <a:gd name="connsiteX18-3467" fmla="*/ 616538 w 643530"/>
                    <a:gd name="connsiteY18-3468" fmla="*/ 244522 h 309279"/>
                    <a:gd name="connsiteX19-3469" fmla="*/ 613358 w 643530"/>
                    <a:gd name="connsiteY19-3470" fmla="*/ 225471 h 309279"/>
                    <a:gd name="connsiteX20-3471" fmla="*/ 603835 w 643530"/>
                    <a:gd name="connsiteY20-3472" fmla="*/ 204833 h 309279"/>
                    <a:gd name="connsiteX21-3473" fmla="*/ 578434 w 643530"/>
                    <a:gd name="connsiteY21-3474" fmla="*/ 200071 h 309279"/>
                    <a:gd name="connsiteX22-3475" fmla="*/ 514935 w 643530"/>
                    <a:gd name="connsiteY22-3476" fmla="*/ 234996 h 309279"/>
                    <a:gd name="connsiteX23-3477" fmla="*/ 433972 w 643530"/>
                    <a:gd name="connsiteY23-3478" fmla="*/ 239758 h 309279"/>
                    <a:gd name="connsiteX24-3479" fmla="*/ 367297 w 643530"/>
                    <a:gd name="connsiteY24-3480" fmla="*/ 296909 h 309279"/>
                    <a:gd name="connsiteX25-3481" fmla="*/ 338722 w 643530"/>
                    <a:gd name="connsiteY25-3482" fmla="*/ 301670 h 309279"/>
                    <a:gd name="connsiteX26-3483" fmla="*/ 383172 w 643530"/>
                    <a:gd name="connsiteY26-3484" fmla="*/ 209596 h 309279"/>
                    <a:gd name="connsiteX27-3485" fmla="*/ 318085 w 643530"/>
                    <a:gd name="connsiteY27-3486" fmla="*/ 236583 h 309279"/>
                    <a:gd name="connsiteX28-3487" fmla="*/ 238710 w 643530"/>
                    <a:gd name="connsiteY28-3488" fmla="*/ 231821 h 309279"/>
                    <a:gd name="connsiteX29-3489" fmla="*/ 167272 w 643530"/>
                    <a:gd name="connsiteY29-3490" fmla="*/ 282620 h 309279"/>
                    <a:gd name="connsiteX30-3491" fmla="*/ 200610 w 643530"/>
                    <a:gd name="connsiteY30-3492" fmla="*/ 214358 h 309279"/>
                    <a:gd name="connsiteX31-3493" fmla="*/ 5347 w 643530"/>
                    <a:gd name="connsiteY31-3494" fmla="*/ 242933 h 309279"/>
                    <a:gd name="connsiteX0-3495" fmla="*/ 5347 w 643530"/>
                    <a:gd name="connsiteY0-3496" fmla="*/ 242933 h 309279"/>
                    <a:gd name="connsiteX1-3497" fmla="*/ 59322 w 643530"/>
                    <a:gd name="connsiteY1-3498" fmla="*/ 122283 h 309279"/>
                    <a:gd name="connsiteX2-3499" fmla="*/ 105360 w 643530"/>
                    <a:gd name="connsiteY2-3500" fmla="*/ 74658 h 309279"/>
                    <a:gd name="connsiteX3-3501" fmla="*/ 87897 w 643530"/>
                    <a:gd name="connsiteY3-3502" fmla="*/ 50846 h 309279"/>
                    <a:gd name="connsiteX4-3503" fmla="*/ 110122 w 643530"/>
                    <a:gd name="connsiteY4-3504" fmla="*/ 6396 h 309279"/>
                    <a:gd name="connsiteX5-3505" fmla="*/ 165685 w 643530"/>
                    <a:gd name="connsiteY5-3506" fmla="*/ 4807 h 309279"/>
                    <a:gd name="connsiteX6-3507" fmla="*/ 184735 w 643530"/>
                    <a:gd name="connsiteY6-3508" fmla="*/ 49258 h 309279"/>
                    <a:gd name="connsiteX7-3509" fmla="*/ 181560 w 643530"/>
                    <a:gd name="connsiteY7-3510" fmla="*/ 73071 h 309279"/>
                    <a:gd name="connsiteX8-3511" fmla="*/ 230772 w 643530"/>
                    <a:gd name="connsiteY8-3512" fmla="*/ 22271 h 309279"/>
                    <a:gd name="connsiteX9-3513" fmla="*/ 353010 w 643530"/>
                    <a:gd name="connsiteY9-3514" fmla="*/ 4808 h 309279"/>
                    <a:gd name="connsiteX10-3515" fmla="*/ 506997 w 643530"/>
                    <a:gd name="connsiteY10-3516" fmla="*/ 65134 h 309279"/>
                    <a:gd name="connsiteX11-3517" fmla="*/ 580022 w 643530"/>
                    <a:gd name="connsiteY11-3518" fmla="*/ 142920 h 309279"/>
                    <a:gd name="connsiteX12-3519" fmla="*/ 637173 w 643530"/>
                    <a:gd name="connsiteY12-3520" fmla="*/ 215945 h 309279"/>
                    <a:gd name="connsiteX13-3521" fmla="*/ 640347 w 643530"/>
                    <a:gd name="connsiteY13-3522" fmla="*/ 254045 h 309279"/>
                    <a:gd name="connsiteX14-3523" fmla="*/ 621298 w 643530"/>
                    <a:gd name="connsiteY14-3524" fmla="*/ 274683 h 309279"/>
                    <a:gd name="connsiteX15-3525" fmla="*/ 581610 w 643530"/>
                    <a:gd name="connsiteY15-3526" fmla="*/ 287383 h 309279"/>
                    <a:gd name="connsiteX16-3527" fmla="*/ 430798 w 643530"/>
                    <a:gd name="connsiteY16-3528" fmla="*/ 284208 h 309279"/>
                    <a:gd name="connsiteX17-3529" fmla="*/ 572085 w 643530"/>
                    <a:gd name="connsiteY17-3530" fmla="*/ 273096 h 309279"/>
                    <a:gd name="connsiteX18-3531" fmla="*/ 616538 w 643530"/>
                    <a:gd name="connsiteY18-3532" fmla="*/ 244522 h 309279"/>
                    <a:gd name="connsiteX19-3533" fmla="*/ 624470 w 643530"/>
                    <a:gd name="connsiteY19-3534" fmla="*/ 225471 h 309279"/>
                    <a:gd name="connsiteX20-3535" fmla="*/ 603835 w 643530"/>
                    <a:gd name="connsiteY20-3536" fmla="*/ 204833 h 309279"/>
                    <a:gd name="connsiteX21-3537" fmla="*/ 578434 w 643530"/>
                    <a:gd name="connsiteY21-3538" fmla="*/ 200071 h 309279"/>
                    <a:gd name="connsiteX22-3539" fmla="*/ 514935 w 643530"/>
                    <a:gd name="connsiteY22-3540" fmla="*/ 234996 h 309279"/>
                    <a:gd name="connsiteX23-3541" fmla="*/ 433972 w 643530"/>
                    <a:gd name="connsiteY23-3542" fmla="*/ 239758 h 309279"/>
                    <a:gd name="connsiteX24-3543" fmla="*/ 367297 w 643530"/>
                    <a:gd name="connsiteY24-3544" fmla="*/ 296909 h 309279"/>
                    <a:gd name="connsiteX25-3545" fmla="*/ 338722 w 643530"/>
                    <a:gd name="connsiteY25-3546" fmla="*/ 301670 h 309279"/>
                    <a:gd name="connsiteX26-3547" fmla="*/ 383172 w 643530"/>
                    <a:gd name="connsiteY26-3548" fmla="*/ 209596 h 309279"/>
                    <a:gd name="connsiteX27-3549" fmla="*/ 318085 w 643530"/>
                    <a:gd name="connsiteY27-3550" fmla="*/ 236583 h 309279"/>
                    <a:gd name="connsiteX28-3551" fmla="*/ 238710 w 643530"/>
                    <a:gd name="connsiteY28-3552" fmla="*/ 231821 h 309279"/>
                    <a:gd name="connsiteX29-3553" fmla="*/ 167272 w 643530"/>
                    <a:gd name="connsiteY29-3554" fmla="*/ 282620 h 309279"/>
                    <a:gd name="connsiteX30-3555" fmla="*/ 200610 w 643530"/>
                    <a:gd name="connsiteY30-3556" fmla="*/ 214358 h 309279"/>
                    <a:gd name="connsiteX31-3557" fmla="*/ 5347 w 643530"/>
                    <a:gd name="connsiteY31-3558" fmla="*/ 242933 h 309279"/>
                    <a:gd name="connsiteX0-3559" fmla="*/ 5347 w 643530"/>
                    <a:gd name="connsiteY0-3560" fmla="*/ 242933 h 309279"/>
                    <a:gd name="connsiteX1-3561" fmla="*/ 59322 w 643530"/>
                    <a:gd name="connsiteY1-3562" fmla="*/ 122283 h 309279"/>
                    <a:gd name="connsiteX2-3563" fmla="*/ 105360 w 643530"/>
                    <a:gd name="connsiteY2-3564" fmla="*/ 74658 h 309279"/>
                    <a:gd name="connsiteX3-3565" fmla="*/ 87897 w 643530"/>
                    <a:gd name="connsiteY3-3566" fmla="*/ 50846 h 309279"/>
                    <a:gd name="connsiteX4-3567" fmla="*/ 110122 w 643530"/>
                    <a:gd name="connsiteY4-3568" fmla="*/ 6396 h 309279"/>
                    <a:gd name="connsiteX5-3569" fmla="*/ 165685 w 643530"/>
                    <a:gd name="connsiteY5-3570" fmla="*/ 4807 h 309279"/>
                    <a:gd name="connsiteX6-3571" fmla="*/ 184735 w 643530"/>
                    <a:gd name="connsiteY6-3572" fmla="*/ 49258 h 309279"/>
                    <a:gd name="connsiteX7-3573" fmla="*/ 181560 w 643530"/>
                    <a:gd name="connsiteY7-3574" fmla="*/ 73071 h 309279"/>
                    <a:gd name="connsiteX8-3575" fmla="*/ 230772 w 643530"/>
                    <a:gd name="connsiteY8-3576" fmla="*/ 22271 h 309279"/>
                    <a:gd name="connsiteX9-3577" fmla="*/ 353010 w 643530"/>
                    <a:gd name="connsiteY9-3578" fmla="*/ 4808 h 309279"/>
                    <a:gd name="connsiteX10-3579" fmla="*/ 506997 w 643530"/>
                    <a:gd name="connsiteY10-3580" fmla="*/ 65134 h 309279"/>
                    <a:gd name="connsiteX11-3581" fmla="*/ 580022 w 643530"/>
                    <a:gd name="connsiteY11-3582" fmla="*/ 142920 h 309279"/>
                    <a:gd name="connsiteX12-3583" fmla="*/ 637173 w 643530"/>
                    <a:gd name="connsiteY12-3584" fmla="*/ 215945 h 309279"/>
                    <a:gd name="connsiteX13-3585" fmla="*/ 640347 w 643530"/>
                    <a:gd name="connsiteY13-3586" fmla="*/ 254045 h 309279"/>
                    <a:gd name="connsiteX14-3587" fmla="*/ 621298 w 643530"/>
                    <a:gd name="connsiteY14-3588" fmla="*/ 274683 h 309279"/>
                    <a:gd name="connsiteX15-3589" fmla="*/ 581610 w 643530"/>
                    <a:gd name="connsiteY15-3590" fmla="*/ 287383 h 309279"/>
                    <a:gd name="connsiteX16-3591" fmla="*/ 430798 w 643530"/>
                    <a:gd name="connsiteY16-3592" fmla="*/ 284208 h 309279"/>
                    <a:gd name="connsiteX17-3593" fmla="*/ 572085 w 643530"/>
                    <a:gd name="connsiteY17-3594" fmla="*/ 273096 h 309279"/>
                    <a:gd name="connsiteX18-3595" fmla="*/ 616538 w 643530"/>
                    <a:gd name="connsiteY18-3596" fmla="*/ 244522 h 309279"/>
                    <a:gd name="connsiteX19-3597" fmla="*/ 613357 w 643530"/>
                    <a:gd name="connsiteY19-3598" fmla="*/ 225471 h 309279"/>
                    <a:gd name="connsiteX20-3599" fmla="*/ 603835 w 643530"/>
                    <a:gd name="connsiteY20-3600" fmla="*/ 204833 h 309279"/>
                    <a:gd name="connsiteX21-3601" fmla="*/ 578434 w 643530"/>
                    <a:gd name="connsiteY21-3602" fmla="*/ 200071 h 309279"/>
                    <a:gd name="connsiteX22-3603" fmla="*/ 514935 w 643530"/>
                    <a:gd name="connsiteY22-3604" fmla="*/ 234996 h 309279"/>
                    <a:gd name="connsiteX23-3605" fmla="*/ 433972 w 643530"/>
                    <a:gd name="connsiteY23-3606" fmla="*/ 239758 h 309279"/>
                    <a:gd name="connsiteX24-3607" fmla="*/ 367297 w 643530"/>
                    <a:gd name="connsiteY24-3608" fmla="*/ 296909 h 309279"/>
                    <a:gd name="connsiteX25-3609" fmla="*/ 338722 w 643530"/>
                    <a:gd name="connsiteY25-3610" fmla="*/ 301670 h 309279"/>
                    <a:gd name="connsiteX26-3611" fmla="*/ 383172 w 643530"/>
                    <a:gd name="connsiteY26-3612" fmla="*/ 209596 h 309279"/>
                    <a:gd name="connsiteX27-3613" fmla="*/ 318085 w 643530"/>
                    <a:gd name="connsiteY27-3614" fmla="*/ 236583 h 309279"/>
                    <a:gd name="connsiteX28-3615" fmla="*/ 238710 w 643530"/>
                    <a:gd name="connsiteY28-3616" fmla="*/ 231821 h 309279"/>
                    <a:gd name="connsiteX29-3617" fmla="*/ 167272 w 643530"/>
                    <a:gd name="connsiteY29-3618" fmla="*/ 282620 h 309279"/>
                    <a:gd name="connsiteX30-3619" fmla="*/ 200610 w 643530"/>
                    <a:gd name="connsiteY30-3620" fmla="*/ 214358 h 309279"/>
                    <a:gd name="connsiteX31-3621" fmla="*/ 5347 w 643530"/>
                    <a:gd name="connsiteY31-3622" fmla="*/ 242933 h 309279"/>
                    <a:gd name="connsiteX0-3623" fmla="*/ 5347 w 643530"/>
                    <a:gd name="connsiteY0-3624" fmla="*/ 242933 h 309279"/>
                    <a:gd name="connsiteX1-3625" fmla="*/ 59322 w 643530"/>
                    <a:gd name="connsiteY1-3626" fmla="*/ 122283 h 309279"/>
                    <a:gd name="connsiteX2-3627" fmla="*/ 105360 w 643530"/>
                    <a:gd name="connsiteY2-3628" fmla="*/ 74658 h 309279"/>
                    <a:gd name="connsiteX3-3629" fmla="*/ 87897 w 643530"/>
                    <a:gd name="connsiteY3-3630" fmla="*/ 50846 h 309279"/>
                    <a:gd name="connsiteX4-3631" fmla="*/ 110122 w 643530"/>
                    <a:gd name="connsiteY4-3632" fmla="*/ 6396 h 309279"/>
                    <a:gd name="connsiteX5-3633" fmla="*/ 165685 w 643530"/>
                    <a:gd name="connsiteY5-3634" fmla="*/ 4807 h 309279"/>
                    <a:gd name="connsiteX6-3635" fmla="*/ 184735 w 643530"/>
                    <a:gd name="connsiteY6-3636" fmla="*/ 49258 h 309279"/>
                    <a:gd name="connsiteX7-3637" fmla="*/ 181560 w 643530"/>
                    <a:gd name="connsiteY7-3638" fmla="*/ 73071 h 309279"/>
                    <a:gd name="connsiteX8-3639" fmla="*/ 230772 w 643530"/>
                    <a:gd name="connsiteY8-3640" fmla="*/ 22271 h 309279"/>
                    <a:gd name="connsiteX9-3641" fmla="*/ 353010 w 643530"/>
                    <a:gd name="connsiteY9-3642" fmla="*/ 4808 h 309279"/>
                    <a:gd name="connsiteX10-3643" fmla="*/ 506997 w 643530"/>
                    <a:gd name="connsiteY10-3644" fmla="*/ 65134 h 309279"/>
                    <a:gd name="connsiteX11-3645" fmla="*/ 580022 w 643530"/>
                    <a:gd name="connsiteY11-3646" fmla="*/ 142920 h 309279"/>
                    <a:gd name="connsiteX12-3647" fmla="*/ 637173 w 643530"/>
                    <a:gd name="connsiteY12-3648" fmla="*/ 215945 h 309279"/>
                    <a:gd name="connsiteX13-3649" fmla="*/ 640347 w 643530"/>
                    <a:gd name="connsiteY13-3650" fmla="*/ 254045 h 309279"/>
                    <a:gd name="connsiteX14-3651" fmla="*/ 621298 w 643530"/>
                    <a:gd name="connsiteY14-3652" fmla="*/ 274683 h 309279"/>
                    <a:gd name="connsiteX15-3653" fmla="*/ 581610 w 643530"/>
                    <a:gd name="connsiteY15-3654" fmla="*/ 287383 h 309279"/>
                    <a:gd name="connsiteX16-3655" fmla="*/ 430798 w 643530"/>
                    <a:gd name="connsiteY16-3656" fmla="*/ 284208 h 309279"/>
                    <a:gd name="connsiteX17-3657" fmla="*/ 572085 w 643530"/>
                    <a:gd name="connsiteY17-3658" fmla="*/ 273096 h 309279"/>
                    <a:gd name="connsiteX18-3659" fmla="*/ 616538 w 643530"/>
                    <a:gd name="connsiteY18-3660" fmla="*/ 244522 h 309279"/>
                    <a:gd name="connsiteX19-3661" fmla="*/ 618119 w 643530"/>
                    <a:gd name="connsiteY19-3662" fmla="*/ 223883 h 309279"/>
                    <a:gd name="connsiteX20-3663" fmla="*/ 603835 w 643530"/>
                    <a:gd name="connsiteY20-3664" fmla="*/ 204833 h 309279"/>
                    <a:gd name="connsiteX21-3665" fmla="*/ 578434 w 643530"/>
                    <a:gd name="connsiteY21-3666" fmla="*/ 200071 h 309279"/>
                    <a:gd name="connsiteX22-3667" fmla="*/ 514935 w 643530"/>
                    <a:gd name="connsiteY22-3668" fmla="*/ 234996 h 309279"/>
                    <a:gd name="connsiteX23-3669" fmla="*/ 433972 w 643530"/>
                    <a:gd name="connsiteY23-3670" fmla="*/ 239758 h 309279"/>
                    <a:gd name="connsiteX24-3671" fmla="*/ 367297 w 643530"/>
                    <a:gd name="connsiteY24-3672" fmla="*/ 296909 h 309279"/>
                    <a:gd name="connsiteX25-3673" fmla="*/ 338722 w 643530"/>
                    <a:gd name="connsiteY25-3674" fmla="*/ 301670 h 309279"/>
                    <a:gd name="connsiteX26-3675" fmla="*/ 383172 w 643530"/>
                    <a:gd name="connsiteY26-3676" fmla="*/ 209596 h 309279"/>
                    <a:gd name="connsiteX27-3677" fmla="*/ 318085 w 643530"/>
                    <a:gd name="connsiteY27-3678" fmla="*/ 236583 h 309279"/>
                    <a:gd name="connsiteX28-3679" fmla="*/ 238710 w 643530"/>
                    <a:gd name="connsiteY28-3680" fmla="*/ 231821 h 309279"/>
                    <a:gd name="connsiteX29-3681" fmla="*/ 167272 w 643530"/>
                    <a:gd name="connsiteY29-3682" fmla="*/ 282620 h 309279"/>
                    <a:gd name="connsiteX30-3683" fmla="*/ 200610 w 643530"/>
                    <a:gd name="connsiteY30-3684" fmla="*/ 214358 h 309279"/>
                    <a:gd name="connsiteX31-3685" fmla="*/ 5347 w 643530"/>
                    <a:gd name="connsiteY31-3686" fmla="*/ 242933 h 309279"/>
                    <a:gd name="connsiteX0-3687" fmla="*/ 5347 w 643530"/>
                    <a:gd name="connsiteY0-3688" fmla="*/ 242933 h 309279"/>
                    <a:gd name="connsiteX1-3689" fmla="*/ 59322 w 643530"/>
                    <a:gd name="connsiteY1-3690" fmla="*/ 122283 h 309279"/>
                    <a:gd name="connsiteX2-3691" fmla="*/ 105360 w 643530"/>
                    <a:gd name="connsiteY2-3692" fmla="*/ 74658 h 309279"/>
                    <a:gd name="connsiteX3-3693" fmla="*/ 87897 w 643530"/>
                    <a:gd name="connsiteY3-3694" fmla="*/ 50846 h 309279"/>
                    <a:gd name="connsiteX4-3695" fmla="*/ 110122 w 643530"/>
                    <a:gd name="connsiteY4-3696" fmla="*/ 6396 h 309279"/>
                    <a:gd name="connsiteX5-3697" fmla="*/ 165685 w 643530"/>
                    <a:gd name="connsiteY5-3698" fmla="*/ 4807 h 309279"/>
                    <a:gd name="connsiteX6-3699" fmla="*/ 184735 w 643530"/>
                    <a:gd name="connsiteY6-3700" fmla="*/ 49258 h 309279"/>
                    <a:gd name="connsiteX7-3701" fmla="*/ 181560 w 643530"/>
                    <a:gd name="connsiteY7-3702" fmla="*/ 73071 h 309279"/>
                    <a:gd name="connsiteX8-3703" fmla="*/ 230772 w 643530"/>
                    <a:gd name="connsiteY8-3704" fmla="*/ 22271 h 309279"/>
                    <a:gd name="connsiteX9-3705" fmla="*/ 353010 w 643530"/>
                    <a:gd name="connsiteY9-3706" fmla="*/ 4808 h 309279"/>
                    <a:gd name="connsiteX10-3707" fmla="*/ 506997 w 643530"/>
                    <a:gd name="connsiteY10-3708" fmla="*/ 65134 h 309279"/>
                    <a:gd name="connsiteX11-3709" fmla="*/ 580022 w 643530"/>
                    <a:gd name="connsiteY11-3710" fmla="*/ 142920 h 309279"/>
                    <a:gd name="connsiteX12-3711" fmla="*/ 637173 w 643530"/>
                    <a:gd name="connsiteY12-3712" fmla="*/ 215945 h 309279"/>
                    <a:gd name="connsiteX13-3713" fmla="*/ 640347 w 643530"/>
                    <a:gd name="connsiteY13-3714" fmla="*/ 254045 h 309279"/>
                    <a:gd name="connsiteX14-3715" fmla="*/ 621298 w 643530"/>
                    <a:gd name="connsiteY14-3716" fmla="*/ 274683 h 309279"/>
                    <a:gd name="connsiteX15-3717" fmla="*/ 581610 w 643530"/>
                    <a:gd name="connsiteY15-3718" fmla="*/ 287383 h 309279"/>
                    <a:gd name="connsiteX16-3719" fmla="*/ 430798 w 643530"/>
                    <a:gd name="connsiteY16-3720" fmla="*/ 284208 h 309279"/>
                    <a:gd name="connsiteX17-3721" fmla="*/ 572085 w 643530"/>
                    <a:gd name="connsiteY17-3722" fmla="*/ 273096 h 309279"/>
                    <a:gd name="connsiteX18-3723" fmla="*/ 616538 w 643530"/>
                    <a:gd name="connsiteY18-3724" fmla="*/ 244522 h 309279"/>
                    <a:gd name="connsiteX19-3725" fmla="*/ 603835 w 643530"/>
                    <a:gd name="connsiteY19-3726" fmla="*/ 204833 h 309279"/>
                    <a:gd name="connsiteX20-3727" fmla="*/ 578434 w 643530"/>
                    <a:gd name="connsiteY20-3728" fmla="*/ 200071 h 309279"/>
                    <a:gd name="connsiteX21-3729" fmla="*/ 514935 w 643530"/>
                    <a:gd name="connsiteY21-3730" fmla="*/ 234996 h 309279"/>
                    <a:gd name="connsiteX22-3731" fmla="*/ 433972 w 643530"/>
                    <a:gd name="connsiteY22-3732" fmla="*/ 239758 h 309279"/>
                    <a:gd name="connsiteX23-3733" fmla="*/ 367297 w 643530"/>
                    <a:gd name="connsiteY23-3734" fmla="*/ 296909 h 309279"/>
                    <a:gd name="connsiteX24-3735" fmla="*/ 338722 w 643530"/>
                    <a:gd name="connsiteY24-3736" fmla="*/ 301670 h 309279"/>
                    <a:gd name="connsiteX25-3737" fmla="*/ 383172 w 643530"/>
                    <a:gd name="connsiteY25-3738" fmla="*/ 209596 h 309279"/>
                    <a:gd name="connsiteX26-3739" fmla="*/ 318085 w 643530"/>
                    <a:gd name="connsiteY26-3740" fmla="*/ 236583 h 309279"/>
                    <a:gd name="connsiteX27-3741" fmla="*/ 238710 w 643530"/>
                    <a:gd name="connsiteY27-3742" fmla="*/ 231821 h 309279"/>
                    <a:gd name="connsiteX28-3743" fmla="*/ 167272 w 643530"/>
                    <a:gd name="connsiteY28-3744" fmla="*/ 282620 h 309279"/>
                    <a:gd name="connsiteX29-3745" fmla="*/ 200610 w 643530"/>
                    <a:gd name="connsiteY29-3746" fmla="*/ 214358 h 309279"/>
                    <a:gd name="connsiteX30-3747" fmla="*/ 5347 w 643530"/>
                    <a:gd name="connsiteY30-3748" fmla="*/ 242933 h 309279"/>
                    <a:gd name="connsiteX0-3749" fmla="*/ 4127 w 642310"/>
                    <a:gd name="connsiteY0-3750" fmla="*/ 242933 h 309279"/>
                    <a:gd name="connsiteX1-3751" fmla="*/ 69215 w 642310"/>
                    <a:gd name="connsiteY1-3752" fmla="*/ 122283 h 309279"/>
                    <a:gd name="connsiteX2-3753" fmla="*/ 104140 w 642310"/>
                    <a:gd name="connsiteY2-3754" fmla="*/ 74658 h 309279"/>
                    <a:gd name="connsiteX3-3755" fmla="*/ 86677 w 642310"/>
                    <a:gd name="connsiteY3-3756" fmla="*/ 50846 h 309279"/>
                    <a:gd name="connsiteX4-3757" fmla="*/ 108902 w 642310"/>
                    <a:gd name="connsiteY4-3758" fmla="*/ 6396 h 309279"/>
                    <a:gd name="connsiteX5-3759" fmla="*/ 164465 w 642310"/>
                    <a:gd name="connsiteY5-3760" fmla="*/ 4807 h 309279"/>
                    <a:gd name="connsiteX6-3761" fmla="*/ 183515 w 642310"/>
                    <a:gd name="connsiteY6-3762" fmla="*/ 49258 h 309279"/>
                    <a:gd name="connsiteX7-3763" fmla="*/ 180340 w 642310"/>
                    <a:gd name="connsiteY7-3764" fmla="*/ 73071 h 309279"/>
                    <a:gd name="connsiteX8-3765" fmla="*/ 229552 w 642310"/>
                    <a:gd name="connsiteY8-3766" fmla="*/ 22271 h 309279"/>
                    <a:gd name="connsiteX9-3767" fmla="*/ 351790 w 642310"/>
                    <a:gd name="connsiteY9-3768" fmla="*/ 4808 h 309279"/>
                    <a:gd name="connsiteX10-3769" fmla="*/ 505777 w 642310"/>
                    <a:gd name="connsiteY10-3770" fmla="*/ 65134 h 309279"/>
                    <a:gd name="connsiteX11-3771" fmla="*/ 578802 w 642310"/>
                    <a:gd name="connsiteY11-3772" fmla="*/ 142920 h 309279"/>
                    <a:gd name="connsiteX12-3773" fmla="*/ 635953 w 642310"/>
                    <a:gd name="connsiteY12-3774" fmla="*/ 215945 h 309279"/>
                    <a:gd name="connsiteX13-3775" fmla="*/ 639127 w 642310"/>
                    <a:gd name="connsiteY13-3776" fmla="*/ 254045 h 309279"/>
                    <a:gd name="connsiteX14-3777" fmla="*/ 620078 w 642310"/>
                    <a:gd name="connsiteY14-3778" fmla="*/ 274683 h 309279"/>
                    <a:gd name="connsiteX15-3779" fmla="*/ 580390 w 642310"/>
                    <a:gd name="connsiteY15-3780" fmla="*/ 287383 h 309279"/>
                    <a:gd name="connsiteX16-3781" fmla="*/ 429578 w 642310"/>
                    <a:gd name="connsiteY16-3782" fmla="*/ 284208 h 309279"/>
                    <a:gd name="connsiteX17-3783" fmla="*/ 570865 w 642310"/>
                    <a:gd name="connsiteY17-3784" fmla="*/ 273096 h 309279"/>
                    <a:gd name="connsiteX18-3785" fmla="*/ 615318 w 642310"/>
                    <a:gd name="connsiteY18-3786" fmla="*/ 244522 h 309279"/>
                    <a:gd name="connsiteX19-3787" fmla="*/ 602615 w 642310"/>
                    <a:gd name="connsiteY19-3788" fmla="*/ 204833 h 309279"/>
                    <a:gd name="connsiteX20-3789" fmla="*/ 577214 w 642310"/>
                    <a:gd name="connsiteY20-3790" fmla="*/ 200071 h 309279"/>
                    <a:gd name="connsiteX21-3791" fmla="*/ 513715 w 642310"/>
                    <a:gd name="connsiteY21-3792" fmla="*/ 234996 h 309279"/>
                    <a:gd name="connsiteX22-3793" fmla="*/ 432752 w 642310"/>
                    <a:gd name="connsiteY22-3794" fmla="*/ 239758 h 309279"/>
                    <a:gd name="connsiteX23-3795" fmla="*/ 366077 w 642310"/>
                    <a:gd name="connsiteY23-3796" fmla="*/ 296909 h 309279"/>
                    <a:gd name="connsiteX24-3797" fmla="*/ 337502 w 642310"/>
                    <a:gd name="connsiteY24-3798" fmla="*/ 301670 h 309279"/>
                    <a:gd name="connsiteX25-3799" fmla="*/ 381952 w 642310"/>
                    <a:gd name="connsiteY25-3800" fmla="*/ 209596 h 309279"/>
                    <a:gd name="connsiteX26-3801" fmla="*/ 316865 w 642310"/>
                    <a:gd name="connsiteY26-3802" fmla="*/ 236583 h 309279"/>
                    <a:gd name="connsiteX27-3803" fmla="*/ 237490 w 642310"/>
                    <a:gd name="connsiteY27-3804" fmla="*/ 231821 h 309279"/>
                    <a:gd name="connsiteX28-3805" fmla="*/ 166052 w 642310"/>
                    <a:gd name="connsiteY28-3806" fmla="*/ 282620 h 309279"/>
                    <a:gd name="connsiteX29-3807" fmla="*/ 199390 w 642310"/>
                    <a:gd name="connsiteY29-3808" fmla="*/ 214358 h 309279"/>
                    <a:gd name="connsiteX30-3809" fmla="*/ 4127 w 642310"/>
                    <a:gd name="connsiteY30-3810" fmla="*/ 242933 h 309279"/>
                    <a:gd name="connsiteX0-3811" fmla="*/ 4127 w 642310"/>
                    <a:gd name="connsiteY0-3812" fmla="*/ 242933 h 309279"/>
                    <a:gd name="connsiteX1-3813" fmla="*/ 69215 w 642310"/>
                    <a:gd name="connsiteY1-3814" fmla="*/ 122283 h 309279"/>
                    <a:gd name="connsiteX2-3815" fmla="*/ 104140 w 642310"/>
                    <a:gd name="connsiteY2-3816" fmla="*/ 74658 h 309279"/>
                    <a:gd name="connsiteX3-3817" fmla="*/ 86677 w 642310"/>
                    <a:gd name="connsiteY3-3818" fmla="*/ 50846 h 309279"/>
                    <a:gd name="connsiteX4-3819" fmla="*/ 108902 w 642310"/>
                    <a:gd name="connsiteY4-3820" fmla="*/ 6396 h 309279"/>
                    <a:gd name="connsiteX5-3821" fmla="*/ 164465 w 642310"/>
                    <a:gd name="connsiteY5-3822" fmla="*/ 4807 h 309279"/>
                    <a:gd name="connsiteX6-3823" fmla="*/ 183515 w 642310"/>
                    <a:gd name="connsiteY6-3824" fmla="*/ 49258 h 309279"/>
                    <a:gd name="connsiteX7-3825" fmla="*/ 180340 w 642310"/>
                    <a:gd name="connsiteY7-3826" fmla="*/ 73071 h 309279"/>
                    <a:gd name="connsiteX8-3827" fmla="*/ 229552 w 642310"/>
                    <a:gd name="connsiteY8-3828" fmla="*/ 22271 h 309279"/>
                    <a:gd name="connsiteX9-3829" fmla="*/ 351790 w 642310"/>
                    <a:gd name="connsiteY9-3830" fmla="*/ 4808 h 309279"/>
                    <a:gd name="connsiteX10-3831" fmla="*/ 505777 w 642310"/>
                    <a:gd name="connsiteY10-3832" fmla="*/ 65134 h 309279"/>
                    <a:gd name="connsiteX11-3833" fmla="*/ 578802 w 642310"/>
                    <a:gd name="connsiteY11-3834" fmla="*/ 142920 h 309279"/>
                    <a:gd name="connsiteX12-3835" fmla="*/ 635953 w 642310"/>
                    <a:gd name="connsiteY12-3836" fmla="*/ 215945 h 309279"/>
                    <a:gd name="connsiteX13-3837" fmla="*/ 639127 w 642310"/>
                    <a:gd name="connsiteY13-3838" fmla="*/ 254045 h 309279"/>
                    <a:gd name="connsiteX14-3839" fmla="*/ 620078 w 642310"/>
                    <a:gd name="connsiteY14-3840" fmla="*/ 274683 h 309279"/>
                    <a:gd name="connsiteX15-3841" fmla="*/ 580390 w 642310"/>
                    <a:gd name="connsiteY15-3842" fmla="*/ 287383 h 309279"/>
                    <a:gd name="connsiteX16-3843" fmla="*/ 429578 w 642310"/>
                    <a:gd name="connsiteY16-3844" fmla="*/ 284208 h 309279"/>
                    <a:gd name="connsiteX17-3845" fmla="*/ 570865 w 642310"/>
                    <a:gd name="connsiteY17-3846" fmla="*/ 273096 h 309279"/>
                    <a:gd name="connsiteX18-3847" fmla="*/ 615318 w 642310"/>
                    <a:gd name="connsiteY18-3848" fmla="*/ 244522 h 309279"/>
                    <a:gd name="connsiteX19-3849" fmla="*/ 602615 w 642310"/>
                    <a:gd name="connsiteY19-3850" fmla="*/ 204833 h 309279"/>
                    <a:gd name="connsiteX20-3851" fmla="*/ 577214 w 642310"/>
                    <a:gd name="connsiteY20-3852" fmla="*/ 200071 h 309279"/>
                    <a:gd name="connsiteX21-3853" fmla="*/ 513715 w 642310"/>
                    <a:gd name="connsiteY21-3854" fmla="*/ 234996 h 309279"/>
                    <a:gd name="connsiteX22-3855" fmla="*/ 432752 w 642310"/>
                    <a:gd name="connsiteY22-3856" fmla="*/ 239758 h 309279"/>
                    <a:gd name="connsiteX23-3857" fmla="*/ 366077 w 642310"/>
                    <a:gd name="connsiteY23-3858" fmla="*/ 296909 h 309279"/>
                    <a:gd name="connsiteX24-3859" fmla="*/ 337502 w 642310"/>
                    <a:gd name="connsiteY24-3860" fmla="*/ 301670 h 309279"/>
                    <a:gd name="connsiteX25-3861" fmla="*/ 381952 w 642310"/>
                    <a:gd name="connsiteY25-3862" fmla="*/ 209596 h 309279"/>
                    <a:gd name="connsiteX26-3863" fmla="*/ 316865 w 642310"/>
                    <a:gd name="connsiteY26-3864" fmla="*/ 236583 h 309279"/>
                    <a:gd name="connsiteX27-3865" fmla="*/ 231140 w 642310"/>
                    <a:gd name="connsiteY27-3866" fmla="*/ 247696 h 309279"/>
                    <a:gd name="connsiteX28-3867" fmla="*/ 166052 w 642310"/>
                    <a:gd name="connsiteY28-3868" fmla="*/ 282620 h 309279"/>
                    <a:gd name="connsiteX29-3869" fmla="*/ 199390 w 642310"/>
                    <a:gd name="connsiteY29-3870" fmla="*/ 214358 h 309279"/>
                    <a:gd name="connsiteX30-3871" fmla="*/ 4127 w 642310"/>
                    <a:gd name="connsiteY30-3872" fmla="*/ 242933 h 309279"/>
                    <a:gd name="connsiteX0-3873" fmla="*/ 3661 w 641844"/>
                    <a:gd name="connsiteY0-3874" fmla="*/ 242933 h 309279"/>
                    <a:gd name="connsiteX1-3875" fmla="*/ 68749 w 641844"/>
                    <a:gd name="connsiteY1-3876" fmla="*/ 122283 h 309279"/>
                    <a:gd name="connsiteX2-3877" fmla="*/ 103674 w 641844"/>
                    <a:gd name="connsiteY2-3878" fmla="*/ 74658 h 309279"/>
                    <a:gd name="connsiteX3-3879" fmla="*/ 86211 w 641844"/>
                    <a:gd name="connsiteY3-3880" fmla="*/ 50846 h 309279"/>
                    <a:gd name="connsiteX4-3881" fmla="*/ 108436 w 641844"/>
                    <a:gd name="connsiteY4-3882" fmla="*/ 6396 h 309279"/>
                    <a:gd name="connsiteX5-3883" fmla="*/ 163999 w 641844"/>
                    <a:gd name="connsiteY5-3884" fmla="*/ 4807 h 309279"/>
                    <a:gd name="connsiteX6-3885" fmla="*/ 183049 w 641844"/>
                    <a:gd name="connsiteY6-3886" fmla="*/ 49258 h 309279"/>
                    <a:gd name="connsiteX7-3887" fmla="*/ 179874 w 641844"/>
                    <a:gd name="connsiteY7-3888" fmla="*/ 73071 h 309279"/>
                    <a:gd name="connsiteX8-3889" fmla="*/ 229086 w 641844"/>
                    <a:gd name="connsiteY8-3890" fmla="*/ 22271 h 309279"/>
                    <a:gd name="connsiteX9-3891" fmla="*/ 351324 w 641844"/>
                    <a:gd name="connsiteY9-3892" fmla="*/ 4808 h 309279"/>
                    <a:gd name="connsiteX10-3893" fmla="*/ 505311 w 641844"/>
                    <a:gd name="connsiteY10-3894" fmla="*/ 65134 h 309279"/>
                    <a:gd name="connsiteX11-3895" fmla="*/ 578336 w 641844"/>
                    <a:gd name="connsiteY11-3896" fmla="*/ 142920 h 309279"/>
                    <a:gd name="connsiteX12-3897" fmla="*/ 635487 w 641844"/>
                    <a:gd name="connsiteY12-3898" fmla="*/ 215945 h 309279"/>
                    <a:gd name="connsiteX13-3899" fmla="*/ 638661 w 641844"/>
                    <a:gd name="connsiteY13-3900" fmla="*/ 254045 h 309279"/>
                    <a:gd name="connsiteX14-3901" fmla="*/ 619612 w 641844"/>
                    <a:gd name="connsiteY14-3902" fmla="*/ 274683 h 309279"/>
                    <a:gd name="connsiteX15-3903" fmla="*/ 579924 w 641844"/>
                    <a:gd name="connsiteY15-3904" fmla="*/ 287383 h 309279"/>
                    <a:gd name="connsiteX16-3905" fmla="*/ 429112 w 641844"/>
                    <a:gd name="connsiteY16-3906" fmla="*/ 284208 h 309279"/>
                    <a:gd name="connsiteX17-3907" fmla="*/ 570399 w 641844"/>
                    <a:gd name="connsiteY17-3908" fmla="*/ 273096 h 309279"/>
                    <a:gd name="connsiteX18-3909" fmla="*/ 614852 w 641844"/>
                    <a:gd name="connsiteY18-3910" fmla="*/ 244522 h 309279"/>
                    <a:gd name="connsiteX19-3911" fmla="*/ 602149 w 641844"/>
                    <a:gd name="connsiteY19-3912" fmla="*/ 204833 h 309279"/>
                    <a:gd name="connsiteX20-3913" fmla="*/ 576748 w 641844"/>
                    <a:gd name="connsiteY20-3914" fmla="*/ 200071 h 309279"/>
                    <a:gd name="connsiteX21-3915" fmla="*/ 513249 w 641844"/>
                    <a:gd name="connsiteY21-3916" fmla="*/ 234996 h 309279"/>
                    <a:gd name="connsiteX22-3917" fmla="*/ 432286 w 641844"/>
                    <a:gd name="connsiteY22-3918" fmla="*/ 239758 h 309279"/>
                    <a:gd name="connsiteX23-3919" fmla="*/ 365611 w 641844"/>
                    <a:gd name="connsiteY23-3920" fmla="*/ 296909 h 309279"/>
                    <a:gd name="connsiteX24-3921" fmla="*/ 337036 w 641844"/>
                    <a:gd name="connsiteY24-3922" fmla="*/ 301670 h 309279"/>
                    <a:gd name="connsiteX25-3923" fmla="*/ 381486 w 641844"/>
                    <a:gd name="connsiteY25-3924" fmla="*/ 209596 h 309279"/>
                    <a:gd name="connsiteX26-3925" fmla="*/ 316399 w 641844"/>
                    <a:gd name="connsiteY26-3926" fmla="*/ 236583 h 309279"/>
                    <a:gd name="connsiteX27-3927" fmla="*/ 230674 w 641844"/>
                    <a:gd name="connsiteY27-3928" fmla="*/ 247696 h 309279"/>
                    <a:gd name="connsiteX28-3929" fmla="*/ 165586 w 641844"/>
                    <a:gd name="connsiteY28-3930" fmla="*/ 282620 h 309279"/>
                    <a:gd name="connsiteX29-3931" fmla="*/ 189399 w 641844"/>
                    <a:gd name="connsiteY29-3932" fmla="*/ 214358 h 309279"/>
                    <a:gd name="connsiteX30-3933" fmla="*/ 3661 w 641844"/>
                    <a:gd name="connsiteY30-3934" fmla="*/ 242933 h 309279"/>
                    <a:gd name="connsiteX0-3935" fmla="*/ 3661 w 641844"/>
                    <a:gd name="connsiteY0-3936" fmla="*/ 242933 h 309279"/>
                    <a:gd name="connsiteX1-3937" fmla="*/ 68749 w 641844"/>
                    <a:gd name="connsiteY1-3938" fmla="*/ 122283 h 309279"/>
                    <a:gd name="connsiteX2-3939" fmla="*/ 103674 w 641844"/>
                    <a:gd name="connsiteY2-3940" fmla="*/ 74658 h 309279"/>
                    <a:gd name="connsiteX3-3941" fmla="*/ 86211 w 641844"/>
                    <a:gd name="connsiteY3-3942" fmla="*/ 50846 h 309279"/>
                    <a:gd name="connsiteX4-3943" fmla="*/ 108436 w 641844"/>
                    <a:gd name="connsiteY4-3944" fmla="*/ 6396 h 309279"/>
                    <a:gd name="connsiteX5-3945" fmla="*/ 163999 w 641844"/>
                    <a:gd name="connsiteY5-3946" fmla="*/ 4807 h 309279"/>
                    <a:gd name="connsiteX6-3947" fmla="*/ 183049 w 641844"/>
                    <a:gd name="connsiteY6-3948" fmla="*/ 49258 h 309279"/>
                    <a:gd name="connsiteX7-3949" fmla="*/ 179874 w 641844"/>
                    <a:gd name="connsiteY7-3950" fmla="*/ 73071 h 309279"/>
                    <a:gd name="connsiteX8-3951" fmla="*/ 229086 w 641844"/>
                    <a:gd name="connsiteY8-3952" fmla="*/ 22271 h 309279"/>
                    <a:gd name="connsiteX9-3953" fmla="*/ 351324 w 641844"/>
                    <a:gd name="connsiteY9-3954" fmla="*/ 4808 h 309279"/>
                    <a:gd name="connsiteX10-3955" fmla="*/ 505311 w 641844"/>
                    <a:gd name="connsiteY10-3956" fmla="*/ 65134 h 309279"/>
                    <a:gd name="connsiteX11-3957" fmla="*/ 578336 w 641844"/>
                    <a:gd name="connsiteY11-3958" fmla="*/ 142920 h 309279"/>
                    <a:gd name="connsiteX12-3959" fmla="*/ 635487 w 641844"/>
                    <a:gd name="connsiteY12-3960" fmla="*/ 215945 h 309279"/>
                    <a:gd name="connsiteX13-3961" fmla="*/ 638661 w 641844"/>
                    <a:gd name="connsiteY13-3962" fmla="*/ 254045 h 309279"/>
                    <a:gd name="connsiteX14-3963" fmla="*/ 619612 w 641844"/>
                    <a:gd name="connsiteY14-3964" fmla="*/ 274683 h 309279"/>
                    <a:gd name="connsiteX15-3965" fmla="*/ 579924 w 641844"/>
                    <a:gd name="connsiteY15-3966" fmla="*/ 287383 h 309279"/>
                    <a:gd name="connsiteX16-3967" fmla="*/ 429112 w 641844"/>
                    <a:gd name="connsiteY16-3968" fmla="*/ 284208 h 309279"/>
                    <a:gd name="connsiteX17-3969" fmla="*/ 570399 w 641844"/>
                    <a:gd name="connsiteY17-3970" fmla="*/ 273096 h 309279"/>
                    <a:gd name="connsiteX18-3971" fmla="*/ 614852 w 641844"/>
                    <a:gd name="connsiteY18-3972" fmla="*/ 244522 h 309279"/>
                    <a:gd name="connsiteX19-3973" fmla="*/ 602149 w 641844"/>
                    <a:gd name="connsiteY19-3974" fmla="*/ 204833 h 309279"/>
                    <a:gd name="connsiteX20-3975" fmla="*/ 576748 w 641844"/>
                    <a:gd name="connsiteY20-3976" fmla="*/ 200071 h 309279"/>
                    <a:gd name="connsiteX21-3977" fmla="*/ 513249 w 641844"/>
                    <a:gd name="connsiteY21-3978" fmla="*/ 234996 h 309279"/>
                    <a:gd name="connsiteX22-3979" fmla="*/ 432286 w 641844"/>
                    <a:gd name="connsiteY22-3980" fmla="*/ 239758 h 309279"/>
                    <a:gd name="connsiteX23-3981" fmla="*/ 365611 w 641844"/>
                    <a:gd name="connsiteY23-3982" fmla="*/ 296909 h 309279"/>
                    <a:gd name="connsiteX24-3983" fmla="*/ 337036 w 641844"/>
                    <a:gd name="connsiteY24-3984" fmla="*/ 301670 h 309279"/>
                    <a:gd name="connsiteX25-3985" fmla="*/ 381486 w 641844"/>
                    <a:gd name="connsiteY25-3986" fmla="*/ 209596 h 309279"/>
                    <a:gd name="connsiteX26-3987" fmla="*/ 316399 w 641844"/>
                    <a:gd name="connsiteY26-3988" fmla="*/ 236583 h 309279"/>
                    <a:gd name="connsiteX27-3989" fmla="*/ 238612 w 641844"/>
                    <a:gd name="connsiteY27-3990" fmla="*/ 227059 h 309279"/>
                    <a:gd name="connsiteX28-3991" fmla="*/ 165586 w 641844"/>
                    <a:gd name="connsiteY28-3992" fmla="*/ 282620 h 309279"/>
                    <a:gd name="connsiteX29-3993" fmla="*/ 189399 w 641844"/>
                    <a:gd name="connsiteY29-3994" fmla="*/ 214358 h 309279"/>
                    <a:gd name="connsiteX30-3995" fmla="*/ 3661 w 641844"/>
                    <a:gd name="connsiteY30-3996" fmla="*/ 242933 h 309279"/>
                    <a:gd name="connsiteX0-3997" fmla="*/ 3661 w 641844"/>
                    <a:gd name="connsiteY0-3998" fmla="*/ 242933 h 308119"/>
                    <a:gd name="connsiteX1-3999" fmla="*/ 68749 w 641844"/>
                    <a:gd name="connsiteY1-4000" fmla="*/ 122283 h 308119"/>
                    <a:gd name="connsiteX2-4001" fmla="*/ 103674 w 641844"/>
                    <a:gd name="connsiteY2-4002" fmla="*/ 74658 h 308119"/>
                    <a:gd name="connsiteX3-4003" fmla="*/ 86211 w 641844"/>
                    <a:gd name="connsiteY3-4004" fmla="*/ 50846 h 308119"/>
                    <a:gd name="connsiteX4-4005" fmla="*/ 108436 w 641844"/>
                    <a:gd name="connsiteY4-4006" fmla="*/ 6396 h 308119"/>
                    <a:gd name="connsiteX5-4007" fmla="*/ 163999 w 641844"/>
                    <a:gd name="connsiteY5-4008" fmla="*/ 4807 h 308119"/>
                    <a:gd name="connsiteX6-4009" fmla="*/ 183049 w 641844"/>
                    <a:gd name="connsiteY6-4010" fmla="*/ 49258 h 308119"/>
                    <a:gd name="connsiteX7-4011" fmla="*/ 179874 w 641844"/>
                    <a:gd name="connsiteY7-4012" fmla="*/ 73071 h 308119"/>
                    <a:gd name="connsiteX8-4013" fmla="*/ 229086 w 641844"/>
                    <a:gd name="connsiteY8-4014" fmla="*/ 22271 h 308119"/>
                    <a:gd name="connsiteX9-4015" fmla="*/ 351324 w 641844"/>
                    <a:gd name="connsiteY9-4016" fmla="*/ 4808 h 308119"/>
                    <a:gd name="connsiteX10-4017" fmla="*/ 505311 w 641844"/>
                    <a:gd name="connsiteY10-4018" fmla="*/ 65134 h 308119"/>
                    <a:gd name="connsiteX11-4019" fmla="*/ 578336 w 641844"/>
                    <a:gd name="connsiteY11-4020" fmla="*/ 142920 h 308119"/>
                    <a:gd name="connsiteX12-4021" fmla="*/ 635487 w 641844"/>
                    <a:gd name="connsiteY12-4022" fmla="*/ 215945 h 308119"/>
                    <a:gd name="connsiteX13-4023" fmla="*/ 638661 w 641844"/>
                    <a:gd name="connsiteY13-4024" fmla="*/ 254045 h 308119"/>
                    <a:gd name="connsiteX14-4025" fmla="*/ 619612 w 641844"/>
                    <a:gd name="connsiteY14-4026" fmla="*/ 274683 h 308119"/>
                    <a:gd name="connsiteX15-4027" fmla="*/ 579924 w 641844"/>
                    <a:gd name="connsiteY15-4028" fmla="*/ 287383 h 308119"/>
                    <a:gd name="connsiteX16-4029" fmla="*/ 429112 w 641844"/>
                    <a:gd name="connsiteY16-4030" fmla="*/ 284208 h 308119"/>
                    <a:gd name="connsiteX17-4031" fmla="*/ 570399 w 641844"/>
                    <a:gd name="connsiteY17-4032" fmla="*/ 273096 h 308119"/>
                    <a:gd name="connsiteX18-4033" fmla="*/ 614852 w 641844"/>
                    <a:gd name="connsiteY18-4034" fmla="*/ 244522 h 308119"/>
                    <a:gd name="connsiteX19-4035" fmla="*/ 602149 w 641844"/>
                    <a:gd name="connsiteY19-4036" fmla="*/ 204833 h 308119"/>
                    <a:gd name="connsiteX20-4037" fmla="*/ 576748 w 641844"/>
                    <a:gd name="connsiteY20-4038" fmla="*/ 200071 h 308119"/>
                    <a:gd name="connsiteX21-4039" fmla="*/ 513249 w 641844"/>
                    <a:gd name="connsiteY21-4040" fmla="*/ 234996 h 308119"/>
                    <a:gd name="connsiteX22-4041" fmla="*/ 432286 w 641844"/>
                    <a:gd name="connsiteY22-4042" fmla="*/ 239758 h 308119"/>
                    <a:gd name="connsiteX23-4043" fmla="*/ 365611 w 641844"/>
                    <a:gd name="connsiteY23-4044" fmla="*/ 296909 h 308119"/>
                    <a:gd name="connsiteX24-4045" fmla="*/ 337036 w 641844"/>
                    <a:gd name="connsiteY24-4046" fmla="*/ 301670 h 308119"/>
                    <a:gd name="connsiteX25-4047" fmla="*/ 391011 w 641844"/>
                    <a:gd name="connsiteY25-4048" fmla="*/ 225471 h 308119"/>
                    <a:gd name="connsiteX26-4049" fmla="*/ 316399 w 641844"/>
                    <a:gd name="connsiteY26-4050" fmla="*/ 236583 h 308119"/>
                    <a:gd name="connsiteX27-4051" fmla="*/ 238612 w 641844"/>
                    <a:gd name="connsiteY27-4052" fmla="*/ 227059 h 308119"/>
                    <a:gd name="connsiteX28-4053" fmla="*/ 165586 w 641844"/>
                    <a:gd name="connsiteY28-4054" fmla="*/ 282620 h 308119"/>
                    <a:gd name="connsiteX29-4055" fmla="*/ 189399 w 641844"/>
                    <a:gd name="connsiteY29-4056" fmla="*/ 214358 h 308119"/>
                    <a:gd name="connsiteX30-4057" fmla="*/ 3661 w 641844"/>
                    <a:gd name="connsiteY30-4058" fmla="*/ 242933 h 308119"/>
                    <a:gd name="connsiteX0-4059" fmla="*/ 3661 w 641844"/>
                    <a:gd name="connsiteY0-4060" fmla="*/ 242933 h 297971"/>
                    <a:gd name="connsiteX1-4061" fmla="*/ 68749 w 641844"/>
                    <a:gd name="connsiteY1-4062" fmla="*/ 122283 h 297971"/>
                    <a:gd name="connsiteX2-4063" fmla="*/ 103674 w 641844"/>
                    <a:gd name="connsiteY2-4064" fmla="*/ 74658 h 297971"/>
                    <a:gd name="connsiteX3-4065" fmla="*/ 86211 w 641844"/>
                    <a:gd name="connsiteY3-4066" fmla="*/ 50846 h 297971"/>
                    <a:gd name="connsiteX4-4067" fmla="*/ 108436 w 641844"/>
                    <a:gd name="connsiteY4-4068" fmla="*/ 6396 h 297971"/>
                    <a:gd name="connsiteX5-4069" fmla="*/ 163999 w 641844"/>
                    <a:gd name="connsiteY5-4070" fmla="*/ 4807 h 297971"/>
                    <a:gd name="connsiteX6-4071" fmla="*/ 183049 w 641844"/>
                    <a:gd name="connsiteY6-4072" fmla="*/ 49258 h 297971"/>
                    <a:gd name="connsiteX7-4073" fmla="*/ 179874 w 641844"/>
                    <a:gd name="connsiteY7-4074" fmla="*/ 73071 h 297971"/>
                    <a:gd name="connsiteX8-4075" fmla="*/ 229086 w 641844"/>
                    <a:gd name="connsiteY8-4076" fmla="*/ 22271 h 297971"/>
                    <a:gd name="connsiteX9-4077" fmla="*/ 351324 w 641844"/>
                    <a:gd name="connsiteY9-4078" fmla="*/ 4808 h 297971"/>
                    <a:gd name="connsiteX10-4079" fmla="*/ 505311 w 641844"/>
                    <a:gd name="connsiteY10-4080" fmla="*/ 65134 h 297971"/>
                    <a:gd name="connsiteX11-4081" fmla="*/ 578336 w 641844"/>
                    <a:gd name="connsiteY11-4082" fmla="*/ 142920 h 297971"/>
                    <a:gd name="connsiteX12-4083" fmla="*/ 635487 w 641844"/>
                    <a:gd name="connsiteY12-4084" fmla="*/ 215945 h 297971"/>
                    <a:gd name="connsiteX13-4085" fmla="*/ 638661 w 641844"/>
                    <a:gd name="connsiteY13-4086" fmla="*/ 254045 h 297971"/>
                    <a:gd name="connsiteX14-4087" fmla="*/ 619612 w 641844"/>
                    <a:gd name="connsiteY14-4088" fmla="*/ 274683 h 297971"/>
                    <a:gd name="connsiteX15-4089" fmla="*/ 579924 w 641844"/>
                    <a:gd name="connsiteY15-4090" fmla="*/ 287383 h 297971"/>
                    <a:gd name="connsiteX16-4091" fmla="*/ 429112 w 641844"/>
                    <a:gd name="connsiteY16-4092" fmla="*/ 284208 h 297971"/>
                    <a:gd name="connsiteX17-4093" fmla="*/ 570399 w 641844"/>
                    <a:gd name="connsiteY17-4094" fmla="*/ 273096 h 297971"/>
                    <a:gd name="connsiteX18-4095" fmla="*/ 614852 w 641844"/>
                    <a:gd name="connsiteY18-4096" fmla="*/ 244522 h 297971"/>
                    <a:gd name="connsiteX19-4097" fmla="*/ 602149 w 641844"/>
                    <a:gd name="connsiteY19-4098" fmla="*/ 204833 h 297971"/>
                    <a:gd name="connsiteX20-4099" fmla="*/ 576748 w 641844"/>
                    <a:gd name="connsiteY20-4100" fmla="*/ 200071 h 297971"/>
                    <a:gd name="connsiteX21-4101" fmla="*/ 513249 w 641844"/>
                    <a:gd name="connsiteY21-4102" fmla="*/ 234996 h 297971"/>
                    <a:gd name="connsiteX22-4103" fmla="*/ 432286 w 641844"/>
                    <a:gd name="connsiteY22-4104" fmla="*/ 239758 h 297971"/>
                    <a:gd name="connsiteX23-4105" fmla="*/ 365611 w 641844"/>
                    <a:gd name="connsiteY23-4106" fmla="*/ 296909 h 297971"/>
                    <a:gd name="connsiteX24-4107" fmla="*/ 337036 w 641844"/>
                    <a:gd name="connsiteY24-4108" fmla="*/ 273095 h 297971"/>
                    <a:gd name="connsiteX25-4109" fmla="*/ 391011 w 641844"/>
                    <a:gd name="connsiteY25-4110" fmla="*/ 225471 h 297971"/>
                    <a:gd name="connsiteX26-4111" fmla="*/ 316399 w 641844"/>
                    <a:gd name="connsiteY26-4112" fmla="*/ 236583 h 297971"/>
                    <a:gd name="connsiteX27-4113" fmla="*/ 238612 w 641844"/>
                    <a:gd name="connsiteY27-4114" fmla="*/ 227059 h 297971"/>
                    <a:gd name="connsiteX28-4115" fmla="*/ 165586 w 641844"/>
                    <a:gd name="connsiteY28-4116" fmla="*/ 282620 h 297971"/>
                    <a:gd name="connsiteX29-4117" fmla="*/ 189399 w 641844"/>
                    <a:gd name="connsiteY29-4118" fmla="*/ 214358 h 297971"/>
                    <a:gd name="connsiteX30-4119" fmla="*/ 3661 w 641844"/>
                    <a:gd name="connsiteY30-4120" fmla="*/ 242933 h 297971"/>
                    <a:gd name="connsiteX0-4121" fmla="*/ 3661 w 641844"/>
                    <a:gd name="connsiteY0-4122" fmla="*/ 242933 h 287897"/>
                    <a:gd name="connsiteX1-4123" fmla="*/ 68749 w 641844"/>
                    <a:gd name="connsiteY1-4124" fmla="*/ 122283 h 287897"/>
                    <a:gd name="connsiteX2-4125" fmla="*/ 103674 w 641844"/>
                    <a:gd name="connsiteY2-4126" fmla="*/ 74658 h 287897"/>
                    <a:gd name="connsiteX3-4127" fmla="*/ 86211 w 641844"/>
                    <a:gd name="connsiteY3-4128" fmla="*/ 50846 h 287897"/>
                    <a:gd name="connsiteX4-4129" fmla="*/ 108436 w 641844"/>
                    <a:gd name="connsiteY4-4130" fmla="*/ 6396 h 287897"/>
                    <a:gd name="connsiteX5-4131" fmla="*/ 163999 w 641844"/>
                    <a:gd name="connsiteY5-4132" fmla="*/ 4807 h 287897"/>
                    <a:gd name="connsiteX6-4133" fmla="*/ 183049 w 641844"/>
                    <a:gd name="connsiteY6-4134" fmla="*/ 49258 h 287897"/>
                    <a:gd name="connsiteX7-4135" fmla="*/ 179874 w 641844"/>
                    <a:gd name="connsiteY7-4136" fmla="*/ 73071 h 287897"/>
                    <a:gd name="connsiteX8-4137" fmla="*/ 229086 w 641844"/>
                    <a:gd name="connsiteY8-4138" fmla="*/ 22271 h 287897"/>
                    <a:gd name="connsiteX9-4139" fmla="*/ 351324 w 641844"/>
                    <a:gd name="connsiteY9-4140" fmla="*/ 4808 h 287897"/>
                    <a:gd name="connsiteX10-4141" fmla="*/ 505311 w 641844"/>
                    <a:gd name="connsiteY10-4142" fmla="*/ 65134 h 287897"/>
                    <a:gd name="connsiteX11-4143" fmla="*/ 578336 w 641844"/>
                    <a:gd name="connsiteY11-4144" fmla="*/ 142920 h 287897"/>
                    <a:gd name="connsiteX12-4145" fmla="*/ 635487 w 641844"/>
                    <a:gd name="connsiteY12-4146" fmla="*/ 215945 h 287897"/>
                    <a:gd name="connsiteX13-4147" fmla="*/ 638661 w 641844"/>
                    <a:gd name="connsiteY13-4148" fmla="*/ 254045 h 287897"/>
                    <a:gd name="connsiteX14-4149" fmla="*/ 619612 w 641844"/>
                    <a:gd name="connsiteY14-4150" fmla="*/ 274683 h 287897"/>
                    <a:gd name="connsiteX15-4151" fmla="*/ 579924 w 641844"/>
                    <a:gd name="connsiteY15-4152" fmla="*/ 287383 h 287897"/>
                    <a:gd name="connsiteX16-4153" fmla="*/ 429112 w 641844"/>
                    <a:gd name="connsiteY16-4154" fmla="*/ 284208 h 287897"/>
                    <a:gd name="connsiteX17-4155" fmla="*/ 570399 w 641844"/>
                    <a:gd name="connsiteY17-4156" fmla="*/ 273096 h 287897"/>
                    <a:gd name="connsiteX18-4157" fmla="*/ 614852 w 641844"/>
                    <a:gd name="connsiteY18-4158" fmla="*/ 244522 h 287897"/>
                    <a:gd name="connsiteX19-4159" fmla="*/ 602149 w 641844"/>
                    <a:gd name="connsiteY19-4160" fmla="*/ 204833 h 287897"/>
                    <a:gd name="connsiteX20-4161" fmla="*/ 576748 w 641844"/>
                    <a:gd name="connsiteY20-4162" fmla="*/ 200071 h 287897"/>
                    <a:gd name="connsiteX21-4163" fmla="*/ 513249 w 641844"/>
                    <a:gd name="connsiteY21-4164" fmla="*/ 234996 h 287897"/>
                    <a:gd name="connsiteX22-4165" fmla="*/ 432286 w 641844"/>
                    <a:gd name="connsiteY22-4166" fmla="*/ 239758 h 287897"/>
                    <a:gd name="connsiteX23-4167" fmla="*/ 368786 w 641844"/>
                    <a:gd name="connsiteY23-4168" fmla="*/ 271509 h 287897"/>
                    <a:gd name="connsiteX24-4169" fmla="*/ 337036 w 641844"/>
                    <a:gd name="connsiteY24-4170" fmla="*/ 273095 h 287897"/>
                    <a:gd name="connsiteX25-4171" fmla="*/ 391011 w 641844"/>
                    <a:gd name="connsiteY25-4172" fmla="*/ 225471 h 287897"/>
                    <a:gd name="connsiteX26-4173" fmla="*/ 316399 w 641844"/>
                    <a:gd name="connsiteY26-4174" fmla="*/ 236583 h 287897"/>
                    <a:gd name="connsiteX27-4175" fmla="*/ 238612 w 641844"/>
                    <a:gd name="connsiteY27-4176" fmla="*/ 227059 h 287897"/>
                    <a:gd name="connsiteX28-4177" fmla="*/ 165586 w 641844"/>
                    <a:gd name="connsiteY28-4178" fmla="*/ 282620 h 287897"/>
                    <a:gd name="connsiteX29-4179" fmla="*/ 189399 w 641844"/>
                    <a:gd name="connsiteY29-4180" fmla="*/ 214358 h 287897"/>
                    <a:gd name="connsiteX30-4181" fmla="*/ 3661 w 641844"/>
                    <a:gd name="connsiteY30-4182" fmla="*/ 242933 h 287897"/>
                    <a:gd name="connsiteX0-4183" fmla="*/ 3661 w 641844"/>
                    <a:gd name="connsiteY0-4184" fmla="*/ 242933 h 287897"/>
                    <a:gd name="connsiteX1-4185" fmla="*/ 68749 w 641844"/>
                    <a:gd name="connsiteY1-4186" fmla="*/ 122283 h 287897"/>
                    <a:gd name="connsiteX2-4187" fmla="*/ 103674 w 641844"/>
                    <a:gd name="connsiteY2-4188" fmla="*/ 74658 h 287897"/>
                    <a:gd name="connsiteX3-4189" fmla="*/ 86211 w 641844"/>
                    <a:gd name="connsiteY3-4190" fmla="*/ 50846 h 287897"/>
                    <a:gd name="connsiteX4-4191" fmla="*/ 108436 w 641844"/>
                    <a:gd name="connsiteY4-4192" fmla="*/ 6396 h 287897"/>
                    <a:gd name="connsiteX5-4193" fmla="*/ 163999 w 641844"/>
                    <a:gd name="connsiteY5-4194" fmla="*/ 4807 h 287897"/>
                    <a:gd name="connsiteX6-4195" fmla="*/ 183049 w 641844"/>
                    <a:gd name="connsiteY6-4196" fmla="*/ 49258 h 287897"/>
                    <a:gd name="connsiteX7-4197" fmla="*/ 179874 w 641844"/>
                    <a:gd name="connsiteY7-4198" fmla="*/ 73071 h 287897"/>
                    <a:gd name="connsiteX8-4199" fmla="*/ 229086 w 641844"/>
                    <a:gd name="connsiteY8-4200" fmla="*/ 22271 h 287897"/>
                    <a:gd name="connsiteX9-4201" fmla="*/ 351324 w 641844"/>
                    <a:gd name="connsiteY9-4202" fmla="*/ 4808 h 287897"/>
                    <a:gd name="connsiteX10-4203" fmla="*/ 505311 w 641844"/>
                    <a:gd name="connsiteY10-4204" fmla="*/ 65134 h 287897"/>
                    <a:gd name="connsiteX11-4205" fmla="*/ 578336 w 641844"/>
                    <a:gd name="connsiteY11-4206" fmla="*/ 142920 h 287897"/>
                    <a:gd name="connsiteX12-4207" fmla="*/ 635487 w 641844"/>
                    <a:gd name="connsiteY12-4208" fmla="*/ 215945 h 287897"/>
                    <a:gd name="connsiteX13-4209" fmla="*/ 638661 w 641844"/>
                    <a:gd name="connsiteY13-4210" fmla="*/ 254045 h 287897"/>
                    <a:gd name="connsiteX14-4211" fmla="*/ 619612 w 641844"/>
                    <a:gd name="connsiteY14-4212" fmla="*/ 274683 h 287897"/>
                    <a:gd name="connsiteX15-4213" fmla="*/ 579924 w 641844"/>
                    <a:gd name="connsiteY15-4214" fmla="*/ 287383 h 287897"/>
                    <a:gd name="connsiteX16-4215" fmla="*/ 429112 w 641844"/>
                    <a:gd name="connsiteY16-4216" fmla="*/ 284208 h 287897"/>
                    <a:gd name="connsiteX17-4217" fmla="*/ 570399 w 641844"/>
                    <a:gd name="connsiteY17-4218" fmla="*/ 273096 h 287897"/>
                    <a:gd name="connsiteX18-4219" fmla="*/ 614852 w 641844"/>
                    <a:gd name="connsiteY18-4220" fmla="*/ 244522 h 287897"/>
                    <a:gd name="connsiteX19-4221" fmla="*/ 602149 w 641844"/>
                    <a:gd name="connsiteY19-4222" fmla="*/ 204833 h 287897"/>
                    <a:gd name="connsiteX20-4223" fmla="*/ 576748 w 641844"/>
                    <a:gd name="connsiteY20-4224" fmla="*/ 200071 h 287897"/>
                    <a:gd name="connsiteX21-4225" fmla="*/ 513249 w 641844"/>
                    <a:gd name="connsiteY21-4226" fmla="*/ 234996 h 287897"/>
                    <a:gd name="connsiteX22-4227" fmla="*/ 432286 w 641844"/>
                    <a:gd name="connsiteY22-4228" fmla="*/ 239758 h 287897"/>
                    <a:gd name="connsiteX23-4229" fmla="*/ 368786 w 641844"/>
                    <a:gd name="connsiteY23-4230" fmla="*/ 271509 h 287897"/>
                    <a:gd name="connsiteX24-4231" fmla="*/ 337036 w 641844"/>
                    <a:gd name="connsiteY24-4232" fmla="*/ 273095 h 287897"/>
                    <a:gd name="connsiteX25-4233" fmla="*/ 391011 w 641844"/>
                    <a:gd name="connsiteY25-4234" fmla="*/ 225471 h 287897"/>
                    <a:gd name="connsiteX26-4235" fmla="*/ 316399 w 641844"/>
                    <a:gd name="connsiteY26-4236" fmla="*/ 236583 h 287897"/>
                    <a:gd name="connsiteX27-4237" fmla="*/ 238612 w 641844"/>
                    <a:gd name="connsiteY27-4238" fmla="*/ 227059 h 287897"/>
                    <a:gd name="connsiteX28-4239" fmla="*/ 152886 w 641844"/>
                    <a:gd name="connsiteY28-4240" fmla="*/ 263570 h 287897"/>
                    <a:gd name="connsiteX29-4241" fmla="*/ 189399 w 641844"/>
                    <a:gd name="connsiteY29-4242" fmla="*/ 214358 h 287897"/>
                    <a:gd name="connsiteX30-4243" fmla="*/ 3661 w 641844"/>
                    <a:gd name="connsiteY30-4244" fmla="*/ 242933 h 287897"/>
                    <a:gd name="connsiteX0-4245" fmla="*/ 3661 w 641844"/>
                    <a:gd name="connsiteY0-4246" fmla="*/ 242933 h 287897"/>
                    <a:gd name="connsiteX1-4247" fmla="*/ 68749 w 641844"/>
                    <a:gd name="connsiteY1-4248" fmla="*/ 122283 h 287897"/>
                    <a:gd name="connsiteX2-4249" fmla="*/ 103674 w 641844"/>
                    <a:gd name="connsiteY2-4250" fmla="*/ 74658 h 287897"/>
                    <a:gd name="connsiteX3-4251" fmla="*/ 86211 w 641844"/>
                    <a:gd name="connsiteY3-4252" fmla="*/ 50846 h 287897"/>
                    <a:gd name="connsiteX4-4253" fmla="*/ 108436 w 641844"/>
                    <a:gd name="connsiteY4-4254" fmla="*/ 6396 h 287897"/>
                    <a:gd name="connsiteX5-4255" fmla="*/ 163999 w 641844"/>
                    <a:gd name="connsiteY5-4256" fmla="*/ 4807 h 287897"/>
                    <a:gd name="connsiteX6-4257" fmla="*/ 183049 w 641844"/>
                    <a:gd name="connsiteY6-4258" fmla="*/ 49258 h 287897"/>
                    <a:gd name="connsiteX7-4259" fmla="*/ 167174 w 641844"/>
                    <a:gd name="connsiteY7-4260" fmla="*/ 50846 h 287897"/>
                    <a:gd name="connsiteX8-4261" fmla="*/ 229086 w 641844"/>
                    <a:gd name="connsiteY8-4262" fmla="*/ 22271 h 287897"/>
                    <a:gd name="connsiteX9-4263" fmla="*/ 351324 w 641844"/>
                    <a:gd name="connsiteY9-4264" fmla="*/ 4808 h 287897"/>
                    <a:gd name="connsiteX10-4265" fmla="*/ 505311 w 641844"/>
                    <a:gd name="connsiteY10-4266" fmla="*/ 65134 h 287897"/>
                    <a:gd name="connsiteX11-4267" fmla="*/ 578336 w 641844"/>
                    <a:gd name="connsiteY11-4268" fmla="*/ 142920 h 287897"/>
                    <a:gd name="connsiteX12-4269" fmla="*/ 635487 w 641844"/>
                    <a:gd name="connsiteY12-4270" fmla="*/ 215945 h 287897"/>
                    <a:gd name="connsiteX13-4271" fmla="*/ 638661 w 641844"/>
                    <a:gd name="connsiteY13-4272" fmla="*/ 254045 h 287897"/>
                    <a:gd name="connsiteX14-4273" fmla="*/ 619612 w 641844"/>
                    <a:gd name="connsiteY14-4274" fmla="*/ 274683 h 287897"/>
                    <a:gd name="connsiteX15-4275" fmla="*/ 579924 w 641844"/>
                    <a:gd name="connsiteY15-4276" fmla="*/ 287383 h 287897"/>
                    <a:gd name="connsiteX16-4277" fmla="*/ 429112 w 641844"/>
                    <a:gd name="connsiteY16-4278" fmla="*/ 284208 h 287897"/>
                    <a:gd name="connsiteX17-4279" fmla="*/ 570399 w 641844"/>
                    <a:gd name="connsiteY17-4280" fmla="*/ 273096 h 287897"/>
                    <a:gd name="connsiteX18-4281" fmla="*/ 614852 w 641844"/>
                    <a:gd name="connsiteY18-4282" fmla="*/ 244522 h 287897"/>
                    <a:gd name="connsiteX19-4283" fmla="*/ 602149 w 641844"/>
                    <a:gd name="connsiteY19-4284" fmla="*/ 204833 h 287897"/>
                    <a:gd name="connsiteX20-4285" fmla="*/ 576748 w 641844"/>
                    <a:gd name="connsiteY20-4286" fmla="*/ 200071 h 287897"/>
                    <a:gd name="connsiteX21-4287" fmla="*/ 513249 w 641844"/>
                    <a:gd name="connsiteY21-4288" fmla="*/ 234996 h 287897"/>
                    <a:gd name="connsiteX22-4289" fmla="*/ 432286 w 641844"/>
                    <a:gd name="connsiteY22-4290" fmla="*/ 239758 h 287897"/>
                    <a:gd name="connsiteX23-4291" fmla="*/ 368786 w 641844"/>
                    <a:gd name="connsiteY23-4292" fmla="*/ 271509 h 287897"/>
                    <a:gd name="connsiteX24-4293" fmla="*/ 337036 w 641844"/>
                    <a:gd name="connsiteY24-4294" fmla="*/ 273095 h 287897"/>
                    <a:gd name="connsiteX25-4295" fmla="*/ 391011 w 641844"/>
                    <a:gd name="connsiteY25-4296" fmla="*/ 225471 h 287897"/>
                    <a:gd name="connsiteX26-4297" fmla="*/ 316399 w 641844"/>
                    <a:gd name="connsiteY26-4298" fmla="*/ 236583 h 287897"/>
                    <a:gd name="connsiteX27-4299" fmla="*/ 238612 w 641844"/>
                    <a:gd name="connsiteY27-4300" fmla="*/ 227059 h 287897"/>
                    <a:gd name="connsiteX28-4301" fmla="*/ 152886 w 641844"/>
                    <a:gd name="connsiteY28-4302" fmla="*/ 263570 h 287897"/>
                    <a:gd name="connsiteX29-4303" fmla="*/ 189399 w 641844"/>
                    <a:gd name="connsiteY29-4304" fmla="*/ 214358 h 287897"/>
                    <a:gd name="connsiteX30-4305" fmla="*/ 3661 w 641844"/>
                    <a:gd name="connsiteY30-4306" fmla="*/ 242933 h 287897"/>
                    <a:gd name="connsiteX0-4307" fmla="*/ 3661 w 641844"/>
                    <a:gd name="connsiteY0-4308" fmla="*/ 242933 h 287897"/>
                    <a:gd name="connsiteX1-4309" fmla="*/ 68749 w 641844"/>
                    <a:gd name="connsiteY1-4310" fmla="*/ 122283 h 287897"/>
                    <a:gd name="connsiteX2-4311" fmla="*/ 103674 w 641844"/>
                    <a:gd name="connsiteY2-4312" fmla="*/ 74658 h 287897"/>
                    <a:gd name="connsiteX3-4313" fmla="*/ 86211 w 641844"/>
                    <a:gd name="connsiteY3-4314" fmla="*/ 50846 h 287897"/>
                    <a:gd name="connsiteX4-4315" fmla="*/ 108436 w 641844"/>
                    <a:gd name="connsiteY4-4316" fmla="*/ 6396 h 287897"/>
                    <a:gd name="connsiteX5-4317" fmla="*/ 163999 w 641844"/>
                    <a:gd name="connsiteY5-4318" fmla="*/ 4807 h 287897"/>
                    <a:gd name="connsiteX6-4319" fmla="*/ 183049 w 641844"/>
                    <a:gd name="connsiteY6-4320" fmla="*/ 49258 h 287897"/>
                    <a:gd name="connsiteX7-4321" fmla="*/ 149711 w 641844"/>
                    <a:gd name="connsiteY7-4322" fmla="*/ 33384 h 287897"/>
                    <a:gd name="connsiteX8-4323" fmla="*/ 229086 w 641844"/>
                    <a:gd name="connsiteY8-4324" fmla="*/ 22271 h 287897"/>
                    <a:gd name="connsiteX9-4325" fmla="*/ 351324 w 641844"/>
                    <a:gd name="connsiteY9-4326" fmla="*/ 4808 h 287897"/>
                    <a:gd name="connsiteX10-4327" fmla="*/ 505311 w 641844"/>
                    <a:gd name="connsiteY10-4328" fmla="*/ 65134 h 287897"/>
                    <a:gd name="connsiteX11-4329" fmla="*/ 578336 w 641844"/>
                    <a:gd name="connsiteY11-4330" fmla="*/ 142920 h 287897"/>
                    <a:gd name="connsiteX12-4331" fmla="*/ 635487 w 641844"/>
                    <a:gd name="connsiteY12-4332" fmla="*/ 215945 h 287897"/>
                    <a:gd name="connsiteX13-4333" fmla="*/ 638661 w 641844"/>
                    <a:gd name="connsiteY13-4334" fmla="*/ 254045 h 287897"/>
                    <a:gd name="connsiteX14-4335" fmla="*/ 619612 w 641844"/>
                    <a:gd name="connsiteY14-4336" fmla="*/ 274683 h 287897"/>
                    <a:gd name="connsiteX15-4337" fmla="*/ 579924 w 641844"/>
                    <a:gd name="connsiteY15-4338" fmla="*/ 287383 h 287897"/>
                    <a:gd name="connsiteX16-4339" fmla="*/ 429112 w 641844"/>
                    <a:gd name="connsiteY16-4340" fmla="*/ 284208 h 287897"/>
                    <a:gd name="connsiteX17-4341" fmla="*/ 570399 w 641844"/>
                    <a:gd name="connsiteY17-4342" fmla="*/ 273096 h 287897"/>
                    <a:gd name="connsiteX18-4343" fmla="*/ 614852 w 641844"/>
                    <a:gd name="connsiteY18-4344" fmla="*/ 244522 h 287897"/>
                    <a:gd name="connsiteX19-4345" fmla="*/ 602149 w 641844"/>
                    <a:gd name="connsiteY19-4346" fmla="*/ 204833 h 287897"/>
                    <a:gd name="connsiteX20-4347" fmla="*/ 576748 w 641844"/>
                    <a:gd name="connsiteY20-4348" fmla="*/ 200071 h 287897"/>
                    <a:gd name="connsiteX21-4349" fmla="*/ 513249 w 641844"/>
                    <a:gd name="connsiteY21-4350" fmla="*/ 234996 h 287897"/>
                    <a:gd name="connsiteX22-4351" fmla="*/ 432286 w 641844"/>
                    <a:gd name="connsiteY22-4352" fmla="*/ 239758 h 287897"/>
                    <a:gd name="connsiteX23-4353" fmla="*/ 368786 w 641844"/>
                    <a:gd name="connsiteY23-4354" fmla="*/ 271509 h 287897"/>
                    <a:gd name="connsiteX24-4355" fmla="*/ 337036 w 641844"/>
                    <a:gd name="connsiteY24-4356" fmla="*/ 273095 h 287897"/>
                    <a:gd name="connsiteX25-4357" fmla="*/ 391011 w 641844"/>
                    <a:gd name="connsiteY25-4358" fmla="*/ 225471 h 287897"/>
                    <a:gd name="connsiteX26-4359" fmla="*/ 316399 w 641844"/>
                    <a:gd name="connsiteY26-4360" fmla="*/ 236583 h 287897"/>
                    <a:gd name="connsiteX27-4361" fmla="*/ 238612 w 641844"/>
                    <a:gd name="connsiteY27-4362" fmla="*/ 227059 h 287897"/>
                    <a:gd name="connsiteX28-4363" fmla="*/ 152886 w 641844"/>
                    <a:gd name="connsiteY28-4364" fmla="*/ 263570 h 287897"/>
                    <a:gd name="connsiteX29-4365" fmla="*/ 189399 w 641844"/>
                    <a:gd name="connsiteY29-4366" fmla="*/ 214358 h 287897"/>
                    <a:gd name="connsiteX30-4367" fmla="*/ 3661 w 641844"/>
                    <a:gd name="connsiteY30-4368" fmla="*/ 242933 h 287897"/>
                    <a:gd name="connsiteX0-4369" fmla="*/ 3661 w 641844"/>
                    <a:gd name="connsiteY0-4370" fmla="*/ 242933 h 287897"/>
                    <a:gd name="connsiteX1-4371" fmla="*/ 68749 w 641844"/>
                    <a:gd name="connsiteY1-4372" fmla="*/ 122283 h 287897"/>
                    <a:gd name="connsiteX2-4373" fmla="*/ 103674 w 641844"/>
                    <a:gd name="connsiteY2-4374" fmla="*/ 74658 h 287897"/>
                    <a:gd name="connsiteX3-4375" fmla="*/ 86211 w 641844"/>
                    <a:gd name="connsiteY3-4376" fmla="*/ 50846 h 287897"/>
                    <a:gd name="connsiteX4-4377" fmla="*/ 108436 w 641844"/>
                    <a:gd name="connsiteY4-4378" fmla="*/ 6396 h 287897"/>
                    <a:gd name="connsiteX5-4379" fmla="*/ 163999 w 641844"/>
                    <a:gd name="connsiteY5-4380" fmla="*/ 4807 h 287897"/>
                    <a:gd name="connsiteX6-4381" fmla="*/ 183049 w 641844"/>
                    <a:gd name="connsiteY6-4382" fmla="*/ 49258 h 287897"/>
                    <a:gd name="connsiteX7-4383" fmla="*/ 149711 w 641844"/>
                    <a:gd name="connsiteY7-4384" fmla="*/ 33384 h 287897"/>
                    <a:gd name="connsiteX8-4385" fmla="*/ 227499 w 641844"/>
                    <a:gd name="connsiteY8-4386" fmla="*/ 47671 h 287897"/>
                    <a:gd name="connsiteX9-4387" fmla="*/ 351324 w 641844"/>
                    <a:gd name="connsiteY9-4388" fmla="*/ 4808 h 287897"/>
                    <a:gd name="connsiteX10-4389" fmla="*/ 505311 w 641844"/>
                    <a:gd name="connsiteY10-4390" fmla="*/ 65134 h 287897"/>
                    <a:gd name="connsiteX11-4391" fmla="*/ 578336 w 641844"/>
                    <a:gd name="connsiteY11-4392" fmla="*/ 142920 h 287897"/>
                    <a:gd name="connsiteX12-4393" fmla="*/ 635487 w 641844"/>
                    <a:gd name="connsiteY12-4394" fmla="*/ 215945 h 287897"/>
                    <a:gd name="connsiteX13-4395" fmla="*/ 638661 w 641844"/>
                    <a:gd name="connsiteY13-4396" fmla="*/ 254045 h 287897"/>
                    <a:gd name="connsiteX14-4397" fmla="*/ 619612 w 641844"/>
                    <a:gd name="connsiteY14-4398" fmla="*/ 274683 h 287897"/>
                    <a:gd name="connsiteX15-4399" fmla="*/ 579924 w 641844"/>
                    <a:gd name="connsiteY15-4400" fmla="*/ 287383 h 287897"/>
                    <a:gd name="connsiteX16-4401" fmla="*/ 429112 w 641844"/>
                    <a:gd name="connsiteY16-4402" fmla="*/ 284208 h 287897"/>
                    <a:gd name="connsiteX17-4403" fmla="*/ 570399 w 641844"/>
                    <a:gd name="connsiteY17-4404" fmla="*/ 273096 h 287897"/>
                    <a:gd name="connsiteX18-4405" fmla="*/ 614852 w 641844"/>
                    <a:gd name="connsiteY18-4406" fmla="*/ 244522 h 287897"/>
                    <a:gd name="connsiteX19-4407" fmla="*/ 602149 w 641844"/>
                    <a:gd name="connsiteY19-4408" fmla="*/ 204833 h 287897"/>
                    <a:gd name="connsiteX20-4409" fmla="*/ 576748 w 641844"/>
                    <a:gd name="connsiteY20-4410" fmla="*/ 200071 h 287897"/>
                    <a:gd name="connsiteX21-4411" fmla="*/ 513249 w 641844"/>
                    <a:gd name="connsiteY21-4412" fmla="*/ 234996 h 287897"/>
                    <a:gd name="connsiteX22-4413" fmla="*/ 432286 w 641844"/>
                    <a:gd name="connsiteY22-4414" fmla="*/ 239758 h 287897"/>
                    <a:gd name="connsiteX23-4415" fmla="*/ 368786 w 641844"/>
                    <a:gd name="connsiteY23-4416" fmla="*/ 271509 h 287897"/>
                    <a:gd name="connsiteX24-4417" fmla="*/ 337036 w 641844"/>
                    <a:gd name="connsiteY24-4418" fmla="*/ 273095 h 287897"/>
                    <a:gd name="connsiteX25-4419" fmla="*/ 391011 w 641844"/>
                    <a:gd name="connsiteY25-4420" fmla="*/ 225471 h 287897"/>
                    <a:gd name="connsiteX26-4421" fmla="*/ 316399 w 641844"/>
                    <a:gd name="connsiteY26-4422" fmla="*/ 236583 h 287897"/>
                    <a:gd name="connsiteX27-4423" fmla="*/ 238612 w 641844"/>
                    <a:gd name="connsiteY27-4424" fmla="*/ 227059 h 287897"/>
                    <a:gd name="connsiteX28-4425" fmla="*/ 152886 w 641844"/>
                    <a:gd name="connsiteY28-4426" fmla="*/ 263570 h 287897"/>
                    <a:gd name="connsiteX29-4427" fmla="*/ 189399 w 641844"/>
                    <a:gd name="connsiteY29-4428" fmla="*/ 214358 h 287897"/>
                    <a:gd name="connsiteX30-4429" fmla="*/ 3661 w 641844"/>
                    <a:gd name="connsiteY30-4430" fmla="*/ 242933 h 287897"/>
                    <a:gd name="connsiteX0-4431" fmla="*/ 3661 w 641844"/>
                    <a:gd name="connsiteY0-4432" fmla="*/ 242933 h 287897"/>
                    <a:gd name="connsiteX1-4433" fmla="*/ 68749 w 641844"/>
                    <a:gd name="connsiteY1-4434" fmla="*/ 122283 h 287897"/>
                    <a:gd name="connsiteX2-4435" fmla="*/ 103674 w 641844"/>
                    <a:gd name="connsiteY2-4436" fmla="*/ 74658 h 287897"/>
                    <a:gd name="connsiteX3-4437" fmla="*/ 86211 w 641844"/>
                    <a:gd name="connsiteY3-4438" fmla="*/ 50846 h 287897"/>
                    <a:gd name="connsiteX4-4439" fmla="*/ 108436 w 641844"/>
                    <a:gd name="connsiteY4-4440" fmla="*/ 6396 h 287897"/>
                    <a:gd name="connsiteX5-4441" fmla="*/ 163999 w 641844"/>
                    <a:gd name="connsiteY5-4442" fmla="*/ 4807 h 287897"/>
                    <a:gd name="connsiteX6-4443" fmla="*/ 183049 w 641844"/>
                    <a:gd name="connsiteY6-4444" fmla="*/ 49258 h 287897"/>
                    <a:gd name="connsiteX7-4445" fmla="*/ 149711 w 641844"/>
                    <a:gd name="connsiteY7-4446" fmla="*/ 33384 h 287897"/>
                    <a:gd name="connsiteX8-4447" fmla="*/ 229087 w 641844"/>
                    <a:gd name="connsiteY8-4448" fmla="*/ 31796 h 287897"/>
                    <a:gd name="connsiteX9-4449" fmla="*/ 351324 w 641844"/>
                    <a:gd name="connsiteY9-4450" fmla="*/ 4808 h 287897"/>
                    <a:gd name="connsiteX10-4451" fmla="*/ 505311 w 641844"/>
                    <a:gd name="connsiteY10-4452" fmla="*/ 65134 h 287897"/>
                    <a:gd name="connsiteX11-4453" fmla="*/ 578336 w 641844"/>
                    <a:gd name="connsiteY11-4454" fmla="*/ 142920 h 287897"/>
                    <a:gd name="connsiteX12-4455" fmla="*/ 635487 w 641844"/>
                    <a:gd name="connsiteY12-4456" fmla="*/ 215945 h 287897"/>
                    <a:gd name="connsiteX13-4457" fmla="*/ 638661 w 641844"/>
                    <a:gd name="connsiteY13-4458" fmla="*/ 254045 h 287897"/>
                    <a:gd name="connsiteX14-4459" fmla="*/ 619612 w 641844"/>
                    <a:gd name="connsiteY14-4460" fmla="*/ 274683 h 287897"/>
                    <a:gd name="connsiteX15-4461" fmla="*/ 579924 w 641844"/>
                    <a:gd name="connsiteY15-4462" fmla="*/ 287383 h 287897"/>
                    <a:gd name="connsiteX16-4463" fmla="*/ 429112 w 641844"/>
                    <a:gd name="connsiteY16-4464" fmla="*/ 284208 h 287897"/>
                    <a:gd name="connsiteX17-4465" fmla="*/ 570399 w 641844"/>
                    <a:gd name="connsiteY17-4466" fmla="*/ 273096 h 287897"/>
                    <a:gd name="connsiteX18-4467" fmla="*/ 614852 w 641844"/>
                    <a:gd name="connsiteY18-4468" fmla="*/ 244522 h 287897"/>
                    <a:gd name="connsiteX19-4469" fmla="*/ 602149 w 641844"/>
                    <a:gd name="connsiteY19-4470" fmla="*/ 204833 h 287897"/>
                    <a:gd name="connsiteX20-4471" fmla="*/ 576748 w 641844"/>
                    <a:gd name="connsiteY20-4472" fmla="*/ 200071 h 287897"/>
                    <a:gd name="connsiteX21-4473" fmla="*/ 513249 w 641844"/>
                    <a:gd name="connsiteY21-4474" fmla="*/ 234996 h 287897"/>
                    <a:gd name="connsiteX22-4475" fmla="*/ 432286 w 641844"/>
                    <a:gd name="connsiteY22-4476" fmla="*/ 239758 h 287897"/>
                    <a:gd name="connsiteX23-4477" fmla="*/ 368786 w 641844"/>
                    <a:gd name="connsiteY23-4478" fmla="*/ 271509 h 287897"/>
                    <a:gd name="connsiteX24-4479" fmla="*/ 337036 w 641844"/>
                    <a:gd name="connsiteY24-4480" fmla="*/ 273095 h 287897"/>
                    <a:gd name="connsiteX25-4481" fmla="*/ 391011 w 641844"/>
                    <a:gd name="connsiteY25-4482" fmla="*/ 225471 h 287897"/>
                    <a:gd name="connsiteX26-4483" fmla="*/ 316399 w 641844"/>
                    <a:gd name="connsiteY26-4484" fmla="*/ 236583 h 287897"/>
                    <a:gd name="connsiteX27-4485" fmla="*/ 238612 w 641844"/>
                    <a:gd name="connsiteY27-4486" fmla="*/ 227059 h 287897"/>
                    <a:gd name="connsiteX28-4487" fmla="*/ 152886 w 641844"/>
                    <a:gd name="connsiteY28-4488" fmla="*/ 263570 h 287897"/>
                    <a:gd name="connsiteX29-4489" fmla="*/ 189399 w 641844"/>
                    <a:gd name="connsiteY29-4490" fmla="*/ 214358 h 287897"/>
                    <a:gd name="connsiteX30-4491" fmla="*/ 3661 w 641844"/>
                    <a:gd name="connsiteY30-4492" fmla="*/ 242933 h 287897"/>
                    <a:gd name="connsiteX0-4493" fmla="*/ 3661 w 641844"/>
                    <a:gd name="connsiteY0-4494" fmla="*/ 241415 h 286379"/>
                    <a:gd name="connsiteX1-4495" fmla="*/ 68749 w 641844"/>
                    <a:gd name="connsiteY1-4496" fmla="*/ 120765 h 286379"/>
                    <a:gd name="connsiteX2-4497" fmla="*/ 103674 w 641844"/>
                    <a:gd name="connsiteY2-4498" fmla="*/ 73140 h 286379"/>
                    <a:gd name="connsiteX3-4499" fmla="*/ 86211 w 641844"/>
                    <a:gd name="connsiteY3-4500" fmla="*/ 49328 h 286379"/>
                    <a:gd name="connsiteX4-4501" fmla="*/ 108436 w 641844"/>
                    <a:gd name="connsiteY4-4502" fmla="*/ 4878 h 286379"/>
                    <a:gd name="connsiteX5-4503" fmla="*/ 163999 w 641844"/>
                    <a:gd name="connsiteY5-4504" fmla="*/ 3289 h 286379"/>
                    <a:gd name="connsiteX6-4505" fmla="*/ 179874 w 641844"/>
                    <a:gd name="connsiteY6-4506" fmla="*/ 23928 h 286379"/>
                    <a:gd name="connsiteX7-4507" fmla="*/ 149711 w 641844"/>
                    <a:gd name="connsiteY7-4508" fmla="*/ 31866 h 286379"/>
                    <a:gd name="connsiteX8-4509" fmla="*/ 229087 w 641844"/>
                    <a:gd name="connsiteY8-4510" fmla="*/ 30278 h 286379"/>
                    <a:gd name="connsiteX9-4511" fmla="*/ 351324 w 641844"/>
                    <a:gd name="connsiteY9-4512" fmla="*/ 3290 h 286379"/>
                    <a:gd name="connsiteX10-4513" fmla="*/ 505311 w 641844"/>
                    <a:gd name="connsiteY10-4514" fmla="*/ 63616 h 286379"/>
                    <a:gd name="connsiteX11-4515" fmla="*/ 578336 w 641844"/>
                    <a:gd name="connsiteY11-4516" fmla="*/ 141402 h 286379"/>
                    <a:gd name="connsiteX12-4517" fmla="*/ 635487 w 641844"/>
                    <a:gd name="connsiteY12-4518" fmla="*/ 214427 h 286379"/>
                    <a:gd name="connsiteX13-4519" fmla="*/ 638661 w 641844"/>
                    <a:gd name="connsiteY13-4520" fmla="*/ 252527 h 286379"/>
                    <a:gd name="connsiteX14-4521" fmla="*/ 619612 w 641844"/>
                    <a:gd name="connsiteY14-4522" fmla="*/ 273165 h 286379"/>
                    <a:gd name="connsiteX15-4523" fmla="*/ 579924 w 641844"/>
                    <a:gd name="connsiteY15-4524" fmla="*/ 285865 h 286379"/>
                    <a:gd name="connsiteX16-4525" fmla="*/ 429112 w 641844"/>
                    <a:gd name="connsiteY16-4526" fmla="*/ 282690 h 286379"/>
                    <a:gd name="connsiteX17-4527" fmla="*/ 570399 w 641844"/>
                    <a:gd name="connsiteY17-4528" fmla="*/ 271578 h 286379"/>
                    <a:gd name="connsiteX18-4529" fmla="*/ 614852 w 641844"/>
                    <a:gd name="connsiteY18-4530" fmla="*/ 243004 h 286379"/>
                    <a:gd name="connsiteX19-4531" fmla="*/ 602149 w 641844"/>
                    <a:gd name="connsiteY19-4532" fmla="*/ 203315 h 286379"/>
                    <a:gd name="connsiteX20-4533" fmla="*/ 576748 w 641844"/>
                    <a:gd name="connsiteY20-4534" fmla="*/ 198553 h 286379"/>
                    <a:gd name="connsiteX21-4535" fmla="*/ 513249 w 641844"/>
                    <a:gd name="connsiteY21-4536" fmla="*/ 233478 h 286379"/>
                    <a:gd name="connsiteX22-4537" fmla="*/ 432286 w 641844"/>
                    <a:gd name="connsiteY22-4538" fmla="*/ 238240 h 286379"/>
                    <a:gd name="connsiteX23-4539" fmla="*/ 368786 w 641844"/>
                    <a:gd name="connsiteY23-4540" fmla="*/ 269991 h 286379"/>
                    <a:gd name="connsiteX24-4541" fmla="*/ 337036 w 641844"/>
                    <a:gd name="connsiteY24-4542" fmla="*/ 271577 h 286379"/>
                    <a:gd name="connsiteX25-4543" fmla="*/ 391011 w 641844"/>
                    <a:gd name="connsiteY25-4544" fmla="*/ 223953 h 286379"/>
                    <a:gd name="connsiteX26-4545" fmla="*/ 316399 w 641844"/>
                    <a:gd name="connsiteY26-4546" fmla="*/ 235065 h 286379"/>
                    <a:gd name="connsiteX27-4547" fmla="*/ 238612 w 641844"/>
                    <a:gd name="connsiteY27-4548" fmla="*/ 225541 h 286379"/>
                    <a:gd name="connsiteX28-4549" fmla="*/ 152886 w 641844"/>
                    <a:gd name="connsiteY28-4550" fmla="*/ 262052 h 286379"/>
                    <a:gd name="connsiteX29-4551" fmla="*/ 189399 w 641844"/>
                    <a:gd name="connsiteY29-4552" fmla="*/ 212840 h 286379"/>
                    <a:gd name="connsiteX30-4553" fmla="*/ 3661 w 641844"/>
                    <a:gd name="connsiteY30-4554" fmla="*/ 241415 h 286379"/>
                    <a:gd name="connsiteX0-4555" fmla="*/ 3661 w 641844"/>
                    <a:gd name="connsiteY0-4556" fmla="*/ 241415 h 286379"/>
                    <a:gd name="connsiteX1-4557" fmla="*/ 68749 w 641844"/>
                    <a:gd name="connsiteY1-4558" fmla="*/ 120765 h 286379"/>
                    <a:gd name="connsiteX2-4559" fmla="*/ 103674 w 641844"/>
                    <a:gd name="connsiteY2-4560" fmla="*/ 73140 h 286379"/>
                    <a:gd name="connsiteX3-4561" fmla="*/ 86211 w 641844"/>
                    <a:gd name="connsiteY3-4562" fmla="*/ 49328 h 286379"/>
                    <a:gd name="connsiteX4-4563" fmla="*/ 108436 w 641844"/>
                    <a:gd name="connsiteY4-4564" fmla="*/ 4878 h 286379"/>
                    <a:gd name="connsiteX5-4565" fmla="*/ 163999 w 641844"/>
                    <a:gd name="connsiteY5-4566" fmla="*/ 3289 h 286379"/>
                    <a:gd name="connsiteX6-4567" fmla="*/ 179874 w 641844"/>
                    <a:gd name="connsiteY6-4568" fmla="*/ 23928 h 286379"/>
                    <a:gd name="connsiteX7-4569" fmla="*/ 149711 w 641844"/>
                    <a:gd name="connsiteY7-4570" fmla="*/ 31866 h 286379"/>
                    <a:gd name="connsiteX8-4571" fmla="*/ 229087 w 641844"/>
                    <a:gd name="connsiteY8-4572" fmla="*/ 35040 h 286379"/>
                    <a:gd name="connsiteX9-4573" fmla="*/ 351324 w 641844"/>
                    <a:gd name="connsiteY9-4574" fmla="*/ 3290 h 286379"/>
                    <a:gd name="connsiteX10-4575" fmla="*/ 505311 w 641844"/>
                    <a:gd name="connsiteY10-4576" fmla="*/ 63616 h 286379"/>
                    <a:gd name="connsiteX11-4577" fmla="*/ 578336 w 641844"/>
                    <a:gd name="connsiteY11-4578" fmla="*/ 141402 h 286379"/>
                    <a:gd name="connsiteX12-4579" fmla="*/ 635487 w 641844"/>
                    <a:gd name="connsiteY12-4580" fmla="*/ 214427 h 286379"/>
                    <a:gd name="connsiteX13-4581" fmla="*/ 638661 w 641844"/>
                    <a:gd name="connsiteY13-4582" fmla="*/ 252527 h 286379"/>
                    <a:gd name="connsiteX14-4583" fmla="*/ 619612 w 641844"/>
                    <a:gd name="connsiteY14-4584" fmla="*/ 273165 h 286379"/>
                    <a:gd name="connsiteX15-4585" fmla="*/ 579924 w 641844"/>
                    <a:gd name="connsiteY15-4586" fmla="*/ 285865 h 286379"/>
                    <a:gd name="connsiteX16-4587" fmla="*/ 429112 w 641844"/>
                    <a:gd name="connsiteY16-4588" fmla="*/ 282690 h 286379"/>
                    <a:gd name="connsiteX17-4589" fmla="*/ 570399 w 641844"/>
                    <a:gd name="connsiteY17-4590" fmla="*/ 271578 h 286379"/>
                    <a:gd name="connsiteX18-4591" fmla="*/ 614852 w 641844"/>
                    <a:gd name="connsiteY18-4592" fmla="*/ 243004 h 286379"/>
                    <a:gd name="connsiteX19-4593" fmla="*/ 602149 w 641844"/>
                    <a:gd name="connsiteY19-4594" fmla="*/ 203315 h 286379"/>
                    <a:gd name="connsiteX20-4595" fmla="*/ 576748 w 641844"/>
                    <a:gd name="connsiteY20-4596" fmla="*/ 198553 h 286379"/>
                    <a:gd name="connsiteX21-4597" fmla="*/ 513249 w 641844"/>
                    <a:gd name="connsiteY21-4598" fmla="*/ 233478 h 286379"/>
                    <a:gd name="connsiteX22-4599" fmla="*/ 432286 w 641844"/>
                    <a:gd name="connsiteY22-4600" fmla="*/ 238240 h 286379"/>
                    <a:gd name="connsiteX23-4601" fmla="*/ 368786 w 641844"/>
                    <a:gd name="connsiteY23-4602" fmla="*/ 269991 h 286379"/>
                    <a:gd name="connsiteX24-4603" fmla="*/ 337036 w 641844"/>
                    <a:gd name="connsiteY24-4604" fmla="*/ 271577 h 286379"/>
                    <a:gd name="connsiteX25-4605" fmla="*/ 391011 w 641844"/>
                    <a:gd name="connsiteY25-4606" fmla="*/ 223953 h 286379"/>
                    <a:gd name="connsiteX26-4607" fmla="*/ 316399 w 641844"/>
                    <a:gd name="connsiteY26-4608" fmla="*/ 235065 h 286379"/>
                    <a:gd name="connsiteX27-4609" fmla="*/ 238612 w 641844"/>
                    <a:gd name="connsiteY27-4610" fmla="*/ 225541 h 286379"/>
                    <a:gd name="connsiteX28-4611" fmla="*/ 152886 w 641844"/>
                    <a:gd name="connsiteY28-4612" fmla="*/ 262052 h 286379"/>
                    <a:gd name="connsiteX29-4613" fmla="*/ 189399 w 641844"/>
                    <a:gd name="connsiteY29-4614" fmla="*/ 212840 h 286379"/>
                    <a:gd name="connsiteX30-4615" fmla="*/ 3661 w 641844"/>
                    <a:gd name="connsiteY30-4616" fmla="*/ 241415 h 286379"/>
                    <a:gd name="connsiteX0-4617" fmla="*/ 4195 w 629678"/>
                    <a:gd name="connsiteY0-4618" fmla="*/ 222365 h 286379"/>
                    <a:gd name="connsiteX1-4619" fmla="*/ 56583 w 629678"/>
                    <a:gd name="connsiteY1-4620" fmla="*/ 120765 h 286379"/>
                    <a:gd name="connsiteX2-4621" fmla="*/ 91508 w 629678"/>
                    <a:gd name="connsiteY2-4622" fmla="*/ 73140 h 286379"/>
                    <a:gd name="connsiteX3-4623" fmla="*/ 74045 w 629678"/>
                    <a:gd name="connsiteY3-4624" fmla="*/ 49328 h 286379"/>
                    <a:gd name="connsiteX4-4625" fmla="*/ 96270 w 629678"/>
                    <a:gd name="connsiteY4-4626" fmla="*/ 4878 h 286379"/>
                    <a:gd name="connsiteX5-4627" fmla="*/ 151833 w 629678"/>
                    <a:gd name="connsiteY5-4628" fmla="*/ 3289 h 286379"/>
                    <a:gd name="connsiteX6-4629" fmla="*/ 167708 w 629678"/>
                    <a:gd name="connsiteY6-4630" fmla="*/ 23928 h 286379"/>
                    <a:gd name="connsiteX7-4631" fmla="*/ 137545 w 629678"/>
                    <a:gd name="connsiteY7-4632" fmla="*/ 31866 h 286379"/>
                    <a:gd name="connsiteX8-4633" fmla="*/ 216921 w 629678"/>
                    <a:gd name="connsiteY8-4634" fmla="*/ 35040 h 286379"/>
                    <a:gd name="connsiteX9-4635" fmla="*/ 339158 w 629678"/>
                    <a:gd name="connsiteY9-4636" fmla="*/ 3290 h 286379"/>
                    <a:gd name="connsiteX10-4637" fmla="*/ 493145 w 629678"/>
                    <a:gd name="connsiteY10-4638" fmla="*/ 63616 h 286379"/>
                    <a:gd name="connsiteX11-4639" fmla="*/ 566170 w 629678"/>
                    <a:gd name="connsiteY11-4640" fmla="*/ 141402 h 286379"/>
                    <a:gd name="connsiteX12-4641" fmla="*/ 623321 w 629678"/>
                    <a:gd name="connsiteY12-4642" fmla="*/ 214427 h 286379"/>
                    <a:gd name="connsiteX13-4643" fmla="*/ 626495 w 629678"/>
                    <a:gd name="connsiteY13-4644" fmla="*/ 252527 h 286379"/>
                    <a:gd name="connsiteX14-4645" fmla="*/ 607446 w 629678"/>
                    <a:gd name="connsiteY14-4646" fmla="*/ 273165 h 286379"/>
                    <a:gd name="connsiteX15-4647" fmla="*/ 567758 w 629678"/>
                    <a:gd name="connsiteY15-4648" fmla="*/ 285865 h 286379"/>
                    <a:gd name="connsiteX16-4649" fmla="*/ 416946 w 629678"/>
                    <a:gd name="connsiteY16-4650" fmla="*/ 282690 h 286379"/>
                    <a:gd name="connsiteX17-4651" fmla="*/ 558233 w 629678"/>
                    <a:gd name="connsiteY17-4652" fmla="*/ 271578 h 286379"/>
                    <a:gd name="connsiteX18-4653" fmla="*/ 602686 w 629678"/>
                    <a:gd name="connsiteY18-4654" fmla="*/ 243004 h 286379"/>
                    <a:gd name="connsiteX19-4655" fmla="*/ 589983 w 629678"/>
                    <a:gd name="connsiteY19-4656" fmla="*/ 203315 h 286379"/>
                    <a:gd name="connsiteX20-4657" fmla="*/ 564582 w 629678"/>
                    <a:gd name="connsiteY20-4658" fmla="*/ 198553 h 286379"/>
                    <a:gd name="connsiteX21-4659" fmla="*/ 501083 w 629678"/>
                    <a:gd name="connsiteY21-4660" fmla="*/ 233478 h 286379"/>
                    <a:gd name="connsiteX22-4661" fmla="*/ 420120 w 629678"/>
                    <a:gd name="connsiteY22-4662" fmla="*/ 238240 h 286379"/>
                    <a:gd name="connsiteX23-4663" fmla="*/ 356620 w 629678"/>
                    <a:gd name="connsiteY23-4664" fmla="*/ 269991 h 286379"/>
                    <a:gd name="connsiteX24-4665" fmla="*/ 324870 w 629678"/>
                    <a:gd name="connsiteY24-4666" fmla="*/ 271577 h 286379"/>
                    <a:gd name="connsiteX25-4667" fmla="*/ 378845 w 629678"/>
                    <a:gd name="connsiteY25-4668" fmla="*/ 223953 h 286379"/>
                    <a:gd name="connsiteX26-4669" fmla="*/ 304233 w 629678"/>
                    <a:gd name="connsiteY26-4670" fmla="*/ 235065 h 286379"/>
                    <a:gd name="connsiteX27-4671" fmla="*/ 226446 w 629678"/>
                    <a:gd name="connsiteY27-4672" fmla="*/ 225541 h 286379"/>
                    <a:gd name="connsiteX28-4673" fmla="*/ 140720 w 629678"/>
                    <a:gd name="connsiteY28-4674" fmla="*/ 262052 h 286379"/>
                    <a:gd name="connsiteX29-4675" fmla="*/ 177233 w 629678"/>
                    <a:gd name="connsiteY29-4676" fmla="*/ 212840 h 286379"/>
                    <a:gd name="connsiteX30-4677" fmla="*/ 4195 w 629678"/>
                    <a:gd name="connsiteY30-4678" fmla="*/ 222365 h 286379"/>
                    <a:gd name="connsiteX0-4679" fmla="*/ 8596 w 634079"/>
                    <a:gd name="connsiteY0-4680" fmla="*/ 222365 h 286379"/>
                    <a:gd name="connsiteX1-4681" fmla="*/ 60984 w 634079"/>
                    <a:gd name="connsiteY1-4682" fmla="*/ 120765 h 286379"/>
                    <a:gd name="connsiteX2-4683" fmla="*/ 95909 w 634079"/>
                    <a:gd name="connsiteY2-4684" fmla="*/ 73140 h 286379"/>
                    <a:gd name="connsiteX3-4685" fmla="*/ 78446 w 634079"/>
                    <a:gd name="connsiteY3-4686" fmla="*/ 49328 h 286379"/>
                    <a:gd name="connsiteX4-4687" fmla="*/ 100671 w 634079"/>
                    <a:gd name="connsiteY4-4688" fmla="*/ 4878 h 286379"/>
                    <a:gd name="connsiteX5-4689" fmla="*/ 156234 w 634079"/>
                    <a:gd name="connsiteY5-4690" fmla="*/ 3289 h 286379"/>
                    <a:gd name="connsiteX6-4691" fmla="*/ 172109 w 634079"/>
                    <a:gd name="connsiteY6-4692" fmla="*/ 23928 h 286379"/>
                    <a:gd name="connsiteX7-4693" fmla="*/ 141946 w 634079"/>
                    <a:gd name="connsiteY7-4694" fmla="*/ 31866 h 286379"/>
                    <a:gd name="connsiteX8-4695" fmla="*/ 221322 w 634079"/>
                    <a:gd name="connsiteY8-4696" fmla="*/ 35040 h 286379"/>
                    <a:gd name="connsiteX9-4697" fmla="*/ 343559 w 634079"/>
                    <a:gd name="connsiteY9-4698" fmla="*/ 3290 h 286379"/>
                    <a:gd name="connsiteX10-4699" fmla="*/ 497546 w 634079"/>
                    <a:gd name="connsiteY10-4700" fmla="*/ 63616 h 286379"/>
                    <a:gd name="connsiteX11-4701" fmla="*/ 570571 w 634079"/>
                    <a:gd name="connsiteY11-4702" fmla="*/ 141402 h 286379"/>
                    <a:gd name="connsiteX12-4703" fmla="*/ 627722 w 634079"/>
                    <a:gd name="connsiteY12-4704" fmla="*/ 214427 h 286379"/>
                    <a:gd name="connsiteX13-4705" fmla="*/ 630896 w 634079"/>
                    <a:gd name="connsiteY13-4706" fmla="*/ 252527 h 286379"/>
                    <a:gd name="connsiteX14-4707" fmla="*/ 611847 w 634079"/>
                    <a:gd name="connsiteY14-4708" fmla="*/ 273165 h 286379"/>
                    <a:gd name="connsiteX15-4709" fmla="*/ 572159 w 634079"/>
                    <a:gd name="connsiteY15-4710" fmla="*/ 285865 h 286379"/>
                    <a:gd name="connsiteX16-4711" fmla="*/ 421347 w 634079"/>
                    <a:gd name="connsiteY16-4712" fmla="*/ 282690 h 286379"/>
                    <a:gd name="connsiteX17-4713" fmla="*/ 562634 w 634079"/>
                    <a:gd name="connsiteY17-4714" fmla="*/ 271578 h 286379"/>
                    <a:gd name="connsiteX18-4715" fmla="*/ 607087 w 634079"/>
                    <a:gd name="connsiteY18-4716" fmla="*/ 243004 h 286379"/>
                    <a:gd name="connsiteX19-4717" fmla="*/ 594384 w 634079"/>
                    <a:gd name="connsiteY19-4718" fmla="*/ 203315 h 286379"/>
                    <a:gd name="connsiteX20-4719" fmla="*/ 568983 w 634079"/>
                    <a:gd name="connsiteY20-4720" fmla="*/ 198553 h 286379"/>
                    <a:gd name="connsiteX21-4721" fmla="*/ 505484 w 634079"/>
                    <a:gd name="connsiteY21-4722" fmla="*/ 233478 h 286379"/>
                    <a:gd name="connsiteX22-4723" fmla="*/ 424521 w 634079"/>
                    <a:gd name="connsiteY22-4724" fmla="*/ 238240 h 286379"/>
                    <a:gd name="connsiteX23-4725" fmla="*/ 361021 w 634079"/>
                    <a:gd name="connsiteY23-4726" fmla="*/ 269991 h 286379"/>
                    <a:gd name="connsiteX24-4727" fmla="*/ 329271 w 634079"/>
                    <a:gd name="connsiteY24-4728" fmla="*/ 271577 h 286379"/>
                    <a:gd name="connsiteX25-4729" fmla="*/ 383246 w 634079"/>
                    <a:gd name="connsiteY25-4730" fmla="*/ 223953 h 286379"/>
                    <a:gd name="connsiteX26-4731" fmla="*/ 308634 w 634079"/>
                    <a:gd name="connsiteY26-4732" fmla="*/ 235065 h 286379"/>
                    <a:gd name="connsiteX27-4733" fmla="*/ 230847 w 634079"/>
                    <a:gd name="connsiteY27-4734" fmla="*/ 225541 h 286379"/>
                    <a:gd name="connsiteX28-4735" fmla="*/ 145121 w 634079"/>
                    <a:gd name="connsiteY28-4736" fmla="*/ 262052 h 286379"/>
                    <a:gd name="connsiteX29-4737" fmla="*/ 181634 w 634079"/>
                    <a:gd name="connsiteY29-4738" fmla="*/ 212840 h 286379"/>
                    <a:gd name="connsiteX30-4739" fmla="*/ 8596 w 634079"/>
                    <a:gd name="connsiteY30-4740" fmla="*/ 222365 h 286379"/>
                    <a:gd name="connsiteX0-4741" fmla="*/ 4195 w 629678"/>
                    <a:gd name="connsiteY0-4742" fmla="*/ 222365 h 286379"/>
                    <a:gd name="connsiteX1-4743" fmla="*/ 56583 w 629678"/>
                    <a:gd name="connsiteY1-4744" fmla="*/ 120765 h 286379"/>
                    <a:gd name="connsiteX2-4745" fmla="*/ 91508 w 629678"/>
                    <a:gd name="connsiteY2-4746" fmla="*/ 73140 h 286379"/>
                    <a:gd name="connsiteX3-4747" fmla="*/ 74045 w 629678"/>
                    <a:gd name="connsiteY3-4748" fmla="*/ 49328 h 286379"/>
                    <a:gd name="connsiteX4-4749" fmla="*/ 96270 w 629678"/>
                    <a:gd name="connsiteY4-4750" fmla="*/ 4878 h 286379"/>
                    <a:gd name="connsiteX5-4751" fmla="*/ 151833 w 629678"/>
                    <a:gd name="connsiteY5-4752" fmla="*/ 3289 h 286379"/>
                    <a:gd name="connsiteX6-4753" fmla="*/ 167708 w 629678"/>
                    <a:gd name="connsiteY6-4754" fmla="*/ 23928 h 286379"/>
                    <a:gd name="connsiteX7-4755" fmla="*/ 137545 w 629678"/>
                    <a:gd name="connsiteY7-4756" fmla="*/ 31866 h 286379"/>
                    <a:gd name="connsiteX8-4757" fmla="*/ 216921 w 629678"/>
                    <a:gd name="connsiteY8-4758" fmla="*/ 35040 h 286379"/>
                    <a:gd name="connsiteX9-4759" fmla="*/ 339158 w 629678"/>
                    <a:gd name="connsiteY9-4760" fmla="*/ 3290 h 286379"/>
                    <a:gd name="connsiteX10-4761" fmla="*/ 493145 w 629678"/>
                    <a:gd name="connsiteY10-4762" fmla="*/ 63616 h 286379"/>
                    <a:gd name="connsiteX11-4763" fmla="*/ 566170 w 629678"/>
                    <a:gd name="connsiteY11-4764" fmla="*/ 141402 h 286379"/>
                    <a:gd name="connsiteX12-4765" fmla="*/ 623321 w 629678"/>
                    <a:gd name="connsiteY12-4766" fmla="*/ 214427 h 286379"/>
                    <a:gd name="connsiteX13-4767" fmla="*/ 626495 w 629678"/>
                    <a:gd name="connsiteY13-4768" fmla="*/ 252527 h 286379"/>
                    <a:gd name="connsiteX14-4769" fmla="*/ 607446 w 629678"/>
                    <a:gd name="connsiteY14-4770" fmla="*/ 273165 h 286379"/>
                    <a:gd name="connsiteX15-4771" fmla="*/ 567758 w 629678"/>
                    <a:gd name="connsiteY15-4772" fmla="*/ 285865 h 286379"/>
                    <a:gd name="connsiteX16-4773" fmla="*/ 416946 w 629678"/>
                    <a:gd name="connsiteY16-4774" fmla="*/ 282690 h 286379"/>
                    <a:gd name="connsiteX17-4775" fmla="*/ 558233 w 629678"/>
                    <a:gd name="connsiteY17-4776" fmla="*/ 271578 h 286379"/>
                    <a:gd name="connsiteX18-4777" fmla="*/ 602686 w 629678"/>
                    <a:gd name="connsiteY18-4778" fmla="*/ 243004 h 286379"/>
                    <a:gd name="connsiteX19-4779" fmla="*/ 589983 w 629678"/>
                    <a:gd name="connsiteY19-4780" fmla="*/ 203315 h 286379"/>
                    <a:gd name="connsiteX20-4781" fmla="*/ 564582 w 629678"/>
                    <a:gd name="connsiteY20-4782" fmla="*/ 198553 h 286379"/>
                    <a:gd name="connsiteX21-4783" fmla="*/ 501083 w 629678"/>
                    <a:gd name="connsiteY21-4784" fmla="*/ 233478 h 286379"/>
                    <a:gd name="connsiteX22-4785" fmla="*/ 420120 w 629678"/>
                    <a:gd name="connsiteY22-4786" fmla="*/ 238240 h 286379"/>
                    <a:gd name="connsiteX23-4787" fmla="*/ 356620 w 629678"/>
                    <a:gd name="connsiteY23-4788" fmla="*/ 269991 h 286379"/>
                    <a:gd name="connsiteX24-4789" fmla="*/ 324870 w 629678"/>
                    <a:gd name="connsiteY24-4790" fmla="*/ 271577 h 286379"/>
                    <a:gd name="connsiteX25-4791" fmla="*/ 378845 w 629678"/>
                    <a:gd name="connsiteY25-4792" fmla="*/ 223953 h 286379"/>
                    <a:gd name="connsiteX26-4793" fmla="*/ 304233 w 629678"/>
                    <a:gd name="connsiteY26-4794" fmla="*/ 235065 h 286379"/>
                    <a:gd name="connsiteX27-4795" fmla="*/ 226446 w 629678"/>
                    <a:gd name="connsiteY27-4796" fmla="*/ 225541 h 286379"/>
                    <a:gd name="connsiteX28-4797" fmla="*/ 140720 w 629678"/>
                    <a:gd name="connsiteY28-4798" fmla="*/ 262052 h 286379"/>
                    <a:gd name="connsiteX29-4799" fmla="*/ 177233 w 629678"/>
                    <a:gd name="connsiteY29-4800" fmla="*/ 212840 h 286379"/>
                    <a:gd name="connsiteX30-4801" fmla="*/ 4195 w 629678"/>
                    <a:gd name="connsiteY30-4802" fmla="*/ 222365 h 286379"/>
                    <a:gd name="connsiteX0-4803" fmla="*/ 5377 w 630860"/>
                    <a:gd name="connsiteY0-4804" fmla="*/ 222365 h 286379"/>
                    <a:gd name="connsiteX1-4805" fmla="*/ 48240 w 630860"/>
                    <a:gd name="connsiteY1-4806" fmla="*/ 119178 h 286379"/>
                    <a:gd name="connsiteX2-4807" fmla="*/ 92690 w 630860"/>
                    <a:gd name="connsiteY2-4808" fmla="*/ 73140 h 286379"/>
                    <a:gd name="connsiteX3-4809" fmla="*/ 75227 w 630860"/>
                    <a:gd name="connsiteY3-4810" fmla="*/ 49328 h 286379"/>
                    <a:gd name="connsiteX4-4811" fmla="*/ 97452 w 630860"/>
                    <a:gd name="connsiteY4-4812" fmla="*/ 4878 h 286379"/>
                    <a:gd name="connsiteX5-4813" fmla="*/ 153015 w 630860"/>
                    <a:gd name="connsiteY5-4814" fmla="*/ 3289 h 286379"/>
                    <a:gd name="connsiteX6-4815" fmla="*/ 168890 w 630860"/>
                    <a:gd name="connsiteY6-4816" fmla="*/ 23928 h 286379"/>
                    <a:gd name="connsiteX7-4817" fmla="*/ 138727 w 630860"/>
                    <a:gd name="connsiteY7-4818" fmla="*/ 31866 h 286379"/>
                    <a:gd name="connsiteX8-4819" fmla="*/ 218103 w 630860"/>
                    <a:gd name="connsiteY8-4820" fmla="*/ 35040 h 286379"/>
                    <a:gd name="connsiteX9-4821" fmla="*/ 340340 w 630860"/>
                    <a:gd name="connsiteY9-4822" fmla="*/ 3290 h 286379"/>
                    <a:gd name="connsiteX10-4823" fmla="*/ 494327 w 630860"/>
                    <a:gd name="connsiteY10-4824" fmla="*/ 63616 h 286379"/>
                    <a:gd name="connsiteX11-4825" fmla="*/ 567352 w 630860"/>
                    <a:gd name="connsiteY11-4826" fmla="*/ 141402 h 286379"/>
                    <a:gd name="connsiteX12-4827" fmla="*/ 624503 w 630860"/>
                    <a:gd name="connsiteY12-4828" fmla="*/ 214427 h 286379"/>
                    <a:gd name="connsiteX13-4829" fmla="*/ 627677 w 630860"/>
                    <a:gd name="connsiteY13-4830" fmla="*/ 252527 h 286379"/>
                    <a:gd name="connsiteX14-4831" fmla="*/ 608628 w 630860"/>
                    <a:gd name="connsiteY14-4832" fmla="*/ 273165 h 286379"/>
                    <a:gd name="connsiteX15-4833" fmla="*/ 568940 w 630860"/>
                    <a:gd name="connsiteY15-4834" fmla="*/ 285865 h 286379"/>
                    <a:gd name="connsiteX16-4835" fmla="*/ 418128 w 630860"/>
                    <a:gd name="connsiteY16-4836" fmla="*/ 282690 h 286379"/>
                    <a:gd name="connsiteX17-4837" fmla="*/ 559415 w 630860"/>
                    <a:gd name="connsiteY17-4838" fmla="*/ 271578 h 286379"/>
                    <a:gd name="connsiteX18-4839" fmla="*/ 603868 w 630860"/>
                    <a:gd name="connsiteY18-4840" fmla="*/ 243004 h 286379"/>
                    <a:gd name="connsiteX19-4841" fmla="*/ 591165 w 630860"/>
                    <a:gd name="connsiteY19-4842" fmla="*/ 203315 h 286379"/>
                    <a:gd name="connsiteX20-4843" fmla="*/ 565764 w 630860"/>
                    <a:gd name="connsiteY20-4844" fmla="*/ 198553 h 286379"/>
                    <a:gd name="connsiteX21-4845" fmla="*/ 502265 w 630860"/>
                    <a:gd name="connsiteY21-4846" fmla="*/ 233478 h 286379"/>
                    <a:gd name="connsiteX22-4847" fmla="*/ 421302 w 630860"/>
                    <a:gd name="connsiteY22-4848" fmla="*/ 238240 h 286379"/>
                    <a:gd name="connsiteX23-4849" fmla="*/ 357802 w 630860"/>
                    <a:gd name="connsiteY23-4850" fmla="*/ 269991 h 286379"/>
                    <a:gd name="connsiteX24-4851" fmla="*/ 326052 w 630860"/>
                    <a:gd name="connsiteY24-4852" fmla="*/ 271577 h 286379"/>
                    <a:gd name="connsiteX25-4853" fmla="*/ 380027 w 630860"/>
                    <a:gd name="connsiteY25-4854" fmla="*/ 223953 h 286379"/>
                    <a:gd name="connsiteX26-4855" fmla="*/ 305415 w 630860"/>
                    <a:gd name="connsiteY26-4856" fmla="*/ 235065 h 286379"/>
                    <a:gd name="connsiteX27-4857" fmla="*/ 227628 w 630860"/>
                    <a:gd name="connsiteY27-4858" fmla="*/ 225541 h 286379"/>
                    <a:gd name="connsiteX28-4859" fmla="*/ 141902 w 630860"/>
                    <a:gd name="connsiteY28-4860" fmla="*/ 262052 h 286379"/>
                    <a:gd name="connsiteX29-4861" fmla="*/ 178415 w 630860"/>
                    <a:gd name="connsiteY29-4862" fmla="*/ 212840 h 286379"/>
                    <a:gd name="connsiteX30-4863" fmla="*/ 5377 w 630860"/>
                    <a:gd name="connsiteY30-4864" fmla="*/ 222365 h 286379"/>
                    <a:gd name="connsiteX0-4865" fmla="*/ 5377 w 630860"/>
                    <a:gd name="connsiteY0-4866" fmla="*/ 227001 h 291015"/>
                    <a:gd name="connsiteX1-4867" fmla="*/ 48240 w 630860"/>
                    <a:gd name="connsiteY1-4868" fmla="*/ 123814 h 291015"/>
                    <a:gd name="connsiteX2-4869" fmla="*/ 92690 w 630860"/>
                    <a:gd name="connsiteY2-4870" fmla="*/ 77776 h 291015"/>
                    <a:gd name="connsiteX3-4871" fmla="*/ 75227 w 630860"/>
                    <a:gd name="connsiteY3-4872" fmla="*/ 53964 h 291015"/>
                    <a:gd name="connsiteX4-4873" fmla="*/ 89501 w 630860"/>
                    <a:gd name="connsiteY4-4874" fmla="*/ 3154 h 291015"/>
                    <a:gd name="connsiteX5-4875" fmla="*/ 153015 w 630860"/>
                    <a:gd name="connsiteY5-4876" fmla="*/ 7925 h 291015"/>
                    <a:gd name="connsiteX6-4877" fmla="*/ 168890 w 630860"/>
                    <a:gd name="connsiteY6-4878" fmla="*/ 28564 h 291015"/>
                    <a:gd name="connsiteX7-4879" fmla="*/ 138727 w 630860"/>
                    <a:gd name="connsiteY7-4880" fmla="*/ 36502 h 291015"/>
                    <a:gd name="connsiteX8-4881" fmla="*/ 218103 w 630860"/>
                    <a:gd name="connsiteY8-4882" fmla="*/ 39676 h 291015"/>
                    <a:gd name="connsiteX9-4883" fmla="*/ 340340 w 630860"/>
                    <a:gd name="connsiteY9-4884" fmla="*/ 7926 h 291015"/>
                    <a:gd name="connsiteX10-4885" fmla="*/ 494327 w 630860"/>
                    <a:gd name="connsiteY10-4886" fmla="*/ 68252 h 291015"/>
                    <a:gd name="connsiteX11-4887" fmla="*/ 567352 w 630860"/>
                    <a:gd name="connsiteY11-4888" fmla="*/ 146038 h 291015"/>
                    <a:gd name="connsiteX12-4889" fmla="*/ 624503 w 630860"/>
                    <a:gd name="connsiteY12-4890" fmla="*/ 219063 h 291015"/>
                    <a:gd name="connsiteX13-4891" fmla="*/ 627677 w 630860"/>
                    <a:gd name="connsiteY13-4892" fmla="*/ 257163 h 291015"/>
                    <a:gd name="connsiteX14-4893" fmla="*/ 608628 w 630860"/>
                    <a:gd name="connsiteY14-4894" fmla="*/ 277801 h 291015"/>
                    <a:gd name="connsiteX15-4895" fmla="*/ 568940 w 630860"/>
                    <a:gd name="connsiteY15-4896" fmla="*/ 290501 h 291015"/>
                    <a:gd name="connsiteX16-4897" fmla="*/ 418128 w 630860"/>
                    <a:gd name="connsiteY16-4898" fmla="*/ 287326 h 291015"/>
                    <a:gd name="connsiteX17-4899" fmla="*/ 559415 w 630860"/>
                    <a:gd name="connsiteY17-4900" fmla="*/ 276214 h 291015"/>
                    <a:gd name="connsiteX18-4901" fmla="*/ 603868 w 630860"/>
                    <a:gd name="connsiteY18-4902" fmla="*/ 247640 h 291015"/>
                    <a:gd name="connsiteX19-4903" fmla="*/ 591165 w 630860"/>
                    <a:gd name="connsiteY19-4904" fmla="*/ 207951 h 291015"/>
                    <a:gd name="connsiteX20-4905" fmla="*/ 565764 w 630860"/>
                    <a:gd name="connsiteY20-4906" fmla="*/ 203189 h 291015"/>
                    <a:gd name="connsiteX21-4907" fmla="*/ 502265 w 630860"/>
                    <a:gd name="connsiteY21-4908" fmla="*/ 238114 h 291015"/>
                    <a:gd name="connsiteX22-4909" fmla="*/ 421302 w 630860"/>
                    <a:gd name="connsiteY22-4910" fmla="*/ 242876 h 291015"/>
                    <a:gd name="connsiteX23-4911" fmla="*/ 357802 w 630860"/>
                    <a:gd name="connsiteY23-4912" fmla="*/ 274627 h 291015"/>
                    <a:gd name="connsiteX24-4913" fmla="*/ 326052 w 630860"/>
                    <a:gd name="connsiteY24-4914" fmla="*/ 276213 h 291015"/>
                    <a:gd name="connsiteX25-4915" fmla="*/ 380027 w 630860"/>
                    <a:gd name="connsiteY25-4916" fmla="*/ 228589 h 291015"/>
                    <a:gd name="connsiteX26-4917" fmla="*/ 305415 w 630860"/>
                    <a:gd name="connsiteY26-4918" fmla="*/ 239701 h 291015"/>
                    <a:gd name="connsiteX27-4919" fmla="*/ 227628 w 630860"/>
                    <a:gd name="connsiteY27-4920" fmla="*/ 230177 h 291015"/>
                    <a:gd name="connsiteX28-4921" fmla="*/ 141902 w 630860"/>
                    <a:gd name="connsiteY28-4922" fmla="*/ 266688 h 291015"/>
                    <a:gd name="connsiteX29-4923" fmla="*/ 178415 w 630860"/>
                    <a:gd name="connsiteY29-4924" fmla="*/ 217476 h 291015"/>
                    <a:gd name="connsiteX30-4925" fmla="*/ 5377 w 630860"/>
                    <a:gd name="connsiteY30-4926" fmla="*/ 227001 h 291015"/>
                    <a:gd name="connsiteX0-4927" fmla="*/ 5377 w 630860"/>
                    <a:gd name="connsiteY0-4928" fmla="*/ 226885 h 290899"/>
                    <a:gd name="connsiteX1-4929" fmla="*/ 48240 w 630860"/>
                    <a:gd name="connsiteY1-4930" fmla="*/ 123698 h 290899"/>
                    <a:gd name="connsiteX2-4931" fmla="*/ 92690 w 630860"/>
                    <a:gd name="connsiteY2-4932" fmla="*/ 77660 h 290899"/>
                    <a:gd name="connsiteX3-4933" fmla="*/ 68866 w 630860"/>
                    <a:gd name="connsiteY3-4934" fmla="*/ 52258 h 290899"/>
                    <a:gd name="connsiteX4-4935" fmla="*/ 89501 w 630860"/>
                    <a:gd name="connsiteY4-4936" fmla="*/ 3038 h 290899"/>
                    <a:gd name="connsiteX5-4937" fmla="*/ 153015 w 630860"/>
                    <a:gd name="connsiteY5-4938" fmla="*/ 7809 h 290899"/>
                    <a:gd name="connsiteX6-4939" fmla="*/ 168890 w 630860"/>
                    <a:gd name="connsiteY6-4940" fmla="*/ 28448 h 290899"/>
                    <a:gd name="connsiteX7-4941" fmla="*/ 138727 w 630860"/>
                    <a:gd name="connsiteY7-4942" fmla="*/ 36386 h 290899"/>
                    <a:gd name="connsiteX8-4943" fmla="*/ 218103 w 630860"/>
                    <a:gd name="connsiteY8-4944" fmla="*/ 39560 h 290899"/>
                    <a:gd name="connsiteX9-4945" fmla="*/ 340340 w 630860"/>
                    <a:gd name="connsiteY9-4946" fmla="*/ 7810 h 290899"/>
                    <a:gd name="connsiteX10-4947" fmla="*/ 494327 w 630860"/>
                    <a:gd name="connsiteY10-4948" fmla="*/ 68136 h 290899"/>
                    <a:gd name="connsiteX11-4949" fmla="*/ 567352 w 630860"/>
                    <a:gd name="connsiteY11-4950" fmla="*/ 145922 h 290899"/>
                    <a:gd name="connsiteX12-4951" fmla="*/ 624503 w 630860"/>
                    <a:gd name="connsiteY12-4952" fmla="*/ 218947 h 290899"/>
                    <a:gd name="connsiteX13-4953" fmla="*/ 627677 w 630860"/>
                    <a:gd name="connsiteY13-4954" fmla="*/ 257047 h 290899"/>
                    <a:gd name="connsiteX14-4955" fmla="*/ 608628 w 630860"/>
                    <a:gd name="connsiteY14-4956" fmla="*/ 277685 h 290899"/>
                    <a:gd name="connsiteX15-4957" fmla="*/ 568940 w 630860"/>
                    <a:gd name="connsiteY15-4958" fmla="*/ 290385 h 290899"/>
                    <a:gd name="connsiteX16-4959" fmla="*/ 418128 w 630860"/>
                    <a:gd name="connsiteY16-4960" fmla="*/ 287210 h 290899"/>
                    <a:gd name="connsiteX17-4961" fmla="*/ 559415 w 630860"/>
                    <a:gd name="connsiteY17-4962" fmla="*/ 276098 h 290899"/>
                    <a:gd name="connsiteX18-4963" fmla="*/ 603868 w 630860"/>
                    <a:gd name="connsiteY18-4964" fmla="*/ 247524 h 290899"/>
                    <a:gd name="connsiteX19-4965" fmla="*/ 591165 w 630860"/>
                    <a:gd name="connsiteY19-4966" fmla="*/ 207835 h 290899"/>
                    <a:gd name="connsiteX20-4967" fmla="*/ 565764 w 630860"/>
                    <a:gd name="connsiteY20-4968" fmla="*/ 203073 h 290899"/>
                    <a:gd name="connsiteX21-4969" fmla="*/ 502265 w 630860"/>
                    <a:gd name="connsiteY21-4970" fmla="*/ 237998 h 290899"/>
                    <a:gd name="connsiteX22-4971" fmla="*/ 421302 w 630860"/>
                    <a:gd name="connsiteY22-4972" fmla="*/ 242760 h 290899"/>
                    <a:gd name="connsiteX23-4973" fmla="*/ 357802 w 630860"/>
                    <a:gd name="connsiteY23-4974" fmla="*/ 274511 h 290899"/>
                    <a:gd name="connsiteX24-4975" fmla="*/ 326052 w 630860"/>
                    <a:gd name="connsiteY24-4976" fmla="*/ 276097 h 290899"/>
                    <a:gd name="connsiteX25-4977" fmla="*/ 380027 w 630860"/>
                    <a:gd name="connsiteY25-4978" fmla="*/ 228473 h 290899"/>
                    <a:gd name="connsiteX26-4979" fmla="*/ 305415 w 630860"/>
                    <a:gd name="connsiteY26-4980" fmla="*/ 239585 h 290899"/>
                    <a:gd name="connsiteX27-4981" fmla="*/ 227628 w 630860"/>
                    <a:gd name="connsiteY27-4982" fmla="*/ 230061 h 290899"/>
                    <a:gd name="connsiteX28-4983" fmla="*/ 141902 w 630860"/>
                    <a:gd name="connsiteY28-4984" fmla="*/ 266572 h 290899"/>
                    <a:gd name="connsiteX29-4985" fmla="*/ 178415 w 630860"/>
                    <a:gd name="connsiteY29-4986" fmla="*/ 217360 h 290899"/>
                    <a:gd name="connsiteX30-4987" fmla="*/ 5377 w 630860"/>
                    <a:gd name="connsiteY30-4988" fmla="*/ 226885 h 290899"/>
                    <a:gd name="connsiteX0-4989" fmla="*/ 5377 w 630860"/>
                    <a:gd name="connsiteY0-4990" fmla="*/ 229413 h 293427"/>
                    <a:gd name="connsiteX1-4991" fmla="*/ 48240 w 630860"/>
                    <a:gd name="connsiteY1-4992" fmla="*/ 126226 h 293427"/>
                    <a:gd name="connsiteX2-4993" fmla="*/ 92690 w 630860"/>
                    <a:gd name="connsiteY2-4994" fmla="*/ 80188 h 293427"/>
                    <a:gd name="connsiteX3-4995" fmla="*/ 68866 w 630860"/>
                    <a:gd name="connsiteY3-4996" fmla="*/ 54786 h 293427"/>
                    <a:gd name="connsiteX4-4997" fmla="*/ 89501 w 630860"/>
                    <a:gd name="connsiteY4-4998" fmla="*/ 5566 h 293427"/>
                    <a:gd name="connsiteX5-4999" fmla="*/ 162557 w 630860"/>
                    <a:gd name="connsiteY5-5000" fmla="*/ 3977 h 293427"/>
                    <a:gd name="connsiteX6-5001" fmla="*/ 168890 w 630860"/>
                    <a:gd name="connsiteY6-5002" fmla="*/ 30976 h 293427"/>
                    <a:gd name="connsiteX7-5003" fmla="*/ 138727 w 630860"/>
                    <a:gd name="connsiteY7-5004" fmla="*/ 38914 h 293427"/>
                    <a:gd name="connsiteX8-5005" fmla="*/ 218103 w 630860"/>
                    <a:gd name="connsiteY8-5006" fmla="*/ 42088 h 293427"/>
                    <a:gd name="connsiteX9-5007" fmla="*/ 340340 w 630860"/>
                    <a:gd name="connsiteY9-5008" fmla="*/ 10338 h 293427"/>
                    <a:gd name="connsiteX10-5009" fmla="*/ 494327 w 630860"/>
                    <a:gd name="connsiteY10-5010" fmla="*/ 70664 h 293427"/>
                    <a:gd name="connsiteX11-5011" fmla="*/ 567352 w 630860"/>
                    <a:gd name="connsiteY11-5012" fmla="*/ 148450 h 293427"/>
                    <a:gd name="connsiteX12-5013" fmla="*/ 624503 w 630860"/>
                    <a:gd name="connsiteY12-5014" fmla="*/ 221475 h 293427"/>
                    <a:gd name="connsiteX13-5015" fmla="*/ 627677 w 630860"/>
                    <a:gd name="connsiteY13-5016" fmla="*/ 259575 h 293427"/>
                    <a:gd name="connsiteX14-5017" fmla="*/ 608628 w 630860"/>
                    <a:gd name="connsiteY14-5018" fmla="*/ 280213 h 293427"/>
                    <a:gd name="connsiteX15-5019" fmla="*/ 568940 w 630860"/>
                    <a:gd name="connsiteY15-5020" fmla="*/ 292913 h 293427"/>
                    <a:gd name="connsiteX16-5021" fmla="*/ 418128 w 630860"/>
                    <a:gd name="connsiteY16-5022" fmla="*/ 289738 h 293427"/>
                    <a:gd name="connsiteX17-5023" fmla="*/ 559415 w 630860"/>
                    <a:gd name="connsiteY17-5024" fmla="*/ 278626 h 293427"/>
                    <a:gd name="connsiteX18-5025" fmla="*/ 603868 w 630860"/>
                    <a:gd name="connsiteY18-5026" fmla="*/ 250052 h 293427"/>
                    <a:gd name="connsiteX19-5027" fmla="*/ 591165 w 630860"/>
                    <a:gd name="connsiteY19-5028" fmla="*/ 210363 h 293427"/>
                    <a:gd name="connsiteX20-5029" fmla="*/ 565764 w 630860"/>
                    <a:gd name="connsiteY20-5030" fmla="*/ 205601 h 293427"/>
                    <a:gd name="connsiteX21-5031" fmla="*/ 502265 w 630860"/>
                    <a:gd name="connsiteY21-5032" fmla="*/ 240526 h 293427"/>
                    <a:gd name="connsiteX22-5033" fmla="*/ 421302 w 630860"/>
                    <a:gd name="connsiteY22-5034" fmla="*/ 245288 h 293427"/>
                    <a:gd name="connsiteX23-5035" fmla="*/ 357802 w 630860"/>
                    <a:gd name="connsiteY23-5036" fmla="*/ 277039 h 293427"/>
                    <a:gd name="connsiteX24-5037" fmla="*/ 326052 w 630860"/>
                    <a:gd name="connsiteY24-5038" fmla="*/ 278625 h 293427"/>
                    <a:gd name="connsiteX25-5039" fmla="*/ 380027 w 630860"/>
                    <a:gd name="connsiteY25-5040" fmla="*/ 231001 h 293427"/>
                    <a:gd name="connsiteX26-5041" fmla="*/ 305415 w 630860"/>
                    <a:gd name="connsiteY26-5042" fmla="*/ 242113 h 293427"/>
                    <a:gd name="connsiteX27-5043" fmla="*/ 227628 w 630860"/>
                    <a:gd name="connsiteY27-5044" fmla="*/ 232589 h 293427"/>
                    <a:gd name="connsiteX28-5045" fmla="*/ 141902 w 630860"/>
                    <a:gd name="connsiteY28-5046" fmla="*/ 269100 h 293427"/>
                    <a:gd name="connsiteX29-5047" fmla="*/ 178415 w 630860"/>
                    <a:gd name="connsiteY29-5048" fmla="*/ 219888 h 293427"/>
                    <a:gd name="connsiteX30-5049" fmla="*/ 5377 w 630860"/>
                    <a:gd name="connsiteY30-5050" fmla="*/ 229413 h 293427"/>
                    <a:gd name="connsiteX0-5051" fmla="*/ 5377 w 630860"/>
                    <a:gd name="connsiteY0-5052" fmla="*/ 229319 h 293333"/>
                    <a:gd name="connsiteX1-5053" fmla="*/ 48240 w 630860"/>
                    <a:gd name="connsiteY1-5054" fmla="*/ 126132 h 293333"/>
                    <a:gd name="connsiteX2-5055" fmla="*/ 92690 w 630860"/>
                    <a:gd name="connsiteY2-5056" fmla="*/ 80094 h 293333"/>
                    <a:gd name="connsiteX3-5057" fmla="*/ 68866 w 630860"/>
                    <a:gd name="connsiteY3-5058" fmla="*/ 54692 h 293333"/>
                    <a:gd name="connsiteX4-5059" fmla="*/ 89501 w 630860"/>
                    <a:gd name="connsiteY4-5060" fmla="*/ 5472 h 293333"/>
                    <a:gd name="connsiteX5-5061" fmla="*/ 162557 w 630860"/>
                    <a:gd name="connsiteY5-5062" fmla="*/ 3883 h 293333"/>
                    <a:gd name="connsiteX6-5063" fmla="*/ 178431 w 630860"/>
                    <a:gd name="connsiteY6-5064" fmla="*/ 29291 h 293333"/>
                    <a:gd name="connsiteX7-5065" fmla="*/ 138727 w 630860"/>
                    <a:gd name="connsiteY7-5066" fmla="*/ 38820 h 293333"/>
                    <a:gd name="connsiteX8-5067" fmla="*/ 218103 w 630860"/>
                    <a:gd name="connsiteY8-5068" fmla="*/ 41994 h 293333"/>
                    <a:gd name="connsiteX9-5069" fmla="*/ 340340 w 630860"/>
                    <a:gd name="connsiteY9-5070" fmla="*/ 10244 h 293333"/>
                    <a:gd name="connsiteX10-5071" fmla="*/ 494327 w 630860"/>
                    <a:gd name="connsiteY10-5072" fmla="*/ 70570 h 293333"/>
                    <a:gd name="connsiteX11-5073" fmla="*/ 567352 w 630860"/>
                    <a:gd name="connsiteY11-5074" fmla="*/ 148356 h 293333"/>
                    <a:gd name="connsiteX12-5075" fmla="*/ 624503 w 630860"/>
                    <a:gd name="connsiteY12-5076" fmla="*/ 221381 h 293333"/>
                    <a:gd name="connsiteX13-5077" fmla="*/ 627677 w 630860"/>
                    <a:gd name="connsiteY13-5078" fmla="*/ 259481 h 293333"/>
                    <a:gd name="connsiteX14-5079" fmla="*/ 608628 w 630860"/>
                    <a:gd name="connsiteY14-5080" fmla="*/ 280119 h 293333"/>
                    <a:gd name="connsiteX15-5081" fmla="*/ 568940 w 630860"/>
                    <a:gd name="connsiteY15-5082" fmla="*/ 292819 h 293333"/>
                    <a:gd name="connsiteX16-5083" fmla="*/ 418128 w 630860"/>
                    <a:gd name="connsiteY16-5084" fmla="*/ 289644 h 293333"/>
                    <a:gd name="connsiteX17-5085" fmla="*/ 559415 w 630860"/>
                    <a:gd name="connsiteY17-5086" fmla="*/ 278532 h 293333"/>
                    <a:gd name="connsiteX18-5087" fmla="*/ 603868 w 630860"/>
                    <a:gd name="connsiteY18-5088" fmla="*/ 249958 h 293333"/>
                    <a:gd name="connsiteX19-5089" fmla="*/ 591165 w 630860"/>
                    <a:gd name="connsiteY19-5090" fmla="*/ 210269 h 293333"/>
                    <a:gd name="connsiteX20-5091" fmla="*/ 565764 w 630860"/>
                    <a:gd name="connsiteY20-5092" fmla="*/ 205507 h 293333"/>
                    <a:gd name="connsiteX21-5093" fmla="*/ 502265 w 630860"/>
                    <a:gd name="connsiteY21-5094" fmla="*/ 240432 h 293333"/>
                    <a:gd name="connsiteX22-5095" fmla="*/ 421302 w 630860"/>
                    <a:gd name="connsiteY22-5096" fmla="*/ 245194 h 293333"/>
                    <a:gd name="connsiteX23-5097" fmla="*/ 357802 w 630860"/>
                    <a:gd name="connsiteY23-5098" fmla="*/ 276945 h 293333"/>
                    <a:gd name="connsiteX24-5099" fmla="*/ 326052 w 630860"/>
                    <a:gd name="connsiteY24-5100" fmla="*/ 278531 h 293333"/>
                    <a:gd name="connsiteX25-5101" fmla="*/ 380027 w 630860"/>
                    <a:gd name="connsiteY25-5102" fmla="*/ 230907 h 293333"/>
                    <a:gd name="connsiteX26-5103" fmla="*/ 305415 w 630860"/>
                    <a:gd name="connsiteY26-5104" fmla="*/ 242019 h 293333"/>
                    <a:gd name="connsiteX27-5105" fmla="*/ 227628 w 630860"/>
                    <a:gd name="connsiteY27-5106" fmla="*/ 232495 h 293333"/>
                    <a:gd name="connsiteX28-5107" fmla="*/ 141902 w 630860"/>
                    <a:gd name="connsiteY28-5108" fmla="*/ 269006 h 293333"/>
                    <a:gd name="connsiteX29-5109" fmla="*/ 178415 w 630860"/>
                    <a:gd name="connsiteY29-5110" fmla="*/ 219794 h 293333"/>
                    <a:gd name="connsiteX30-5111" fmla="*/ 5377 w 630860"/>
                    <a:gd name="connsiteY30-5112" fmla="*/ 229319 h 293333"/>
                    <a:gd name="connsiteX0-5113" fmla="*/ 5377 w 630860"/>
                    <a:gd name="connsiteY0-5114" fmla="*/ 229319 h 293333"/>
                    <a:gd name="connsiteX1-5115" fmla="*/ 48240 w 630860"/>
                    <a:gd name="connsiteY1-5116" fmla="*/ 126132 h 293333"/>
                    <a:gd name="connsiteX2-5117" fmla="*/ 92690 w 630860"/>
                    <a:gd name="connsiteY2-5118" fmla="*/ 80094 h 293333"/>
                    <a:gd name="connsiteX3-5119" fmla="*/ 68866 w 630860"/>
                    <a:gd name="connsiteY3-5120" fmla="*/ 54692 h 293333"/>
                    <a:gd name="connsiteX4-5121" fmla="*/ 89501 w 630860"/>
                    <a:gd name="connsiteY4-5122" fmla="*/ 5472 h 293333"/>
                    <a:gd name="connsiteX5-5123" fmla="*/ 162557 w 630860"/>
                    <a:gd name="connsiteY5-5124" fmla="*/ 3883 h 293333"/>
                    <a:gd name="connsiteX6-5125" fmla="*/ 178431 w 630860"/>
                    <a:gd name="connsiteY6-5126" fmla="*/ 29291 h 293333"/>
                    <a:gd name="connsiteX7-5127" fmla="*/ 173713 w 630860"/>
                    <a:gd name="connsiteY7-5128" fmla="*/ 46772 h 293333"/>
                    <a:gd name="connsiteX8-5129" fmla="*/ 218103 w 630860"/>
                    <a:gd name="connsiteY8-5130" fmla="*/ 41994 h 293333"/>
                    <a:gd name="connsiteX9-5131" fmla="*/ 340340 w 630860"/>
                    <a:gd name="connsiteY9-5132" fmla="*/ 10244 h 293333"/>
                    <a:gd name="connsiteX10-5133" fmla="*/ 494327 w 630860"/>
                    <a:gd name="connsiteY10-5134" fmla="*/ 70570 h 293333"/>
                    <a:gd name="connsiteX11-5135" fmla="*/ 567352 w 630860"/>
                    <a:gd name="connsiteY11-5136" fmla="*/ 148356 h 293333"/>
                    <a:gd name="connsiteX12-5137" fmla="*/ 624503 w 630860"/>
                    <a:gd name="connsiteY12-5138" fmla="*/ 221381 h 293333"/>
                    <a:gd name="connsiteX13-5139" fmla="*/ 627677 w 630860"/>
                    <a:gd name="connsiteY13-5140" fmla="*/ 259481 h 293333"/>
                    <a:gd name="connsiteX14-5141" fmla="*/ 608628 w 630860"/>
                    <a:gd name="connsiteY14-5142" fmla="*/ 280119 h 293333"/>
                    <a:gd name="connsiteX15-5143" fmla="*/ 568940 w 630860"/>
                    <a:gd name="connsiteY15-5144" fmla="*/ 292819 h 293333"/>
                    <a:gd name="connsiteX16-5145" fmla="*/ 418128 w 630860"/>
                    <a:gd name="connsiteY16-5146" fmla="*/ 289644 h 293333"/>
                    <a:gd name="connsiteX17-5147" fmla="*/ 559415 w 630860"/>
                    <a:gd name="connsiteY17-5148" fmla="*/ 278532 h 293333"/>
                    <a:gd name="connsiteX18-5149" fmla="*/ 603868 w 630860"/>
                    <a:gd name="connsiteY18-5150" fmla="*/ 249958 h 293333"/>
                    <a:gd name="connsiteX19-5151" fmla="*/ 591165 w 630860"/>
                    <a:gd name="connsiteY19-5152" fmla="*/ 210269 h 293333"/>
                    <a:gd name="connsiteX20-5153" fmla="*/ 565764 w 630860"/>
                    <a:gd name="connsiteY20-5154" fmla="*/ 205507 h 293333"/>
                    <a:gd name="connsiteX21-5155" fmla="*/ 502265 w 630860"/>
                    <a:gd name="connsiteY21-5156" fmla="*/ 240432 h 293333"/>
                    <a:gd name="connsiteX22-5157" fmla="*/ 421302 w 630860"/>
                    <a:gd name="connsiteY22-5158" fmla="*/ 245194 h 293333"/>
                    <a:gd name="connsiteX23-5159" fmla="*/ 357802 w 630860"/>
                    <a:gd name="connsiteY23-5160" fmla="*/ 276945 h 293333"/>
                    <a:gd name="connsiteX24-5161" fmla="*/ 326052 w 630860"/>
                    <a:gd name="connsiteY24-5162" fmla="*/ 278531 h 293333"/>
                    <a:gd name="connsiteX25-5163" fmla="*/ 380027 w 630860"/>
                    <a:gd name="connsiteY25-5164" fmla="*/ 230907 h 293333"/>
                    <a:gd name="connsiteX26-5165" fmla="*/ 305415 w 630860"/>
                    <a:gd name="connsiteY26-5166" fmla="*/ 242019 h 293333"/>
                    <a:gd name="connsiteX27-5167" fmla="*/ 227628 w 630860"/>
                    <a:gd name="connsiteY27-5168" fmla="*/ 232495 h 293333"/>
                    <a:gd name="connsiteX28-5169" fmla="*/ 141902 w 630860"/>
                    <a:gd name="connsiteY28-5170" fmla="*/ 269006 h 293333"/>
                    <a:gd name="connsiteX29-5171" fmla="*/ 178415 w 630860"/>
                    <a:gd name="connsiteY29-5172" fmla="*/ 219794 h 293333"/>
                    <a:gd name="connsiteX30-5173" fmla="*/ 5377 w 630860"/>
                    <a:gd name="connsiteY30-5174" fmla="*/ 229319 h 293333"/>
                    <a:gd name="connsiteX0-5175" fmla="*/ 5377 w 630860"/>
                    <a:gd name="connsiteY0-5176" fmla="*/ 230219 h 294233"/>
                    <a:gd name="connsiteX1-5177" fmla="*/ 48240 w 630860"/>
                    <a:gd name="connsiteY1-5178" fmla="*/ 127032 h 294233"/>
                    <a:gd name="connsiteX2-5179" fmla="*/ 92690 w 630860"/>
                    <a:gd name="connsiteY2-5180" fmla="*/ 80994 h 294233"/>
                    <a:gd name="connsiteX3-5181" fmla="*/ 68866 w 630860"/>
                    <a:gd name="connsiteY3-5182" fmla="*/ 55592 h 294233"/>
                    <a:gd name="connsiteX4-5183" fmla="*/ 89501 w 630860"/>
                    <a:gd name="connsiteY4-5184" fmla="*/ 6372 h 294233"/>
                    <a:gd name="connsiteX5-5185" fmla="*/ 148244 w 630860"/>
                    <a:gd name="connsiteY5-5186" fmla="*/ 3192 h 294233"/>
                    <a:gd name="connsiteX6-5187" fmla="*/ 178431 w 630860"/>
                    <a:gd name="connsiteY6-5188" fmla="*/ 30191 h 294233"/>
                    <a:gd name="connsiteX7-5189" fmla="*/ 173713 w 630860"/>
                    <a:gd name="connsiteY7-5190" fmla="*/ 47672 h 294233"/>
                    <a:gd name="connsiteX8-5191" fmla="*/ 218103 w 630860"/>
                    <a:gd name="connsiteY8-5192" fmla="*/ 42894 h 294233"/>
                    <a:gd name="connsiteX9-5193" fmla="*/ 340340 w 630860"/>
                    <a:gd name="connsiteY9-5194" fmla="*/ 11144 h 294233"/>
                    <a:gd name="connsiteX10-5195" fmla="*/ 494327 w 630860"/>
                    <a:gd name="connsiteY10-5196" fmla="*/ 71470 h 294233"/>
                    <a:gd name="connsiteX11-5197" fmla="*/ 567352 w 630860"/>
                    <a:gd name="connsiteY11-5198" fmla="*/ 149256 h 294233"/>
                    <a:gd name="connsiteX12-5199" fmla="*/ 624503 w 630860"/>
                    <a:gd name="connsiteY12-5200" fmla="*/ 222281 h 294233"/>
                    <a:gd name="connsiteX13-5201" fmla="*/ 627677 w 630860"/>
                    <a:gd name="connsiteY13-5202" fmla="*/ 260381 h 294233"/>
                    <a:gd name="connsiteX14-5203" fmla="*/ 608628 w 630860"/>
                    <a:gd name="connsiteY14-5204" fmla="*/ 281019 h 294233"/>
                    <a:gd name="connsiteX15-5205" fmla="*/ 568940 w 630860"/>
                    <a:gd name="connsiteY15-5206" fmla="*/ 293719 h 294233"/>
                    <a:gd name="connsiteX16-5207" fmla="*/ 418128 w 630860"/>
                    <a:gd name="connsiteY16-5208" fmla="*/ 290544 h 294233"/>
                    <a:gd name="connsiteX17-5209" fmla="*/ 559415 w 630860"/>
                    <a:gd name="connsiteY17-5210" fmla="*/ 279432 h 294233"/>
                    <a:gd name="connsiteX18-5211" fmla="*/ 603868 w 630860"/>
                    <a:gd name="connsiteY18-5212" fmla="*/ 250858 h 294233"/>
                    <a:gd name="connsiteX19-5213" fmla="*/ 591165 w 630860"/>
                    <a:gd name="connsiteY19-5214" fmla="*/ 211169 h 294233"/>
                    <a:gd name="connsiteX20-5215" fmla="*/ 565764 w 630860"/>
                    <a:gd name="connsiteY20-5216" fmla="*/ 206407 h 294233"/>
                    <a:gd name="connsiteX21-5217" fmla="*/ 502265 w 630860"/>
                    <a:gd name="connsiteY21-5218" fmla="*/ 241332 h 294233"/>
                    <a:gd name="connsiteX22-5219" fmla="*/ 421302 w 630860"/>
                    <a:gd name="connsiteY22-5220" fmla="*/ 246094 h 294233"/>
                    <a:gd name="connsiteX23-5221" fmla="*/ 357802 w 630860"/>
                    <a:gd name="connsiteY23-5222" fmla="*/ 277845 h 294233"/>
                    <a:gd name="connsiteX24-5223" fmla="*/ 326052 w 630860"/>
                    <a:gd name="connsiteY24-5224" fmla="*/ 279431 h 294233"/>
                    <a:gd name="connsiteX25-5225" fmla="*/ 380027 w 630860"/>
                    <a:gd name="connsiteY25-5226" fmla="*/ 231807 h 294233"/>
                    <a:gd name="connsiteX26-5227" fmla="*/ 305415 w 630860"/>
                    <a:gd name="connsiteY26-5228" fmla="*/ 242919 h 294233"/>
                    <a:gd name="connsiteX27-5229" fmla="*/ 227628 w 630860"/>
                    <a:gd name="connsiteY27-5230" fmla="*/ 233395 h 294233"/>
                    <a:gd name="connsiteX28-5231" fmla="*/ 141902 w 630860"/>
                    <a:gd name="connsiteY28-5232" fmla="*/ 269906 h 294233"/>
                    <a:gd name="connsiteX29-5233" fmla="*/ 178415 w 630860"/>
                    <a:gd name="connsiteY29-5234" fmla="*/ 220694 h 294233"/>
                    <a:gd name="connsiteX30-5235" fmla="*/ 5377 w 630860"/>
                    <a:gd name="connsiteY30-5236" fmla="*/ 230219 h 294233"/>
                    <a:gd name="connsiteX0-5237" fmla="*/ 5377 w 630860"/>
                    <a:gd name="connsiteY0-5238" fmla="*/ 229806 h 293820"/>
                    <a:gd name="connsiteX1-5239" fmla="*/ 48240 w 630860"/>
                    <a:gd name="connsiteY1-5240" fmla="*/ 126619 h 293820"/>
                    <a:gd name="connsiteX2-5241" fmla="*/ 92690 w 630860"/>
                    <a:gd name="connsiteY2-5242" fmla="*/ 80581 h 293820"/>
                    <a:gd name="connsiteX3-5243" fmla="*/ 68866 w 630860"/>
                    <a:gd name="connsiteY3-5244" fmla="*/ 55179 h 293820"/>
                    <a:gd name="connsiteX4-5245" fmla="*/ 89501 w 630860"/>
                    <a:gd name="connsiteY4-5246" fmla="*/ 5959 h 293820"/>
                    <a:gd name="connsiteX5-5247" fmla="*/ 148244 w 630860"/>
                    <a:gd name="connsiteY5-5248" fmla="*/ 2779 h 293820"/>
                    <a:gd name="connsiteX6-5249" fmla="*/ 178431 w 630860"/>
                    <a:gd name="connsiteY6-5250" fmla="*/ 23417 h 293820"/>
                    <a:gd name="connsiteX7-5251" fmla="*/ 173713 w 630860"/>
                    <a:gd name="connsiteY7-5252" fmla="*/ 47259 h 293820"/>
                    <a:gd name="connsiteX8-5253" fmla="*/ 218103 w 630860"/>
                    <a:gd name="connsiteY8-5254" fmla="*/ 42481 h 293820"/>
                    <a:gd name="connsiteX9-5255" fmla="*/ 340340 w 630860"/>
                    <a:gd name="connsiteY9-5256" fmla="*/ 10731 h 293820"/>
                    <a:gd name="connsiteX10-5257" fmla="*/ 494327 w 630860"/>
                    <a:gd name="connsiteY10-5258" fmla="*/ 71057 h 293820"/>
                    <a:gd name="connsiteX11-5259" fmla="*/ 567352 w 630860"/>
                    <a:gd name="connsiteY11-5260" fmla="*/ 148843 h 293820"/>
                    <a:gd name="connsiteX12-5261" fmla="*/ 624503 w 630860"/>
                    <a:gd name="connsiteY12-5262" fmla="*/ 221868 h 293820"/>
                    <a:gd name="connsiteX13-5263" fmla="*/ 627677 w 630860"/>
                    <a:gd name="connsiteY13-5264" fmla="*/ 259968 h 293820"/>
                    <a:gd name="connsiteX14-5265" fmla="*/ 608628 w 630860"/>
                    <a:gd name="connsiteY14-5266" fmla="*/ 280606 h 293820"/>
                    <a:gd name="connsiteX15-5267" fmla="*/ 568940 w 630860"/>
                    <a:gd name="connsiteY15-5268" fmla="*/ 293306 h 293820"/>
                    <a:gd name="connsiteX16-5269" fmla="*/ 418128 w 630860"/>
                    <a:gd name="connsiteY16-5270" fmla="*/ 290131 h 293820"/>
                    <a:gd name="connsiteX17-5271" fmla="*/ 559415 w 630860"/>
                    <a:gd name="connsiteY17-5272" fmla="*/ 279019 h 293820"/>
                    <a:gd name="connsiteX18-5273" fmla="*/ 603868 w 630860"/>
                    <a:gd name="connsiteY18-5274" fmla="*/ 250445 h 293820"/>
                    <a:gd name="connsiteX19-5275" fmla="*/ 591165 w 630860"/>
                    <a:gd name="connsiteY19-5276" fmla="*/ 210756 h 293820"/>
                    <a:gd name="connsiteX20-5277" fmla="*/ 565764 w 630860"/>
                    <a:gd name="connsiteY20-5278" fmla="*/ 205994 h 293820"/>
                    <a:gd name="connsiteX21-5279" fmla="*/ 502265 w 630860"/>
                    <a:gd name="connsiteY21-5280" fmla="*/ 240919 h 293820"/>
                    <a:gd name="connsiteX22-5281" fmla="*/ 421302 w 630860"/>
                    <a:gd name="connsiteY22-5282" fmla="*/ 245681 h 293820"/>
                    <a:gd name="connsiteX23-5283" fmla="*/ 357802 w 630860"/>
                    <a:gd name="connsiteY23-5284" fmla="*/ 277432 h 293820"/>
                    <a:gd name="connsiteX24-5285" fmla="*/ 326052 w 630860"/>
                    <a:gd name="connsiteY24-5286" fmla="*/ 279018 h 293820"/>
                    <a:gd name="connsiteX25-5287" fmla="*/ 380027 w 630860"/>
                    <a:gd name="connsiteY25-5288" fmla="*/ 231394 h 293820"/>
                    <a:gd name="connsiteX26-5289" fmla="*/ 305415 w 630860"/>
                    <a:gd name="connsiteY26-5290" fmla="*/ 242506 h 293820"/>
                    <a:gd name="connsiteX27-5291" fmla="*/ 227628 w 630860"/>
                    <a:gd name="connsiteY27-5292" fmla="*/ 232982 h 293820"/>
                    <a:gd name="connsiteX28-5293" fmla="*/ 141902 w 630860"/>
                    <a:gd name="connsiteY28-5294" fmla="*/ 269493 h 293820"/>
                    <a:gd name="connsiteX29-5295" fmla="*/ 178415 w 630860"/>
                    <a:gd name="connsiteY29-5296" fmla="*/ 220281 h 293820"/>
                    <a:gd name="connsiteX30-5297" fmla="*/ 5377 w 630860"/>
                    <a:gd name="connsiteY30-5298" fmla="*/ 229806 h 293820"/>
                    <a:gd name="connsiteX0-5299" fmla="*/ 5377 w 630860"/>
                    <a:gd name="connsiteY0-5300" fmla="*/ 227909 h 291923"/>
                    <a:gd name="connsiteX1-5301" fmla="*/ 48240 w 630860"/>
                    <a:gd name="connsiteY1-5302" fmla="*/ 124722 h 291923"/>
                    <a:gd name="connsiteX2-5303" fmla="*/ 92690 w 630860"/>
                    <a:gd name="connsiteY2-5304" fmla="*/ 78684 h 291923"/>
                    <a:gd name="connsiteX3-5305" fmla="*/ 68866 w 630860"/>
                    <a:gd name="connsiteY3-5306" fmla="*/ 53282 h 291923"/>
                    <a:gd name="connsiteX4-5307" fmla="*/ 94272 w 630860"/>
                    <a:gd name="connsiteY4-5308" fmla="*/ 8833 h 291923"/>
                    <a:gd name="connsiteX5-5309" fmla="*/ 148244 w 630860"/>
                    <a:gd name="connsiteY5-5310" fmla="*/ 882 h 291923"/>
                    <a:gd name="connsiteX6-5311" fmla="*/ 178431 w 630860"/>
                    <a:gd name="connsiteY6-5312" fmla="*/ 21520 h 291923"/>
                    <a:gd name="connsiteX7-5313" fmla="*/ 173713 w 630860"/>
                    <a:gd name="connsiteY7-5314" fmla="*/ 45362 h 291923"/>
                    <a:gd name="connsiteX8-5315" fmla="*/ 218103 w 630860"/>
                    <a:gd name="connsiteY8-5316" fmla="*/ 40584 h 291923"/>
                    <a:gd name="connsiteX9-5317" fmla="*/ 340340 w 630860"/>
                    <a:gd name="connsiteY9-5318" fmla="*/ 8834 h 291923"/>
                    <a:gd name="connsiteX10-5319" fmla="*/ 494327 w 630860"/>
                    <a:gd name="connsiteY10-5320" fmla="*/ 69160 h 291923"/>
                    <a:gd name="connsiteX11-5321" fmla="*/ 567352 w 630860"/>
                    <a:gd name="connsiteY11-5322" fmla="*/ 146946 h 291923"/>
                    <a:gd name="connsiteX12-5323" fmla="*/ 624503 w 630860"/>
                    <a:gd name="connsiteY12-5324" fmla="*/ 219971 h 291923"/>
                    <a:gd name="connsiteX13-5325" fmla="*/ 627677 w 630860"/>
                    <a:gd name="connsiteY13-5326" fmla="*/ 258071 h 291923"/>
                    <a:gd name="connsiteX14-5327" fmla="*/ 608628 w 630860"/>
                    <a:gd name="connsiteY14-5328" fmla="*/ 278709 h 291923"/>
                    <a:gd name="connsiteX15-5329" fmla="*/ 568940 w 630860"/>
                    <a:gd name="connsiteY15-5330" fmla="*/ 291409 h 291923"/>
                    <a:gd name="connsiteX16-5331" fmla="*/ 418128 w 630860"/>
                    <a:gd name="connsiteY16-5332" fmla="*/ 288234 h 291923"/>
                    <a:gd name="connsiteX17-5333" fmla="*/ 559415 w 630860"/>
                    <a:gd name="connsiteY17-5334" fmla="*/ 277122 h 291923"/>
                    <a:gd name="connsiteX18-5335" fmla="*/ 603868 w 630860"/>
                    <a:gd name="connsiteY18-5336" fmla="*/ 248548 h 291923"/>
                    <a:gd name="connsiteX19-5337" fmla="*/ 591165 w 630860"/>
                    <a:gd name="connsiteY19-5338" fmla="*/ 208859 h 291923"/>
                    <a:gd name="connsiteX20-5339" fmla="*/ 565764 w 630860"/>
                    <a:gd name="connsiteY20-5340" fmla="*/ 204097 h 291923"/>
                    <a:gd name="connsiteX21-5341" fmla="*/ 502265 w 630860"/>
                    <a:gd name="connsiteY21-5342" fmla="*/ 239022 h 291923"/>
                    <a:gd name="connsiteX22-5343" fmla="*/ 421302 w 630860"/>
                    <a:gd name="connsiteY22-5344" fmla="*/ 243784 h 291923"/>
                    <a:gd name="connsiteX23-5345" fmla="*/ 357802 w 630860"/>
                    <a:gd name="connsiteY23-5346" fmla="*/ 275535 h 291923"/>
                    <a:gd name="connsiteX24-5347" fmla="*/ 326052 w 630860"/>
                    <a:gd name="connsiteY24-5348" fmla="*/ 277121 h 291923"/>
                    <a:gd name="connsiteX25-5349" fmla="*/ 380027 w 630860"/>
                    <a:gd name="connsiteY25-5350" fmla="*/ 229497 h 291923"/>
                    <a:gd name="connsiteX26-5351" fmla="*/ 305415 w 630860"/>
                    <a:gd name="connsiteY26-5352" fmla="*/ 240609 h 291923"/>
                    <a:gd name="connsiteX27-5353" fmla="*/ 227628 w 630860"/>
                    <a:gd name="connsiteY27-5354" fmla="*/ 231085 h 291923"/>
                    <a:gd name="connsiteX28-5355" fmla="*/ 141902 w 630860"/>
                    <a:gd name="connsiteY28-5356" fmla="*/ 267596 h 291923"/>
                    <a:gd name="connsiteX29-5357" fmla="*/ 178415 w 630860"/>
                    <a:gd name="connsiteY29-5358" fmla="*/ 218384 h 291923"/>
                    <a:gd name="connsiteX30-5359" fmla="*/ 5377 w 630860"/>
                    <a:gd name="connsiteY30-5360" fmla="*/ 227909 h 291923"/>
                    <a:gd name="connsiteX0-5361" fmla="*/ 5358 w 630841"/>
                    <a:gd name="connsiteY0-5362" fmla="*/ 227909 h 291923"/>
                    <a:gd name="connsiteX1-5363" fmla="*/ 48221 w 630841"/>
                    <a:gd name="connsiteY1-5364" fmla="*/ 124722 h 291923"/>
                    <a:gd name="connsiteX2-5365" fmla="*/ 91080 w 630841"/>
                    <a:gd name="connsiteY2-5366" fmla="*/ 80275 h 291923"/>
                    <a:gd name="connsiteX3-5367" fmla="*/ 68847 w 630841"/>
                    <a:gd name="connsiteY3-5368" fmla="*/ 53282 h 291923"/>
                    <a:gd name="connsiteX4-5369" fmla="*/ 94253 w 630841"/>
                    <a:gd name="connsiteY4-5370" fmla="*/ 8833 h 291923"/>
                    <a:gd name="connsiteX5-5371" fmla="*/ 148225 w 630841"/>
                    <a:gd name="connsiteY5-5372" fmla="*/ 882 h 291923"/>
                    <a:gd name="connsiteX6-5373" fmla="*/ 178412 w 630841"/>
                    <a:gd name="connsiteY6-5374" fmla="*/ 21520 h 291923"/>
                    <a:gd name="connsiteX7-5375" fmla="*/ 173694 w 630841"/>
                    <a:gd name="connsiteY7-5376" fmla="*/ 45362 h 291923"/>
                    <a:gd name="connsiteX8-5377" fmla="*/ 218084 w 630841"/>
                    <a:gd name="connsiteY8-5378" fmla="*/ 40584 h 291923"/>
                    <a:gd name="connsiteX9-5379" fmla="*/ 340321 w 630841"/>
                    <a:gd name="connsiteY9-5380" fmla="*/ 8834 h 291923"/>
                    <a:gd name="connsiteX10-5381" fmla="*/ 494308 w 630841"/>
                    <a:gd name="connsiteY10-5382" fmla="*/ 69160 h 291923"/>
                    <a:gd name="connsiteX11-5383" fmla="*/ 567333 w 630841"/>
                    <a:gd name="connsiteY11-5384" fmla="*/ 146946 h 291923"/>
                    <a:gd name="connsiteX12-5385" fmla="*/ 624484 w 630841"/>
                    <a:gd name="connsiteY12-5386" fmla="*/ 219971 h 291923"/>
                    <a:gd name="connsiteX13-5387" fmla="*/ 627658 w 630841"/>
                    <a:gd name="connsiteY13-5388" fmla="*/ 258071 h 291923"/>
                    <a:gd name="connsiteX14-5389" fmla="*/ 608609 w 630841"/>
                    <a:gd name="connsiteY14-5390" fmla="*/ 278709 h 291923"/>
                    <a:gd name="connsiteX15-5391" fmla="*/ 568921 w 630841"/>
                    <a:gd name="connsiteY15-5392" fmla="*/ 291409 h 291923"/>
                    <a:gd name="connsiteX16-5393" fmla="*/ 418109 w 630841"/>
                    <a:gd name="connsiteY16-5394" fmla="*/ 288234 h 291923"/>
                    <a:gd name="connsiteX17-5395" fmla="*/ 559396 w 630841"/>
                    <a:gd name="connsiteY17-5396" fmla="*/ 277122 h 291923"/>
                    <a:gd name="connsiteX18-5397" fmla="*/ 603849 w 630841"/>
                    <a:gd name="connsiteY18-5398" fmla="*/ 248548 h 291923"/>
                    <a:gd name="connsiteX19-5399" fmla="*/ 591146 w 630841"/>
                    <a:gd name="connsiteY19-5400" fmla="*/ 208859 h 291923"/>
                    <a:gd name="connsiteX20-5401" fmla="*/ 565745 w 630841"/>
                    <a:gd name="connsiteY20-5402" fmla="*/ 204097 h 291923"/>
                    <a:gd name="connsiteX21-5403" fmla="*/ 502246 w 630841"/>
                    <a:gd name="connsiteY21-5404" fmla="*/ 239022 h 291923"/>
                    <a:gd name="connsiteX22-5405" fmla="*/ 421283 w 630841"/>
                    <a:gd name="connsiteY22-5406" fmla="*/ 243784 h 291923"/>
                    <a:gd name="connsiteX23-5407" fmla="*/ 357783 w 630841"/>
                    <a:gd name="connsiteY23-5408" fmla="*/ 275535 h 291923"/>
                    <a:gd name="connsiteX24-5409" fmla="*/ 326033 w 630841"/>
                    <a:gd name="connsiteY24-5410" fmla="*/ 277121 h 291923"/>
                    <a:gd name="connsiteX25-5411" fmla="*/ 380008 w 630841"/>
                    <a:gd name="connsiteY25-5412" fmla="*/ 229497 h 291923"/>
                    <a:gd name="connsiteX26-5413" fmla="*/ 305396 w 630841"/>
                    <a:gd name="connsiteY26-5414" fmla="*/ 240609 h 291923"/>
                    <a:gd name="connsiteX27-5415" fmla="*/ 227609 w 630841"/>
                    <a:gd name="connsiteY27-5416" fmla="*/ 231085 h 291923"/>
                    <a:gd name="connsiteX28-5417" fmla="*/ 141883 w 630841"/>
                    <a:gd name="connsiteY28-5418" fmla="*/ 267596 h 291923"/>
                    <a:gd name="connsiteX29-5419" fmla="*/ 178396 w 630841"/>
                    <a:gd name="connsiteY29-5420" fmla="*/ 218384 h 291923"/>
                    <a:gd name="connsiteX30-5421" fmla="*/ 5358 w 630841"/>
                    <a:gd name="connsiteY30-5422" fmla="*/ 227909 h 291923"/>
                    <a:gd name="connsiteX0-5423" fmla="*/ 5358 w 630841"/>
                    <a:gd name="connsiteY0-5424" fmla="*/ 238430 h 302444"/>
                    <a:gd name="connsiteX1-5425" fmla="*/ 48221 w 630841"/>
                    <a:gd name="connsiteY1-5426" fmla="*/ 135243 h 302444"/>
                    <a:gd name="connsiteX2-5427" fmla="*/ 91080 w 630841"/>
                    <a:gd name="connsiteY2-5428" fmla="*/ 90796 h 302444"/>
                    <a:gd name="connsiteX3-5429" fmla="*/ 68847 w 630841"/>
                    <a:gd name="connsiteY3-5430" fmla="*/ 63803 h 302444"/>
                    <a:gd name="connsiteX4-5431" fmla="*/ 94253 w 630841"/>
                    <a:gd name="connsiteY4-5432" fmla="*/ 19354 h 302444"/>
                    <a:gd name="connsiteX5-5433" fmla="*/ 148225 w 630841"/>
                    <a:gd name="connsiteY5-5434" fmla="*/ 271 h 302444"/>
                    <a:gd name="connsiteX6-5435" fmla="*/ 178412 w 630841"/>
                    <a:gd name="connsiteY6-5436" fmla="*/ 32041 h 302444"/>
                    <a:gd name="connsiteX7-5437" fmla="*/ 173694 w 630841"/>
                    <a:gd name="connsiteY7-5438" fmla="*/ 55883 h 302444"/>
                    <a:gd name="connsiteX8-5439" fmla="*/ 218084 w 630841"/>
                    <a:gd name="connsiteY8-5440" fmla="*/ 51105 h 302444"/>
                    <a:gd name="connsiteX9-5441" fmla="*/ 340321 w 630841"/>
                    <a:gd name="connsiteY9-5442" fmla="*/ 19355 h 302444"/>
                    <a:gd name="connsiteX10-5443" fmla="*/ 494308 w 630841"/>
                    <a:gd name="connsiteY10-5444" fmla="*/ 79681 h 302444"/>
                    <a:gd name="connsiteX11-5445" fmla="*/ 567333 w 630841"/>
                    <a:gd name="connsiteY11-5446" fmla="*/ 157467 h 302444"/>
                    <a:gd name="connsiteX12-5447" fmla="*/ 624484 w 630841"/>
                    <a:gd name="connsiteY12-5448" fmla="*/ 230492 h 302444"/>
                    <a:gd name="connsiteX13-5449" fmla="*/ 627658 w 630841"/>
                    <a:gd name="connsiteY13-5450" fmla="*/ 268592 h 302444"/>
                    <a:gd name="connsiteX14-5451" fmla="*/ 608609 w 630841"/>
                    <a:gd name="connsiteY14-5452" fmla="*/ 289230 h 302444"/>
                    <a:gd name="connsiteX15-5453" fmla="*/ 568921 w 630841"/>
                    <a:gd name="connsiteY15-5454" fmla="*/ 301930 h 302444"/>
                    <a:gd name="connsiteX16-5455" fmla="*/ 418109 w 630841"/>
                    <a:gd name="connsiteY16-5456" fmla="*/ 298755 h 302444"/>
                    <a:gd name="connsiteX17-5457" fmla="*/ 559396 w 630841"/>
                    <a:gd name="connsiteY17-5458" fmla="*/ 287643 h 302444"/>
                    <a:gd name="connsiteX18-5459" fmla="*/ 603849 w 630841"/>
                    <a:gd name="connsiteY18-5460" fmla="*/ 259069 h 302444"/>
                    <a:gd name="connsiteX19-5461" fmla="*/ 591146 w 630841"/>
                    <a:gd name="connsiteY19-5462" fmla="*/ 219380 h 302444"/>
                    <a:gd name="connsiteX20-5463" fmla="*/ 565745 w 630841"/>
                    <a:gd name="connsiteY20-5464" fmla="*/ 214618 h 302444"/>
                    <a:gd name="connsiteX21-5465" fmla="*/ 502246 w 630841"/>
                    <a:gd name="connsiteY21-5466" fmla="*/ 249543 h 302444"/>
                    <a:gd name="connsiteX22-5467" fmla="*/ 421283 w 630841"/>
                    <a:gd name="connsiteY22-5468" fmla="*/ 254305 h 302444"/>
                    <a:gd name="connsiteX23-5469" fmla="*/ 357783 w 630841"/>
                    <a:gd name="connsiteY23-5470" fmla="*/ 286056 h 302444"/>
                    <a:gd name="connsiteX24-5471" fmla="*/ 326033 w 630841"/>
                    <a:gd name="connsiteY24-5472" fmla="*/ 287642 h 302444"/>
                    <a:gd name="connsiteX25-5473" fmla="*/ 380008 w 630841"/>
                    <a:gd name="connsiteY25-5474" fmla="*/ 240018 h 302444"/>
                    <a:gd name="connsiteX26-5475" fmla="*/ 305396 w 630841"/>
                    <a:gd name="connsiteY26-5476" fmla="*/ 251130 h 302444"/>
                    <a:gd name="connsiteX27-5477" fmla="*/ 227609 w 630841"/>
                    <a:gd name="connsiteY27-5478" fmla="*/ 241606 h 302444"/>
                    <a:gd name="connsiteX28-5479" fmla="*/ 141883 w 630841"/>
                    <a:gd name="connsiteY28-5480" fmla="*/ 278117 h 302444"/>
                    <a:gd name="connsiteX29-5481" fmla="*/ 178396 w 630841"/>
                    <a:gd name="connsiteY29-5482" fmla="*/ 228905 h 302444"/>
                    <a:gd name="connsiteX30-5483" fmla="*/ 5358 w 630841"/>
                    <a:gd name="connsiteY30-5484" fmla="*/ 238430 h 302444"/>
                    <a:gd name="connsiteX0-5485" fmla="*/ 5358 w 630841"/>
                    <a:gd name="connsiteY0-5486" fmla="*/ 227909 h 291923"/>
                    <a:gd name="connsiteX1-5487" fmla="*/ 48221 w 630841"/>
                    <a:gd name="connsiteY1-5488" fmla="*/ 124722 h 291923"/>
                    <a:gd name="connsiteX2-5489" fmla="*/ 91080 w 630841"/>
                    <a:gd name="connsiteY2-5490" fmla="*/ 80275 h 291923"/>
                    <a:gd name="connsiteX3-5491" fmla="*/ 68847 w 630841"/>
                    <a:gd name="connsiteY3-5492" fmla="*/ 53282 h 291923"/>
                    <a:gd name="connsiteX4-5493" fmla="*/ 94253 w 630841"/>
                    <a:gd name="connsiteY4-5494" fmla="*/ 8833 h 291923"/>
                    <a:gd name="connsiteX5-5495" fmla="*/ 148225 w 630841"/>
                    <a:gd name="connsiteY5-5496" fmla="*/ 882 h 291923"/>
                    <a:gd name="connsiteX6-5497" fmla="*/ 178412 w 630841"/>
                    <a:gd name="connsiteY6-5498" fmla="*/ 21520 h 291923"/>
                    <a:gd name="connsiteX7-5499" fmla="*/ 173694 w 630841"/>
                    <a:gd name="connsiteY7-5500" fmla="*/ 45362 h 291923"/>
                    <a:gd name="connsiteX8-5501" fmla="*/ 218084 w 630841"/>
                    <a:gd name="connsiteY8-5502" fmla="*/ 40584 h 291923"/>
                    <a:gd name="connsiteX9-5503" fmla="*/ 340321 w 630841"/>
                    <a:gd name="connsiteY9-5504" fmla="*/ 8834 h 291923"/>
                    <a:gd name="connsiteX10-5505" fmla="*/ 494308 w 630841"/>
                    <a:gd name="connsiteY10-5506" fmla="*/ 69160 h 291923"/>
                    <a:gd name="connsiteX11-5507" fmla="*/ 567333 w 630841"/>
                    <a:gd name="connsiteY11-5508" fmla="*/ 146946 h 291923"/>
                    <a:gd name="connsiteX12-5509" fmla="*/ 624484 w 630841"/>
                    <a:gd name="connsiteY12-5510" fmla="*/ 219971 h 291923"/>
                    <a:gd name="connsiteX13-5511" fmla="*/ 627658 w 630841"/>
                    <a:gd name="connsiteY13-5512" fmla="*/ 258071 h 291923"/>
                    <a:gd name="connsiteX14-5513" fmla="*/ 608609 w 630841"/>
                    <a:gd name="connsiteY14-5514" fmla="*/ 278709 h 291923"/>
                    <a:gd name="connsiteX15-5515" fmla="*/ 568921 w 630841"/>
                    <a:gd name="connsiteY15-5516" fmla="*/ 291409 h 291923"/>
                    <a:gd name="connsiteX16-5517" fmla="*/ 418109 w 630841"/>
                    <a:gd name="connsiteY16-5518" fmla="*/ 288234 h 291923"/>
                    <a:gd name="connsiteX17-5519" fmla="*/ 559396 w 630841"/>
                    <a:gd name="connsiteY17-5520" fmla="*/ 277122 h 291923"/>
                    <a:gd name="connsiteX18-5521" fmla="*/ 603849 w 630841"/>
                    <a:gd name="connsiteY18-5522" fmla="*/ 248548 h 291923"/>
                    <a:gd name="connsiteX19-5523" fmla="*/ 591146 w 630841"/>
                    <a:gd name="connsiteY19-5524" fmla="*/ 208859 h 291923"/>
                    <a:gd name="connsiteX20-5525" fmla="*/ 565745 w 630841"/>
                    <a:gd name="connsiteY20-5526" fmla="*/ 204097 h 291923"/>
                    <a:gd name="connsiteX21-5527" fmla="*/ 502246 w 630841"/>
                    <a:gd name="connsiteY21-5528" fmla="*/ 239022 h 291923"/>
                    <a:gd name="connsiteX22-5529" fmla="*/ 421283 w 630841"/>
                    <a:gd name="connsiteY22-5530" fmla="*/ 243784 h 291923"/>
                    <a:gd name="connsiteX23-5531" fmla="*/ 357783 w 630841"/>
                    <a:gd name="connsiteY23-5532" fmla="*/ 275535 h 291923"/>
                    <a:gd name="connsiteX24-5533" fmla="*/ 326033 w 630841"/>
                    <a:gd name="connsiteY24-5534" fmla="*/ 277121 h 291923"/>
                    <a:gd name="connsiteX25-5535" fmla="*/ 380008 w 630841"/>
                    <a:gd name="connsiteY25-5536" fmla="*/ 229497 h 291923"/>
                    <a:gd name="connsiteX26-5537" fmla="*/ 305396 w 630841"/>
                    <a:gd name="connsiteY26-5538" fmla="*/ 240609 h 291923"/>
                    <a:gd name="connsiteX27-5539" fmla="*/ 227609 w 630841"/>
                    <a:gd name="connsiteY27-5540" fmla="*/ 231085 h 291923"/>
                    <a:gd name="connsiteX28-5541" fmla="*/ 141883 w 630841"/>
                    <a:gd name="connsiteY28-5542" fmla="*/ 267596 h 291923"/>
                    <a:gd name="connsiteX29-5543" fmla="*/ 178396 w 630841"/>
                    <a:gd name="connsiteY29-5544" fmla="*/ 218384 h 291923"/>
                    <a:gd name="connsiteX30-5545" fmla="*/ 5358 w 630841"/>
                    <a:gd name="connsiteY30-5546" fmla="*/ 227909 h 291923"/>
                    <a:gd name="connsiteX0-5547" fmla="*/ 5358 w 630841"/>
                    <a:gd name="connsiteY0-5548" fmla="*/ 232259 h 296273"/>
                    <a:gd name="connsiteX1-5549" fmla="*/ 48221 w 630841"/>
                    <a:gd name="connsiteY1-5550" fmla="*/ 129072 h 296273"/>
                    <a:gd name="connsiteX2-5551" fmla="*/ 91080 w 630841"/>
                    <a:gd name="connsiteY2-5552" fmla="*/ 84625 h 296273"/>
                    <a:gd name="connsiteX3-5553" fmla="*/ 68847 w 630841"/>
                    <a:gd name="connsiteY3-5554" fmla="*/ 57632 h 296273"/>
                    <a:gd name="connsiteX4-5555" fmla="*/ 94253 w 630841"/>
                    <a:gd name="connsiteY4-5556" fmla="*/ 13183 h 296273"/>
                    <a:gd name="connsiteX5-5557" fmla="*/ 148225 w 630841"/>
                    <a:gd name="connsiteY5-5558" fmla="*/ 461 h 296273"/>
                    <a:gd name="connsiteX6-5559" fmla="*/ 178412 w 630841"/>
                    <a:gd name="connsiteY6-5560" fmla="*/ 25870 h 296273"/>
                    <a:gd name="connsiteX7-5561" fmla="*/ 173694 w 630841"/>
                    <a:gd name="connsiteY7-5562" fmla="*/ 49712 h 296273"/>
                    <a:gd name="connsiteX8-5563" fmla="*/ 218084 w 630841"/>
                    <a:gd name="connsiteY8-5564" fmla="*/ 44934 h 296273"/>
                    <a:gd name="connsiteX9-5565" fmla="*/ 340321 w 630841"/>
                    <a:gd name="connsiteY9-5566" fmla="*/ 13184 h 296273"/>
                    <a:gd name="connsiteX10-5567" fmla="*/ 494308 w 630841"/>
                    <a:gd name="connsiteY10-5568" fmla="*/ 73510 h 296273"/>
                    <a:gd name="connsiteX11-5569" fmla="*/ 567333 w 630841"/>
                    <a:gd name="connsiteY11-5570" fmla="*/ 151296 h 296273"/>
                    <a:gd name="connsiteX12-5571" fmla="*/ 624484 w 630841"/>
                    <a:gd name="connsiteY12-5572" fmla="*/ 224321 h 296273"/>
                    <a:gd name="connsiteX13-5573" fmla="*/ 627658 w 630841"/>
                    <a:gd name="connsiteY13-5574" fmla="*/ 262421 h 296273"/>
                    <a:gd name="connsiteX14-5575" fmla="*/ 608609 w 630841"/>
                    <a:gd name="connsiteY14-5576" fmla="*/ 283059 h 296273"/>
                    <a:gd name="connsiteX15-5577" fmla="*/ 568921 w 630841"/>
                    <a:gd name="connsiteY15-5578" fmla="*/ 295759 h 296273"/>
                    <a:gd name="connsiteX16-5579" fmla="*/ 418109 w 630841"/>
                    <a:gd name="connsiteY16-5580" fmla="*/ 292584 h 296273"/>
                    <a:gd name="connsiteX17-5581" fmla="*/ 559396 w 630841"/>
                    <a:gd name="connsiteY17-5582" fmla="*/ 281472 h 296273"/>
                    <a:gd name="connsiteX18-5583" fmla="*/ 603849 w 630841"/>
                    <a:gd name="connsiteY18-5584" fmla="*/ 252898 h 296273"/>
                    <a:gd name="connsiteX19-5585" fmla="*/ 591146 w 630841"/>
                    <a:gd name="connsiteY19-5586" fmla="*/ 213209 h 296273"/>
                    <a:gd name="connsiteX20-5587" fmla="*/ 565745 w 630841"/>
                    <a:gd name="connsiteY20-5588" fmla="*/ 208447 h 296273"/>
                    <a:gd name="connsiteX21-5589" fmla="*/ 502246 w 630841"/>
                    <a:gd name="connsiteY21-5590" fmla="*/ 243372 h 296273"/>
                    <a:gd name="connsiteX22-5591" fmla="*/ 421283 w 630841"/>
                    <a:gd name="connsiteY22-5592" fmla="*/ 248134 h 296273"/>
                    <a:gd name="connsiteX23-5593" fmla="*/ 357783 w 630841"/>
                    <a:gd name="connsiteY23-5594" fmla="*/ 279885 h 296273"/>
                    <a:gd name="connsiteX24-5595" fmla="*/ 326033 w 630841"/>
                    <a:gd name="connsiteY24-5596" fmla="*/ 281471 h 296273"/>
                    <a:gd name="connsiteX25-5597" fmla="*/ 380008 w 630841"/>
                    <a:gd name="connsiteY25-5598" fmla="*/ 233847 h 296273"/>
                    <a:gd name="connsiteX26-5599" fmla="*/ 305396 w 630841"/>
                    <a:gd name="connsiteY26-5600" fmla="*/ 244959 h 296273"/>
                    <a:gd name="connsiteX27-5601" fmla="*/ 227609 w 630841"/>
                    <a:gd name="connsiteY27-5602" fmla="*/ 235435 h 296273"/>
                    <a:gd name="connsiteX28-5603" fmla="*/ 141883 w 630841"/>
                    <a:gd name="connsiteY28-5604" fmla="*/ 271946 h 296273"/>
                    <a:gd name="connsiteX29-5605" fmla="*/ 178396 w 630841"/>
                    <a:gd name="connsiteY29-5606" fmla="*/ 222734 h 296273"/>
                    <a:gd name="connsiteX30-5607" fmla="*/ 5358 w 630841"/>
                    <a:gd name="connsiteY30-5608" fmla="*/ 232259 h 296273"/>
                    <a:gd name="connsiteX0-5609" fmla="*/ 5358 w 630841"/>
                    <a:gd name="connsiteY0-5610" fmla="*/ 232307 h 296321"/>
                    <a:gd name="connsiteX1-5611" fmla="*/ 48221 w 630841"/>
                    <a:gd name="connsiteY1-5612" fmla="*/ 129120 h 296321"/>
                    <a:gd name="connsiteX2-5613" fmla="*/ 91080 w 630841"/>
                    <a:gd name="connsiteY2-5614" fmla="*/ 84673 h 296321"/>
                    <a:gd name="connsiteX3-5615" fmla="*/ 76799 w 630841"/>
                    <a:gd name="connsiteY3-5616" fmla="*/ 62451 h 296321"/>
                    <a:gd name="connsiteX4-5617" fmla="*/ 94253 w 630841"/>
                    <a:gd name="connsiteY4-5618" fmla="*/ 13231 h 296321"/>
                    <a:gd name="connsiteX5-5619" fmla="*/ 148225 w 630841"/>
                    <a:gd name="connsiteY5-5620" fmla="*/ 509 h 296321"/>
                    <a:gd name="connsiteX6-5621" fmla="*/ 178412 w 630841"/>
                    <a:gd name="connsiteY6-5622" fmla="*/ 25918 h 296321"/>
                    <a:gd name="connsiteX7-5623" fmla="*/ 173694 w 630841"/>
                    <a:gd name="connsiteY7-5624" fmla="*/ 49760 h 296321"/>
                    <a:gd name="connsiteX8-5625" fmla="*/ 218084 w 630841"/>
                    <a:gd name="connsiteY8-5626" fmla="*/ 44982 h 296321"/>
                    <a:gd name="connsiteX9-5627" fmla="*/ 340321 w 630841"/>
                    <a:gd name="connsiteY9-5628" fmla="*/ 13232 h 296321"/>
                    <a:gd name="connsiteX10-5629" fmla="*/ 494308 w 630841"/>
                    <a:gd name="connsiteY10-5630" fmla="*/ 73558 h 296321"/>
                    <a:gd name="connsiteX11-5631" fmla="*/ 567333 w 630841"/>
                    <a:gd name="connsiteY11-5632" fmla="*/ 151344 h 296321"/>
                    <a:gd name="connsiteX12-5633" fmla="*/ 624484 w 630841"/>
                    <a:gd name="connsiteY12-5634" fmla="*/ 224369 h 296321"/>
                    <a:gd name="connsiteX13-5635" fmla="*/ 627658 w 630841"/>
                    <a:gd name="connsiteY13-5636" fmla="*/ 262469 h 296321"/>
                    <a:gd name="connsiteX14-5637" fmla="*/ 608609 w 630841"/>
                    <a:gd name="connsiteY14-5638" fmla="*/ 283107 h 296321"/>
                    <a:gd name="connsiteX15-5639" fmla="*/ 568921 w 630841"/>
                    <a:gd name="connsiteY15-5640" fmla="*/ 295807 h 296321"/>
                    <a:gd name="connsiteX16-5641" fmla="*/ 418109 w 630841"/>
                    <a:gd name="connsiteY16-5642" fmla="*/ 292632 h 296321"/>
                    <a:gd name="connsiteX17-5643" fmla="*/ 559396 w 630841"/>
                    <a:gd name="connsiteY17-5644" fmla="*/ 281520 h 296321"/>
                    <a:gd name="connsiteX18-5645" fmla="*/ 603849 w 630841"/>
                    <a:gd name="connsiteY18-5646" fmla="*/ 252946 h 296321"/>
                    <a:gd name="connsiteX19-5647" fmla="*/ 591146 w 630841"/>
                    <a:gd name="connsiteY19-5648" fmla="*/ 213257 h 296321"/>
                    <a:gd name="connsiteX20-5649" fmla="*/ 565745 w 630841"/>
                    <a:gd name="connsiteY20-5650" fmla="*/ 208495 h 296321"/>
                    <a:gd name="connsiteX21-5651" fmla="*/ 502246 w 630841"/>
                    <a:gd name="connsiteY21-5652" fmla="*/ 243420 h 296321"/>
                    <a:gd name="connsiteX22-5653" fmla="*/ 421283 w 630841"/>
                    <a:gd name="connsiteY22-5654" fmla="*/ 248182 h 296321"/>
                    <a:gd name="connsiteX23-5655" fmla="*/ 357783 w 630841"/>
                    <a:gd name="connsiteY23-5656" fmla="*/ 279933 h 296321"/>
                    <a:gd name="connsiteX24-5657" fmla="*/ 326033 w 630841"/>
                    <a:gd name="connsiteY24-5658" fmla="*/ 281519 h 296321"/>
                    <a:gd name="connsiteX25-5659" fmla="*/ 380008 w 630841"/>
                    <a:gd name="connsiteY25-5660" fmla="*/ 233895 h 296321"/>
                    <a:gd name="connsiteX26-5661" fmla="*/ 305396 w 630841"/>
                    <a:gd name="connsiteY26-5662" fmla="*/ 245007 h 296321"/>
                    <a:gd name="connsiteX27-5663" fmla="*/ 227609 w 630841"/>
                    <a:gd name="connsiteY27-5664" fmla="*/ 235483 h 296321"/>
                    <a:gd name="connsiteX28-5665" fmla="*/ 141883 w 630841"/>
                    <a:gd name="connsiteY28-5666" fmla="*/ 271994 h 296321"/>
                    <a:gd name="connsiteX29-5667" fmla="*/ 178396 w 630841"/>
                    <a:gd name="connsiteY29-5668" fmla="*/ 222782 h 296321"/>
                    <a:gd name="connsiteX30-5669" fmla="*/ 5358 w 630841"/>
                    <a:gd name="connsiteY30-5670" fmla="*/ 232307 h 296321"/>
                    <a:gd name="connsiteX0-5671" fmla="*/ 5358 w 630841"/>
                    <a:gd name="connsiteY0-5672" fmla="*/ 223923 h 287937"/>
                    <a:gd name="connsiteX1-5673" fmla="*/ 48221 w 630841"/>
                    <a:gd name="connsiteY1-5674" fmla="*/ 120736 h 287937"/>
                    <a:gd name="connsiteX2-5675" fmla="*/ 91080 w 630841"/>
                    <a:gd name="connsiteY2-5676" fmla="*/ 76289 h 287937"/>
                    <a:gd name="connsiteX3-5677" fmla="*/ 76799 w 630841"/>
                    <a:gd name="connsiteY3-5678" fmla="*/ 54067 h 287937"/>
                    <a:gd name="connsiteX4-5679" fmla="*/ 94253 w 630841"/>
                    <a:gd name="connsiteY4-5680" fmla="*/ 4847 h 287937"/>
                    <a:gd name="connsiteX5-5681" fmla="*/ 151405 w 630841"/>
                    <a:gd name="connsiteY5-5682" fmla="*/ 3257 h 287937"/>
                    <a:gd name="connsiteX6-5683" fmla="*/ 178412 w 630841"/>
                    <a:gd name="connsiteY6-5684" fmla="*/ 17534 h 287937"/>
                    <a:gd name="connsiteX7-5685" fmla="*/ 173694 w 630841"/>
                    <a:gd name="connsiteY7-5686" fmla="*/ 41376 h 287937"/>
                    <a:gd name="connsiteX8-5687" fmla="*/ 218084 w 630841"/>
                    <a:gd name="connsiteY8-5688" fmla="*/ 36598 h 287937"/>
                    <a:gd name="connsiteX9-5689" fmla="*/ 340321 w 630841"/>
                    <a:gd name="connsiteY9-5690" fmla="*/ 4848 h 287937"/>
                    <a:gd name="connsiteX10-5691" fmla="*/ 494308 w 630841"/>
                    <a:gd name="connsiteY10-5692" fmla="*/ 65174 h 287937"/>
                    <a:gd name="connsiteX11-5693" fmla="*/ 567333 w 630841"/>
                    <a:gd name="connsiteY11-5694" fmla="*/ 142960 h 287937"/>
                    <a:gd name="connsiteX12-5695" fmla="*/ 624484 w 630841"/>
                    <a:gd name="connsiteY12-5696" fmla="*/ 215985 h 287937"/>
                    <a:gd name="connsiteX13-5697" fmla="*/ 627658 w 630841"/>
                    <a:gd name="connsiteY13-5698" fmla="*/ 254085 h 287937"/>
                    <a:gd name="connsiteX14-5699" fmla="*/ 608609 w 630841"/>
                    <a:gd name="connsiteY14-5700" fmla="*/ 274723 h 287937"/>
                    <a:gd name="connsiteX15-5701" fmla="*/ 568921 w 630841"/>
                    <a:gd name="connsiteY15-5702" fmla="*/ 287423 h 287937"/>
                    <a:gd name="connsiteX16-5703" fmla="*/ 418109 w 630841"/>
                    <a:gd name="connsiteY16-5704" fmla="*/ 284248 h 287937"/>
                    <a:gd name="connsiteX17-5705" fmla="*/ 559396 w 630841"/>
                    <a:gd name="connsiteY17-5706" fmla="*/ 273136 h 287937"/>
                    <a:gd name="connsiteX18-5707" fmla="*/ 603849 w 630841"/>
                    <a:gd name="connsiteY18-5708" fmla="*/ 244562 h 287937"/>
                    <a:gd name="connsiteX19-5709" fmla="*/ 591146 w 630841"/>
                    <a:gd name="connsiteY19-5710" fmla="*/ 204873 h 287937"/>
                    <a:gd name="connsiteX20-5711" fmla="*/ 565745 w 630841"/>
                    <a:gd name="connsiteY20-5712" fmla="*/ 200111 h 287937"/>
                    <a:gd name="connsiteX21-5713" fmla="*/ 502246 w 630841"/>
                    <a:gd name="connsiteY21-5714" fmla="*/ 235036 h 287937"/>
                    <a:gd name="connsiteX22-5715" fmla="*/ 421283 w 630841"/>
                    <a:gd name="connsiteY22-5716" fmla="*/ 239798 h 287937"/>
                    <a:gd name="connsiteX23-5717" fmla="*/ 357783 w 630841"/>
                    <a:gd name="connsiteY23-5718" fmla="*/ 271549 h 287937"/>
                    <a:gd name="connsiteX24-5719" fmla="*/ 326033 w 630841"/>
                    <a:gd name="connsiteY24-5720" fmla="*/ 273135 h 287937"/>
                    <a:gd name="connsiteX25-5721" fmla="*/ 380008 w 630841"/>
                    <a:gd name="connsiteY25-5722" fmla="*/ 225511 h 287937"/>
                    <a:gd name="connsiteX26-5723" fmla="*/ 305396 w 630841"/>
                    <a:gd name="connsiteY26-5724" fmla="*/ 236623 h 287937"/>
                    <a:gd name="connsiteX27-5725" fmla="*/ 227609 w 630841"/>
                    <a:gd name="connsiteY27-5726" fmla="*/ 227099 h 287937"/>
                    <a:gd name="connsiteX28-5727" fmla="*/ 141883 w 630841"/>
                    <a:gd name="connsiteY28-5728" fmla="*/ 263610 h 287937"/>
                    <a:gd name="connsiteX29-5729" fmla="*/ 178396 w 630841"/>
                    <a:gd name="connsiteY29-5730" fmla="*/ 214398 h 287937"/>
                    <a:gd name="connsiteX30-5731" fmla="*/ 5358 w 630841"/>
                    <a:gd name="connsiteY30-5732" fmla="*/ 223923 h 287937"/>
                    <a:gd name="connsiteX0-5733" fmla="*/ 5358 w 630841"/>
                    <a:gd name="connsiteY0-5734" fmla="*/ 220721 h 284735"/>
                    <a:gd name="connsiteX1-5735" fmla="*/ 48221 w 630841"/>
                    <a:gd name="connsiteY1-5736" fmla="*/ 117534 h 284735"/>
                    <a:gd name="connsiteX2-5737" fmla="*/ 91080 w 630841"/>
                    <a:gd name="connsiteY2-5738" fmla="*/ 73087 h 284735"/>
                    <a:gd name="connsiteX3-5739" fmla="*/ 76799 w 630841"/>
                    <a:gd name="connsiteY3-5740" fmla="*/ 50865 h 284735"/>
                    <a:gd name="connsiteX4-5741" fmla="*/ 102204 w 630841"/>
                    <a:gd name="connsiteY4-5742" fmla="*/ 11186 h 284735"/>
                    <a:gd name="connsiteX5-5743" fmla="*/ 151405 w 630841"/>
                    <a:gd name="connsiteY5-5744" fmla="*/ 55 h 284735"/>
                    <a:gd name="connsiteX6-5745" fmla="*/ 178412 w 630841"/>
                    <a:gd name="connsiteY6-5746" fmla="*/ 14332 h 284735"/>
                    <a:gd name="connsiteX7-5747" fmla="*/ 173694 w 630841"/>
                    <a:gd name="connsiteY7-5748" fmla="*/ 38174 h 284735"/>
                    <a:gd name="connsiteX8-5749" fmla="*/ 218084 w 630841"/>
                    <a:gd name="connsiteY8-5750" fmla="*/ 33396 h 284735"/>
                    <a:gd name="connsiteX9-5751" fmla="*/ 340321 w 630841"/>
                    <a:gd name="connsiteY9-5752" fmla="*/ 1646 h 284735"/>
                    <a:gd name="connsiteX10-5753" fmla="*/ 494308 w 630841"/>
                    <a:gd name="connsiteY10-5754" fmla="*/ 61972 h 284735"/>
                    <a:gd name="connsiteX11-5755" fmla="*/ 567333 w 630841"/>
                    <a:gd name="connsiteY11-5756" fmla="*/ 139758 h 284735"/>
                    <a:gd name="connsiteX12-5757" fmla="*/ 624484 w 630841"/>
                    <a:gd name="connsiteY12-5758" fmla="*/ 212783 h 284735"/>
                    <a:gd name="connsiteX13-5759" fmla="*/ 627658 w 630841"/>
                    <a:gd name="connsiteY13-5760" fmla="*/ 250883 h 284735"/>
                    <a:gd name="connsiteX14-5761" fmla="*/ 608609 w 630841"/>
                    <a:gd name="connsiteY14-5762" fmla="*/ 271521 h 284735"/>
                    <a:gd name="connsiteX15-5763" fmla="*/ 568921 w 630841"/>
                    <a:gd name="connsiteY15-5764" fmla="*/ 284221 h 284735"/>
                    <a:gd name="connsiteX16-5765" fmla="*/ 418109 w 630841"/>
                    <a:gd name="connsiteY16-5766" fmla="*/ 281046 h 284735"/>
                    <a:gd name="connsiteX17-5767" fmla="*/ 559396 w 630841"/>
                    <a:gd name="connsiteY17-5768" fmla="*/ 269934 h 284735"/>
                    <a:gd name="connsiteX18-5769" fmla="*/ 603849 w 630841"/>
                    <a:gd name="connsiteY18-5770" fmla="*/ 241360 h 284735"/>
                    <a:gd name="connsiteX19-5771" fmla="*/ 591146 w 630841"/>
                    <a:gd name="connsiteY19-5772" fmla="*/ 201671 h 284735"/>
                    <a:gd name="connsiteX20-5773" fmla="*/ 565745 w 630841"/>
                    <a:gd name="connsiteY20-5774" fmla="*/ 196909 h 284735"/>
                    <a:gd name="connsiteX21-5775" fmla="*/ 502246 w 630841"/>
                    <a:gd name="connsiteY21-5776" fmla="*/ 231834 h 284735"/>
                    <a:gd name="connsiteX22-5777" fmla="*/ 421283 w 630841"/>
                    <a:gd name="connsiteY22-5778" fmla="*/ 236596 h 284735"/>
                    <a:gd name="connsiteX23-5779" fmla="*/ 357783 w 630841"/>
                    <a:gd name="connsiteY23-5780" fmla="*/ 268347 h 284735"/>
                    <a:gd name="connsiteX24-5781" fmla="*/ 326033 w 630841"/>
                    <a:gd name="connsiteY24-5782" fmla="*/ 269933 h 284735"/>
                    <a:gd name="connsiteX25-5783" fmla="*/ 380008 w 630841"/>
                    <a:gd name="connsiteY25-5784" fmla="*/ 222309 h 284735"/>
                    <a:gd name="connsiteX26-5785" fmla="*/ 305396 w 630841"/>
                    <a:gd name="connsiteY26-5786" fmla="*/ 233421 h 284735"/>
                    <a:gd name="connsiteX27-5787" fmla="*/ 227609 w 630841"/>
                    <a:gd name="connsiteY27-5788" fmla="*/ 223897 h 284735"/>
                    <a:gd name="connsiteX28-5789" fmla="*/ 141883 w 630841"/>
                    <a:gd name="connsiteY28-5790" fmla="*/ 260408 h 284735"/>
                    <a:gd name="connsiteX29-5791" fmla="*/ 178396 w 630841"/>
                    <a:gd name="connsiteY29-5792" fmla="*/ 211196 h 284735"/>
                    <a:gd name="connsiteX30-5793" fmla="*/ 5358 w 630841"/>
                    <a:gd name="connsiteY30-5794" fmla="*/ 220721 h 284735"/>
                  </a:gdLst>
                  <a:ahLst/>
                  <a:cxnLst>
                    <a:cxn ang="0">
                      <a:pos x="connsiteX0-1" y="connsiteY0-2"/>
                    </a:cxn>
                    <a:cxn ang="0">
                      <a:pos x="connsiteX1-3" y="connsiteY1-4"/>
                    </a:cxn>
                    <a:cxn ang="0">
                      <a:pos x="connsiteX2-5" y="connsiteY2-6"/>
                    </a:cxn>
                    <a:cxn ang="0">
                      <a:pos x="connsiteX3-7" y="connsiteY3-8"/>
                    </a:cxn>
                    <a:cxn ang="0">
                      <a:pos x="connsiteX4-9" y="connsiteY4-10"/>
                    </a:cxn>
                    <a:cxn ang="0">
                      <a:pos x="connsiteX5-11" y="connsiteY5-12"/>
                    </a:cxn>
                    <a:cxn ang="0">
                      <a:pos x="connsiteX6-13" y="connsiteY6-14"/>
                    </a:cxn>
                    <a:cxn ang="0">
                      <a:pos x="connsiteX7-15" y="connsiteY7-16"/>
                    </a:cxn>
                    <a:cxn ang="0">
                      <a:pos x="connsiteX8-17" y="connsiteY8-18"/>
                    </a:cxn>
                    <a:cxn ang="0">
                      <a:pos x="connsiteX9-19" y="connsiteY9-20"/>
                    </a:cxn>
                    <a:cxn ang="0">
                      <a:pos x="connsiteX10-21" y="connsiteY10-22"/>
                    </a:cxn>
                    <a:cxn ang="0">
                      <a:pos x="connsiteX11-23" y="connsiteY11-24"/>
                    </a:cxn>
                    <a:cxn ang="0">
                      <a:pos x="connsiteX12-25" y="connsiteY12-26"/>
                    </a:cxn>
                    <a:cxn ang="0">
                      <a:pos x="connsiteX13-27" y="connsiteY13-28"/>
                    </a:cxn>
                    <a:cxn ang="0">
                      <a:pos x="connsiteX14-29" y="connsiteY14-30"/>
                    </a:cxn>
                    <a:cxn ang="0">
                      <a:pos x="connsiteX15-31" y="connsiteY15-32"/>
                    </a:cxn>
                    <a:cxn ang="0">
                      <a:pos x="connsiteX16-33" y="connsiteY16-34"/>
                    </a:cxn>
                    <a:cxn ang="0">
                      <a:pos x="connsiteX17-35" y="connsiteY17-36"/>
                    </a:cxn>
                    <a:cxn ang="0">
                      <a:pos x="connsiteX18-37" y="connsiteY18-38"/>
                    </a:cxn>
                    <a:cxn ang="0">
                      <a:pos x="connsiteX19-39" y="connsiteY19-40"/>
                    </a:cxn>
                    <a:cxn ang="0">
                      <a:pos x="connsiteX20-41" y="connsiteY20-42"/>
                    </a:cxn>
                    <a:cxn ang="0">
                      <a:pos x="connsiteX21-43" y="connsiteY21-44"/>
                    </a:cxn>
                    <a:cxn ang="0">
                      <a:pos x="connsiteX22-45" y="connsiteY22-46"/>
                    </a:cxn>
                    <a:cxn ang="0">
                      <a:pos x="connsiteX23-47" y="connsiteY23-48"/>
                    </a:cxn>
                    <a:cxn ang="0">
                      <a:pos x="connsiteX24-49" y="connsiteY24-50"/>
                    </a:cxn>
                    <a:cxn ang="0">
                      <a:pos x="connsiteX25-51" y="connsiteY25-52"/>
                    </a:cxn>
                    <a:cxn ang="0">
                      <a:pos x="connsiteX26-53" y="connsiteY26-54"/>
                    </a:cxn>
                    <a:cxn ang="0">
                      <a:pos x="connsiteX27-55" y="connsiteY27-56"/>
                    </a:cxn>
                    <a:cxn ang="0">
                      <a:pos x="connsiteX28-57" y="connsiteY28-58"/>
                    </a:cxn>
                    <a:cxn ang="0">
                      <a:pos x="connsiteX29-59" y="connsiteY29-60"/>
                    </a:cxn>
                    <a:cxn ang="0">
                      <a:pos x="connsiteX30-61" y="connsiteY30-62"/>
                    </a:cxn>
                  </a:cxnLst>
                  <a:rect l="l" t="t" r="r" b="b"/>
                  <a:pathLst>
                    <a:path w="630841" h="284735">
                      <a:moveTo>
                        <a:pt x="5358" y="220721"/>
                      </a:moveTo>
                      <a:cubicBezTo>
                        <a:pt x="-16338" y="205111"/>
                        <a:pt x="33934" y="142140"/>
                        <a:pt x="48221" y="117534"/>
                      </a:cubicBezTo>
                      <a:cubicBezTo>
                        <a:pt x="62508" y="92928"/>
                        <a:pt x="86317" y="84199"/>
                        <a:pt x="91080" y="73087"/>
                      </a:cubicBezTo>
                      <a:cubicBezTo>
                        <a:pt x="95843" y="61976"/>
                        <a:pt x="74945" y="61182"/>
                        <a:pt x="76799" y="50865"/>
                      </a:cubicBezTo>
                      <a:cubicBezTo>
                        <a:pt x="78653" y="40548"/>
                        <a:pt x="89770" y="19654"/>
                        <a:pt x="102204" y="11186"/>
                      </a:cubicBezTo>
                      <a:cubicBezTo>
                        <a:pt x="114638" y="2718"/>
                        <a:pt x="138704" y="-469"/>
                        <a:pt x="151405" y="55"/>
                      </a:cubicBezTo>
                      <a:cubicBezTo>
                        <a:pt x="164106" y="579"/>
                        <a:pt x="174697" y="7979"/>
                        <a:pt x="178412" y="14332"/>
                      </a:cubicBezTo>
                      <a:cubicBezTo>
                        <a:pt x="182127" y="20685"/>
                        <a:pt x="167082" y="34997"/>
                        <a:pt x="173694" y="38174"/>
                      </a:cubicBezTo>
                      <a:cubicBezTo>
                        <a:pt x="180306" y="41351"/>
                        <a:pt x="190313" y="39484"/>
                        <a:pt x="218084" y="33396"/>
                      </a:cubicBezTo>
                      <a:cubicBezTo>
                        <a:pt x="245855" y="27308"/>
                        <a:pt x="294284" y="-3117"/>
                        <a:pt x="340321" y="1646"/>
                      </a:cubicBezTo>
                      <a:cubicBezTo>
                        <a:pt x="386358" y="6409"/>
                        <a:pt x="456473" y="38953"/>
                        <a:pt x="494308" y="61972"/>
                      </a:cubicBezTo>
                      <a:cubicBezTo>
                        <a:pt x="532143" y="84991"/>
                        <a:pt x="545637" y="114623"/>
                        <a:pt x="567333" y="139758"/>
                      </a:cubicBezTo>
                      <a:cubicBezTo>
                        <a:pt x="589029" y="164893"/>
                        <a:pt x="614430" y="194262"/>
                        <a:pt x="624484" y="212783"/>
                      </a:cubicBezTo>
                      <a:cubicBezTo>
                        <a:pt x="634538" y="231304"/>
                        <a:pt x="630304" y="241093"/>
                        <a:pt x="627658" y="250883"/>
                      </a:cubicBezTo>
                      <a:cubicBezTo>
                        <a:pt x="625012" y="260673"/>
                        <a:pt x="618398" y="265965"/>
                        <a:pt x="608609" y="271521"/>
                      </a:cubicBezTo>
                      <a:cubicBezTo>
                        <a:pt x="598820" y="277077"/>
                        <a:pt x="600671" y="282633"/>
                        <a:pt x="568921" y="284221"/>
                      </a:cubicBezTo>
                      <a:cubicBezTo>
                        <a:pt x="537171" y="285809"/>
                        <a:pt x="419697" y="283427"/>
                        <a:pt x="418109" y="281046"/>
                      </a:cubicBezTo>
                      <a:cubicBezTo>
                        <a:pt x="416522" y="278665"/>
                        <a:pt x="528439" y="276548"/>
                        <a:pt x="559396" y="269934"/>
                      </a:cubicBezTo>
                      <a:cubicBezTo>
                        <a:pt x="590353" y="263320"/>
                        <a:pt x="598557" y="252737"/>
                        <a:pt x="603849" y="241360"/>
                      </a:cubicBezTo>
                      <a:cubicBezTo>
                        <a:pt x="609141" y="229983"/>
                        <a:pt x="597497" y="209080"/>
                        <a:pt x="591146" y="201671"/>
                      </a:cubicBezTo>
                      <a:cubicBezTo>
                        <a:pt x="584795" y="194263"/>
                        <a:pt x="580561" y="191882"/>
                        <a:pt x="565745" y="196909"/>
                      </a:cubicBezTo>
                      <a:cubicBezTo>
                        <a:pt x="550929" y="201936"/>
                        <a:pt x="526323" y="225220"/>
                        <a:pt x="502246" y="231834"/>
                      </a:cubicBezTo>
                      <a:cubicBezTo>
                        <a:pt x="478169" y="238448"/>
                        <a:pt x="445360" y="230511"/>
                        <a:pt x="421283" y="236596"/>
                      </a:cubicBezTo>
                      <a:cubicBezTo>
                        <a:pt x="397206" y="242681"/>
                        <a:pt x="373658" y="262791"/>
                        <a:pt x="357783" y="268347"/>
                      </a:cubicBezTo>
                      <a:cubicBezTo>
                        <a:pt x="341908" y="273903"/>
                        <a:pt x="322329" y="277606"/>
                        <a:pt x="326033" y="269933"/>
                      </a:cubicBezTo>
                      <a:cubicBezTo>
                        <a:pt x="329737" y="262260"/>
                        <a:pt x="383447" y="228394"/>
                        <a:pt x="380008" y="222309"/>
                      </a:cubicBezTo>
                      <a:cubicBezTo>
                        <a:pt x="376569" y="216224"/>
                        <a:pt x="330796" y="233156"/>
                        <a:pt x="305396" y="233421"/>
                      </a:cubicBezTo>
                      <a:cubicBezTo>
                        <a:pt x="279996" y="233686"/>
                        <a:pt x="254861" y="219399"/>
                        <a:pt x="227609" y="223897"/>
                      </a:cubicBezTo>
                      <a:cubicBezTo>
                        <a:pt x="200357" y="228395"/>
                        <a:pt x="148233" y="263318"/>
                        <a:pt x="141883" y="260408"/>
                      </a:cubicBezTo>
                      <a:cubicBezTo>
                        <a:pt x="135533" y="257498"/>
                        <a:pt x="201150" y="217811"/>
                        <a:pt x="178396" y="211196"/>
                      </a:cubicBezTo>
                      <a:cubicBezTo>
                        <a:pt x="155642" y="204582"/>
                        <a:pt x="27054" y="236331"/>
                        <a:pt x="5358" y="220721"/>
                      </a:cubicBezTo>
                      <a:close/>
                    </a:path>
                  </a:pathLst>
                </a:custGeom>
                <a:solidFill>
                  <a:schemeClr val="bg1"/>
                </a:solidFill>
                <a:ln w="6350">
                  <a:solidFill>
                    <a:schemeClr val="bg2">
                      <a:lumMod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" name="任意多边形: 形状 57"/>
                <p:cNvSpPr/>
                <p:nvPr/>
              </p:nvSpPr>
              <p:spPr>
                <a:xfrm rot="21253049">
                  <a:off x="850304" y="2052603"/>
                  <a:ext cx="143532" cy="109757"/>
                </a:xfrm>
                <a:custGeom>
                  <a:avLst/>
                  <a:gdLst>
                    <a:gd name="connsiteX0" fmla="*/ 9345 w 107773"/>
                    <a:gd name="connsiteY0" fmla="*/ 82999 h 84586"/>
                    <a:gd name="connsiteX1" fmla="*/ 1408 w 107773"/>
                    <a:gd name="connsiteY1" fmla="*/ 32199 h 84586"/>
                    <a:gd name="connsiteX2" fmla="*/ 34745 w 107773"/>
                    <a:gd name="connsiteY2" fmla="*/ 449 h 84586"/>
                    <a:gd name="connsiteX3" fmla="*/ 91895 w 107773"/>
                    <a:gd name="connsiteY3" fmla="*/ 16324 h 84586"/>
                    <a:gd name="connsiteX4" fmla="*/ 107770 w 107773"/>
                    <a:gd name="connsiteY4" fmla="*/ 54424 h 84586"/>
                    <a:gd name="connsiteX5" fmla="*/ 93483 w 107773"/>
                    <a:gd name="connsiteY5" fmla="*/ 84586 h 84586"/>
                    <a:gd name="connsiteX6" fmla="*/ 93483 w 107773"/>
                    <a:gd name="connsiteY6" fmla="*/ 84586 h 84586"/>
                    <a:gd name="connsiteX0-1" fmla="*/ 11466 w 109894"/>
                    <a:gd name="connsiteY0-2" fmla="*/ 101791 h 103378"/>
                    <a:gd name="connsiteX1-3" fmla="*/ 3529 w 109894"/>
                    <a:gd name="connsiteY1-4" fmla="*/ 50991 h 103378"/>
                    <a:gd name="connsiteX2-5" fmla="*/ 66782 w 109894"/>
                    <a:gd name="connsiteY2-6" fmla="*/ 191 h 103378"/>
                    <a:gd name="connsiteX3-7" fmla="*/ 94016 w 109894"/>
                    <a:gd name="connsiteY3-8" fmla="*/ 35116 h 103378"/>
                    <a:gd name="connsiteX4-9" fmla="*/ 109891 w 109894"/>
                    <a:gd name="connsiteY4-10" fmla="*/ 73216 h 103378"/>
                    <a:gd name="connsiteX5-11" fmla="*/ 95604 w 109894"/>
                    <a:gd name="connsiteY5-12" fmla="*/ 103378 h 103378"/>
                    <a:gd name="connsiteX6-13" fmla="*/ 95604 w 109894"/>
                    <a:gd name="connsiteY6-14" fmla="*/ 103378 h 103378"/>
                    <a:gd name="connsiteX0-15" fmla="*/ 11592 w 110020"/>
                    <a:gd name="connsiteY0-16" fmla="*/ 86093 h 87680"/>
                    <a:gd name="connsiteX1-17" fmla="*/ 3655 w 110020"/>
                    <a:gd name="connsiteY1-18" fmla="*/ 35293 h 87680"/>
                    <a:gd name="connsiteX2-19" fmla="*/ 68668 w 110020"/>
                    <a:gd name="connsiteY2-20" fmla="*/ 368 h 87680"/>
                    <a:gd name="connsiteX3-21" fmla="*/ 94142 w 110020"/>
                    <a:gd name="connsiteY3-22" fmla="*/ 19418 h 87680"/>
                    <a:gd name="connsiteX4-23" fmla="*/ 110017 w 110020"/>
                    <a:gd name="connsiteY4-24" fmla="*/ 57518 h 87680"/>
                    <a:gd name="connsiteX5-25" fmla="*/ 95730 w 110020"/>
                    <a:gd name="connsiteY5-26" fmla="*/ 87680 h 87680"/>
                    <a:gd name="connsiteX6-27" fmla="*/ 95730 w 110020"/>
                    <a:gd name="connsiteY6-28" fmla="*/ 87680 h 87680"/>
                    <a:gd name="connsiteX0-29" fmla="*/ 11592 w 104743"/>
                    <a:gd name="connsiteY0-30" fmla="*/ 86093 h 87680"/>
                    <a:gd name="connsiteX1-31" fmla="*/ 3655 w 104743"/>
                    <a:gd name="connsiteY1-32" fmla="*/ 35293 h 87680"/>
                    <a:gd name="connsiteX2-33" fmla="*/ 68668 w 104743"/>
                    <a:gd name="connsiteY2-34" fmla="*/ 368 h 87680"/>
                    <a:gd name="connsiteX3-35" fmla="*/ 94142 w 104743"/>
                    <a:gd name="connsiteY3-36" fmla="*/ 19418 h 87680"/>
                    <a:gd name="connsiteX4-37" fmla="*/ 104738 w 104743"/>
                    <a:gd name="connsiteY4-38" fmla="*/ 57518 h 87680"/>
                    <a:gd name="connsiteX5-39" fmla="*/ 95730 w 104743"/>
                    <a:gd name="connsiteY5-40" fmla="*/ 87680 h 87680"/>
                    <a:gd name="connsiteX6-41" fmla="*/ 95730 w 104743"/>
                    <a:gd name="connsiteY6-42" fmla="*/ 87680 h 87680"/>
                    <a:gd name="connsiteX0-43" fmla="*/ 11592 w 104743"/>
                    <a:gd name="connsiteY0-44" fmla="*/ 86093 h 87680"/>
                    <a:gd name="connsiteX1-45" fmla="*/ 3655 w 104743"/>
                    <a:gd name="connsiteY1-46" fmla="*/ 35293 h 87680"/>
                    <a:gd name="connsiteX2-47" fmla="*/ 68668 w 104743"/>
                    <a:gd name="connsiteY2-48" fmla="*/ 368 h 87680"/>
                    <a:gd name="connsiteX3-49" fmla="*/ 94142 w 104743"/>
                    <a:gd name="connsiteY3-50" fmla="*/ 19418 h 87680"/>
                    <a:gd name="connsiteX4-51" fmla="*/ 104738 w 104743"/>
                    <a:gd name="connsiteY4-52" fmla="*/ 57518 h 87680"/>
                    <a:gd name="connsiteX5-53" fmla="*/ 95730 w 104743"/>
                    <a:gd name="connsiteY5-54" fmla="*/ 87680 h 87680"/>
                    <a:gd name="connsiteX6-55" fmla="*/ 79893 w 104743"/>
                    <a:gd name="connsiteY6-56" fmla="*/ 82917 h 87680"/>
                    <a:gd name="connsiteX0-57" fmla="*/ 11592 w 104743"/>
                    <a:gd name="connsiteY0-58" fmla="*/ 86222 h 87809"/>
                    <a:gd name="connsiteX1-59" fmla="*/ 3655 w 104743"/>
                    <a:gd name="connsiteY1-60" fmla="*/ 38597 h 87809"/>
                    <a:gd name="connsiteX2-61" fmla="*/ 68668 w 104743"/>
                    <a:gd name="connsiteY2-62" fmla="*/ 497 h 87809"/>
                    <a:gd name="connsiteX3-63" fmla="*/ 94142 w 104743"/>
                    <a:gd name="connsiteY3-64" fmla="*/ 19547 h 87809"/>
                    <a:gd name="connsiteX4-65" fmla="*/ 104738 w 104743"/>
                    <a:gd name="connsiteY4-66" fmla="*/ 57647 h 87809"/>
                    <a:gd name="connsiteX5-67" fmla="*/ 95730 w 104743"/>
                    <a:gd name="connsiteY5-68" fmla="*/ 87809 h 87809"/>
                    <a:gd name="connsiteX6-69" fmla="*/ 79893 w 104743"/>
                    <a:gd name="connsiteY6-70" fmla="*/ 83046 h 87809"/>
                    <a:gd name="connsiteX0-71" fmla="*/ 11592 w 125007"/>
                    <a:gd name="connsiteY0-72" fmla="*/ 86169 h 87756"/>
                    <a:gd name="connsiteX1-73" fmla="*/ 3655 w 125007"/>
                    <a:gd name="connsiteY1-74" fmla="*/ 38544 h 87756"/>
                    <a:gd name="connsiteX2-75" fmla="*/ 68668 w 125007"/>
                    <a:gd name="connsiteY2-76" fmla="*/ 444 h 87756"/>
                    <a:gd name="connsiteX3-77" fmla="*/ 94142 w 125007"/>
                    <a:gd name="connsiteY3-78" fmla="*/ 19494 h 87756"/>
                    <a:gd name="connsiteX4-79" fmla="*/ 125006 w 125007"/>
                    <a:gd name="connsiteY4-80" fmla="*/ 45850 h 87756"/>
                    <a:gd name="connsiteX5-81" fmla="*/ 95730 w 125007"/>
                    <a:gd name="connsiteY5-82" fmla="*/ 87756 h 87756"/>
                    <a:gd name="connsiteX6-83" fmla="*/ 79893 w 125007"/>
                    <a:gd name="connsiteY6-84" fmla="*/ 82993 h 87756"/>
                    <a:gd name="connsiteX0-85" fmla="*/ 11592 w 125007"/>
                    <a:gd name="connsiteY0-86" fmla="*/ 86169 h 90332"/>
                    <a:gd name="connsiteX1-87" fmla="*/ 3655 w 125007"/>
                    <a:gd name="connsiteY1-88" fmla="*/ 38544 h 90332"/>
                    <a:gd name="connsiteX2-89" fmla="*/ 68668 w 125007"/>
                    <a:gd name="connsiteY2-90" fmla="*/ 444 h 90332"/>
                    <a:gd name="connsiteX3-91" fmla="*/ 94142 w 125007"/>
                    <a:gd name="connsiteY3-92" fmla="*/ 19494 h 90332"/>
                    <a:gd name="connsiteX4-93" fmla="*/ 125006 w 125007"/>
                    <a:gd name="connsiteY4-94" fmla="*/ 45850 h 90332"/>
                    <a:gd name="connsiteX5-95" fmla="*/ 95730 w 125007"/>
                    <a:gd name="connsiteY5-96" fmla="*/ 87756 h 90332"/>
                    <a:gd name="connsiteX6-97" fmla="*/ 78051 w 125007"/>
                    <a:gd name="connsiteY6-98" fmla="*/ 90332 h 90332"/>
                    <a:gd name="connsiteX0-99" fmla="*/ 11592 w 125341"/>
                    <a:gd name="connsiteY0-100" fmla="*/ 86716 h 90879"/>
                    <a:gd name="connsiteX1-101" fmla="*/ 3655 w 125341"/>
                    <a:gd name="connsiteY1-102" fmla="*/ 39091 h 90879"/>
                    <a:gd name="connsiteX2-103" fmla="*/ 68668 w 125341"/>
                    <a:gd name="connsiteY2-104" fmla="*/ 991 h 90879"/>
                    <a:gd name="connsiteX3-105" fmla="*/ 108881 w 125341"/>
                    <a:gd name="connsiteY3-106" fmla="*/ 14169 h 90879"/>
                    <a:gd name="connsiteX4-107" fmla="*/ 125006 w 125341"/>
                    <a:gd name="connsiteY4-108" fmla="*/ 46397 h 90879"/>
                    <a:gd name="connsiteX5-109" fmla="*/ 95730 w 125341"/>
                    <a:gd name="connsiteY5-110" fmla="*/ 88303 h 90879"/>
                    <a:gd name="connsiteX6-111" fmla="*/ 78051 w 125341"/>
                    <a:gd name="connsiteY6-112" fmla="*/ 90879 h 90879"/>
                    <a:gd name="connsiteX0-113" fmla="*/ 10404 w 124254"/>
                    <a:gd name="connsiteY0-114" fmla="*/ 88102 h 92265"/>
                    <a:gd name="connsiteX1-115" fmla="*/ 2467 w 124254"/>
                    <a:gd name="connsiteY1-116" fmla="*/ 40477 h 92265"/>
                    <a:gd name="connsiteX2-117" fmla="*/ 50898 w 124254"/>
                    <a:gd name="connsiteY2-118" fmla="*/ 909 h 92265"/>
                    <a:gd name="connsiteX3-119" fmla="*/ 107693 w 124254"/>
                    <a:gd name="connsiteY3-120" fmla="*/ 15555 h 92265"/>
                    <a:gd name="connsiteX4-121" fmla="*/ 123818 w 124254"/>
                    <a:gd name="connsiteY4-122" fmla="*/ 47783 h 92265"/>
                    <a:gd name="connsiteX5-123" fmla="*/ 94542 w 124254"/>
                    <a:gd name="connsiteY5-124" fmla="*/ 89689 h 92265"/>
                    <a:gd name="connsiteX6-125" fmla="*/ 76863 w 124254"/>
                    <a:gd name="connsiteY6-126" fmla="*/ 92265 h 92265"/>
                  </a:gdLst>
                  <a:ahLst/>
                  <a:cxnLst>
                    <a:cxn ang="0">
                      <a:pos x="connsiteX0-1" y="connsiteY0-2"/>
                    </a:cxn>
                    <a:cxn ang="0">
                      <a:pos x="connsiteX1-3" y="connsiteY1-4"/>
                    </a:cxn>
                    <a:cxn ang="0">
                      <a:pos x="connsiteX2-5" y="connsiteY2-6"/>
                    </a:cxn>
                    <a:cxn ang="0">
                      <a:pos x="connsiteX3-7" y="connsiteY3-8"/>
                    </a:cxn>
                    <a:cxn ang="0">
                      <a:pos x="connsiteX4-9" y="connsiteY4-10"/>
                    </a:cxn>
                    <a:cxn ang="0">
                      <a:pos x="connsiteX5-11" y="connsiteY5-12"/>
                    </a:cxn>
                    <a:cxn ang="0">
                      <a:pos x="connsiteX6-13" y="connsiteY6-14"/>
                    </a:cxn>
                  </a:cxnLst>
                  <a:rect l="l" t="t" r="r" b="b"/>
                  <a:pathLst>
                    <a:path w="124254" h="92265">
                      <a:moveTo>
                        <a:pt x="10404" y="88102"/>
                      </a:moveTo>
                      <a:cubicBezTo>
                        <a:pt x="4319" y="69581"/>
                        <a:pt x="-4282" y="55009"/>
                        <a:pt x="2467" y="40477"/>
                      </a:cubicBezTo>
                      <a:cubicBezTo>
                        <a:pt x="9216" y="25945"/>
                        <a:pt x="33360" y="5063"/>
                        <a:pt x="50898" y="909"/>
                      </a:cubicBezTo>
                      <a:cubicBezTo>
                        <a:pt x="68436" y="-3245"/>
                        <a:pt x="95540" y="7743"/>
                        <a:pt x="107693" y="15555"/>
                      </a:cubicBezTo>
                      <a:cubicBezTo>
                        <a:pt x="119846" y="23367"/>
                        <a:pt x="126010" y="35427"/>
                        <a:pt x="123818" y="47783"/>
                      </a:cubicBezTo>
                      <a:cubicBezTo>
                        <a:pt x="121626" y="60139"/>
                        <a:pt x="94542" y="89689"/>
                        <a:pt x="94542" y="89689"/>
                      </a:cubicBezTo>
                      <a:lnTo>
                        <a:pt x="76863" y="92265"/>
                      </a:lnTo>
                    </a:path>
                  </a:pathLst>
                </a:cu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" name="任意多边形: 形状 58"/>
                <p:cNvSpPr/>
                <p:nvPr/>
              </p:nvSpPr>
              <p:spPr>
                <a:xfrm rot="3979339">
                  <a:off x="960069" y="2163525"/>
                  <a:ext cx="107596" cy="112109"/>
                </a:xfrm>
                <a:custGeom>
                  <a:avLst/>
                  <a:gdLst>
                    <a:gd name="connsiteX0" fmla="*/ 9345 w 107773"/>
                    <a:gd name="connsiteY0" fmla="*/ 82999 h 84586"/>
                    <a:gd name="connsiteX1" fmla="*/ 1408 w 107773"/>
                    <a:gd name="connsiteY1" fmla="*/ 32199 h 84586"/>
                    <a:gd name="connsiteX2" fmla="*/ 34745 w 107773"/>
                    <a:gd name="connsiteY2" fmla="*/ 449 h 84586"/>
                    <a:gd name="connsiteX3" fmla="*/ 91895 w 107773"/>
                    <a:gd name="connsiteY3" fmla="*/ 16324 h 84586"/>
                    <a:gd name="connsiteX4" fmla="*/ 107770 w 107773"/>
                    <a:gd name="connsiteY4" fmla="*/ 54424 h 84586"/>
                    <a:gd name="connsiteX5" fmla="*/ 93483 w 107773"/>
                    <a:gd name="connsiteY5" fmla="*/ 84586 h 84586"/>
                    <a:gd name="connsiteX6" fmla="*/ 93483 w 107773"/>
                    <a:gd name="connsiteY6" fmla="*/ 84586 h 84586"/>
                    <a:gd name="connsiteX0-1" fmla="*/ 10092 w 108520"/>
                    <a:gd name="connsiteY0-2" fmla="*/ 101294 h 102881"/>
                    <a:gd name="connsiteX1-3" fmla="*/ 2155 w 108520"/>
                    <a:gd name="connsiteY1-4" fmla="*/ 50494 h 102881"/>
                    <a:gd name="connsiteX2-5" fmla="*/ 46206 w 108520"/>
                    <a:gd name="connsiteY2-6" fmla="*/ 194 h 102881"/>
                    <a:gd name="connsiteX3-7" fmla="*/ 92642 w 108520"/>
                    <a:gd name="connsiteY3-8" fmla="*/ 34619 h 102881"/>
                    <a:gd name="connsiteX4-9" fmla="*/ 108517 w 108520"/>
                    <a:gd name="connsiteY4-10" fmla="*/ 72719 h 102881"/>
                    <a:gd name="connsiteX5-11" fmla="*/ 94230 w 108520"/>
                    <a:gd name="connsiteY5-12" fmla="*/ 102881 h 102881"/>
                    <a:gd name="connsiteX6-13" fmla="*/ 94230 w 108520"/>
                    <a:gd name="connsiteY6-14" fmla="*/ 102881 h 102881"/>
                    <a:gd name="connsiteX0-15" fmla="*/ 10092 w 108629"/>
                    <a:gd name="connsiteY0-16" fmla="*/ 101178 h 102765"/>
                    <a:gd name="connsiteX1-17" fmla="*/ 2155 w 108629"/>
                    <a:gd name="connsiteY1-18" fmla="*/ 50378 h 102765"/>
                    <a:gd name="connsiteX2-19" fmla="*/ 46206 w 108629"/>
                    <a:gd name="connsiteY2-20" fmla="*/ 78 h 102765"/>
                    <a:gd name="connsiteX3-21" fmla="*/ 84724 w 108629"/>
                    <a:gd name="connsiteY3-22" fmla="*/ 39704 h 102765"/>
                    <a:gd name="connsiteX4-23" fmla="*/ 108517 w 108629"/>
                    <a:gd name="connsiteY4-24" fmla="*/ 72603 h 102765"/>
                    <a:gd name="connsiteX5-25" fmla="*/ 94230 w 108629"/>
                    <a:gd name="connsiteY5-26" fmla="*/ 102765 h 102765"/>
                    <a:gd name="connsiteX6-27" fmla="*/ 94230 w 108629"/>
                    <a:gd name="connsiteY6-28" fmla="*/ 102765 h 102765"/>
                    <a:gd name="connsiteX0-29" fmla="*/ 9584 w 108120"/>
                    <a:gd name="connsiteY0-30" fmla="*/ 93821 h 95408"/>
                    <a:gd name="connsiteX1-31" fmla="*/ 1647 w 108120"/>
                    <a:gd name="connsiteY1-32" fmla="*/ 43021 h 95408"/>
                    <a:gd name="connsiteX2-33" fmla="*/ 38425 w 108120"/>
                    <a:gd name="connsiteY2-34" fmla="*/ 97 h 95408"/>
                    <a:gd name="connsiteX3-35" fmla="*/ 84216 w 108120"/>
                    <a:gd name="connsiteY3-36" fmla="*/ 32347 h 95408"/>
                    <a:gd name="connsiteX4-37" fmla="*/ 108009 w 108120"/>
                    <a:gd name="connsiteY4-38" fmla="*/ 65246 h 95408"/>
                    <a:gd name="connsiteX5-39" fmla="*/ 93722 w 108120"/>
                    <a:gd name="connsiteY5-40" fmla="*/ 95408 h 95408"/>
                    <a:gd name="connsiteX6-41" fmla="*/ 93722 w 108120"/>
                    <a:gd name="connsiteY6-42" fmla="*/ 95408 h 95408"/>
                    <a:gd name="connsiteX0-43" fmla="*/ 6536 w 105072"/>
                    <a:gd name="connsiteY0-44" fmla="*/ 93894 h 95481"/>
                    <a:gd name="connsiteX1-45" fmla="*/ 2429 w 105072"/>
                    <a:gd name="connsiteY1-46" fmla="*/ 46892 h 95481"/>
                    <a:gd name="connsiteX2-47" fmla="*/ 35377 w 105072"/>
                    <a:gd name="connsiteY2-48" fmla="*/ 170 h 95481"/>
                    <a:gd name="connsiteX3-49" fmla="*/ 81168 w 105072"/>
                    <a:gd name="connsiteY3-50" fmla="*/ 32420 h 95481"/>
                    <a:gd name="connsiteX4-51" fmla="*/ 104961 w 105072"/>
                    <a:gd name="connsiteY4-52" fmla="*/ 65319 h 95481"/>
                    <a:gd name="connsiteX5-53" fmla="*/ 90674 w 105072"/>
                    <a:gd name="connsiteY5-54" fmla="*/ 95481 h 95481"/>
                    <a:gd name="connsiteX6-55" fmla="*/ 90674 w 105072"/>
                    <a:gd name="connsiteY6-56" fmla="*/ 95481 h 95481"/>
                    <a:gd name="connsiteX0-57" fmla="*/ 13934 w 103261"/>
                    <a:gd name="connsiteY0-58" fmla="*/ 93045 h 95481"/>
                    <a:gd name="connsiteX1-59" fmla="*/ 618 w 103261"/>
                    <a:gd name="connsiteY1-60" fmla="*/ 46892 h 95481"/>
                    <a:gd name="connsiteX2-61" fmla="*/ 33566 w 103261"/>
                    <a:gd name="connsiteY2-62" fmla="*/ 170 h 95481"/>
                    <a:gd name="connsiteX3-63" fmla="*/ 79357 w 103261"/>
                    <a:gd name="connsiteY3-64" fmla="*/ 32420 h 95481"/>
                    <a:gd name="connsiteX4-65" fmla="*/ 103150 w 103261"/>
                    <a:gd name="connsiteY4-66" fmla="*/ 65319 h 95481"/>
                    <a:gd name="connsiteX5-67" fmla="*/ 88863 w 103261"/>
                    <a:gd name="connsiteY5-68" fmla="*/ 95481 h 95481"/>
                    <a:gd name="connsiteX6-69" fmla="*/ 88863 w 103261"/>
                    <a:gd name="connsiteY6-70" fmla="*/ 95481 h 95481"/>
                    <a:gd name="connsiteX0-71" fmla="*/ 13934 w 103161"/>
                    <a:gd name="connsiteY0-72" fmla="*/ 93509 h 95945"/>
                    <a:gd name="connsiteX1-73" fmla="*/ 618 w 103161"/>
                    <a:gd name="connsiteY1-74" fmla="*/ 47356 h 95945"/>
                    <a:gd name="connsiteX2-75" fmla="*/ 33566 w 103161"/>
                    <a:gd name="connsiteY2-76" fmla="*/ 634 h 95945"/>
                    <a:gd name="connsiteX3-77" fmla="*/ 85984 w 103161"/>
                    <a:gd name="connsiteY3-78" fmla="*/ 23332 h 95945"/>
                    <a:gd name="connsiteX4-79" fmla="*/ 103150 w 103161"/>
                    <a:gd name="connsiteY4-80" fmla="*/ 65783 h 95945"/>
                    <a:gd name="connsiteX5-81" fmla="*/ 88863 w 103161"/>
                    <a:gd name="connsiteY5-82" fmla="*/ 95945 h 95945"/>
                    <a:gd name="connsiteX6-83" fmla="*/ 88863 w 103161"/>
                    <a:gd name="connsiteY6-84" fmla="*/ 95945 h 95945"/>
                    <a:gd name="connsiteX0-85" fmla="*/ 13934 w 90842"/>
                    <a:gd name="connsiteY0-86" fmla="*/ 93519 h 95955"/>
                    <a:gd name="connsiteX1-87" fmla="*/ 618 w 90842"/>
                    <a:gd name="connsiteY1-88" fmla="*/ 47366 h 95955"/>
                    <a:gd name="connsiteX2-89" fmla="*/ 33566 w 90842"/>
                    <a:gd name="connsiteY2-90" fmla="*/ 644 h 95955"/>
                    <a:gd name="connsiteX3-91" fmla="*/ 85984 w 90842"/>
                    <a:gd name="connsiteY3-92" fmla="*/ 23342 h 95955"/>
                    <a:gd name="connsiteX4-93" fmla="*/ 88863 w 90842"/>
                    <a:gd name="connsiteY4-94" fmla="*/ 67748 h 95955"/>
                    <a:gd name="connsiteX5-95" fmla="*/ 88863 w 90842"/>
                    <a:gd name="connsiteY5-96" fmla="*/ 95955 h 95955"/>
                    <a:gd name="connsiteX6-97" fmla="*/ 88863 w 90842"/>
                    <a:gd name="connsiteY6-98" fmla="*/ 95955 h 95955"/>
                    <a:gd name="connsiteX0-99" fmla="*/ 13934 w 90842"/>
                    <a:gd name="connsiteY0-100" fmla="*/ 93519 h 95955"/>
                    <a:gd name="connsiteX1-101" fmla="*/ 618 w 90842"/>
                    <a:gd name="connsiteY1-102" fmla="*/ 47366 h 95955"/>
                    <a:gd name="connsiteX2-103" fmla="*/ 33566 w 90842"/>
                    <a:gd name="connsiteY2-104" fmla="*/ 644 h 95955"/>
                    <a:gd name="connsiteX3-105" fmla="*/ 85984 w 90842"/>
                    <a:gd name="connsiteY3-106" fmla="*/ 23342 h 95955"/>
                    <a:gd name="connsiteX4-107" fmla="*/ 88863 w 90842"/>
                    <a:gd name="connsiteY4-108" fmla="*/ 67748 h 95955"/>
                    <a:gd name="connsiteX5-109" fmla="*/ 88863 w 90842"/>
                    <a:gd name="connsiteY5-110" fmla="*/ 95955 h 95955"/>
                    <a:gd name="connsiteX6-111" fmla="*/ 65669 w 90842"/>
                    <a:gd name="connsiteY6-112" fmla="*/ 95219 h 95955"/>
                    <a:gd name="connsiteX0-113" fmla="*/ 13934 w 102218"/>
                    <a:gd name="connsiteY0-114" fmla="*/ 93517 h 95953"/>
                    <a:gd name="connsiteX1-115" fmla="*/ 618 w 102218"/>
                    <a:gd name="connsiteY1-116" fmla="*/ 47364 h 95953"/>
                    <a:gd name="connsiteX2-117" fmla="*/ 33566 w 102218"/>
                    <a:gd name="connsiteY2-118" fmla="*/ 642 h 95953"/>
                    <a:gd name="connsiteX3-119" fmla="*/ 85984 w 102218"/>
                    <a:gd name="connsiteY3-120" fmla="*/ 23340 h 95953"/>
                    <a:gd name="connsiteX4-121" fmla="*/ 102206 w 102218"/>
                    <a:gd name="connsiteY4-122" fmla="*/ 67155 h 95953"/>
                    <a:gd name="connsiteX5-123" fmla="*/ 88863 w 102218"/>
                    <a:gd name="connsiteY5-124" fmla="*/ 95953 h 95953"/>
                    <a:gd name="connsiteX6-125" fmla="*/ 65669 w 102218"/>
                    <a:gd name="connsiteY6-126" fmla="*/ 95217 h 95953"/>
                    <a:gd name="connsiteX0-127" fmla="*/ 13934 w 102211"/>
                    <a:gd name="connsiteY0-128" fmla="*/ 93628 h 96064"/>
                    <a:gd name="connsiteX1-129" fmla="*/ 618 w 102211"/>
                    <a:gd name="connsiteY1-130" fmla="*/ 47475 h 96064"/>
                    <a:gd name="connsiteX2-131" fmla="*/ 33566 w 102211"/>
                    <a:gd name="connsiteY2-132" fmla="*/ 753 h 96064"/>
                    <a:gd name="connsiteX3-133" fmla="*/ 86932 w 102211"/>
                    <a:gd name="connsiteY3-134" fmla="*/ 22086 h 96064"/>
                    <a:gd name="connsiteX4-135" fmla="*/ 102206 w 102211"/>
                    <a:gd name="connsiteY4-136" fmla="*/ 67266 h 96064"/>
                    <a:gd name="connsiteX5-137" fmla="*/ 88863 w 102211"/>
                    <a:gd name="connsiteY5-138" fmla="*/ 96064 h 96064"/>
                    <a:gd name="connsiteX6-139" fmla="*/ 65669 w 102211"/>
                    <a:gd name="connsiteY6-140" fmla="*/ 95328 h 96064"/>
                    <a:gd name="connsiteX0-141" fmla="*/ 13743 w 102020"/>
                    <a:gd name="connsiteY0-142" fmla="*/ 85139 h 87575"/>
                    <a:gd name="connsiteX1-143" fmla="*/ 427 w 102020"/>
                    <a:gd name="connsiteY1-144" fmla="*/ 38986 h 87575"/>
                    <a:gd name="connsiteX2-145" fmla="*/ 29287 w 102020"/>
                    <a:gd name="connsiteY2-146" fmla="*/ 1263 h 87575"/>
                    <a:gd name="connsiteX3-147" fmla="*/ 86741 w 102020"/>
                    <a:gd name="connsiteY3-148" fmla="*/ 13597 h 87575"/>
                    <a:gd name="connsiteX4-149" fmla="*/ 102015 w 102020"/>
                    <a:gd name="connsiteY4-150" fmla="*/ 58777 h 87575"/>
                    <a:gd name="connsiteX5-151" fmla="*/ 88672 w 102020"/>
                    <a:gd name="connsiteY5-152" fmla="*/ 87575 h 87575"/>
                    <a:gd name="connsiteX6-153" fmla="*/ 65478 w 102020"/>
                    <a:gd name="connsiteY6-154" fmla="*/ 86839 h 87575"/>
                    <a:gd name="connsiteX0-155" fmla="*/ 13743 w 102020"/>
                    <a:gd name="connsiteY0-156" fmla="*/ 85139 h 87575"/>
                    <a:gd name="connsiteX1-157" fmla="*/ 427 w 102020"/>
                    <a:gd name="connsiteY1-158" fmla="*/ 38986 h 87575"/>
                    <a:gd name="connsiteX2-159" fmla="*/ 29287 w 102020"/>
                    <a:gd name="connsiteY2-160" fmla="*/ 1263 h 87575"/>
                    <a:gd name="connsiteX3-161" fmla="*/ 86741 w 102020"/>
                    <a:gd name="connsiteY3-162" fmla="*/ 13597 h 87575"/>
                    <a:gd name="connsiteX4-163" fmla="*/ 102015 w 102020"/>
                    <a:gd name="connsiteY4-164" fmla="*/ 58777 h 87575"/>
                    <a:gd name="connsiteX5-165" fmla="*/ 88672 w 102020"/>
                    <a:gd name="connsiteY5-166" fmla="*/ 87575 h 87575"/>
                    <a:gd name="connsiteX6-167" fmla="*/ 65479 w 102020"/>
                    <a:gd name="connsiteY6-168" fmla="*/ 86839 h 87575"/>
                    <a:gd name="connsiteX0-169" fmla="*/ 13743 w 102020"/>
                    <a:gd name="connsiteY0-170" fmla="*/ 85139 h 96907"/>
                    <a:gd name="connsiteX1-171" fmla="*/ 427 w 102020"/>
                    <a:gd name="connsiteY1-172" fmla="*/ 38986 h 96907"/>
                    <a:gd name="connsiteX2-173" fmla="*/ 29287 w 102020"/>
                    <a:gd name="connsiteY2-174" fmla="*/ 1263 h 96907"/>
                    <a:gd name="connsiteX3-175" fmla="*/ 86741 w 102020"/>
                    <a:gd name="connsiteY3-176" fmla="*/ 13597 h 96907"/>
                    <a:gd name="connsiteX4-177" fmla="*/ 102015 w 102020"/>
                    <a:gd name="connsiteY4-178" fmla="*/ 58777 h 96907"/>
                    <a:gd name="connsiteX5-179" fmla="*/ 88672 w 102020"/>
                    <a:gd name="connsiteY5-180" fmla="*/ 87575 h 96907"/>
                    <a:gd name="connsiteX6-181" fmla="*/ 67114 w 102020"/>
                    <a:gd name="connsiteY6-182" fmla="*/ 96907 h 96907"/>
                  </a:gdLst>
                  <a:ahLst/>
                  <a:cxnLst>
                    <a:cxn ang="0">
                      <a:pos x="connsiteX0-1" y="connsiteY0-2"/>
                    </a:cxn>
                    <a:cxn ang="0">
                      <a:pos x="connsiteX1-3" y="connsiteY1-4"/>
                    </a:cxn>
                    <a:cxn ang="0">
                      <a:pos x="connsiteX2-5" y="connsiteY2-6"/>
                    </a:cxn>
                    <a:cxn ang="0">
                      <a:pos x="connsiteX3-7" y="connsiteY3-8"/>
                    </a:cxn>
                    <a:cxn ang="0">
                      <a:pos x="connsiteX4-9" y="connsiteY4-10"/>
                    </a:cxn>
                    <a:cxn ang="0">
                      <a:pos x="connsiteX5-11" y="connsiteY5-12"/>
                    </a:cxn>
                    <a:cxn ang="0">
                      <a:pos x="connsiteX6-13" y="connsiteY6-14"/>
                    </a:cxn>
                  </a:cxnLst>
                  <a:rect l="l" t="t" r="r" b="b"/>
                  <a:pathLst>
                    <a:path w="102020" h="96907">
                      <a:moveTo>
                        <a:pt x="13743" y="85139"/>
                      </a:moveTo>
                      <a:cubicBezTo>
                        <a:pt x="7658" y="66618"/>
                        <a:pt x="-2164" y="52965"/>
                        <a:pt x="427" y="38986"/>
                      </a:cubicBezTo>
                      <a:cubicBezTo>
                        <a:pt x="3018" y="25007"/>
                        <a:pt x="14901" y="5494"/>
                        <a:pt x="29287" y="1263"/>
                      </a:cubicBezTo>
                      <a:cubicBezTo>
                        <a:pt x="43673" y="-2968"/>
                        <a:pt x="74620" y="4011"/>
                        <a:pt x="86741" y="13597"/>
                      </a:cubicBezTo>
                      <a:cubicBezTo>
                        <a:pt x="98862" y="23183"/>
                        <a:pt x="101693" y="46447"/>
                        <a:pt x="102015" y="58777"/>
                      </a:cubicBezTo>
                      <a:cubicBezTo>
                        <a:pt x="102337" y="71107"/>
                        <a:pt x="88672" y="87575"/>
                        <a:pt x="88672" y="87575"/>
                      </a:cubicBezTo>
                      <a:lnTo>
                        <a:pt x="67114" y="96907"/>
                      </a:lnTo>
                    </a:path>
                  </a:pathLst>
                </a:cu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" name="椭圆 63"/>
                <p:cNvSpPr/>
                <p:nvPr/>
              </p:nvSpPr>
              <p:spPr>
                <a:xfrm rot="670531">
                  <a:off x="822586" y="2227539"/>
                  <a:ext cx="66284" cy="67334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 defTabSz="489585">
                    <a:defRPr/>
                  </a:pPr>
                  <a:endParaRPr lang="zh-CN" altLang="en-US" sz="700">
                    <a:solidFill>
                      <a:prstClr val="white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65" name="组合 64"/>
                <p:cNvGrpSpPr/>
                <p:nvPr/>
              </p:nvGrpSpPr>
              <p:grpSpPr>
                <a:xfrm rot="21094909">
                  <a:off x="693845" y="2281652"/>
                  <a:ext cx="113257" cy="130991"/>
                  <a:chOff x="438582" y="2101846"/>
                  <a:chExt cx="137041" cy="174349"/>
                </a:xfrm>
                <a:solidFill>
                  <a:schemeClr val="tx1">
                    <a:lumMod val="75000"/>
                    <a:lumOff val="25000"/>
                  </a:schemeClr>
                </a:solidFill>
              </p:grpSpPr>
              <p:grpSp>
                <p:nvGrpSpPr>
                  <p:cNvPr id="66" name="组合 65"/>
                  <p:cNvGrpSpPr/>
                  <p:nvPr/>
                </p:nvGrpSpPr>
                <p:grpSpPr>
                  <a:xfrm rot="9583191">
                    <a:off x="438582" y="2101846"/>
                    <a:ext cx="79154" cy="115994"/>
                    <a:chOff x="3803021" y="3934734"/>
                    <a:chExt cx="153080" cy="163993"/>
                  </a:xfrm>
                  <a:grpFill/>
                </p:grpSpPr>
                <p:sp>
                  <p:nvSpPr>
                    <p:cNvPr id="71" name="减号 70"/>
                    <p:cNvSpPr/>
                    <p:nvPr/>
                  </p:nvSpPr>
                  <p:spPr>
                    <a:xfrm rot="3985780">
                      <a:off x="3773635" y="3987769"/>
                      <a:ext cx="163993" cy="57923"/>
                    </a:xfrm>
                    <a:prstGeom prst="mathMinus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 defTabSz="489585">
                        <a:defRPr/>
                      </a:pPr>
                      <a:endParaRPr lang="zh-CN" altLang="en-US" sz="700" dirty="0">
                        <a:solidFill>
                          <a:prstClr val="white"/>
                        </a:solidFill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2" name="减号 71"/>
                    <p:cNvSpPr/>
                    <p:nvPr/>
                  </p:nvSpPr>
                  <p:spPr>
                    <a:xfrm rot="5400000">
                      <a:off x="3754148" y="3990700"/>
                      <a:ext cx="153080" cy="45719"/>
                    </a:xfrm>
                    <a:prstGeom prst="mathMinus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 defTabSz="489585">
                        <a:defRPr/>
                      </a:pPr>
                      <a:endParaRPr lang="zh-CN" altLang="en-US" sz="700">
                        <a:solidFill>
                          <a:prstClr val="white"/>
                        </a:solidFill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3" name="减号 72"/>
                    <p:cNvSpPr/>
                    <p:nvPr/>
                  </p:nvSpPr>
                  <p:spPr>
                    <a:xfrm rot="2025815">
                      <a:off x="3803021" y="3968972"/>
                      <a:ext cx="153080" cy="45719"/>
                    </a:xfrm>
                    <a:prstGeom prst="mathMinus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 defTabSz="489585">
                        <a:defRPr/>
                      </a:pPr>
                      <a:endParaRPr lang="zh-CN" altLang="en-US" sz="700" dirty="0">
                        <a:solidFill>
                          <a:prstClr val="white"/>
                        </a:solidFill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67" name="减号 66"/>
                  <p:cNvSpPr/>
                  <p:nvPr/>
                </p:nvSpPr>
                <p:spPr>
                  <a:xfrm rot="4656311">
                    <a:off x="462497" y="2203222"/>
                    <a:ext cx="115994" cy="29951"/>
                  </a:xfrm>
                  <a:prstGeom prst="mathMinus">
                    <a:avLst/>
                  </a:prstGeom>
                  <a:grpFill/>
                  <a:ln w="3175"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 defTabSz="489585">
                      <a:defRPr/>
                    </a:pPr>
                    <a:endParaRPr lang="zh-CN" altLang="en-US" sz="700">
                      <a:solidFill>
                        <a:prstClr val="white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8" name="减号 67"/>
                  <p:cNvSpPr/>
                  <p:nvPr/>
                </p:nvSpPr>
                <p:spPr>
                  <a:xfrm rot="6070531">
                    <a:off x="452578" y="2206377"/>
                    <a:ext cx="108275" cy="23640"/>
                  </a:xfrm>
                  <a:prstGeom prst="mathMinus">
                    <a:avLst/>
                  </a:prstGeom>
                  <a:grpFill/>
                  <a:ln w="3175"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 defTabSz="489585">
                      <a:defRPr/>
                    </a:pPr>
                    <a:endParaRPr lang="zh-CN" altLang="en-US" sz="700">
                      <a:solidFill>
                        <a:prstClr val="white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9" name="减号 68"/>
                  <p:cNvSpPr/>
                  <p:nvPr/>
                </p:nvSpPr>
                <p:spPr>
                  <a:xfrm rot="2696346">
                    <a:off x="496469" y="2187149"/>
                    <a:ext cx="79154" cy="32338"/>
                  </a:xfrm>
                  <a:prstGeom prst="mathMinus">
                    <a:avLst/>
                  </a:prstGeom>
                  <a:grpFill/>
                  <a:ln w="3175"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 defTabSz="489585">
                      <a:defRPr/>
                    </a:pPr>
                    <a:endParaRPr lang="zh-CN" altLang="en-US" sz="700">
                      <a:solidFill>
                        <a:prstClr val="white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0" name="椭圆 69"/>
                  <p:cNvSpPr/>
                  <p:nvPr/>
                </p:nvSpPr>
                <p:spPr>
                  <a:xfrm rot="670531">
                    <a:off x="484329" y="2156615"/>
                    <a:ext cx="46066" cy="52082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 defTabSz="489585">
                      <a:defRPr/>
                    </a:pPr>
                    <a:endParaRPr lang="zh-CN" altLang="en-US" sz="700">
                      <a:solidFill>
                        <a:prstClr val="white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60" name="矩形 59"/>
              <p:cNvSpPr/>
              <p:nvPr/>
            </p:nvSpPr>
            <p:spPr>
              <a:xfrm>
                <a:off x="179360" y="1502098"/>
                <a:ext cx="946726" cy="18823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 defTabSz="489585">
                  <a:defRPr/>
                </a:pPr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BALB/c 8w </a:t>
                </a:r>
                <a:r>
                  <a:rPr lang="zh-CN" altLang="en-US" sz="700" b="1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♀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85" name="直接连接符 84"/>
            <p:cNvCxnSpPr/>
            <p:nvPr/>
          </p:nvCxnSpPr>
          <p:spPr>
            <a:xfrm flipV="1">
              <a:off x="2412386" y="4337054"/>
              <a:ext cx="53013" cy="234693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文本框 92"/>
            <p:cNvSpPr txBox="1"/>
            <p:nvPr/>
          </p:nvSpPr>
          <p:spPr>
            <a:xfrm>
              <a:off x="513234" y="3695375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4" name="文本框 93"/>
          <p:cNvSpPr txBox="1"/>
          <p:nvPr/>
        </p:nvSpPr>
        <p:spPr>
          <a:xfrm rot="16200000">
            <a:off x="3336009" y="4267431"/>
            <a:ext cx="738606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weight (g)</a:t>
            </a:r>
            <a:endParaRPr lang="zh-CN" altLang="en-US" sz="7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12" name="文本框 111"/>
          <p:cNvSpPr txBox="1"/>
          <p:nvPr/>
        </p:nvSpPr>
        <p:spPr>
          <a:xfrm>
            <a:off x="53340" y="5376121"/>
            <a:ext cx="55778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                                                                           e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矩形 113"/>
          <p:cNvSpPr/>
          <p:nvPr/>
        </p:nvSpPr>
        <p:spPr>
          <a:xfrm>
            <a:off x="1769284" y="5360078"/>
            <a:ext cx="1553452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489585">
              <a:defRPr/>
            </a:pPr>
            <a:r>
              <a:rPr lang="en-US" altLang="zh-CN" sz="700" dirty="0" err="1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uaier</a:t>
            </a: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(4.5 g/kg)</a:t>
            </a:r>
          </a:p>
        </p:txBody>
      </p:sp>
      <p:sp>
        <p:nvSpPr>
          <p:cNvPr id="115" name="矩形 114"/>
          <p:cNvSpPr/>
          <p:nvPr/>
        </p:nvSpPr>
        <p:spPr>
          <a:xfrm>
            <a:off x="5042871" y="5357993"/>
            <a:ext cx="1553452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489585">
              <a:defRPr/>
            </a:pPr>
            <a:r>
              <a:rPr lang="en-US" altLang="zh-CN" sz="700" dirty="0" err="1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uaier</a:t>
            </a: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(4.5 g/kg)</a:t>
            </a:r>
          </a:p>
        </p:txBody>
      </p:sp>
      <p:sp>
        <p:nvSpPr>
          <p:cNvPr id="116" name="矩形 115"/>
          <p:cNvSpPr/>
          <p:nvPr/>
        </p:nvSpPr>
        <p:spPr>
          <a:xfrm>
            <a:off x="3717184" y="5357993"/>
            <a:ext cx="1553452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489585">
              <a:defRPr/>
            </a:pPr>
            <a:r>
              <a:rPr lang="en-US" altLang="zh-CN" sz="7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tr</a:t>
            </a:r>
            <a:endParaRPr lang="en-US" altLang="zh-CN" sz="7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17" name="矩形 116"/>
          <p:cNvSpPr/>
          <p:nvPr/>
        </p:nvSpPr>
        <p:spPr>
          <a:xfrm>
            <a:off x="335820" y="5357993"/>
            <a:ext cx="1553452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489585">
              <a:defRPr/>
            </a:pPr>
            <a:r>
              <a:rPr lang="en-US" altLang="zh-CN" sz="7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tr</a:t>
            </a:r>
            <a:endParaRPr lang="en-US" altLang="zh-CN" sz="7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18" name="文本框 117"/>
          <p:cNvSpPr txBox="1"/>
          <p:nvPr/>
        </p:nvSpPr>
        <p:spPr>
          <a:xfrm>
            <a:off x="2875894" y="6596407"/>
            <a:ext cx="43997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l-GR" altLang="zh-CN" sz="5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5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5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直接连接符 118"/>
          <p:cNvCxnSpPr/>
          <p:nvPr/>
        </p:nvCxnSpPr>
        <p:spPr>
          <a:xfrm>
            <a:off x="2919171" y="6715012"/>
            <a:ext cx="27662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文本框 122"/>
          <p:cNvSpPr txBox="1"/>
          <p:nvPr/>
        </p:nvSpPr>
        <p:spPr>
          <a:xfrm>
            <a:off x="6188929" y="6596407"/>
            <a:ext cx="43997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l-GR" altLang="zh-CN" sz="5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5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5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4" name="直接连接符 123"/>
          <p:cNvCxnSpPr/>
          <p:nvPr/>
        </p:nvCxnSpPr>
        <p:spPr>
          <a:xfrm>
            <a:off x="6232206" y="6715012"/>
            <a:ext cx="27662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文本框 2"/>
          <p:cNvSpPr txBox="1"/>
          <p:nvPr/>
        </p:nvSpPr>
        <p:spPr>
          <a:xfrm>
            <a:off x="172663" y="1941570"/>
            <a:ext cx="637032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 S1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Huaier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inhibits the progression of lung cancer and exhibits no significant toxic effects on mice in long-term toxicity experiments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等腰三角形 5"/>
          <p:cNvSpPr/>
          <p:nvPr/>
        </p:nvSpPr>
        <p:spPr>
          <a:xfrm rot="14376074">
            <a:off x="944379" y="3288877"/>
            <a:ext cx="69143" cy="70329"/>
          </a:xfrm>
          <a:prstGeom prst="triangle">
            <a:avLst/>
          </a:prstGeom>
          <a:solidFill>
            <a:srgbClr val="FFFF00"/>
          </a:solidFill>
          <a:ln w="1270">
            <a:solidFill>
              <a:srgbClr val="15151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椭圆 6"/>
          <p:cNvSpPr/>
          <p:nvPr/>
        </p:nvSpPr>
        <p:spPr>
          <a:xfrm>
            <a:off x="1314507" y="3152295"/>
            <a:ext cx="111010" cy="107926"/>
          </a:xfrm>
          <a:prstGeom prst="ellipse">
            <a:avLst/>
          </a:prstGeom>
          <a:noFill/>
          <a:ln w="317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等腰三角形 7"/>
          <p:cNvSpPr/>
          <p:nvPr/>
        </p:nvSpPr>
        <p:spPr>
          <a:xfrm rot="14376074">
            <a:off x="1427049" y="3136845"/>
            <a:ext cx="69143" cy="70329"/>
          </a:xfrm>
          <a:prstGeom prst="triangle">
            <a:avLst/>
          </a:prstGeom>
          <a:solidFill>
            <a:srgbClr val="FFFF00"/>
          </a:solidFill>
          <a:ln w="1270">
            <a:solidFill>
              <a:srgbClr val="15151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椭圆 8"/>
          <p:cNvSpPr/>
          <p:nvPr/>
        </p:nvSpPr>
        <p:spPr>
          <a:xfrm>
            <a:off x="1925872" y="3251816"/>
            <a:ext cx="95283" cy="92374"/>
          </a:xfrm>
          <a:prstGeom prst="ellipse">
            <a:avLst/>
          </a:prstGeom>
          <a:noFill/>
          <a:ln w="317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等腰三角形 9"/>
          <p:cNvSpPr/>
          <p:nvPr/>
        </p:nvSpPr>
        <p:spPr>
          <a:xfrm rot="7330238">
            <a:off x="1226293" y="3392044"/>
            <a:ext cx="69143" cy="70329"/>
          </a:xfrm>
          <a:prstGeom prst="triangle">
            <a:avLst/>
          </a:prstGeom>
          <a:solidFill>
            <a:srgbClr val="FFFF00"/>
          </a:solidFill>
          <a:ln w="1270">
            <a:solidFill>
              <a:srgbClr val="15151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椭圆 10"/>
          <p:cNvSpPr/>
          <p:nvPr/>
        </p:nvSpPr>
        <p:spPr>
          <a:xfrm>
            <a:off x="3072723" y="3095618"/>
            <a:ext cx="71265" cy="69380"/>
          </a:xfrm>
          <a:prstGeom prst="ellipse">
            <a:avLst/>
          </a:prstGeom>
          <a:noFill/>
          <a:ln w="317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等腰三角形 11"/>
          <p:cNvSpPr/>
          <p:nvPr/>
        </p:nvSpPr>
        <p:spPr>
          <a:xfrm rot="5596841">
            <a:off x="2001131" y="3185554"/>
            <a:ext cx="69143" cy="70329"/>
          </a:xfrm>
          <a:prstGeom prst="triangle">
            <a:avLst/>
          </a:prstGeom>
          <a:solidFill>
            <a:srgbClr val="FFFF00"/>
          </a:solidFill>
          <a:ln w="1270">
            <a:solidFill>
              <a:srgbClr val="15151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椭圆 12"/>
          <p:cNvSpPr/>
          <p:nvPr/>
        </p:nvSpPr>
        <p:spPr>
          <a:xfrm rot="1765386">
            <a:off x="549809" y="3117337"/>
            <a:ext cx="110483" cy="113963"/>
          </a:xfrm>
          <a:prstGeom prst="ellipse">
            <a:avLst/>
          </a:prstGeom>
          <a:noFill/>
          <a:ln w="317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697204" y="4988180"/>
            <a:ext cx="1194048" cy="2142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defTabSz="914400">
              <a:defRPr/>
            </a:pPr>
            <a:r>
              <a:rPr lang="en-US" altLang="zh-CN" sz="7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ung surface 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1296123" y="2678813"/>
            <a:ext cx="1284781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458470">
              <a:defRPr/>
            </a:pPr>
            <a:r>
              <a:rPr lang="en-US" altLang="zh-CN" sz="7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Urethane (240 days)</a:t>
            </a:r>
            <a:endParaRPr lang="zh-CN" altLang="en-US" sz="700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383314" y="2807874"/>
            <a:ext cx="33103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8470">
              <a:defRPr/>
            </a:pPr>
            <a:r>
              <a:rPr lang="en-US" altLang="zh-CN" sz="7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Huaier    0                    0.5                       1.5                   4.5 </a:t>
            </a:r>
            <a:r>
              <a:rPr lang="en-US" altLang="zh-CN" sz="7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  <a:sym typeface="+mn-ea"/>
              </a:rPr>
              <a:t>(g/kg)</a:t>
            </a:r>
            <a:endParaRPr lang="zh-CN" altLang="en-US" sz="700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17" name="直接连接符 16"/>
          <p:cNvCxnSpPr/>
          <p:nvPr/>
        </p:nvCxnSpPr>
        <p:spPr>
          <a:xfrm>
            <a:off x="383314" y="2851787"/>
            <a:ext cx="289426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>
            <a:off x="151211" y="2852067"/>
            <a:ext cx="378630" cy="169277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15 mm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接连接符 18"/>
          <p:cNvCxnSpPr/>
          <p:nvPr/>
        </p:nvCxnSpPr>
        <p:spPr>
          <a:xfrm>
            <a:off x="358081" y="2989883"/>
            <a:ext cx="0" cy="61624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/>
          <p:cNvCxnSpPr/>
          <p:nvPr/>
        </p:nvCxnSpPr>
        <p:spPr>
          <a:xfrm>
            <a:off x="360633" y="2990400"/>
            <a:ext cx="1929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358515" y="3605663"/>
            <a:ext cx="1929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21"/>
          <p:cNvCxnSpPr/>
          <p:nvPr/>
        </p:nvCxnSpPr>
        <p:spPr>
          <a:xfrm>
            <a:off x="358950" y="3194694"/>
            <a:ext cx="1929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>
            <a:off x="358136" y="3398988"/>
            <a:ext cx="1929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任意多边形: 形状 23"/>
          <p:cNvSpPr/>
          <p:nvPr/>
        </p:nvSpPr>
        <p:spPr>
          <a:xfrm>
            <a:off x="465384" y="3035722"/>
            <a:ext cx="591508" cy="536601"/>
          </a:xfrm>
          <a:custGeom>
            <a:avLst/>
            <a:gdLst>
              <a:gd name="connsiteX0" fmla="*/ 213563 w 551806"/>
              <a:gd name="connsiteY0" fmla="*/ 38229 h 536601"/>
              <a:gd name="connsiteX1" fmla="*/ 156413 w 551806"/>
              <a:gd name="connsiteY1" fmla="*/ 129 h 536601"/>
              <a:gd name="connsiteX2" fmla="*/ 89738 w 551806"/>
              <a:gd name="connsiteY2" fmla="*/ 31086 h 536601"/>
              <a:gd name="connsiteX3" fmla="*/ 4013 w 551806"/>
              <a:gd name="connsiteY3" fmla="*/ 152529 h 536601"/>
              <a:gd name="connsiteX4" fmla="*/ 13538 w 551806"/>
              <a:gd name="connsiteY4" fmla="*/ 295404 h 536601"/>
              <a:gd name="connsiteX5" fmla="*/ 8775 w 551806"/>
              <a:gd name="connsiteY5" fmla="*/ 385892 h 536601"/>
              <a:gd name="connsiteX6" fmla="*/ 70688 w 551806"/>
              <a:gd name="connsiteY6" fmla="*/ 462092 h 536601"/>
              <a:gd name="connsiteX7" fmla="*/ 156413 w 551806"/>
              <a:gd name="connsiteY7" fmla="*/ 528767 h 536601"/>
              <a:gd name="connsiteX8" fmla="*/ 230231 w 551806"/>
              <a:gd name="connsiteY8" fmla="*/ 440661 h 536601"/>
              <a:gd name="connsiteX9" fmla="*/ 251663 w 551806"/>
              <a:gd name="connsiteY9" fmla="*/ 393036 h 536601"/>
              <a:gd name="connsiteX10" fmla="*/ 263569 w 551806"/>
              <a:gd name="connsiteY10" fmla="*/ 366842 h 536601"/>
              <a:gd name="connsiteX11" fmla="*/ 318338 w 551806"/>
              <a:gd name="connsiteY11" fmla="*/ 426373 h 536601"/>
              <a:gd name="connsiteX12" fmla="*/ 330244 w 551806"/>
              <a:gd name="connsiteY12" fmla="*/ 454948 h 536601"/>
              <a:gd name="connsiteX13" fmla="*/ 327863 w 551806"/>
              <a:gd name="connsiteY13" fmla="*/ 502573 h 536601"/>
              <a:gd name="connsiteX14" fmla="*/ 392156 w 551806"/>
              <a:gd name="connsiteY14" fmla="*/ 535911 h 536601"/>
              <a:gd name="connsiteX15" fmla="*/ 489788 w 551806"/>
              <a:gd name="connsiteY15" fmla="*/ 471617 h 536601"/>
              <a:gd name="connsiteX16" fmla="*/ 525506 w 551806"/>
              <a:gd name="connsiteY16" fmla="*/ 350173 h 536601"/>
              <a:gd name="connsiteX17" fmla="*/ 523125 w 551806"/>
              <a:gd name="connsiteY17" fmla="*/ 231111 h 536601"/>
              <a:gd name="connsiteX18" fmla="*/ 511219 w 551806"/>
              <a:gd name="connsiteY18" fmla="*/ 140623 h 536601"/>
              <a:gd name="connsiteX19" fmla="*/ 551700 w 551806"/>
              <a:gd name="connsiteY19" fmla="*/ 92998 h 536601"/>
              <a:gd name="connsiteX20" fmla="*/ 496931 w 551806"/>
              <a:gd name="connsiteY20" fmla="*/ 42992 h 536601"/>
              <a:gd name="connsiteX21" fmla="*/ 425494 w 551806"/>
              <a:gd name="connsiteY21" fmla="*/ 12036 h 536601"/>
              <a:gd name="connsiteX22" fmla="*/ 339769 w 551806"/>
              <a:gd name="connsiteY22" fmla="*/ 31086 h 536601"/>
              <a:gd name="connsiteX23" fmla="*/ 282619 w 551806"/>
              <a:gd name="connsiteY23" fmla="*/ 16798 h 536601"/>
              <a:gd name="connsiteX24" fmla="*/ 213563 w 551806"/>
              <a:gd name="connsiteY24" fmla="*/ 38229 h 53660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</a:cxnLst>
            <a:rect l="l" t="t" r="r" b="b"/>
            <a:pathLst>
              <a:path w="551806" h="536601">
                <a:moveTo>
                  <a:pt x="213563" y="38229"/>
                </a:moveTo>
                <a:cubicBezTo>
                  <a:pt x="192529" y="35451"/>
                  <a:pt x="177050" y="1319"/>
                  <a:pt x="156413" y="129"/>
                </a:cubicBezTo>
                <a:cubicBezTo>
                  <a:pt x="135776" y="-1061"/>
                  <a:pt x="115138" y="5686"/>
                  <a:pt x="89738" y="31086"/>
                </a:cubicBezTo>
                <a:cubicBezTo>
                  <a:pt x="64338" y="56486"/>
                  <a:pt x="16713" y="108476"/>
                  <a:pt x="4013" y="152529"/>
                </a:cubicBezTo>
                <a:cubicBezTo>
                  <a:pt x="-8687" y="196582"/>
                  <a:pt x="12744" y="256510"/>
                  <a:pt x="13538" y="295404"/>
                </a:cubicBezTo>
                <a:cubicBezTo>
                  <a:pt x="14332" y="334298"/>
                  <a:pt x="-750" y="358111"/>
                  <a:pt x="8775" y="385892"/>
                </a:cubicBezTo>
                <a:cubicBezTo>
                  <a:pt x="18300" y="413673"/>
                  <a:pt x="46082" y="438280"/>
                  <a:pt x="70688" y="462092"/>
                </a:cubicBezTo>
                <a:cubicBezTo>
                  <a:pt x="95294" y="485904"/>
                  <a:pt x="129823" y="532339"/>
                  <a:pt x="156413" y="528767"/>
                </a:cubicBezTo>
                <a:cubicBezTo>
                  <a:pt x="183003" y="525195"/>
                  <a:pt x="214356" y="463283"/>
                  <a:pt x="230231" y="440661"/>
                </a:cubicBezTo>
                <a:cubicBezTo>
                  <a:pt x="246106" y="418039"/>
                  <a:pt x="246107" y="405339"/>
                  <a:pt x="251663" y="393036"/>
                </a:cubicBezTo>
                <a:cubicBezTo>
                  <a:pt x="257219" y="380733"/>
                  <a:pt x="252457" y="361286"/>
                  <a:pt x="263569" y="366842"/>
                </a:cubicBezTo>
                <a:cubicBezTo>
                  <a:pt x="274682" y="372398"/>
                  <a:pt x="307226" y="411689"/>
                  <a:pt x="318338" y="426373"/>
                </a:cubicBezTo>
                <a:cubicBezTo>
                  <a:pt x="329451" y="441057"/>
                  <a:pt x="328657" y="442248"/>
                  <a:pt x="330244" y="454948"/>
                </a:cubicBezTo>
                <a:cubicBezTo>
                  <a:pt x="331831" y="467648"/>
                  <a:pt x="317544" y="489079"/>
                  <a:pt x="327863" y="502573"/>
                </a:cubicBezTo>
                <a:cubicBezTo>
                  <a:pt x="338182" y="516067"/>
                  <a:pt x="365169" y="541070"/>
                  <a:pt x="392156" y="535911"/>
                </a:cubicBezTo>
                <a:cubicBezTo>
                  <a:pt x="419143" y="530752"/>
                  <a:pt x="467563" y="502573"/>
                  <a:pt x="489788" y="471617"/>
                </a:cubicBezTo>
                <a:cubicBezTo>
                  <a:pt x="512013" y="440661"/>
                  <a:pt x="519950" y="390257"/>
                  <a:pt x="525506" y="350173"/>
                </a:cubicBezTo>
                <a:cubicBezTo>
                  <a:pt x="531062" y="310089"/>
                  <a:pt x="525506" y="266036"/>
                  <a:pt x="523125" y="231111"/>
                </a:cubicBezTo>
                <a:cubicBezTo>
                  <a:pt x="520744" y="196186"/>
                  <a:pt x="506457" y="163642"/>
                  <a:pt x="511219" y="140623"/>
                </a:cubicBezTo>
                <a:cubicBezTo>
                  <a:pt x="515982" y="117604"/>
                  <a:pt x="554081" y="109270"/>
                  <a:pt x="551700" y="92998"/>
                </a:cubicBezTo>
                <a:cubicBezTo>
                  <a:pt x="549319" y="76726"/>
                  <a:pt x="517965" y="56486"/>
                  <a:pt x="496931" y="42992"/>
                </a:cubicBezTo>
                <a:cubicBezTo>
                  <a:pt x="475897" y="29498"/>
                  <a:pt x="451688" y="14020"/>
                  <a:pt x="425494" y="12036"/>
                </a:cubicBezTo>
                <a:cubicBezTo>
                  <a:pt x="399300" y="10052"/>
                  <a:pt x="363581" y="30292"/>
                  <a:pt x="339769" y="31086"/>
                </a:cubicBezTo>
                <a:cubicBezTo>
                  <a:pt x="315957" y="31880"/>
                  <a:pt x="304447" y="15608"/>
                  <a:pt x="282619" y="16798"/>
                </a:cubicBezTo>
                <a:cubicBezTo>
                  <a:pt x="260791" y="17988"/>
                  <a:pt x="234597" y="41007"/>
                  <a:pt x="213563" y="38229"/>
                </a:cubicBezTo>
                <a:close/>
              </a:path>
            </a:pathLst>
          </a:custGeom>
          <a:noFill/>
          <a:ln w="3175">
            <a:solidFill>
              <a:srgbClr val="CAC4C4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椭圆 24"/>
          <p:cNvSpPr/>
          <p:nvPr/>
        </p:nvSpPr>
        <p:spPr>
          <a:xfrm rot="1765386">
            <a:off x="564197" y="3253564"/>
            <a:ext cx="162574" cy="175015"/>
          </a:xfrm>
          <a:prstGeom prst="ellipse">
            <a:avLst/>
          </a:prstGeom>
          <a:noFill/>
          <a:ln w="317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椭圆 25"/>
          <p:cNvSpPr/>
          <p:nvPr/>
        </p:nvSpPr>
        <p:spPr>
          <a:xfrm rot="1765386">
            <a:off x="853739" y="3342008"/>
            <a:ext cx="110483" cy="113963"/>
          </a:xfrm>
          <a:prstGeom prst="ellipse">
            <a:avLst/>
          </a:prstGeom>
          <a:noFill/>
          <a:ln w="317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等腰三角形 26"/>
          <p:cNvSpPr/>
          <p:nvPr/>
        </p:nvSpPr>
        <p:spPr>
          <a:xfrm rot="14376074">
            <a:off x="663444" y="3070712"/>
            <a:ext cx="69143" cy="70329"/>
          </a:xfrm>
          <a:prstGeom prst="triangle">
            <a:avLst/>
          </a:prstGeom>
          <a:solidFill>
            <a:srgbClr val="FFFF00"/>
          </a:solidFill>
          <a:ln w="1270">
            <a:solidFill>
              <a:srgbClr val="15151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等腰三角形 27"/>
          <p:cNvSpPr/>
          <p:nvPr/>
        </p:nvSpPr>
        <p:spPr>
          <a:xfrm rot="14376074">
            <a:off x="729292" y="3243955"/>
            <a:ext cx="69143" cy="70329"/>
          </a:xfrm>
          <a:prstGeom prst="triangle">
            <a:avLst/>
          </a:prstGeom>
          <a:solidFill>
            <a:srgbClr val="FFFF00"/>
          </a:solidFill>
          <a:ln w="1270">
            <a:solidFill>
              <a:srgbClr val="15151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任意多边形: 形状 28"/>
          <p:cNvSpPr/>
          <p:nvPr/>
        </p:nvSpPr>
        <p:spPr>
          <a:xfrm>
            <a:off x="1183713" y="3064900"/>
            <a:ext cx="625585" cy="518666"/>
          </a:xfrm>
          <a:custGeom>
            <a:avLst/>
            <a:gdLst>
              <a:gd name="connsiteX0" fmla="*/ 207816 w 583596"/>
              <a:gd name="connsiteY0" fmla="*/ 63820 h 518666"/>
              <a:gd name="connsiteX1" fmla="*/ 133998 w 583596"/>
              <a:gd name="connsiteY1" fmla="*/ 37626 h 518666"/>
              <a:gd name="connsiteX2" fmla="*/ 55416 w 583596"/>
              <a:gd name="connsiteY2" fmla="*/ 66201 h 518666"/>
              <a:gd name="connsiteX3" fmla="*/ 3029 w 583596"/>
              <a:gd name="connsiteY3" fmla="*/ 182883 h 518666"/>
              <a:gd name="connsiteX4" fmla="*/ 14935 w 583596"/>
              <a:gd name="connsiteY4" fmla="*/ 344808 h 518666"/>
              <a:gd name="connsiteX5" fmla="*/ 86373 w 583596"/>
              <a:gd name="connsiteY5" fmla="*/ 401958 h 518666"/>
              <a:gd name="connsiteX6" fmla="*/ 129235 w 583596"/>
              <a:gd name="connsiteY6" fmla="*/ 478158 h 518666"/>
              <a:gd name="connsiteX7" fmla="*/ 243535 w 583596"/>
              <a:gd name="connsiteY7" fmla="*/ 518639 h 518666"/>
              <a:gd name="connsiteX8" fmla="*/ 355454 w 583596"/>
              <a:gd name="connsiteY8" fmla="*/ 482920 h 518666"/>
              <a:gd name="connsiteX9" fmla="*/ 462610 w 583596"/>
              <a:gd name="connsiteY9" fmla="*/ 399576 h 518666"/>
              <a:gd name="connsiteX10" fmla="*/ 541191 w 583596"/>
              <a:gd name="connsiteY10" fmla="*/ 351951 h 518666"/>
              <a:gd name="connsiteX11" fmla="*/ 581673 w 583596"/>
              <a:gd name="connsiteY11" fmla="*/ 306708 h 518666"/>
              <a:gd name="connsiteX12" fmla="*/ 567385 w 583596"/>
              <a:gd name="connsiteY12" fmla="*/ 132876 h 518666"/>
              <a:gd name="connsiteX13" fmla="*/ 484041 w 583596"/>
              <a:gd name="connsiteY13" fmla="*/ 54295 h 518666"/>
              <a:gd name="connsiteX14" fmla="*/ 367360 w 583596"/>
              <a:gd name="connsiteY14" fmla="*/ 1908 h 518666"/>
              <a:gd name="connsiteX15" fmla="*/ 260204 w 583596"/>
              <a:gd name="connsiteY15" fmla="*/ 16195 h 518666"/>
              <a:gd name="connsiteX16" fmla="*/ 207816 w 583596"/>
              <a:gd name="connsiteY16" fmla="*/ 63820 h 5186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583596" h="518666">
                <a:moveTo>
                  <a:pt x="207816" y="63820"/>
                </a:moveTo>
                <a:cubicBezTo>
                  <a:pt x="186782" y="67392"/>
                  <a:pt x="159398" y="37229"/>
                  <a:pt x="133998" y="37626"/>
                </a:cubicBezTo>
                <a:cubicBezTo>
                  <a:pt x="108598" y="38023"/>
                  <a:pt x="77244" y="41991"/>
                  <a:pt x="55416" y="66201"/>
                </a:cubicBezTo>
                <a:cubicBezTo>
                  <a:pt x="33588" y="90411"/>
                  <a:pt x="9776" y="136449"/>
                  <a:pt x="3029" y="182883"/>
                </a:cubicBezTo>
                <a:cubicBezTo>
                  <a:pt x="-3718" y="229318"/>
                  <a:pt x="1044" y="308296"/>
                  <a:pt x="14935" y="344808"/>
                </a:cubicBezTo>
                <a:cubicBezTo>
                  <a:pt x="28826" y="381321"/>
                  <a:pt x="67323" y="379733"/>
                  <a:pt x="86373" y="401958"/>
                </a:cubicBezTo>
                <a:cubicBezTo>
                  <a:pt x="105423" y="424183"/>
                  <a:pt x="103041" y="458711"/>
                  <a:pt x="129235" y="478158"/>
                </a:cubicBezTo>
                <a:cubicBezTo>
                  <a:pt x="155429" y="497605"/>
                  <a:pt x="205832" y="517845"/>
                  <a:pt x="243535" y="518639"/>
                </a:cubicBezTo>
                <a:cubicBezTo>
                  <a:pt x="281238" y="519433"/>
                  <a:pt x="318942" y="502764"/>
                  <a:pt x="355454" y="482920"/>
                </a:cubicBezTo>
                <a:cubicBezTo>
                  <a:pt x="391967" y="463076"/>
                  <a:pt x="431654" y="421404"/>
                  <a:pt x="462610" y="399576"/>
                </a:cubicBezTo>
                <a:cubicBezTo>
                  <a:pt x="493566" y="377748"/>
                  <a:pt x="521347" y="367429"/>
                  <a:pt x="541191" y="351951"/>
                </a:cubicBezTo>
                <a:cubicBezTo>
                  <a:pt x="561035" y="336473"/>
                  <a:pt x="577307" y="343221"/>
                  <a:pt x="581673" y="306708"/>
                </a:cubicBezTo>
                <a:cubicBezTo>
                  <a:pt x="586039" y="270196"/>
                  <a:pt x="583657" y="174945"/>
                  <a:pt x="567385" y="132876"/>
                </a:cubicBezTo>
                <a:cubicBezTo>
                  <a:pt x="551113" y="90807"/>
                  <a:pt x="517379" y="76123"/>
                  <a:pt x="484041" y="54295"/>
                </a:cubicBezTo>
                <a:cubicBezTo>
                  <a:pt x="450703" y="32467"/>
                  <a:pt x="404666" y="8258"/>
                  <a:pt x="367360" y="1908"/>
                </a:cubicBezTo>
                <a:cubicBezTo>
                  <a:pt x="330054" y="-4442"/>
                  <a:pt x="286795" y="6273"/>
                  <a:pt x="260204" y="16195"/>
                </a:cubicBezTo>
                <a:cubicBezTo>
                  <a:pt x="233613" y="26117"/>
                  <a:pt x="228850" y="60248"/>
                  <a:pt x="207816" y="63820"/>
                </a:cubicBezTo>
                <a:close/>
              </a:path>
            </a:pathLst>
          </a:custGeom>
          <a:noFill/>
          <a:ln w="3175">
            <a:solidFill>
              <a:srgbClr val="CAC4C4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椭圆 29"/>
          <p:cNvSpPr/>
          <p:nvPr/>
        </p:nvSpPr>
        <p:spPr>
          <a:xfrm>
            <a:off x="1187979" y="3253649"/>
            <a:ext cx="121234" cy="116475"/>
          </a:xfrm>
          <a:prstGeom prst="ellipse">
            <a:avLst/>
          </a:prstGeom>
          <a:noFill/>
          <a:ln w="317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椭圆 30"/>
          <p:cNvSpPr/>
          <p:nvPr/>
        </p:nvSpPr>
        <p:spPr>
          <a:xfrm>
            <a:off x="1898658" y="3357023"/>
            <a:ext cx="95283" cy="92374"/>
          </a:xfrm>
          <a:prstGeom prst="ellipse">
            <a:avLst/>
          </a:prstGeom>
          <a:noFill/>
          <a:ln w="317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椭圆 31"/>
          <p:cNvSpPr/>
          <p:nvPr/>
        </p:nvSpPr>
        <p:spPr>
          <a:xfrm>
            <a:off x="1968600" y="3427751"/>
            <a:ext cx="95283" cy="92374"/>
          </a:xfrm>
          <a:prstGeom prst="ellipse">
            <a:avLst/>
          </a:prstGeom>
          <a:noFill/>
          <a:ln w="317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等腰三角形 32"/>
          <p:cNvSpPr/>
          <p:nvPr/>
        </p:nvSpPr>
        <p:spPr>
          <a:xfrm rot="4044040">
            <a:off x="1911728" y="3479665"/>
            <a:ext cx="69143" cy="70329"/>
          </a:xfrm>
          <a:prstGeom prst="triangle">
            <a:avLst/>
          </a:prstGeom>
          <a:solidFill>
            <a:srgbClr val="FFFF00"/>
          </a:solidFill>
          <a:ln w="1270">
            <a:solidFill>
              <a:srgbClr val="15151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等腰三角形 33"/>
          <p:cNvSpPr/>
          <p:nvPr/>
        </p:nvSpPr>
        <p:spPr>
          <a:xfrm rot="1382639">
            <a:off x="2017408" y="3340521"/>
            <a:ext cx="74118" cy="65609"/>
          </a:xfrm>
          <a:prstGeom prst="triangle">
            <a:avLst/>
          </a:prstGeom>
          <a:solidFill>
            <a:srgbClr val="FFFF00"/>
          </a:solidFill>
          <a:ln w="1270">
            <a:solidFill>
              <a:srgbClr val="15151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任意多边形: 形状 34"/>
          <p:cNvSpPr/>
          <p:nvPr/>
        </p:nvSpPr>
        <p:spPr>
          <a:xfrm>
            <a:off x="1930901" y="3026994"/>
            <a:ext cx="592779" cy="571633"/>
          </a:xfrm>
          <a:custGeom>
            <a:avLst/>
            <a:gdLst>
              <a:gd name="connsiteX0" fmla="*/ 187848 w 552992"/>
              <a:gd name="connsiteY0" fmla="*/ 136651 h 571633"/>
              <a:gd name="connsiteX1" fmla="*/ 121173 w 552992"/>
              <a:gd name="connsiteY1" fmla="*/ 120776 h 571633"/>
              <a:gd name="connsiteX2" fmla="*/ 38623 w 552992"/>
              <a:gd name="connsiteY2" fmla="*/ 203326 h 571633"/>
              <a:gd name="connsiteX3" fmla="*/ 523 w 552992"/>
              <a:gd name="connsiteY3" fmla="*/ 343026 h 571633"/>
              <a:gd name="connsiteX4" fmla="*/ 64023 w 552992"/>
              <a:gd name="connsiteY4" fmla="*/ 536701 h 571633"/>
              <a:gd name="connsiteX5" fmla="*/ 260873 w 552992"/>
              <a:gd name="connsiteY5" fmla="*/ 571626 h 571633"/>
              <a:gd name="connsiteX6" fmla="*/ 251348 w 552992"/>
              <a:gd name="connsiteY6" fmla="*/ 539876 h 571633"/>
              <a:gd name="connsiteX7" fmla="*/ 352948 w 552992"/>
              <a:gd name="connsiteY7" fmla="*/ 546226 h 571633"/>
              <a:gd name="connsiteX8" fmla="*/ 457723 w 552992"/>
              <a:gd name="connsiteY8" fmla="*/ 431926 h 571633"/>
              <a:gd name="connsiteX9" fmla="*/ 543448 w 552992"/>
              <a:gd name="connsiteY9" fmla="*/ 425576 h 571633"/>
              <a:gd name="connsiteX10" fmla="*/ 546623 w 552992"/>
              <a:gd name="connsiteY10" fmla="*/ 323976 h 571633"/>
              <a:gd name="connsiteX11" fmla="*/ 505348 w 552992"/>
              <a:gd name="connsiteY11" fmla="*/ 314451 h 571633"/>
              <a:gd name="connsiteX12" fmla="*/ 498998 w 552992"/>
              <a:gd name="connsiteY12" fmla="*/ 146176 h 571633"/>
              <a:gd name="connsiteX13" fmla="*/ 438673 w 552992"/>
              <a:gd name="connsiteY13" fmla="*/ 57276 h 571633"/>
              <a:gd name="connsiteX14" fmla="*/ 305323 w 552992"/>
              <a:gd name="connsiteY14" fmla="*/ 126 h 571633"/>
              <a:gd name="connsiteX15" fmla="*/ 257698 w 552992"/>
              <a:gd name="connsiteY15" fmla="*/ 44576 h 571633"/>
              <a:gd name="connsiteX16" fmla="*/ 187848 w 552992"/>
              <a:gd name="connsiteY16" fmla="*/ 136651 h 5716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552992" h="571633">
                <a:moveTo>
                  <a:pt x="187848" y="136651"/>
                </a:moveTo>
                <a:cubicBezTo>
                  <a:pt x="165094" y="149351"/>
                  <a:pt x="146044" y="109664"/>
                  <a:pt x="121173" y="120776"/>
                </a:cubicBezTo>
                <a:cubicBezTo>
                  <a:pt x="96302" y="131888"/>
                  <a:pt x="58731" y="166284"/>
                  <a:pt x="38623" y="203326"/>
                </a:cubicBezTo>
                <a:cubicBezTo>
                  <a:pt x="18515" y="240368"/>
                  <a:pt x="-3710" y="287463"/>
                  <a:pt x="523" y="343026"/>
                </a:cubicBezTo>
                <a:cubicBezTo>
                  <a:pt x="4756" y="398589"/>
                  <a:pt x="20631" y="498601"/>
                  <a:pt x="64023" y="536701"/>
                </a:cubicBezTo>
                <a:cubicBezTo>
                  <a:pt x="107415" y="574801"/>
                  <a:pt x="229652" y="571097"/>
                  <a:pt x="260873" y="571626"/>
                </a:cubicBezTo>
                <a:cubicBezTo>
                  <a:pt x="292094" y="572155"/>
                  <a:pt x="236002" y="544109"/>
                  <a:pt x="251348" y="539876"/>
                </a:cubicBezTo>
                <a:cubicBezTo>
                  <a:pt x="266694" y="535643"/>
                  <a:pt x="318552" y="564218"/>
                  <a:pt x="352948" y="546226"/>
                </a:cubicBezTo>
                <a:cubicBezTo>
                  <a:pt x="387344" y="528234"/>
                  <a:pt x="425973" y="452034"/>
                  <a:pt x="457723" y="431926"/>
                </a:cubicBezTo>
                <a:cubicBezTo>
                  <a:pt x="489473" y="411818"/>
                  <a:pt x="528631" y="443568"/>
                  <a:pt x="543448" y="425576"/>
                </a:cubicBezTo>
                <a:cubicBezTo>
                  <a:pt x="558265" y="407584"/>
                  <a:pt x="552973" y="342497"/>
                  <a:pt x="546623" y="323976"/>
                </a:cubicBezTo>
                <a:cubicBezTo>
                  <a:pt x="540273" y="305455"/>
                  <a:pt x="513285" y="344084"/>
                  <a:pt x="505348" y="314451"/>
                </a:cubicBezTo>
                <a:cubicBezTo>
                  <a:pt x="497411" y="284818"/>
                  <a:pt x="510110" y="189038"/>
                  <a:pt x="498998" y="146176"/>
                </a:cubicBezTo>
                <a:cubicBezTo>
                  <a:pt x="487886" y="103314"/>
                  <a:pt x="470952" y="81618"/>
                  <a:pt x="438673" y="57276"/>
                </a:cubicBezTo>
                <a:cubicBezTo>
                  <a:pt x="406394" y="32934"/>
                  <a:pt x="335485" y="2243"/>
                  <a:pt x="305323" y="126"/>
                </a:cubicBezTo>
                <a:cubicBezTo>
                  <a:pt x="275161" y="-1991"/>
                  <a:pt x="278865" y="22880"/>
                  <a:pt x="257698" y="44576"/>
                </a:cubicBezTo>
                <a:cubicBezTo>
                  <a:pt x="236531" y="66272"/>
                  <a:pt x="210602" y="123951"/>
                  <a:pt x="187848" y="136651"/>
                </a:cubicBezTo>
                <a:close/>
              </a:path>
            </a:pathLst>
          </a:custGeom>
          <a:noFill/>
          <a:ln w="3175">
            <a:solidFill>
              <a:srgbClr val="CAC4C4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6" name="任意多边形: 形状 35"/>
          <p:cNvSpPr/>
          <p:nvPr/>
        </p:nvSpPr>
        <p:spPr>
          <a:xfrm>
            <a:off x="2669524" y="3023276"/>
            <a:ext cx="611593" cy="585428"/>
          </a:xfrm>
          <a:custGeom>
            <a:avLst/>
            <a:gdLst>
              <a:gd name="connsiteX0" fmla="*/ 232225 w 570543"/>
              <a:gd name="connsiteY0" fmla="*/ 64169 h 585428"/>
              <a:gd name="connsiteX1" fmla="*/ 156025 w 570543"/>
              <a:gd name="connsiteY1" fmla="*/ 16544 h 585428"/>
              <a:gd name="connsiteX2" fmla="*/ 73475 w 570543"/>
              <a:gd name="connsiteY2" fmla="*/ 67344 h 585428"/>
              <a:gd name="connsiteX3" fmla="*/ 19500 w 570543"/>
              <a:gd name="connsiteY3" fmla="*/ 194344 h 585428"/>
              <a:gd name="connsiteX4" fmla="*/ 3625 w 570543"/>
              <a:gd name="connsiteY4" fmla="*/ 391194 h 585428"/>
              <a:gd name="connsiteX5" fmla="*/ 83000 w 570543"/>
              <a:gd name="connsiteY5" fmla="*/ 540419 h 585428"/>
              <a:gd name="connsiteX6" fmla="*/ 171900 w 570543"/>
              <a:gd name="connsiteY6" fmla="*/ 584869 h 585428"/>
              <a:gd name="connsiteX7" fmla="*/ 254450 w 570543"/>
              <a:gd name="connsiteY7" fmla="*/ 559469 h 585428"/>
              <a:gd name="connsiteX8" fmla="*/ 432250 w 570543"/>
              <a:gd name="connsiteY8" fmla="*/ 476919 h 585428"/>
              <a:gd name="connsiteX9" fmla="*/ 514800 w 570543"/>
              <a:gd name="connsiteY9" fmla="*/ 330869 h 585428"/>
              <a:gd name="connsiteX10" fmla="*/ 568775 w 570543"/>
              <a:gd name="connsiteY10" fmla="*/ 280069 h 585428"/>
              <a:gd name="connsiteX11" fmla="*/ 546550 w 570543"/>
              <a:gd name="connsiteY11" fmla="*/ 89569 h 585428"/>
              <a:gd name="connsiteX12" fmla="*/ 441775 w 570543"/>
              <a:gd name="connsiteY12" fmla="*/ 32419 h 585428"/>
              <a:gd name="connsiteX13" fmla="*/ 340175 w 570543"/>
              <a:gd name="connsiteY13" fmla="*/ 669 h 585428"/>
              <a:gd name="connsiteX14" fmla="*/ 232225 w 570543"/>
              <a:gd name="connsiteY14" fmla="*/ 64169 h 5854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</a:cxnLst>
            <a:rect l="l" t="t" r="r" b="b"/>
            <a:pathLst>
              <a:path w="570543" h="585428">
                <a:moveTo>
                  <a:pt x="232225" y="64169"/>
                </a:moveTo>
                <a:cubicBezTo>
                  <a:pt x="201533" y="66815"/>
                  <a:pt x="182483" y="16015"/>
                  <a:pt x="156025" y="16544"/>
                </a:cubicBezTo>
                <a:cubicBezTo>
                  <a:pt x="129567" y="17073"/>
                  <a:pt x="96229" y="37711"/>
                  <a:pt x="73475" y="67344"/>
                </a:cubicBezTo>
                <a:cubicBezTo>
                  <a:pt x="50721" y="96977"/>
                  <a:pt x="31142" y="140369"/>
                  <a:pt x="19500" y="194344"/>
                </a:cubicBezTo>
                <a:cubicBezTo>
                  <a:pt x="7858" y="248319"/>
                  <a:pt x="-6958" y="333515"/>
                  <a:pt x="3625" y="391194"/>
                </a:cubicBezTo>
                <a:cubicBezTo>
                  <a:pt x="14208" y="448873"/>
                  <a:pt x="54954" y="508140"/>
                  <a:pt x="83000" y="540419"/>
                </a:cubicBezTo>
                <a:cubicBezTo>
                  <a:pt x="111046" y="572698"/>
                  <a:pt x="143325" y="581694"/>
                  <a:pt x="171900" y="584869"/>
                </a:cubicBezTo>
                <a:cubicBezTo>
                  <a:pt x="200475" y="588044"/>
                  <a:pt x="211058" y="577461"/>
                  <a:pt x="254450" y="559469"/>
                </a:cubicBezTo>
                <a:cubicBezTo>
                  <a:pt x="297842" y="541477"/>
                  <a:pt x="388858" y="515019"/>
                  <a:pt x="432250" y="476919"/>
                </a:cubicBezTo>
                <a:cubicBezTo>
                  <a:pt x="475642" y="438819"/>
                  <a:pt x="492046" y="363677"/>
                  <a:pt x="514800" y="330869"/>
                </a:cubicBezTo>
                <a:cubicBezTo>
                  <a:pt x="537554" y="298061"/>
                  <a:pt x="563483" y="320286"/>
                  <a:pt x="568775" y="280069"/>
                </a:cubicBezTo>
                <a:cubicBezTo>
                  <a:pt x="574067" y="239852"/>
                  <a:pt x="567717" y="130844"/>
                  <a:pt x="546550" y="89569"/>
                </a:cubicBezTo>
                <a:cubicBezTo>
                  <a:pt x="525383" y="48294"/>
                  <a:pt x="476171" y="47236"/>
                  <a:pt x="441775" y="32419"/>
                </a:cubicBezTo>
                <a:cubicBezTo>
                  <a:pt x="407379" y="17602"/>
                  <a:pt x="368221" y="-4093"/>
                  <a:pt x="340175" y="669"/>
                </a:cubicBezTo>
                <a:cubicBezTo>
                  <a:pt x="312129" y="5431"/>
                  <a:pt x="262917" y="61523"/>
                  <a:pt x="232225" y="64169"/>
                </a:cubicBezTo>
                <a:close/>
              </a:path>
            </a:pathLst>
          </a:custGeom>
          <a:noFill/>
          <a:ln w="3175">
            <a:solidFill>
              <a:srgbClr val="CAC4C4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等腰三角形 36"/>
          <p:cNvSpPr/>
          <p:nvPr/>
        </p:nvSpPr>
        <p:spPr>
          <a:xfrm rot="5596841">
            <a:off x="3000924" y="3082466"/>
            <a:ext cx="69143" cy="70329"/>
          </a:xfrm>
          <a:prstGeom prst="triangle">
            <a:avLst/>
          </a:prstGeom>
          <a:solidFill>
            <a:srgbClr val="FFFF00"/>
          </a:solidFill>
          <a:ln w="1270">
            <a:solidFill>
              <a:srgbClr val="15151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任意多边形: 形状 37"/>
          <p:cNvSpPr/>
          <p:nvPr/>
        </p:nvSpPr>
        <p:spPr>
          <a:xfrm>
            <a:off x="478729" y="3711732"/>
            <a:ext cx="572969" cy="603084"/>
          </a:xfrm>
          <a:custGeom>
            <a:avLst/>
            <a:gdLst>
              <a:gd name="connsiteX0" fmla="*/ 229689 w 534512"/>
              <a:gd name="connsiteY0" fmla="*/ 102788 h 603084"/>
              <a:gd name="connsiteX1" fmla="*/ 98720 w 534512"/>
              <a:gd name="connsiteY1" fmla="*/ 69451 h 603084"/>
              <a:gd name="connsiteX2" fmla="*/ 12995 w 534512"/>
              <a:gd name="connsiteY2" fmla="*/ 128982 h 603084"/>
              <a:gd name="connsiteX3" fmla="*/ 1089 w 534512"/>
              <a:gd name="connsiteY3" fmla="*/ 288526 h 603084"/>
              <a:gd name="connsiteX4" fmla="*/ 15376 w 534512"/>
              <a:gd name="connsiteY4" fmla="*/ 429019 h 603084"/>
              <a:gd name="connsiteX5" fmla="*/ 132057 w 534512"/>
              <a:gd name="connsiteY5" fmla="*/ 576657 h 603084"/>
              <a:gd name="connsiteX6" fmla="*/ 177301 w 534512"/>
              <a:gd name="connsiteY6" fmla="*/ 569513 h 603084"/>
              <a:gd name="connsiteX7" fmla="*/ 251120 w 534512"/>
              <a:gd name="connsiteY7" fmla="*/ 602851 h 603084"/>
              <a:gd name="connsiteX8" fmla="*/ 401139 w 534512"/>
              <a:gd name="connsiteY8" fmla="*/ 579038 h 603084"/>
              <a:gd name="connsiteX9" fmla="*/ 494007 w 534512"/>
              <a:gd name="connsiteY9" fmla="*/ 488551 h 603084"/>
              <a:gd name="connsiteX10" fmla="*/ 534489 w 534512"/>
              <a:gd name="connsiteY10" fmla="*/ 293288 h 603084"/>
              <a:gd name="connsiteX11" fmla="*/ 489245 w 534512"/>
              <a:gd name="connsiteY11" fmla="*/ 167082 h 603084"/>
              <a:gd name="connsiteX12" fmla="*/ 446382 w 534512"/>
              <a:gd name="connsiteY12" fmla="*/ 76594 h 603084"/>
              <a:gd name="connsiteX13" fmla="*/ 372564 w 534512"/>
              <a:gd name="connsiteY13" fmla="*/ 26588 h 603084"/>
              <a:gd name="connsiteX14" fmla="*/ 315414 w 534512"/>
              <a:gd name="connsiteY14" fmla="*/ 394 h 603084"/>
              <a:gd name="connsiteX15" fmla="*/ 255882 w 534512"/>
              <a:gd name="connsiteY15" fmla="*/ 45638 h 603084"/>
              <a:gd name="connsiteX16" fmla="*/ 229689 w 534512"/>
              <a:gd name="connsiteY16" fmla="*/ 102788 h 6030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534512" h="603084">
                <a:moveTo>
                  <a:pt x="229689" y="102788"/>
                </a:moveTo>
                <a:cubicBezTo>
                  <a:pt x="203495" y="106757"/>
                  <a:pt x="134836" y="65085"/>
                  <a:pt x="98720" y="69451"/>
                </a:cubicBezTo>
                <a:cubicBezTo>
                  <a:pt x="62604" y="73817"/>
                  <a:pt x="29267" y="92470"/>
                  <a:pt x="12995" y="128982"/>
                </a:cubicBezTo>
                <a:cubicBezTo>
                  <a:pt x="-3277" y="165494"/>
                  <a:pt x="692" y="238520"/>
                  <a:pt x="1089" y="288526"/>
                </a:cubicBezTo>
                <a:cubicBezTo>
                  <a:pt x="1486" y="338532"/>
                  <a:pt x="-6452" y="380997"/>
                  <a:pt x="15376" y="429019"/>
                </a:cubicBezTo>
                <a:cubicBezTo>
                  <a:pt x="37204" y="477041"/>
                  <a:pt x="105069" y="553241"/>
                  <a:pt x="132057" y="576657"/>
                </a:cubicBezTo>
                <a:cubicBezTo>
                  <a:pt x="159044" y="600073"/>
                  <a:pt x="157457" y="565147"/>
                  <a:pt x="177301" y="569513"/>
                </a:cubicBezTo>
                <a:cubicBezTo>
                  <a:pt x="197145" y="573879"/>
                  <a:pt x="213814" y="601264"/>
                  <a:pt x="251120" y="602851"/>
                </a:cubicBezTo>
                <a:cubicBezTo>
                  <a:pt x="288426" y="604439"/>
                  <a:pt x="360658" y="598088"/>
                  <a:pt x="401139" y="579038"/>
                </a:cubicBezTo>
                <a:cubicBezTo>
                  <a:pt x="441620" y="559988"/>
                  <a:pt x="471782" y="536176"/>
                  <a:pt x="494007" y="488551"/>
                </a:cubicBezTo>
                <a:cubicBezTo>
                  <a:pt x="516232" y="440926"/>
                  <a:pt x="535283" y="346866"/>
                  <a:pt x="534489" y="293288"/>
                </a:cubicBezTo>
                <a:cubicBezTo>
                  <a:pt x="533695" y="239710"/>
                  <a:pt x="503930" y="203198"/>
                  <a:pt x="489245" y="167082"/>
                </a:cubicBezTo>
                <a:cubicBezTo>
                  <a:pt x="474561" y="130966"/>
                  <a:pt x="465829" y="100010"/>
                  <a:pt x="446382" y="76594"/>
                </a:cubicBezTo>
                <a:cubicBezTo>
                  <a:pt x="426935" y="53178"/>
                  <a:pt x="394392" y="39288"/>
                  <a:pt x="372564" y="26588"/>
                </a:cubicBezTo>
                <a:cubicBezTo>
                  <a:pt x="350736" y="13888"/>
                  <a:pt x="334861" y="-2781"/>
                  <a:pt x="315414" y="394"/>
                </a:cubicBezTo>
                <a:cubicBezTo>
                  <a:pt x="295967" y="3569"/>
                  <a:pt x="271757" y="28969"/>
                  <a:pt x="255882" y="45638"/>
                </a:cubicBezTo>
                <a:cubicBezTo>
                  <a:pt x="240007" y="62307"/>
                  <a:pt x="255883" y="98819"/>
                  <a:pt x="229689" y="102788"/>
                </a:cubicBezTo>
                <a:close/>
              </a:path>
            </a:pathLst>
          </a:custGeom>
          <a:noFill/>
          <a:ln w="3175">
            <a:solidFill>
              <a:srgbClr val="CAC4C4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椭圆 38"/>
          <p:cNvSpPr/>
          <p:nvPr/>
        </p:nvSpPr>
        <p:spPr>
          <a:xfrm rot="1765386">
            <a:off x="731309" y="3968169"/>
            <a:ext cx="124701" cy="134477"/>
          </a:xfrm>
          <a:prstGeom prst="ellipse">
            <a:avLst/>
          </a:prstGeom>
          <a:noFill/>
          <a:ln w="317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等腰三角形 39"/>
          <p:cNvSpPr/>
          <p:nvPr/>
        </p:nvSpPr>
        <p:spPr>
          <a:xfrm rot="14376074">
            <a:off x="1001615" y="3886623"/>
            <a:ext cx="69143" cy="70329"/>
          </a:xfrm>
          <a:prstGeom prst="triangle">
            <a:avLst/>
          </a:prstGeom>
          <a:solidFill>
            <a:srgbClr val="FFFF00"/>
          </a:solidFill>
          <a:ln w="1270">
            <a:solidFill>
              <a:srgbClr val="15151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椭圆 40"/>
          <p:cNvSpPr/>
          <p:nvPr/>
        </p:nvSpPr>
        <p:spPr>
          <a:xfrm rot="1765386">
            <a:off x="877006" y="3922069"/>
            <a:ext cx="124701" cy="134477"/>
          </a:xfrm>
          <a:prstGeom prst="ellipse">
            <a:avLst/>
          </a:prstGeom>
          <a:noFill/>
          <a:ln w="317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椭圆 41"/>
          <p:cNvSpPr/>
          <p:nvPr/>
        </p:nvSpPr>
        <p:spPr>
          <a:xfrm rot="1765386">
            <a:off x="838081" y="4074273"/>
            <a:ext cx="124701" cy="134477"/>
          </a:xfrm>
          <a:prstGeom prst="ellipse">
            <a:avLst/>
          </a:prstGeom>
          <a:noFill/>
          <a:ln w="317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等腰三角形 42"/>
          <p:cNvSpPr/>
          <p:nvPr/>
        </p:nvSpPr>
        <p:spPr>
          <a:xfrm rot="14376074">
            <a:off x="968044" y="4040552"/>
            <a:ext cx="69143" cy="70329"/>
          </a:xfrm>
          <a:prstGeom prst="triangle">
            <a:avLst/>
          </a:prstGeom>
          <a:solidFill>
            <a:srgbClr val="FFFF00"/>
          </a:solidFill>
          <a:ln w="1270">
            <a:solidFill>
              <a:srgbClr val="15151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等腰三角形 43"/>
          <p:cNvSpPr/>
          <p:nvPr/>
        </p:nvSpPr>
        <p:spPr>
          <a:xfrm rot="14376074">
            <a:off x="659214" y="3944677"/>
            <a:ext cx="69143" cy="70329"/>
          </a:xfrm>
          <a:prstGeom prst="triangle">
            <a:avLst/>
          </a:prstGeom>
          <a:solidFill>
            <a:srgbClr val="FFFF00"/>
          </a:solidFill>
          <a:ln w="1270">
            <a:solidFill>
              <a:srgbClr val="15151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任意多边形: 形状 44"/>
          <p:cNvSpPr/>
          <p:nvPr/>
        </p:nvSpPr>
        <p:spPr>
          <a:xfrm>
            <a:off x="1234033" y="3682993"/>
            <a:ext cx="571168" cy="617813"/>
          </a:xfrm>
          <a:custGeom>
            <a:avLst/>
            <a:gdLst>
              <a:gd name="connsiteX0" fmla="*/ 210880 w 532832"/>
              <a:gd name="connsiteY0" fmla="*/ 141052 h 617813"/>
              <a:gd name="connsiteX1" fmla="*/ 208498 w 532832"/>
              <a:gd name="connsiteY1" fmla="*/ 45802 h 617813"/>
              <a:gd name="connsiteX2" fmla="*/ 194211 w 532832"/>
              <a:gd name="connsiteY2" fmla="*/ 558 h 617813"/>
              <a:gd name="connsiteX3" fmla="*/ 79911 w 532832"/>
              <a:gd name="connsiteY3" fmla="*/ 74377 h 617813"/>
              <a:gd name="connsiteX4" fmla="*/ 6092 w 532832"/>
              <a:gd name="connsiteY4" fmla="*/ 248208 h 617813"/>
              <a:gd name="connsiteX5" fmla="*/ 15617 w 532832"/>
              <a:gd name="connsiteY5" fmla="*/ 362508 h 617813"/>
              <a:gd name="connsiteX6" fmla="*/ 106105 w 532832"/>
              <a:gd name="connsiteY6" fmla="*/ 550627 h 617813"/>
              <a:gd name="connsiteX7" fmla="*/ 256123 w 532832"/>
              <a:gd name="connsiteY7" fmla="*/ 617302 h 617813"/>
              <a:gd name="connsiteX8" fmla="*/ 339467 w 532832"/>
              <a:gd name="connsiteY8" fmla="*/ 522052 h 617813"/>
              <a:gd name="connsiteX9" fmla="*/ 291842 w 532832"/>
              <a:gd name="connsiteY9" fmla="*/ 429183 h 617813"/>
              <a:gd name="connsiteX10" fmla="*/ 346611 w 532832"/>
              <a:gd name="connsiteY10" fmla="*/ 386321 h 617813"/>
              <a:gd name="connsiteX11" fmla="*/ 460911 w 532832"/>
              <a:gd name="connsiteY11" fmla="*/ 519671 h 617813"/>
              <a:gd name="connsiteX12" fmla="*/ 529967 w 532832"/>
              <a:gd name="connsiteY12" fmla="*/ 350602 h 617813"/>
              <a:gd name="connsiteX13" fmla="*/ 506155 w 532832"/>
              <a:gd name="connsiteY13" fmla="*/ 188677 h 617813"/>
              <a:gd name="connsiteX14" fmla="*/ 384711 w 532832"/>
              <a:gd name="connsiteY14" fmla="*/ 60090 h 617813"/>
              <a:gd name="connsiteX15" fmla="*/ 275173 w 532832"/>
              <a:gd name="connsiteY15" fmla="*/ 52946 h 617813"/>
              <a:gd name="connsiteX16" fmla="*/ 210880 w 532832"/>
              <a:gd name="connsiteY16" fmla="*/ 141052 h 61781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532832" h="617813">
                <a:moveTo>
                  <a:pt x="210880" y="141052"/>
                </a:moveTo>
                <a:cubicBezTo>
                  <a:pt x="199767" y="139861"/>
                  <a:pt x="211276" y="69218"/>
                  <a:pt x="208498" y="45802"/>
                </a:cubicBezTo>
                <a:cubicBezTo>
                  <a:pt x="205720" y="22386"/>
                  <a:pt x="215642" y="-4204"/>
                  <a:pt x="194211" y="558"/>
                </a:cubicBezTo>
                <a:cubicBezTo>
                  <a:pt x="172780" y="5320"/>
                  <a:pt x="111264" y="33102"/>
                  <a:pt x="79911" y="74377"/>
                </a:cubicBezTo>
                <a:cubicBezTo>
                  <a:pt x="48558" y="115652"/>
                  <a:pt x="16808" y="200186"/>
                  <a:pt x="6092" y="248208"/>
                </a:cubicBezTo>
                <a:cubicBezTo>
                  <a:pt x="-4624" y="296230"/>
                  <a:pt x="-1052" y="312105"/>
                  <a:pt x="15617" y="362508"/>
                </a:cubicBezTo>
                <a:cubicBezTo>
                  <a:pt x="32286" y="412911"/>
                  <a:pt x="66021" y="508161"/>
                  <a:pt x="106105" y="550627"/>
                </a:cubicBezTo>
                <a:cubicBezTo>
                  <a:pt x="146189" y="593093"/>
                  <a:pt x="217229" y="622064"/>
                  <a:pt x="256123" y="617302"/>
                </a:cubicBezTo>
                <a:cubicBezTo>
                  <a:pt x="295017" y="612540"/>
                  <a:pt x="333514" y="553405"/>
                  <a:pt x="339467" y="522052"/>
                </a:cubicBezTo>
                <a:cubicBezTo>
                  <a:pt x="345420" y="490699"/>
                  <a:pt x="290651" y="451805"/>
                  <a:pt x="291842" y="429183"/>
                </a:cubicBezTo>
                <a:cubicBezTo>
                  <a:pt x="293033" y="406561"/>
                  <a:pt x="318433" y="371240"/>
                  <a:pt x="346611" y="386321"/>
                </a:cubicBezTo>
                <a:cubicBezTo>
                  <a:pt x="374789" y="401402"/>
                  <a:pt x="430352" y="525624"/>
                  <a:pt x="460911" y="519671"/>
                </a:cubicBezTo>
                <a:cubicBezTo>
                  <a:pt x="491470" y="513718"/>
                  <a:pt x="522426" y="405768"/>
                  <a:pt x="529967" y="350602"/>
                </a:cubicBezTo>
                <a:cubicBezTo>
                  <a:pt x="537508" y="295436"/>
                  <a:pt x="530364" y="237096"/>
                  <a:pt x="506155" y="188677"/>
                </a:cubicBezTo>
                <a:cubicBezTo>
                  <a:pt x="481946" y="140258"/>
                  <a:pt x="423208" y="82712"/>
                  <a:pt x="384711" y="60090"/>
                </a:cubicBezTo>
                <a:cubicBezTo>
                  <a:pt x="346214" y="37468"/>
                  <a:pt x="303351" y="42230"/>
                  <a:pt x="275173" y="52946"/>
                </a:cubicBezTo>
                <a:cubicBezTo>
                  <a:pt x="246995" y="63661"/>
                  <a:pt x="221993" y="142243"/>
                  <a:pt x="210880" y="141052"/>
                </a:cubicBezTo>
                <a:close/>
              </a:path>
            </a:pathLst>
          </a:custGeom>
          <a:noFill/>
          <a:ln w="3175">
            <a:solidFill>
              <a:srgbClr val="CAC4C4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6" name="椭圆 45"/>
          <p:cNvSpPr/>
          <p:nvPr/>
        </p:nvSpPr>
        <p:spPr>
          <a:xfrm rot="1765386">
            <a:off x="1655533" y="3836201"/>
            <a:ext cx="124701" cy="134477"/>
          </a:xfrm>
          <a:prstGeom prst="ellipse">
            <a:avLst/>
          </a:prstGeom>
          <a:noFill/>
          <a:ln w="317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等腰三角形 46"/>
          <p:cNvSpPr/>
          <p:nvPr/>
        </p:nvSpPr>
        <p:spPr>
          <a:xfrm rot="14376074">
            <a:off x="1583439" y="3812709"/>
            <a:ext cx="69143" cy="70329"/>
          </a:xfrm>
          <a:prstGeom prst="triangle">
            <a:avLst/>
          </a:prstGeom>
          <a:solidFill>
            <a:srgbClr val="FFFF00"/>
          </a:solidFill>
          <a:ln w="1270">
            <a:solidFill>
              <a:srgbClr val="15151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椭圆 47"/>
          <p:cNvSpPr/>
          <p:nvPr/>
        </p:nvSpPr>
        <p:spPr>
          <a:xfrm rot="1765386">
            <a:off x="1557183" y="3907252"/>
            <a:ext cx="77628" cy="80919"/>
          </a:xfrm>
          <a:prstGeom prst="ellipse">
            <a:avLst/>
          </a:prstGeom>
          <a:noFill/>
          <a:ln w="317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等腰三角形 50"/>
          <p:cNvSpPr/>
          <p:nvPr/>
        </p:nvSpPr>
        <p:spPr>
          <a:xfrm rot="14376074">
            <a:off x="1476367" y="3874554"/>
            <a:ext cx="69143" cy="70329"/>
          </a:xfrm>
          <a:prstGeom prst="triangle">
            <a:avLst/>
          </a:prstGeom>
          <a:solidFill>
            <a:srgbClr val="FFFF00"/>
          </a:solidFill>
          <a:ln w="1270">
            <a:solidFill>
              <a:srgbClr val="15151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任意多边形: 形状 51"/>
          <p:cNvSpPr/>
          <p:nvPr/>
        </p:nvSpPr>
        <p:spPr>
          <a:xfrm>
            <a:off x="1931002" y="3681219"/>
            <a:ext cx="587446" cy="587477"/>
          </a:xfrm>
          <a:custGeom>
            <a:avLst/>
            <a:gdLst>
              <a:gd name="connsiteX0" fmla="*/ 177434 w 548017"/>
              <a:gd name="connsiteY0" fmla="*/ 57101 h 587477"/>
              <a:gd name="connsiteX1" fmla="*/ 110759 w 548017"/>
              <a:gd name="connsiteY1" fmla="*/ 78532 h 587477"/>
              <a:gd name="connsiteX2" fmla="*/ 77422 w 548017"/>
              <a:gd name="connsiteY2" fmla="*/ 19001 h 587477"/>
              <a:gd name="connsiteX3" fmla="*/ 25034 w 548017"/>
              <a:gd name="connsiteY3" fmla="*/ 16620 h 587477"/>
              <a:gd name="connsiteX4" fmla="*/ 1222 w 548017"/>
              <a:gd name="connsiteY4" fmla="*/ 219026 h 587477"/>
              <a:gd name="connsiteX5" fmla="*/ 60753 w 548017"/>
              <a:gd name="connsiteY5" fmla="*/ 357139 h 587477"/>
              <a:gd name="connsiteX6" fmla="*/ 125047 w 548017"/>
              <a:gd name="connsiteY6" fmla="*/ 488107 h 587477"/>
              <a:gd name="connsiteX7" fmla="*/ 296497 w 548017"/>
              <a:gd name="connsiteY7" fmla="*/ 583357 h 587477"/>
              <a:gd name="connsiteX8" fmla="*/ 320309 w 548017"/>
              <a:gd name="connsiteY8" fmla="*/ 530970 h 587477"/>
              <a:gd name="connsiteX9" fmla="*/ 341741 w 548017"/>
              <a:gd name="connsiteY9" fmla="*/ 583357 h 587477"/>
              <a:gd name="connsiteX10" fmla="*/ 467947 w 548017"/>
              <a:gd name="connsiteY10" fmla="*/ 554782 h 587477"/>
              <a:gd name="connsiteX11" fmla="*/ 546528 w 548017"/>
              <a:gd name="connsiteY11" fmla="*/ 323801 h 587477"/>
              <a:gd name="connsiteX12" fmla="*/ 513191 w 548017"/>
              <a:gd name="connsiteY12" fmla="*/ 173782 h 587477"/>
              <a:gd name="connsiteX13" fmla="*/ 436991 w 548017"/>
              <a:gd name="connsiteY13" fmla="*/ 111870 h 587477"/>
              <a:gd name="connsiteX14" fmla="*/ 479853 w 548017"/>
              <a:gd name="connsiteY14" fmla="*/ 88057 h 587477"/>
              <a:gd name="connsiteX15" fmla="*/ 453659 w 548017"/>
              <a:gd name="connsiteY15" fmla="*/ 47576 h 587477"/>
              <a:gd name="connsiteX16" fmla="*/ 336978 w 548017"/>
              <a:gd name="connsiteY16" fmla="*/ 80914 h 587477"/>
              <a:gd name="connsiteX17" fmla="*/ 241728 w 548017"/>
              <a:gd name="connsiteY17" fmla="*/ 80914 h 587477"/>
              <a:gd name="connsiteX18" fmla="*/ 210772 w 548017"/>
              <a:gd name="connsiteY18" fmla="*/ 11857 h 587477"/>
              <a:gd name="connsiteX19" fmla="*/ 177434 w 548017"/>
              <a:gd name="connsiteY19" fmla="*/ 57101 h 5874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</a:cxnLst>
            <a:rect l="l" t="t" r="r" b="b"/>
            <a:pathLst>
              <a:path w="548017" h="587477">
                <a:moveTo>
                  <a:pt x="177434" y="57101"/>
                </a:moveTo>
                <a:cubicBezTo>
                  <a:pt x="160765" y="68213"/>
                  <a:pt x="127428" y="84882"/>
                  <a:pt x="110759" y="78532"/>
                </a:cubicBezTo>
                <a:cubicBezTo>
                  <a:pt x="94090" y="72182"/>
                  <a:pt x="91709" y="29320"/>
                  <a:pt x="77422" y="19001"/>
                </a:cubicBezTo>
                <a:cubicBezTo>
                  <a:pt x="63135" y="8682"/>
                  <a:pt x="37734" y="-16718"/>
                  <a:pt x="25034" y="16620"/>
                </a:cubicBezTo>
                <a:cubicBezTo>
                  <a:pt x="12334" y="49957"/>
                  <a:pt x="-4731" y="162273"/>
                  <a:pt x="1222" y="219026"/>
                </a:cubicBezTo>
                <a:cubicBezTo>
                  <a:pt x="7175" y="275779"/>
                  <a:pt x="40115" y="312292"/>
                  <a:pt x="60753" y="357139"/>
                </a:cubicBezTo>
                <a:cubicBezTo>
                  <a:pt x="81391" y="401986"/>
                  <a:pt x="85756" y="450404"/>
                  <a:pt x="125047" y="488107"/>
                </a:cubicBezTo>
                <a:cubicBezTo>
                  <a:pt x="164338" y="525810"/>
                  <a:pt x="263953" y="576213"/>
                  <a:pt x="296497" y="583357"/>
                </a:cubicBezTo>
                <a:cubicBezTo>
                  <a:pt x="329041" y="590501"/>
                  <a:pt x="312768" y="530970"/>
                  <a:pt x="320309" y="530970"/>
                </a:cubicBezTo>
                <a:cubicBezTo>
                  <a:pt x="327850" y="530970"/>
                  <a:pt x="317135" y="579388"/>
                  <a:pt x="341741" y="583357"/>
                </a:cubicBezTo>
                <a:cubicBezTo>
                  <a:pt x="366347" y="587326"/>
                  <a:pt x="433816" y="598041"/>
                  <a:pt x="467947" y="554782"/>
                </a:cubicBezTo>
                <a:cubicBezTo>
                  <a:pt x="502078" y="511523"/>
                  <a:pt x="538987" y="387301"/>
                  <a:pt x="546528" y="323801"/>
                </a:cubicBezTo>
                <a:cubicBezTo>
                  <a:pt x="554069" y="260301"/>
                  <a:pt x="531447" y="209104"/>
                  <a:pt x="513191" y="173782"/>
                </a:cubicBezTo>
                <a:cubicBezTo>
                  <a:pt x="494935" y="138460"/>
                  <a:pt x="442547" y="126158"/>
                  <a:pt x="436991" y="111870"/>
                </a:cubicBezTo>
                <a:cubicBezTo>
                  <a:pt x="431435" y="97582"/>
                  <a:pt x="477075" y="98773"/>
                  <a:pt x="479853" y="88057"/>
                </a:cubicBezTo>
                <a:cubicBezTo>
                  <a:pt x="482631" y="77341"/>
                  <a:pt x="477471" y="48766"/>
                  <a:pt x="453659" y="47576"/>
                </a:cubicBezTo>
                <a:cubicBezTo>
                  <a:pt x="429847" y="46386"/>
                  <a:pt x="372300" y="75358"/>
                  <a:pt x="336978" y="80914"/>
                </a:cubicBezTo>
                <a:cubicBezTo>
                  <a:pt x="301656" y="86470"/>
                  <a:pt x="262762" y="92423"/>
                  <a:pt x="241728" y="80914"/>
                </a:cubicBezTo>
                <a:cubicBezTo>
                  <a:pt x="220694" y="69405"/>
                  <a:pt x="223075" y="15032"/>
                  <a:pt x="210772" y="11857"/>
                </a:cubicBezTo>
                <a:cubicBezTo>
                  <a:pt x="198469" y="8682"/>
                  <a:pt x="194103" y="45989"/>
                  <a:pt x="177434" y="57101"/>
                </a:cubicBezTo>
                <a:close/>
              </a:path>
            </a:pathLst>
          </a:custGeom>
          <a:noFill/>
          <a:ln w="3175">
            <a:solidFill>
              <a:srgbClr val="CAC4C4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3" name="椭圆 52"/>
          <p:cNvSpPr/>
          <p:nvPr/>
        </p:nvSpPr>
        <p:spPr>
          <a:xfrm rot="1765386">
            <a:off x="1956584" y="3749060"/>
            <a:ext cx="124701" cy="134477"/>
          </a:xfrm>
          <a:prstGeom prst="ellipse">
            <a:avLst/>
          </a:prstGeom>
          <a:noFill/>
          <a:ln w="317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等腰三角形 53"/>
          <p:cNvSpPr/>
          <p:nvPr/>
        </p:nvSpPr>
        <p:spPr>
          <a:xfrm rot="14376074">
            <a:off x="2086106" y="3740411"/>
            <a:ext cx="69143" cy="70329"/>
          </a:xfrm>
          <a:prstGeom prst="triangle">
            <a:avLst/>
          </a:prstGeom>
          <a:solidFill>
            <a:srgbClr val="FFFF00"/>
          </a:solidFill>
          <a:ln w="1270">
            <a:solidFill>
              <a:srgbClr val="15151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任意多边形: 形状 55"/>
          <p:cNvSpPr/>
          <p:nvPr/>
        </p:nvSpPr>
        <p:spPr>
          <a:xfrm>
            <a:off x="2639414" y="3718719"/>
            <a:ext cx="621465" cy="576787"/>
          </a:xfrm>
          <a:custGeom>
            <a:avLst/>
            <a:gdLst>
              <a:gd name="connsiteX0" fmla="*/ 209514 w 579753"/>
              <a:gd name="connsiteY0" fmla="*/ 107707 h 576787"/>
              <a:gd name="connsiteX1" fmla="*/ 242852 w 579753"/>
              <a:gd name="connsiteY1" fmla="*/ 45795 h 576787"/>
              <a:gd name="connsiteX2" fmla="*/ 242852 w 579753"/>
              <a:gd name="connsiteY2" fmla="*/ 7695 h 576787"/>
              <a:gd name="connsiteX3" fmla="*/ 135695 w 579753"/>
              <a:gd name="connsiteY3" fmla="*/ 67226 h 576787"/>
              <a:gd name="connsiteX4" fmla="*/ 4727 w 579753"/>
              <a:gd name="connsiteY4" fmla="*/ 164857 h 576787"/>
              <a:gd name="connsiteX5" fmla="*/ 33302 w 579753"/>
              <a:gd name="connsiteY5" fmla="*/ 350595 h 576787"/>
              <a:gd name="connsiteX6" fmla="*/ 76164 w 579753"/>
              <a:gd name="connsiteY6" fmla="*/ 467276 h 576787"/>
              <a:gd name="connsiteX7" fmla="*/ 192845 w 579753"/>
              <a:gd name="connsiteY7" fmla="*/ 548239 h 576787"/>
              <a:gd name="connsiteX8" fmla="*/ 311908 w 579753"/>
              <a:gd name="connsiteY8" fmla="*/ 574432 h 576787"/>
              <a:gd name="connsiteX9" fmla="*/ 371439 w 579753"/>
              <a:gd name="connsiteY9" fmla="*/ 495851 h 576787"/>
              <a:gd name="connsiteX10" fmla="*/ 466689 w 579753"/>
              <a:gd name="connsiteY10" fmla="*/ 507757 h 576787"/>
              <a:gd name="connsiteX11" fmla="*/ 550033 w 579753"/>
              <a:gd name="connsiteY11" fmla="*/ 407745 h 576787"/>
              <a:gd name="connsiteX12" fmla="*/ 578608 w 579753"/>
              <a:gd name="connsiteY12" fmla="*/ 217245 h 576787"/>
              <a:gd name="connsiteX13" fmla="*/ 516695 w 579753"/>
              <a:gd name="connsiteY13" fmla="*/ 81514 h 576787"/>
              <a:gd name="connsiteX14" fmla="*/ 411920 w 579753"/>
              <a:gd name="connsiteY14" fmla="*/ 7695 h 576787"/>
              <a:gd name="connsiteX15" fmla="*/ 335720 w 579753"/>
              <a:gd name="connsiteY15" fmla="*/ 10076 h 576787"/>
              <a:gd name="connsiteX16" fmla="*/ 302383 w 579753"/>
              <a:gd name="connsiteY16" fmla="*/ 76751 h 576787"/>
              <a:gd name="connsiteX17" fmla="*/ 273808 w 579753"/>
              <a:gd name="connsiteY17" fmla="*/ 45795 h 576787"/>
              <a:gd name="connsiteX18" fmla="*/ 288095 w 579753"/>
              <a:gd name="connsiteY18" fmla="*/ 2932 h 576787"/>
              <a:gd name="connsiteX19" fmla="*/ 254758 w 579753"/>
              <a:gd name="connsiteY19" fmla="*/ 29126 h 576787"/>
              <a:gd name="connsiteX20" fmla="*/ 209514 w 579753"/>
              <a:gd name="connsiteY20" fmla="*/ 107707 h 5767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579753" h="576787">
                <a:moveTo>
                  <a:pt x="209514" y="107707"/>
                </a:moveTo>
                <a:cubicBezTo>
                  <a:pt x="207530" y="110485"/>
                  <a:pt x="237296" y="62464"/>
                  <a:pt x="242852" y="45795"/>
                </a:cubicBezTo>
                <a:cubicBezTo>
                  <a:pt x="248408" y="29126"/>
                  <a:pt x="260711" y="4123"/>
                  <a:pt x="242852" y="7695"/>
                </a:cubicBezTo>
                <a:cubicBezTo>
                  <a:pt x="224993" y="11267"/>
                  <a:pt x="175382" y="41032"/>
                  <a:pt x="135695" y="67226"/>
                </a:cubicBezTo>
                <a:cubicBezTo>
                  <a:pt x="96007" y="93420"/>
                  <a:pt x="21792" y="117629"/>
                  <a:pt x="4727" y="164857"/>
                </a:cubicBezTo>
                <a:cubicBezTo>
                  <a:pt x="-12339" y="212085"/>
                  <a:pt x="21396" y="300192"/>
                  <a:pt x="33302" y="350595"/>
                </a:cubicBezTo>
                <a:cubicBezTo>
                  <a:pt x="45208" y="400998"/>
                  <a:pt x="49574" y="434335"/>
                  <a:pt x="76164" y="467276"/>
                </a:cubicBezTo>
                <a:cubicBezTo>
                  <a:pt x="102754" y="500217"/>
                  <a:pt x="153554" y="530380"/>
                  <a:pt x="192845" y="548239"/>
                </a:cubicBezTo>
                <a:cubicBezTo>
                  <a:pt x="232136" y="566098"/>
                  <a:pt x="282142" y="583163"/>
                  <a:pt x="311908" y="574432"/>
                </a:cubicBezTo>
                <a:cubicBezTo>
                  <a:pt x="341674" y="565701"/>
                  <a:pt x="345642" y="506963"/>
                  <a:pt x="371439" y="495851"/>
                </a:cubicBezTo>
                <a:cubicBezTo>
                  <a:pt x="397236" y="484739"/>
                  <a:pt x="436923" y="522441"/>
                  <a:pt x="466689" y="507757"/>
                </a:cubicBezTo>
                <a:cubicBezTo>
                  <a:pt x="496455" y="493073"/>
                  <a:pt x="531380" y="456164"/>
                  <a:pt x="550033" y="407745"/>
                </a:cubicBezTo>
                <a:cubicBezTo>
                  <a:pt x="568686" y="359326"/>
                  <a:pt x="584164" y="271617"/>
                  <a:pt x="578608" y="217245"/>
                </a:cubicBezTo>
                <a:cubicBezTo>
                  <a:pt x="573052" y="162873"/>
                  <a:pt x="544476" y="116439"/>
                  <a:pt x="516695" y="81514"/>
                </a:cubicBezTo>
                <a:cubicBezTo>
                  <a:pt x="488914" y="46589"/>
                  <a:pt x="442082" y="19601"/>
                  <a:pt x="411920" y="7695"/>
                </a:cubicBezTo>
                <a:cubicBezTo>
                  <a:pt x="381758" y="-4211"/>
                  <a:pt x="353976" y="-1433"/>
                  <a:pt x="335720" y="10076"/>
                </a:cubicBezTo>
                <a:cubicBezTo>
                  <a:pt x="317464" y="21585"/>
                  <a:pt x="312702" y="70798"/>
                  <a:pt x="302383" y="76751"/>
                </a:cubicBezTo>
                <a:cubicBezTo>
                  <a:pt x="292064" y="82704"/>
                  <a:pt x="276189" y="58098"/>
                  <a:pt x="273808" y="45795"/>
                </a:cubicBezTo>
                <a:cubicBezTo>
                  <a:pt x="271427" y="33492"/>
                  <a:pt x="291270" y="5710"/>
                  <a:pt x="288095" y="2932"/>
                </a:cubicBezTo>
                <a:cubicBezTo>
                  <a:pt x="284920" y="154"/>
                  <a:pt x="265870" y="11664"/>
                  <a:pt x="254758" y="29126"/>
                </a:cubicBezTo>
                <a:cubicBezTo>
                  <a:pt x="243646" y="46588"/>
                  <a:pt x="211498" y="104929"/>
                  <a:pt x="209514" y="107707"/>
                </a:cubicBezTo>
                <a:close/>
              </a:path>
            </a:pathLst>
          </a:custGeom>
          <a:noFill/>
          <a:ln w="3175">
            <a:solidFill>
              <a:srgbClr val="CAC4C4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7" name="椭圆 76"/>
          <p:cNvSpPr/>
          <p:nvPr/>
        </p:nvSpPr>
        <p:spPr>
          <a:xfrm rot="1765386">
            <a:off x="3051521" y="4562984"/>
            <a:ext cx="95227" cy="86353"/>
          </a:xfrm>
          <a:prstGeom prst="ellipse">
            <a:avLst/>
          </a:prstGeom>
          <a:noFill/>
          <a:ln w="317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等腰三角形 77"/>
          <p:cNvSpPr/>
          <p:nvPr/>
        </p:nvSpPr>
        <p:spPr>
          <a:xfrm rot="14376074">
            <a:off x="2490547" y="4643433"/>
            <a:ext cx="69143" cy="70329"/>
          </a:xfrm>
          <a:prstGeom prst="triangle">
            <a:avLst/>
          </a:prstGeom>
          <a:solidFill>
            <a:srgbClr val="FFFF00"/>
          </a:solidFill>
          <a:ln w="1270">
            <a:solidFill>
              <a:srgbClr val="15151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任意多边形: 形状 83"/>
          <p:cNvSpPr/>
          <p:nvPr/>
        </p:nvSpPr>
        <p:spPr>
          <a:xfrm>
            <a:off x="2662065" y="4421612"/>
            <a:ext cx="625715" cy="580033"/>
          </a:xfrm>
          <a:custGeom>
            <a:avLst/>
            <a:gdLst>
              <a:gd name="connsiteX0" fmla="*/ 207434 w 583717"/>
              <a:gd name="connsiteY0" fmla="*/ 97758 h 580033"/>
              <a:gd name="connsiteX1" fmla="*/ 124090 w 583717"/>
              <a:gd name="connsiteY1" fmla="*/ 119189 h 580033"/>
              <a:gd name="connsiteX2" fmla="*/ 69322 w 583717"/>
              <a:gd name="connsiteY2" fmla="*/ 157289 h 580033"/>
              <a:gd name="connsiteX3" fmla="*/ 47890 w 583717"/>
              <a:gd name="connsiteY3" fmla="*/ 238252 h 580033"/>
              <a:gd name="connsiteX4" fmla="*/ 31222 w 583717"/>
              <a:gd name="connsiteY4" fmla="*/ 278733 h 580033"/>
              <a:gd name="connsiteX5" fmla="*/ 265 w 583717"/>
              <a:gd name="connsiteY5" fmla="*/ 435896 h 580033"/>
              <a:gd name="connsiteX6" fmla="*/ 50272 w 583717"/>
              <a:gd name="connsiteY6" fmla="*/ 531146 h 580033"/>
              <a:gd name="connsiteX7" fmla="*/ 169334 w 583717"/>
              <a:gd name="connsiteY7" fmla="*/ 554958 h 580033"/>
              <a:gd name="connsiteX8" fmla="*/ 178859 w 583717"/>
              <a:gd name="connsiteY8" fmla="*/ 488283 h 580033"/>
              <a:gd name="connsiteX9" fmla="*/ 243153 w 583717"/>
              <a:gd name="connsiteY9" fmla="*/ 509714 h 580033"/>
              <a:gd name="connsiteX10" fmla="*/ 290778 w 583717"/>
              <a:gd name="connsiteY10" fmla="*/ 443039 h 580033"/>
              <a:gd name="connsiteX11" fmla="*/ 309828 w 583717"/>
              <a:gd name="connsiteY11" fmla="*/ 547814 h 580033"/>
              <a:gd name="connsiteX12" fmla="*/ 371740 w 583717"/>
              <a:gd name="connsiteY12" fmla="*/ 571627 h 580033"/>
              <a:gd name="connsiteX13" fmla="*/ 457465 w 583717"/>
              <a:gd name="connsiteY13" fmla="*/ 419227 h 580033"/>
              <a:gd name="connsiteX14" fmla="*/ 524140 w 583717"/>
              <a:gd name="connsiteY14" fmla="*/ 347789 h 580033"/>
              <a:gd name="connsiteX15" fmla="*/ 552715 w 583717"/>
              <a:gd name="connsiteY15" fmla="*/ 283496 h 580033"/>
              <a:gd name="connsiteX16" fmla="*/ 583672 w 583717"/>
              <a:gd name="connsiteY16" fmla="*/ 200152 h 580033"/>
              <a:gd name="connsiteX17" fmla="*/ 545572 w 583717"/>
              <a:gd name="connsiteY17" fmla="*/ 104902 h 580033"/>
              <a:gd name="connsiteX18" fmla="*/ 514615 w 583717"/>
              <a:gd name="connsiteY18" fmla="*/ 88233 h 580033"/>
              <a:gd name="connsiteX19" fmla="*/ 416984 w 583717"/>
              <a:gd name="connsiteY19" fmla="*/ 28702 h 580033"/>
              <a:gd name="connsiteX20" fmla="*/ 338403 w 583717"/>
              <a:gd name="connsiteY20" fmla="*/ 127 h 580033"/>
              <a:gd name="connsiteX21" fmla="*/ 255059 w 583717"/>
              <a:gd name="connsiteY21" fmla="*/ 21558 h 580033"/>
              <a:gd name="connsiteX22" fmla="*/ 207434 w 583717"/>
              <a:gd name="connsiteY22" fmla="*/ 97758 h 5800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</a:cxnLst>
            <a:rect l="l" t="t" r="r" b="b"/>
            <a:pathLst>
              <a:path w="583717" h="580033">
                <a:moveTo>
                  <a:pt x="207434" y="97758"/>
                </a:moveTo>
                <a:cubicBezTo>
                  <a:pt x="185606" y="114030"/>
                  <a:pt x="147109" y="109267"/>
                  <a:pt x="124090" y="119189"/>
                </a:cubicBezTo>
                <a:cubicBezTo>
                  <a:pt x="101071" y="129111"/>
                  <a:pt x="82022" y="137445"/>
                  <a:pt x="69322" y="157289"/>
                </a:cubicBezTo>
                <a:cubicBezTo>
                  <a:pt x="56622" y="177133"/>
                  <a:pt x="54240" y="218011"/>
                  <a:pt x="47890" y="238252"/>
                </a:cubicBezTo>
                <a:cubicBezTo>
                  <a:pt x="41540" y="258493"/>
                  <a:pt x="39159" y="245792"/>
                  <a:pt x="31222" y="278733"/>
                </a:cubicBezTo>
                <a:cubicBezTo>
                  <a:pt x="23284" y="311674"/>
                  <a:pt x="-2910" y="393827"/>
                  <a:pt x="265" y="435896"/>
                </a:cubicBezTo>
                <a:cubicBezTo>
                  <a:pt x="3440" y="477965"/>
                  <a:pt x="22094" y="511302"/>
                  <a:pt x="50272" y="531146"/>
                </a:cubicBezTo>
                <a:cubicBezTo>
                  <a:pt x="78450" y="550990"/>
                  <a:pt x="147903" y="562102"/>
                  <a:pt x="169334" y="554958"/>
                </a:cubicBezTo>
                <a:cubicBezTo>
                  <a:pt x="190765" y="547814"/>
                  <a:pt x="166556" y="495824"/>
                  <a:pt x="178859" y="488283"/>
                </a:cubicBezTo>
                <a:cubicBezTo>
                  <a:pt x="191162" y="480742"/>
                  <a:pt x="224500" y="517255"/>
                  <a:pt x="243153" y="509714"/>
                </a:cubicBezTo>
                <a:cubicBezTo>
                  <a:pt x="261806" y="502173"/>
                  <a:pt x="279666" y="436689"/>
                  <a:pt x="290778" y="443039"/>
                </a:cubicBezTo>
                <a:cubicBezTo>
                  <a:pt x="301890" y="449389"/>
                  <a:pt x="296334" y="526383"/>
                  <a:pt x="309828" y="547814"/>
                </a:cubicBezTo>
                <a:cubicBezTo>
                  <a:pt x="323322" y="569245"/>
                  <a:pt x="347134" y="593058"/>
                  <a:pt x="371740" y="571627"/>
                </a:cubicBezTo>
                <a:cubicBezTo>
                  <a:pt x="396346" y="550196"/>
                  <a:pt x="432065" y="456533"/>
                  <a:pt x="457465" y="419227"/>
                </a:cubicBezTo>
                <a:cubicBezTo>
                  <a:pt x="482865" y="381921"/>
                  <a:pt x="508265" y="370411"/>
                  <a:pt x="524140" y="347789"/>
                </a:cubicBezTo>
                <a:cubicBezTo>
                  <a:pt x="540015" y="325167"/>
                  <a:pt x="542793" y="308102"/>
                  <a:pt x="552715" y="283496"/>
                </a:cubicBezTo>
                <a:cubicBezTo>
                  <a:pt x="562637" y="258890"/>
                  <a:pt x="584862" y="229918"/>
                  <a:pt x="583672" y="200152"/>
                </a:cubicBezTo>
                <a:cubicBezTo>
                  <a:pt x="582482" y="170386"/>
                  <a:pt x="557081" y="123555"/>
                  <a:pt x="545572" y="104902"/>
                </a:cubicBezTo>
                <a:cubicBezTo>
                  <a:pt x="534063" y="86249"/>
                  <a:pt x="536046" y="100933"/>
                  <a:pt x="514615" y="88233"/>
                </a:cubicBezTo>
                <a:cubicBezTo>
                  <a:pt x="493184" y="75533"/>
                  <a:pt x="446353" y="43386"/>
                  <a:pt x="416984" y="28702"/>
                </a:cubicBezTo>
                <a:cubicBezTo>
                  <a:pt x="387615" y="14018"/>
                  <a:pt x="365390" y="1318"/>
                  <a:pt x="338403" y="127"/>
                </a:cubicBezTo>
                <a:cubicBezTo>
                  <a:pt x="311416" y="-1064"/>
                  <a:pt x="276490" y="6080"/>
                  <a:pt x="255059" y="21558"/>
                </a:cubicBezTo>
                <a:cubicBezTo>
                  <a:pt x="233628" y="37036"/>
                  <a:pt x="229262" y="81486"/>
                  <a:pt x="207434" y="97758"/>
                </a:cubicBezTo>
                <a:close/>
              </a:path>
            </a:pathLst>
          </a:custGeom>
          <a:noFill/>
          <a:ln w="3175">
            <a:solidFill>
              <a:srgbClr val="CAC4C4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6" name="任意多边形: 形状 85"/>
          <p:cNvSpPr/>
          <p:nvPr/>
        </p:nvSpPr>
        <p:spPr>
          <a:xfrm>
            <a:off x="1962899" y="4411748"/>
            <a:ext cx="605981" cy="562427"/>
          </a:xfrm>
          <a:custGeom>
            <a:avLst/>
            <a:gdLst>
              <a:gd name="connsiteX0" fmla="*/ 221497 w 565308"/>
              <a:gd name="connsiteY0" fmla="*/ 102860 h 562427"/>
              <a:gd name="connsiteX1" fmla="*/ 145297 w 565308"/>
              <a:gd name="connsiteY1" fmla="*/ 67141 h 562427"/>
              <a:gd name="connsiteX2" fmla="*/ 66716 w 565308"/>
              <a:gd name="connsiteY2" fmla="*/ 98097 h 562427"/>
              <a:gd name="connsiteX3" fmla="*/ 9566 w 565308"/>
              <a:gd name="connsiteY3" fmla="*/ 219541 h 562427"/>
              <a:gd name="connsiteX4" fmla="*/ 16710 w 565308"/>
              <a:gd name="connsiteY4" fmla="*/ 371941 h 562427"/>
              <a:gd name="connsiteX5" fmla="*/ 169110 w 565308"/>
              <a:gd name="connsiteY5" fmla="*/ 557678 h 562427"/>
              <a:gd name="connsiteX6" fmla="*/ 266741 w 565308"/>
              <a:gd name="connsiteY6" fmla="*/ 502910 h 562427"/>
              <a:gd name="connsiteX7" fmla="*/ 309603 w 565308"/>
              <a:gd name="connsiteY7" fmla="*/ 455285 h 562427"/>
              <a:gd name="connsiteX8" fmla="*/ 338178 w 565308"/>
              <a:gd name="connsiteY8" fmla="*/ 390991 h 562427"/>
              <a:gd name="connsiteX9" fmla="*/ 373897 w 565308"/>
              <a:gd name="connsiteY9" fmla="*/ 438616 h 562427"/>
              <a:gd name="connsiteX10" fmla="*/ 402472 w 565308"/>
              <a:gd name="connsiteY10" fmla="*/ 507672 h 562427"/>
              <a:gd name="connsiteX11" fmla="*/ 492960 w 565308"/>
              <a:gd name="connsiteY11" fmla="*/ 510053 h 562427"/>
              <a:gd name="connsiteX12" fmla="*/ 562016 w 565308"/>
              <a:gd name="connsiteY12" fmla="*/ 393372 h 562427"/>
              <a:gd name="connsiteX13" fmla="*/ 547728 w 565308"/>
              <a:gd name="connsiteY13" fmla="*/ 226685 h 562427"/>
              <a:gd name="connsiteX14" fmla="*/ 490578 w 565308"/>
              <a:gd name="connsiteY14" fmla="*/ 95716 h 562427"/>
              <a:gd name="connsiteX15" fmla="*/ 373897 w 565308"/>
              <a:gd name="connsiteY15" fmla="*/ 26660 h 562427"/>
              <a:gd name="connsiteX16" fmla="*/ 273885 w 565308"/>
              <a:gd name="connsiteY16" fmla="*/ 466 h 562427"/>
              <a:gd name="connsiteX17" fmla="*/ 214353 w 565308"/>
              <a:gd name="connsiteY17" fmla="*/ 45710 h 562427"/>
              <a:gd name="connsiteX18" fmla="*/ 221497 w 565308"/>
              <a:gd name="connsiteY18" fmla="*/ 102860 h 56242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</a:cxnLst>
            <a:rect l="l" t="t" r="r" b="b"/>
            <a:pathLst>
              <a:path w="565308" h="562427">
                <a:moveTo>
                  <a:pt x="221497" y="102860"/>
                </a:moveTo>
                <a:cubicBezTo>
                  <a:pt x="209988" y="106432"/>
                  <a:pt x="171094" y="67935"/>
                  <a:pt x="145297" y="67141"/>
                </a:cubicBezTo>
                <a:cubicBezTo>
                  <a:pt x="119500" y="66347"/>
                  <a:pt x="89338" y="72697"/>
                  <a:pt x="66716" y="98097"/>
                </a:cubicBezTo>
                <a:cubicBezTo>
                  <a:pt x="44094" y="123497"/>
                  <a:pt x="17900" y="173900"/>
                  <a:pt x="9566" y="219541"/>
                </a:cubicBezTo>
                <a:cubicBezTo>
                  <a:pt x="1232" y="265182"/>
                  <a:pt x="-9881" y="315585"/>
                  <a:pt x="16710" y="371941"/>
                </a:cubicBezTo>
                <a:cubicBezTo>
                  <a:pt x="43301" y="428297"/>
                  <a:pt x="127438" y="535850"/>
                  <a:pt x="169110" y="557678"/>
                </a:cubicBezTo>
                <a:cubicBezTo>
                  <a:pt x="210782" y="579506"/>
                  <a:pt x="243326" y="519976"/>
                  <a:pt x="266741" y="502910"/>
                </a:cubicBezTo>
                <a:cubicBezTo>
                  <a:pt x="290157" y="485845"/>
                  <a:pt x="297697" y="473938"/>
                  <a:pt x="309603" y="455285"/>
                </a:cubicBezTo>
                <a:cubicBezTo>
                  <a:pt x="321509" y="436632"/>
                  <a:pt x="327462" y="393769"/>
                  <a:pt x="338178" y="390991"/>
                </a:cubicBezTo>
                <a:cubicBezTo>
                  <a:pt x="348894" y="388213"/>
                  <a:pt x="363181" y="419169"/>
                  <a:pt x="373897" y="438616"/>
                </a:cubicBezTo>
                <a:cubicBezTo>
                  <a:pt x="384613" y="458063"/>
                  <a:pt x="382628" y="495766"/>
                  <a:pt x="402472" y="507672"/>
                </a:cubicBezTo>
                <a:cubicBezTo>
                  <a:pt x="422316" y="519578"/>
                  <a:pt x="466369" y="529103"/>
                  <a:pt x="492960" y="510053"/>
                </a:cubicBezTo>
                <a:cubicBezTo>
                  <a:pt x="519551" y="491003"/>
                  <a:pt x="552888" y="440600"/>
                  <a:pt x="562016" y="393372"/>
                </a:cubicBezTo>
                <a:cubicBezTo>
                  <a:pt x="571144" y="346144"/>
                  <a:pt x="559634" y="276294"/>
                  <a:pt x="547728" y="226685"/>
                </a:cubicBezTo>
                <a:cubicBezTo>
                  <a:pt x="535822" y="177076"/>
                  <a:pt x="519550" y="129053"/>
                  <a:pt x="490578" y="95716"/>
                </a:cubicBezTo>
                <a:cubicBezTo>
                  <a:pt x="461606" y="62379"/>
                  <a:pt x="410013" y="42535"/>
                  <a:pt x="373897" y="26660"/>
                </a:cubicBezTo>
                <a:cubicBezTo>
                  <a:pt x="337782" y="10785"/>
                  <a:pt x="300476" y="-2709"/>
                  <a:pt x="273885" y="466"/>
                </a:cubicBezTo>
                <a:cubicBezTo>
                  <a:pt x="247294" y="3641"/>
                  <a:pt x="222290" y="29041"/>
                  <a:pt x="214353" y="45710"/>
                </a:cubicBezTo>
                <a:cubicBezTo>
                  <a:pt x="206416" y="62379"/>
                  <a:pt x="233006" y="99288"/>
                  <a:pt x="221497" y="102860"/>
                </a:cubicBezTo>
                <a:close/>
              </a:path>
            </a:pathLst>
          </a:custGeom>
          <a:noFill/>
          <a:ln w="3175">
            <a:solidFill>
              <a:srgbClr val="CAC4C4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1" name="椭圆 90"/>
          <p:cNvSpPr/>
          <p:nvPr/>
        </p:nvSpPr>
        <p:spPr>
          <a:xfrm rot="1765386">
            <a:off x="2413084" y="4681840"/>
            <a:ext cx="95227" cy="86353"/>
          </a:xfrm>
          <a:prstGeom prst="ellipse">
            <a:avLst/>
          </a:prstGeom>
          <a:noFill/>
          <a:ln w="317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等腰三角形 91"/>
          <p:cNvSpPr/>
          <p:nvPr/>
        </p:nvSpPr>
        <p:spPr>
          <a:xfrm rot="14376074">
            <a:off x="3141907" y="4539868"/>
            <a:ext cx="69143" cy="70329"/>
          </a:xfrm>
          <a:prstGeom prst="triangle">
            <a:avLst/>
          </a:prstGeom>
          <a:solidFill>
            <a:srgbClr val="FFFF00"/>
          </a:solidFill>
          <a:ln w="1270">
            <a:solidFill>
              <a:srgbClr val="15151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任意多边形: 形状 95"/>
          <p:cNvSpPr/>
          <p:nvPr/>
        </p:nvSpPr>
        <p:spPr>
          <a:xfrm>
            <a:off x="1207176" y="4399112"/>
            <a:ext cx="589837" cy="633226"/>
          </a:xfrm>
          <a:custGeom>
            <a:avLst/>
            <a:gdLst>
              <a:gd name="connsiteX0" fmla="*/ 216885 w 550248"/>
              <a:gd name="connsiteY0" fmla="*/ 141689 h 633226"/>
              <a:gd name="connsiteX1" fmla="*/ 121635 w 550248"/>
              <a:gd name="connsiteY1" fmla="*/ 86921 h 633226"/>
              <a:gd name="connsiteX2" fmla="*/ 38291 w 550248"/>
              <a:gd name="connsiteY2" fmla="*/ 136927 h 633226"/>
              <a:gd name="connsiteX3" fmla="*/ 191 w 550248"/>
              <a:gd name="connsiteY3" fmla="*/ 398864 h 633226"/>
              <a:gd name="connsiteX4" fmla="*/ 52578 w 550248"/>
              <a:gd name="connsiteY4" fmla="*/ 541739 h 633226"/>
              <a:gd name="connsiteX5" fmla="*/ 181166 w 550248"/>
              <a:gd name="connsiteY5" fmla="*/ 632227 h 633226"/>
              <a:gd name="connsiteX6" fmla="*/ 226410 w 550248"/>
              <a:gd name="connsiteY6" fmla="*/ 591746 h 633226"/>
              <a:gd name="connsiteX7" fmla="*/ 321660 w 550248"/>
              <a:gd name="connsiteY7" fmla="*/ 617939 h 633226"/>
              <a:gd name="connsiteX8" fmla="*/ 450247 w 550248"/>
              <a:gd name="connsiteY8" fmla="*/ 513164 h 633226"/>
              <a:gd name="connsiteX9" fmla="*/ 512160 w 550248"/>
              <a:gd name="connsiteY9" fmla="*/ 334571 h 633226"/>
              <a:gd name="connsiteX10" fmla="*/ 535972 w 550248"/>
              <a:gd name="connsiteY10" fmla="*/ 196458 h 633226"/>
              <a:gd name="connsiteX11" fmla="*/ 543116 w 550248"/>
              <a:gd name="connsiteY11" fmla="*/ 127402 h 633226"/>
              <a:gd name="connsiteX12" fmla="*/ 431197 w 550248"/>
              <a:gd name="connsiteY12" fmla="*/ 77396 h 633226"/>
              <a:gd name="connsiteX13" fmla="*/ 269272 w 550248"/>
              <a:gd name="connsiteY13" fmla="*/ 1196 h 633226"/>
              <a:gd name="connsiteX14" fmla="*/ 128778 w 550248"/>
              <a:gd name="connsiteY14" fmla="*/ 34533 h 633226"/>
              <a:gd name="connsiteX15" fmla="*/ 204978 w 550248"/>
              <a:gd name="connsiteY15" fmla="*/ 84539 h 633226"/>
              <a:gd name="connsiteX16" fmla="*/ 216885 w 550248"/>
              <a:gd name="connsiteY16" fmla="*/ 141689 h 63322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550248" h="633226">
                <a:moveTo>
                  <a:pt x="216885" y="141689"/>
                </a:moveTo>
                <a:cubicBezTo>
                  <a:pt x="202995" y="142086"/>
                  <a:pt x="151401" y="87715"/>
                  <a:pt x="121635" y="86921"/>
                </a:cubicBezTo>
                <a:cubicBezTo>
                  <a:pt x="91869" y="86127"/>
                  <a:pt x="58532" y="84937"/>
                  <a:pt x="38291" y="136927"/>
                </a:cubicBezTo>
                <a:cubicBezTo>
                  <a:pt x="18050" y="188917"/>
                  <a:pt x="-2190" y="331395"/>
                  <a:pt x="191" y="398864"/>
                </a:cubicBezTo>
                <a:cubicBezTo>
                  <a:pt x="2572" y="466333"/>
                  <a:pt x="22416" y="502845"/>
                  <a:pt x="52578" y="541739"/>
                </a:cubicBezTo>
                <a:cubicBezTo>
                  <a:pt x="82740" y="580633"/>
                  <a:pt x="152194" y="623893"/>
                  <a:pt x="181166" y="632227"/>
                </a:cubicBezTo>
                <a:cubicBezTo>
                  <a:pt x="210138" y="640561"/>
                  <a:pt x="202994" y="594127"/>
                  <a:pt x="226410" y="591746"/>
                </a:cubicBezTo>
                <a:cubicBezTo>
                  <a:pt x="249826" y="589365"/>
                  <a:pt x="284354" y="631036"/>
                  <a:pt x="321660" y="617939"/>
                </a:cubicBezTo>
                <a:cubicBezTo>
                  <a:pt x="358966" y="604842"/>
                  <a:pt x="418497" y="560392"/>
                  <a:pt x="450247" y="513164"/>
                </a:cubicBezTo>
                <a:cubicBezTo>
                  <a:pt x="481997" y="465936"/>
                  <a:pt x="497873" y="387355"/>
                  <a:pt x="512160" y="334571"/>
                </a:cubicBezTo>
                <a:cubicBezTo>
                  <a:pt x="526448" y="281787"/>
                  <a:pt x="530813" y="230986"/>
                  <a:pt x="535972" y="196458"/>
                </a:cubicBezTo>
                <a:cubicBezTo>
                  <a:pt x="541131" y="161930"/>
                  <a:pt x="560578" y="147246"/>
                  <a:pt x="543116" y="127402"/>
                </a:cubicBezTo>
                <a:cubicBezTo>
                  <a:pt x="525654" y="107558"/>
                  <a:pt x="431197" y="77396"/>
                  <a:pt x="431197" y="77396"/>
                </a:cubicBezTo>
                <a:cubicBezTo>
                  <a:pt x="385556" y="56362"/>
                  <a:pt x="319675" y="8340"/>
                  <a:pt x="269272" y="1196"/>
                </a:cubicBezTo>
                <a:cubicBezTo>
                  <a:pt x="218869" y="-5948"/>
                  <a:pt x="139494" y="20643"/>
                  <a:pt x="128778" y="34533"/>
                </a:cubicBezTo>
                <a:cubicBezTo>
                  <a:pt x="118062" y="48423"/>
                  <a:pt x="187118" y="72236"/>
                  <a:pt x="204978" y="84539"/>
                </a:cubicBezTo>
                <a:cubicBezTo>
                  <a:pt x="222838" y="96842"/>
                  <a:pt x="230775" y="141292"/>
                  <a:pt x="216885" y="141689"/>
                </a:cubicBezTo>
                <a:close/>
              </a:path>
            </a:pathLst>
          </a:custGeom>
          <a:noFill/>
          <a:ln w="3175">
            <a:solidFill>
              <a:srgbClr val="CAC4C4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8" name="等腰三角形 97"/>
          <p:cNvSpPr/>
          <p:nvPr/>
        </p:nvSpPr>
        <p:spPr>
          <a:xfrm rot="14376074">
            <a:off x="1794553" y="4475966"/>
            <a:ext cx="69143" cy="70329"/>
          </a:xfrm>
          <a:prstGeom prst="triangle">
            <a:avLst/>
          </a:prstGeom>
          <a:solidFill>
            <a:srgbClr val="FFFF00"/>
          </a:solidFill>
          <a:ln w="1270">
            <a:solidFill>
              <a:srgbClr val="15151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椭圆 98"/>
          <p:cNvSpPr/>
          <p:nvPr/>
        </p:nvSpPr>
        <p:spPr>
          <a:xfrm rot="1765386">
            <a:off x="1658669" y="4503410"/>
            <a:ext cx="137237" cy="123277"/>
          </a:xfrm>
          <a:prstGeom prst="ellipse">
            <a:avLst/>
          </a:prstGeom>
          <a:noFill/>
          <a:ln w="317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任意多边形: 形状 99"/>
          <p:cNvSpPr/>
          <p:nvPr/>
        </p:nvSpPr>
        <p:spPr>
          <a:xfrm>
            <a:off x="454839" y="4387603"/>
            <a:ext cx="591161" cy="615270"/>
          </a:xfrm>
          <a:custGeom>
            <a:avLst/>
            <a:gdLst>
              <a:gd name="connsiteX0" fmla="*/ 142437 w 551483"/>
              <a:gd name="connsiteY0" fmla="*/ 86523 h 615270"/>
              <a:gd name="connsiteX1" fmla="*/ 68618 w 551483"/>
              <a:gd name="connsiteY1" fmla="*/ 69855 h 615270"/>
              <a:gd name="connsiteX2" fmla="*/ 4325 w 551483"/>
              <a:gd name="connsiteY2" fmla="*/ 229398 h 615270"/>
              <a:gd name="connsiteX3" fmla="*/ 20993 w 551483"/>
              <a:gd name="connsiteY3" fmla="*/ 486573 h 615270"/>
              <a:gd name="connsiteX4" fmla="*/ 142437 w 551483"/>
              <a:gd name="connsiteY4" fmla="*/ 608017 h 615270"/>
              <a:gd name="connsiteX5" fmla="*/ 306743 w 551483"/>
              <a:gd name="connsiteY5" fmla="*/ 591348 h 615270"/>
              <a:gd name="connsiteX6" fmla="*/ 311506 w 551483"/>
              <a:gd name="connsiteY6" fmla="*/ 508005 h 615270"/>
              <a:gd name="connsiteX7" fmla="*/ 356750 w 551483"/>
              <a:gd name="connsiteY7" fmla="*/ 579442 h 615270"/>
              <a:gd name="connsiteX8" fmla="*/ 518675 w 551483"/>
              <a:gd name="connsiteY8" fmla="*/ 486573 h 615270"/>
              <a:gd name="connsiteX9" fmla="*/ 549631 w 551483"/>
              <a:gd name="connsiteY9" fmla="*/ 219873 h 615270"/>
              <a:gd name="connsiteX10" fmla="*/ 537725 w 551483"/>
              <a:gd name="connsiteY10" fmla="*/ 138911 h 615270"/>
              <a:gd name="connsiteX11" fmla="*/ 454381 w 551483"/>
              <a:gd name="connsiteY11" fmla="*/ 57948 h 615270"/>
              <a:gd name="connsiteX12" fmla="*/ 473431 w 551483"/>
              <a:gd name="connsiteY12" fmla="*/ 12705 h 615270"/>
              <a:gd name="connsiteX13" fmla="*/ 371037 w 551483"/>
              <a:gd name="connsiteY13" fmla="*/ 3180 h 615270"/>
              <a:gd name="connsiteX14" fmla="*/ 275787 w 551483"/>
              <a:gd name="connsiteY14" fmla="*/ 60330 h 615270"/>
              <a:gd name="connsiteX15" fmla="*/ 190062 w 551483"/>
              <a:gd name="connsiteY15" fmla="*/ 60330 h 615270"/>
              <a:gd name="connsiteX16" fmla="*/ 142437 w 551483"/>
              <a:gd name="connsiteY16" fmla="*/ 86523 h 6152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551483" h="615270">
                <a:moveTo>
                  <a:pt x="142437" y="86523"/>
                </a:moveTo>
                <a:cubicBezTo>
                  <a:pt x="122196" y="88110"/>
                  <a:pt x="91637" y="46042"/>
                  <a:pt x="68618" y="69855"/>
                </a:cubicBezTo>
                <a:cubicBezTo>
                  <a:pt x="45599" y="93668"/>
                  <a:pt x="12262" y="159945"/>
                  <a:pt x="4325" y="229398"/>
                </a:cubicBezTo>
                <a:cubicBezTo>
                  <a:pt x="-3613" y="298851"/>
                  <a:pt x="-2026" y="423470"/>
                  <a:pt x="20993" y="486573"/>
                </a:cubicBezTo>
                <a:cubicBezTo>
                  <a:pt x="44012" y="549676"/>
                  <a:pt x="94812" y="590555"/>
                  <a:pt x="142437" y="608017"/>
                </a:cubicBezTo>
                <a:cubicBezTo>
                  <a:pt x="190062" y="625480"/>
                  <a:pt x="278565" y="608017"/>
                  <a:pt x="306743" y="591348"/>
                </a:cubicBezTo>
                <a:cubicBezTo>
                  <a:pt x="334921" y="574679"/>
                  <a:pt x="303172" y="509989"/>
                  <a:pt x="311506" y="508005"/>
                </a:cubicBezTo>
                <a:cubicBezTo>
                  <a:pt x="319840" y="506021"/>
                  <a:pt x="322222" y="583014"/>
                  <a:pt x="356750" y="579442"/>
                </a:cubicBezTo>
                <a:cubicBezTo>
                  <a:pt x="391278" y="575870"/>
                  <a:pt x="486528" y="546501"/>
                  <a:pt x="518675" y="486573"/>
                </a:cubicBezTo>
                <a:cubicBezTo>
                  <a:pt x="550822" y="426645"/>
                  <a:pt x="546456" y="277817"/>
                  <a:pt x="549631" y="219873"/>
                </a:cubicBezTo>
                <a:cubicBezTo>
                  <a:pt x="552806" y="161929"/>
                  <a:pt x="553600" y="165899"/>
                  <a:pt x="537725" y="138911"/>
                </a:cubicBezTo>
                <a:cubicBezTo>
                  <a:pt x="521850" y="111924"/>
                  <a:pt x="465097" y="78982"/>
                  <a:pt x="454381" y="57948"/>
                </a:cubicBezTo>
                <a:cubicBezTo>
                  <a:pt x="443665" y="36914"/>
                  <a:pt x="487322" y="21833"/>
                  <a:pt x="473431" y="12705"/>
                </a:cubicBezTo>
                <a:cubicBezTo>
                  <a:pt x="459540" y="3577"/>
                  <a:pt x="403978" y="-4758"/>
                  <a:pt x="371037" y="3180"/>
                </a:cubicBezTo>
                <a:cubicBezTo>
                  <a:pt x="338096" y="11117"/>
                  <a:pt x="305949" y="50805"/>
                  <a:pt x="275787" y="60330"/>
                </a:cubicBezTo>
                <a:cubicBezTo>
                  <a:pt x="245625" y="69855"/>
                  <a:pt x="213081" y="58346"/>
                  <a:pt x="190062" y="60330"/>
                </a:cubicBezTo>
                <a:cubicBezTo>
                  <a:pt x="167043" y="62314"/>
                  <a:pt x="162678" y="84936"/>
                  <a:pt x="142437" y="86523"/>
                </a:cubicBezTo>
                <a:close/>
              </a:path>
            </a:pathLst>
          </a:custGeom>
          <a:noFill/>
          <a:ln w="3175">
            <a:solidFill>
              <a:srgbClr val="CAC4C4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1" name="椭圆 100"/>
          <p:cNvSpPr/>
          <p:nvPr/>
        </p:nvSpPr>
        <p:spPr>
          <a:xfrm rot="1765386">
            <a:off x="455647" y="4534642"/>
            <a:ext cx="159331" cy="210338"/>
          </a:xfrm>
          <a:prstGeom prst="ellipse">
            <a:avLst/>
          </a:prstGeom>
          <a:noFill/>
          <a:ln w="317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等腰三角形 101"/>
          <p:cNvSpPr/>
          <p:nvPr/>
        </p:nvSpPr>
        <p:spPr>
          <a:xfrm rot="14376074">
            <a:off x="606845" y="4497366"/>
            <a:ext cx="69143" cy="70329"/>
          </a:xfrm>
          <a:prstGeom prst="triangle">
            <a:avLst/>
          </a:prstGeom>
          <a:solidFill>
            <a:srgbClr val="FFFF00"/>
          </a:solidFill>
          <a:ln w="1270">
            <a:solidFill>
              <a:srgbClr val="15151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椭圆 103"/>
          <p:cNvSpPr/>
          <p:nvPr/>
        </p:nvSpPr>
        <p:spPr>
          <a:xfrm rot="1765386">
            <a:off x="2816033" y="3839071"/>
            <a:ext cx="83691" cy="87945"/>
          </a:xfrm>
          <a:prstGeom prst="ellipse">
            <a:avLst/>
          </a:prstGeom>
          <a:noFill/>
          <a:ln w="317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等腰三角形 104"/>
          <p:cNvSpPr/>
          <p:nvPr/>
        </p:nvSpPr>
        <p:spPr>
          <a:xfrm rot="14376074">
            <a:off x="2089571" y="3734810"/>
            <a:ext cx="69143" cy="70329"/>
          </a:xfrm>
          <a:prstGeom prst="triangle">
            <a:avLst/>
          </a:prstGeom>
          <a:solidFill>
            <a:srgbClr val="FFFF00"/>
          </a:solidFill>
          <a:ln w="1270">
            <a:solidFill>
              <a:srgbClr val="15151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等腰三角形 105"/>
          <p:cNvSpPr/>
          <p:nvPr/>
        </p:nvSpPr>
        <p:spPr>
          <a:xfrm rot="14376074">
            <a:off x="2897451" y="3793787"/>
            <a:ext cx="69143" cy="70329"/>
          </a:xfrm>
          <a:prstGeom prst="triangle">
            <a:avLst/>
          </a:prstGeom>
          <a:solidFill>
            <a:srgbClr val="FFFF00"/>
          </a:solidFill>
          <a:ln w="1270">
            <a:solidFill>
              <a:srgbClr val="15151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文本框 112"/>
          <p:cNvSpPr txBox="1"/>
          <p:nvPr/>
        </p:nvSpPr>
        <p:spPr>
          <a:xfrm>
            <a:off x="3408779" y="3732188"/>
            <a:ext cx="279244" cy="2771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/>
          <p:cNvSpPr txBox="1"/>
          <p:nvPr/>
        </p:nvSpPr>
        <p:spPr>
          <a:xfrm>
            <a:off x="153874" y="3565653"/>
            <a:ext cx="378630" cy="169277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15 mm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直接连接符 107"/>
          <p:cNvCxnSpPr/>
          <p:nvPr/>
        </p:nvCxnSpPr>
        <p:spPr>
          <a:xfrm>
            <a:off x="360744" y="3703469"/>
            <a:ext cx="0" cy="61624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直接连接符 119"/>
          <p:cNvCxnSpPr/>
          <p:nvPr/>
        </p:nvCxnSpPr>
        <p:spPr>
          <a:xfrm>
            <a:off x="363296" y="3703986"/>
            <a:ext cx="1929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直接连接符 120"/>
          <p:cNvCxnSpPr/>
          <p:nvPr/>
        </p:nvCxnSpPr>
        <p:spPr>
          <a:xfrm>
            <a:off x="361178" y="4319249"/>
            <a:ext cx="1929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直接连接符 121"/>
          <p:cNvCxnSpPr/>
          <p:nvPr/>
        </p:nvCxnSpPr>
        <p:spPr>
          <a:xfrm>
            <a:off x="361613" y="3908280"/>
            <a:ext cx="1929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直接连接符 124"/>
          <p:cNvCxnSpPr/>
          <p:nvPr/>
        </p:nvCxnSpPr>
        <p:spPr>
          <a:xfrm>
            <a:off x="360799" y="4112574"/>
            <a:ext cx="1929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文本框 125"/>
          <p:cNvSpPr txBox="1"/>
          <p:nvPr/>
        </p:nvSpPr>
        <p:spPr>
          <a:xfrm>
            <a:off x="148173" y="4276348"/>
            <a:ext cx="378630" cy="169277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500" dirty="0">
                <a:latin typeface="Arial" panose="020B0604020202020204" pitchFamily="34" charset="0"/>
                <a:cs typeface="Arial" panose="020B0604020202020204" pitchFamily="34" charset="0"/>
              </a:rPr>
              <a:t>15 mm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7" name="直接连接符 126"/>
          <p:cNvCxnSpPr/>
          <p:nvPr/>
        </p:nvCxnSpPr>
        <p:spPr>
          <a:xfrm>
            <a:off x="355043" y="4414164"/>
            <a:ext cx="0" cy="61624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直接连接符 127"/>
          <p:cNvCxnSpPr/>
          <p:nvPr/>
        </p:nvCxnSpPr>
        <p:spPr>
          <a:xfrm>
            <a:off x="357595" y="4414681"/>
            <a:ext cx="1929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直接连接符 128"/>
          <p:cNvCxnSpPr/>
          <p:nvPr/>
        </p:nvCxnSpPr>
        <p:spPr>
          <a:xfrm>
            <a:off x="355477" y="5029944"/>
            <a:ext cx="1929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直接连接符 129"/>
          <p:cNvCxnSpPr/>
          <p:nvPr/>
        </p:nvCxnSpPr>
        <p:spPr>
          <a:xfrm>
            <a:off x="355912" y="4618975"/>
            <a:ext cx="1929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直接连接符 130"/>
          <p:cNvCxnSpPr/>
          <p:nvPr/>
        </p:nvCxnSpPr>
        <p:spPr>
          <a:xfrm>
            <a:off x="355098" y="4823269"/>
            <a:ext cx="1929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2</TotalTime>
  <Words>111</Words>
  <Application>Microsoft Office PowerPoint</Application>
  <PresentationFormat>A4 纸张(210x297 毫米)</PresentationFormat>
  <Paragraphs>26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Office 主题​​</vt:lpstr>
      <vt:lpstr>Prism 7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i star</dc:creator>
  <cp:lastModifiedBy>star shi</cp:lastModifiedBy>
  <cp:revision>187</cp:revision>
  <cp:lastPrinted>2023-08-28T08:32:00Z</cp:lastPrinted>
  <dcterms:created xsi:type="dcterms:W3CDTF">2023-03-09T04:00:00Z</dcterms:created>
  <dcterms:modified xsi:type="dcterms:W3CDTF">2025-06-10T02:56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F78C81CABE7344A08EE65F877D03DE87_13</vt:lpwstr>
  </property>
  <property fmtid="{D5CDD505-2E9C-101B-9397-08002B2CF9AE}" pid="3" name="KSOProductBuildVer">
    <vt:lpwstr>2052-12.1.0.21541</vt:lpwstr>
  </property>
</Properties>
</file>